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handoutMasterIdLst>
    <p:handoutMasterId r:id="rId12"/>
  </p:handoutMasterIdLst>
  <p:sldIdLst>
    <p:sldId id="273" r:id="rId2"/>
    <p:sldId id="276" r:id="rId3"/>
    <p:sldId id="267" r:id="rId4"/>
    <p:sldId id="274" r:id="rId5"/>
    <p:sldId id="275" r:id="rId6"/>
    <p:sldId id="270" r:id="rId7"/>
    <p:sldId id="278" r:id="rId8"/>
    <p:sldId id="261" r:id="rId9"/>
    <p:sldId id="277" r:id="rId10"/>
    <p:sldId id="272" r:id="rId11"/>
  </p:sldIdLst>
  <p:sldSz cx="6858000" cy="9906000" type="A4"/>
  <p:notesSz cx="9918700" cy="68199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5705" userDrawn="1">
          <p15:clr>
            <a:srgbClr val="A4A3A4"/>
          </p15:clr>
        </p15:guide>
        <p15:guide id="3" pos="4088" userDrawn="1">
          <p15:clr>
            <a:srgbClr val="A4A3A4"/>
          </p15:clr>
        </p15:guide>
        <p15:guide id="4" orient="horz" pos="1192" userDrawn="1">
          <p15:clr>
            <a:srgbClr val="A4A3A4"/>
          </p15:clr>
        </p15:guide>
        <p15:guide id="5" pos="29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77" autoAdjust="0"/>
    <p:restoredTop sz="96433" autoAdjust="0"/>
  </p:normalViewPr>
  <p:slideViewPr>
    <p:cSldViewPr snapToGrid="0" showGuides="1">
      <p:cViewPr>
        <p:scale>
          <a:sx n="100" d="100"/>
          <a:sy n="100" d="100"/>
        </p:scale>
        <p:origin x="-3030" y="504"/>
      </p:cViewPr>
      <p:guideLst>
        <p:guide orient="horz" pos="5705"/>
        <p:guide orient="horz" pos="2043"/>
        <p:guide pos="4088"/>
        <p:guide pos="20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97102" cy="3418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5619288" y="0"/>
            <a:ext cx="4297101" cy="3418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8F0F1E-E614-4347-8103-D4DC45641323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1" y="6478089"/>
            <a:ext cx="4297102" cy="3418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5619288" y="6478089"/>
            <a:ext cx="4297101" cy="3418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AFB36C-E0C4-436A-A947-A5CB6D339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004231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9837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4422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9384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3712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8242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3227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7473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3529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4710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9760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913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037B6-7F53-4E2B-8D34-3A1BD028199B}" type="datetimeFigureOut">
              <a:rPr lang="fr-FR" smtClean="0"/>
              <a:t>15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962F67-B6A0-46F2-962A-3EF1E814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9188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4.emf"/><Relationship Id="rId7" Type="http://schemas.openxmlformats.org/officeDocument/2006/relationships/image" Target="../media/image28.png"/><Relationship Id="rId12" Type="http://schemas.openxmlformats.org/officeDocument/2006/relationships/image" Target="../media/image31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emf"/><Relationship Id="rId11" Type="http://schemas.openxmlformats.org/officeDocument/2006/relationships/image" Target="../media/image30.emf"/><Relationship Id="rId5" Type="http://schemas.openxmlformats.org/officeDocument/2006/relationships/image" Target="../media/image26.emf"/><Relationship Id="rId10" Type="http://schemas.microsoft.com/office/2007/relationships/hdphoto" Target="../media/hdphoto2.wdp"/><Relationship Id="rId4" Type="http://schemas.openxmlformats.org/officeDocument/2006/relationships/image" Target="../media/image25.emf"/><Relationship Id="rId9" Type="http://schemas.openxmlformats.org/officeDocument/2006/relationships/image" Target="../media/image29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="" xmlns:a16="http://schemas.microsoft.com/office/drawing/2014/main" id="{21E7464A-EC3F-4225-9F44-CB673F516D11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004434" y="3209197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ZoneTexte 2">
            <a:extLst>
              <a:ext uri="{FF2B5EF4-FFF2-40B4-BE49-F238E27FC236}">
                <a16:creationId xmlns="" xmlns:a16="http://schemas.microsoft.com/office/drawing/2014/main" id="{F2059E7F-4FC8-4AC1-BE92-776DE62CD833}"/>
              </a:ext>
            </a:extLst>
          </p:cNvPr>
          <p:cNvSpPr txBox="1"/>
          <p:nvPr/>
        </p:nvSpPr>
        <p:spPr>
          <a:xfrm>
            <a:off x="2426442" y="3176087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="" xmlns:a16="http://schemas.microsoft.com/office/drawing/2014/main" id="{C38B0D2A-BFE8-4D2D-AB5D-256FDEA1E6EF}"/>
              </a:ext>
            </a:extLst>
          </p:cNvPr>
          <p:cNvSpPr txBox="1"/>
          <p:nvPr/>
        </p:nvSpPr>
        <p:spPr>
          <a:xfrm>
            <a:off x="2985882" y="2046206"/>
            <a:ext cx="9412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WT   Hsp70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="" xmlns:a16="http://schemas.microsoft.com/office/drawing/2014/main" id="{65026D37-8532-4980-A4D3-B766EBA47D9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26989" r="25160"/>
          <a:stretch/>
        </p:blipFill>
        <p:spPr>
          <a:xfrm>
            <a:off x="3004434" y="3433078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age 5">
            <a:extLst>
              <a:ext uri="{FF2B5EF4-FFF2-40B4-BE49-F238E27FC236}">
                <a16:creationId xmlns="" xmlns:a16="http://schemas.microsoft.com/office/drawing/2014/main" id="{9120AAC6-651F-4B06-85F2-AFD8723538E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27712" r="24871"/>
          <a:stretch/>
        </p:blipFill>
        <p:spPr>
          <a:xfrm>
            <a:off x="3004434" y="3660148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ZoneTexte 6">
            <a:extLst>
              <a:ext uri="{FF2B5EF4-FFF2-40B4-BE49-F238E27FC236}">
                <a16:creationId xmlns="" xmlns:a16="http://schemas.microsoft.com/office/drawing/2014/main" id="{75B1A47C-E0B7-44B7-8A53-AFAC78B09BBA}"/>
              </a:ext>
            </a:extLst>
          </p:cNvPr>
          <p:cNvSpPr txBox="1"/>
          <p:nvPr/>
        </p:nvSpPr>
        <p:spPr>
          <a:xfrm>
            <a:off x="2575522" y="362703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="" xmlns:a16="http://schemas.microsoft.com/office/drawing/2014/main" id="{6D923EC0-4525-48A8-BA82-523A418E45EB}"/>
              </a:ext>
            </a:extLst>
          </p:cNvPr>
          <p:cNvSpPr txBox="1"/>
          <p:nvPr/>
        </p:nvSpPr>
        <p:spPr>
          <a:xfrm>
            <a:off x="2452091" y="3856285"/>
            <a:ext cx="5709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Image 8">
            <a:extLst>
              <a:ext uri="{FF2B5EF4-FFF2-40B4-BE49-F238E27FC236}">
                <a16:creationId xmlns="" xmlns:a16="http://schemas.microsoft.com/office/drawing/2014/main" id="{5FCDB2FE-876D-43D9-B99C-44FDF9D223C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27016" r="24700"/>
          <a:stretch/>
        </p:blipFill>
        <p:spPr>
          <a:xfrm>
            <a:off x="3004434" y="3889395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Image 9">
            <a:extLst>
              <a:ext uri="{FF2B5EF4-FFF2-40B4-BE49-F238E27FC236}">
                <a16:creationId xmlns="" xmlns:a16="http://schemas.microsoft.com/office/drawing/2014/main" id="{EB6563D0-F863-4F86-9571-7C259FF5BD1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/>
          <a:srcRect l="28880" r="32954"/>
          <a:stretch/>
        </p:blipFill>
        <p:spPr>
          <a:xfrm>
            <a:off x="3004434" y="2313502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ZoneTexte 10">
            <a:extLst>
              <a:ext uri="{FF2B5EF4-FFF2-40B4-BE49-F238E27FC236}">
                <a16:creationId xmlns="" xmlns:a16="http://schemas.microsoft.com/office/drawing/2014/main" id="{F0DB584B-2800-43C5-9528-5DCE504B22A9}"/>
              </a:ext>
            </a:extLst>
          </p:cNvPr>
          <p:cNvSpPr txBox="1"/>
          <p:nvPr/>
        </p:nvSpPr>
        <p:spPr>
          <a:xfrm>
            <a:off x="2434457" y="228039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SP70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="" xmlns:a16="http://schemas.microsoft.com/office/drawing/2014/main" id="{0D812C94-C116-4034-8F6E-7549B7B87431}"/>
              </a:ext>
            </a:extLst>
          </p:cNvPr>
          <p:cNvSpPr txBox="1"/>
          <p:nvPr/>
        </p:nvSpPr>
        <p:spPr>
          <a:xfrm>
            <a:off x="2434457" y="272015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="" xmlns:a16="http://schemas.microsoft.com/office/drawing/2014/main" id="{B6706C8A-8817-416D-82BF-C8D592FFF65E}"/>
              </a:ext>
            </a:extLst>
          </p:cNvPr>
          <p:cNvSpPr txBox="1"/>
          <p:nvPr/>
        </p:nvSpPr>
        <p:spPr>
          <a:xfrm>
            <a:off x="2434457" y="2497201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="" xmlns:a16="http://schemas.microsoft.com/office/drawing/2014/main" id="{6E2F7E1E-BECD-4A18-B392-F9248762F443}"/>
              </a:ext>
            </a:extLst>
          </p:cNvPr>
          <p:cNvSpPr txBox="1"/>
          <p:nvPr/>
        </p:nvSpPr>
        <p:spPr>
          <a:xfrm>
            <a:off x="2434457" y="294567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HSP40</a:t>
            </a:r>
          </a:p>
        </p:txBody>
      </p:sp>
      <p:pic>
        <p:nvPicPr>
          <p:cNvPr id="15" name="Image 14">
            <a:extLst>
              <a:ext uri="{FF2B5EF4-FFF2-40B4-BE49-F238E27FC236}">
                <a16:creationId xmlns="" xmlns:a16="http://schemas.microsoft.com/office/drawing/2014/main" id="{CBC7527F-1199-4EAA-8129-A4E7691E95F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04434" y="2743422"/>
            <a:ext cx="720000" cy="1940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Image 15">
            <a:extLst>
              <a:ext uri="{FF2B5EF4-FFF2-40B4-BE49-F238E27FC236}">
                <a16:creationId xmlns="" xmlns:a16="http://schemas.microsoft.com/office/drawing/2014/main" id="{D940FDDC-2B29-47D8-A07B-B87D14D038C1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004434" y="2526278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Image 16">
            <a:extLst>
              <a:ext uri="{FF2B5EF4-FFF2-40B4-BE49-F238E27FC236}">
                <a16:creationId xmlns="" xmlns:a16="http://schemas.microsoft.com/office/drawing/2014/main" id="{A61888AC-8FB9-46EB-9434-A006E07151FF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004434" y="2980249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Rectangle 17"/>
          <p:cNvSpPr/>
          <p:nvPr/>
        </p:nvSpPr>
        <p:spPr>
          <a:xfrm>
            <a:off x="167640" y="4435316"/>
            <a:ext cx="653796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cs typeface="Arial" pitchFamily="34" charset="0"/>
              </a:rPr>
              <a:t>Supplementary Figure </a:t>
            </a:r>
            <a:r>
              <a:rPr lang="en-US" sz="1200" b="1" dirty="0" smtClean="0">
                <a:cs typeface="Arial" pitchFamily="34" charset="0"/>
              </a:rPr>
              <a:t>1</a:t>
            </a:r>
            <a:r>
              <a:rPr lang="en-US" sz="1200" b="1" dirty="0" smtClean="0">
                <a:ea typeface="Times New Roman" panose="02020603050405020304" pitchFamily="18" charset="0"/>
                <a:cs typeface="Arial" pitchFamily="34" charset="0"/>
              </a:rPr>
              <a:t>: </a:t>
            </a:r>
            <a:r>
              <a:rPr lang="en-US" sz="1200" b="1" dirty="0">
                <a:ea typeface="Times New Roman" panose="02020603050405020304" pitchFamily="18" charset="0"/>
                <a:cs typeface="Arial" pitchFamily="34" charset="0"/>
              </a:rPr>
              <a:t>Expression of HSPs and NLRP3 </a:t>
            </a:r>
            <a:r>
              <a:rPr lang="en-US" sz="1200" b="1" dirty="0" err="1">
                <a:ea typeface="Times New Roman" panose="02020603050405020304" pitchFamily="18" charset="0"/>
                <a:cs typeface="Arial" pitchFamily="34" charset="0"/>
              </a:rPr>
              <a:t>inflammasome</a:t>
            </a:r>
            <a:r>
              <a:rPr lang="en-US" sz="1200" b="1" dirty="0"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en-US" sz="1200" b="1" dirty="0" err="1" smtClean="0">
                <a:ea typeface="Times New Roman" panose="02020603050405020304" pitchFamily="18" charset="0"/>
                <a:cs typeface="Arial" pitchFamily="34" charset="0"/>
              </a:rPr>
              <a:t>constituants</a:t>
            </a:r>
            <a:r>
              <a:rPr lang="en-US" sz="1200" b="1" dirty="0" smtClean="0"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en-US" sz="1200" b="1" dirty="0">
                <a:ea typeface="Times New Roman" panose="02020603050405020304" pitchFamily="18" charset="0"/>
                <a:cs typeface="Arial" pitchFamily="34" charset="0"/>
              </a:rPr>
              <a:t>in </a:t>
            </a:r>
            <a:r>
              <a:rPr lang="en-US" sz="1200" b="1" dirty="0" smtClean="0">
                <a:ea typeface="Times New Roman" panose="02020603050405020304" pitchFamily="18" charset="0"/>
                <a:cs typeface="Arial" pitchFamily="34" charset="0"/>
              </a:rPr>
              <a:t>WT and HSP70</a:t>
            </a:r>
            <a:r>
              <a:rPr lang="en-US" sz="1200" b="1" baseline="30000" dirty="0" smtClean="0">
                <a:ea typeface="Times New Roman" panose="02020603050405020304" pitchFamily="18" charset="0"/>
                <a:cs typeface="Arial" pitchFamily="34" charset="0"/>
              </a:rPr>
              <a:t>-/- </a:t>
            </a:r>
            <a:r>
              <a:rPr lang="en-US" sz="1200" b="1" dirty="0" smtClean="0">
                <a:ea typeface="Times New Roman" panose="02020603050405020304" pitchFamily="18" charset="0"/>
                <a:cs typeface="Arial" pitchFamily="34" charset="0"/>
              </a:rPr>
              <a:t>BMDM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Protein expression was evaluated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in BMDM isolated from WT and HSP70</a:t>
            </a:r>
            <a:r>
              <a:rPr lang="en-US" sz="1200" baseline="300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-/-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mice by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western blot. </a:t>
            </a:r>
            <a:r>
              <a:rPr lang="fr-FR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-Actin was used as a loading control. Data are representative of at least three independent experiments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</a:t>
            </a:r>
            <a:endParaRPr lang="fr-FR" sz="1200" dirty="0"/>
          </a:p>
        </p:txBody>
      </p:sp>
      <p:sp>
        <p:nvSpPr>
          <p:cNvPr id="19" name="ZoneTexte 18">
            <a:extLst>
              <a:ext uri="{FF2B5EF4-FFF2-40B4-BE49-F238E27FC236}">
                <a16:creationId xmlns="" xmlns:a16="http://schemas.microsoft.com/office/drawing/2014/main" id="{F2059E7F-4FC8-4AC1-BE92-776DE62CD833}"/>
              </a:ext>
            </a:extLst>
          </p:cNvPr>
          <p:cNvSpPr txBox="1"/>
          <p:nvPr/>
        </p:nvSpPr>
        <p:spPr>
          <a:xfrm>
            <a:off x="2051339" y="3399968"/>
            <a:ext cx="9717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1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75154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2413209" y="1359467"/>
            <a:ext cx="162973" cy="1249363"/>
            <a:chOff x="2298909" y="4685123"/>
            <a:chExt cx="76200" cy="1249363"/>
          </a:xfrm>
        </p:grpSpPr>
        <p:sp>
          <p:nvSpPr>
            <p:cNvPr id="44" name="Rectangle 5"/>
            <p:cNvSpPr>
              <a:spLocks noChangeArrowheads="1"/>
            </p:cNvSpPr>
            <p:nvPr/>
          </p:nvSpPr>
          <p:spPr bwMode="auto">
            <a:xfrm>
              <a:off x="2300497" y="4793073"/>
              <a:ext cx="71438" cy="11398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" name="Freeform 6"/>
            <p:cNvSpPr>
              <a:spLocks noEditPoints="1"/>
            </p:cNvSpPr>
            <p:nvPr/>
          </p:nvSpPr>
          <p:spPr bwMode="auto">
            <a:xfrm>
              <a:off x="2298909" y="4791486"/>
              <a:ext cx="76200" cy="1143000"/>
            </a:xfrm>
            <a:custGeom>
              <a:avLst/>
              <a:gdLst>
                <a:gd name="T0" fmla="*/ 0 w 984"/>
                <a:gd name="T1" fmla="*/ 24 h 15016"/>
                <a:gd name="T2" fmla="*/ 24 w 984"/>
                <a:gd name="T3" fmla="*/ 0 h 15016"/>
                <a:gd name="T4" fmla="*/ 960 w 984"/>
                <a:gd name="T5" fmla="*/ 0 h 15016"/>
                <a:gd name="T6" fmla="*/ 984 w 984"/>
                <a:gd name="T7" fmla="*/ 24 h 15016"/>
                <a:gd name="T8" fmla="*/ 984 w 984"/>
                <a:gd name="T9" fmla="*/ 14992 h 15016"/>
                <a:gd name="T10" fmla="*/ 960 w 984"/>
                <a:gd name="T11" fmla="*/ 15016 h 15016"/>
                <a:gd name="T12" fmla="*/ 24 w 984"/>
                <a:gd name="T13" fmla="*/ 15016 h 15016"/>
                <a:gd name="T14" fmla="*/ 0 w 984"/>
                <a:gd name="T15" fmla="*/ 14992 h 15016"/>
                <a:gd name="T16" fmla="*/ 0 w 984"/>
                <a:gd name="T17" fmla="*/ 24 h 15016"/>
                <a:gd name="T18" fmla="*/ 48 w 984"/>
                <a:gd name="T19" fmla="*/ 14992 h 15016"/>
                <a:gd name="T20" fmla="*/ 24 w 984"/>
                <a:gd name="T21" fmla="*/ 14968 h 15016"/>
                <a:gd name="T22" fmla="*/ 960 w 984"/>
                <a:gd name="T23" fmla="*/ 14968 h 15016"/>
                <a:gd name="T24" fmla="*/ 936 w 984"/>
                <a:gd name="T25" fmla="*/ 14992 h 15016"/>
                <a:gd name="T26" fmla="*/ 936 w 984"/>
                <a:gd name="T27" fmla="*/ 24 h 15016"/>
                <a:gd name="T28" fmla="*/ 960 w 984"/>
                <a:gd name="T29" fmla="*/ 48 h 15016"/>
                <a:gd name="T30" fmla="*/ 24 w 984"/>
                <a:gd name="T31" fmla="*/ 48 h 15016"/>
                <a:gd name="T32" fmla="*/ 48 w 984"/>
                <a:gd name="T33" fmla="*/ 24 h 15016"/>
                <a:gd name="T34" fmla="*/ 48 w 984"/>
                <a:gd name="T35" fmla="*/ 14992 h 150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50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4992"/>
                  </a:lnTo>
                  <a:cubicBezTo>
                    <a:pt x="984" y="15006"/>
                    <a:pt x="974" y="15016"/>
                    <a:pt x="960" y="15016"/>
                  </a:cubicBezTo>
                  <a:lnTo>
                    <a:pt x="24" y="15016"/>
                  </a:lnTo>
                  <a:cubicBezTo>
                    <a:pt x="11" y="15016"/>
                    <a:pt x="0" y="15006"/>
                    <a:pt x="0" y="14992"/>
                  </a:cubicBezTo>
                  <a:lnTo>
                    <a:pt x="0" y="24"/>
                  </a:lnTo>
                  <a:close/>
                  <a:moveTo>
                    <a:pt x="48" y="14992"/>
                  </a:moveTo>
                  <a:lnTo>
                    <a:pt x="24" y="14968"/>
                  </a:lnTo>
                  <a:lnTo>
                    <a:pt x="960" y="14968"/>
                  </a:lnTo>
                  <a:lnTo>
                    <a:pt x="936" y="14992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4992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" name="Freeform 29"/>
            <p:cNvSpPr>
              <a:spLocks noEditPoints="1"/>
            </p:cNvSpPr>
            <p:nvPr/>
          </p:nvSpPr>
          <p:spPr bwMode="auto">
            <a:xfrm>
              <a:off x="2324309" y="4685123"/>
              <a:ext cx="23813" cy="107950"/>
            </a:xfrm>
            <a:custGeom>
              <a:avLst/>
              <a:gdLst>
                <a:gd name="T0" fmla="*/ 7 w 15"/>
                <a:gd name="T1" fmla="*/ 68 h 68"/>
                <a:gd name="T2" fmla="*/ 7 w 15"/>
                <a:gd name="T3" fmla="*/ 1 h 68"/>
                <a:gd name="T4" fmla="*/ 9 w 15"/>
                <a:gd name="T5" fmla="*/ 1 h 68"/>
                <a:gd name="T6" fmla="*/ 9 w 15"/>
                <a:gd name="T7" fmla="*/ 68 h 68"/>
                <a:gd name="T8" fmla="*/ 7 w 15"/>
                <a:gd name="T9" fmla="*/ 68 h 68"/>
                <a:gd name="T10" fmla="*/ 0 w 15"/>
                <a:gd name="T11" fmla="*/ 0 h 68"/>
                <a:gd name="T12" fmla="*/ 15 w 15"/>
                <a:gd name="T13" fmla="*/ 0 h 68"/>
                <a:gd name="T14" fmla="*/ 15 w 15"/>
                <a:gd name="T15" fmla="*/ 2 h 68"/>
                <a:gd name="T16" fmla="*/ 0 w 15"/>
                <a:gd name="T17" fmla="*/ 2 h 68"/>
                <a:gd name="T18" fmla="*/ 0 w 15"/>
                <a:gd name="T19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5" h="68">
                  <a:moveTo>
                    <a:pt x="7" y="68"/>
                  </a:moveTo>
                  <a:lnTo>
                    <a:pt x="7" y="1"/>
                  </a:lnTo>
                  <a:lnTo>
                    <a:pt x="9" y="1"/>
                  </a:lnTo>
                  <a:lnTo>
                    <a:pt x="9" y="68"/>
                  </a:lnTo>
                  <a:lnTo>
                    <a:pt x="7" y="68"/>
                  </a:lnTo>
                  <a:close/>
                  <a:moveTo>
                    <a:pt x="0" y="0"/>
                  </a:moveTo>
                  <a:lnTo>
                    <a:pt x="15" y="0"/>
                  </a:lnTo>
                  <a:lnTo>
                    <a:pt x="15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4" name="Groupe 3"/>
          <p:cNvGrpSpPr/>
          <p:nvPr/>
        </p:nvGrpSpPr>
        <p:grpSpPr>
          <a:xfrm>
            <a:off x="2730709" y="1427730"/>
            <a:ext cx="162973" cy="1181100"/>
            <a:chOff x="2616409" y="4753386"/>
            <a:chExt cx="76200" cy="1181100"/>
          </a:xfrm>
        </p:grpSpPr>
        <p:sp>
          <p:nvSpPr>
            <p:cNvPr id="41" name="Rectangle 7"/>
            <p:cNvSpPr>
              <a:spLocks noChangeArrowheads="1"/>
            </p:cNvSpPr>
            <p:nvPr/>
          </p:nvSpPr>
          <p:spPr bwMode="auto">
            <a:xfrm>
              <a:off x="2619584" y="4893086"/>
              <a:ext cx="69850" cy="103981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" name="Freeform 8"/>
            <p:cNvSpPr>
              <a:spLocks noEditPoints="1"/>
            </p:cNvSpPr>
            <p:nvPr/>
          </p:nvSpPr>
          <p:spPr bwMode="auto">
            <a:xfrm>
              <a:off x="2616409" y="4891498"/>
              <a:ext cx="76200" cy="1042988"/>
            </a:xfrm>
            <a:custGeom>
              <a:avLst/>
              <a:gdLst>
                <a:gd name="T0" fmla="*/ 0 w 984"/>
                <a:gd name="T1" fmla="*/ 24 h 13704"/>
                <a:gd name="T2" fmla="*/ 24 w 984"/>
                <a:gd name="T3" fmla="*/ 0 h 13704"/>
                <a:gd name="T4" fmla="*/ 960 w 984"/>
                <a:gd name="T5" fmla="*/ 0 h 13704"/>
                <a:gd name="T6" fmla="*/ 984 w 984"/>
                <a:gd name="T7" fmla="*/ 24 h 13704"/>
                <a:gd name="T8" fmla="*/ 984 w 984"/>
                <a:gd name="T9" fmla="*/ 13680 h 13704"/>
                <a:gd name="T10" fmla="*/ 960 w 984"/>
                <a:gd name="T11" fmla="*/ 13704 h 13704"/>
                <a:gd name="T12" fmla="*/ 24 w 984"/>
                <a:gd name="T13" fmla="*/ 13704 h 13704"/>
                <a:gd name="T14" fmla="*/ 0 w 984"/>
                <a:gd name="T15" fmla="*/ 13680 h 13704"/>
                <a:gd name="T16" fmla="*/ 0 w 984"/>
                <a:gd name="T17" fmla="*/ 24 h 13704"/>
                <a:gd name="T18" fmla="*/ 48 w 984"/>
                <a:gd name="T19" fmla="*/ 13680 h 13704"/>
                <a:gd name="T20" fmla="*/ 24 w 984"/>
                <a:gd name="T21" fmla="*/ 13656 h 13704"/>
                <a:gd name="T22" fmla="*/ 960 w 984"/>
                <a:gd name="T23" fmla="*/ 13656 h 13704"/>
                <a:gd name="T24" fmla="*/ 936 w 984"/>
                <a:gd name="T25" fmla="*/ 13680 h 13704"/>
                <a:gd name="T26" fmla="*/ 936 w 984"/>
                <a:gd name="T27" fmla="*/ 24 h 13704"/>
                <a:gd name="T28" fmla="*/ 960 w 984"/>
                <a:gd name="T29" fmla="*/ 48 h 13704"/>
                <a:gd name="T30" fmla="*/ 24 w 984"/>
                <a:gd name="T31" fmla="*/ 48 h 13704"/>
                <a:gd name="T32" fmla="*/ 48 w 984"/>
                <a:gd name="T33" fmla="*/ 24 h 13704"/>
                <a:gd name="T34" fmla="*/ 48 w 984"/>
                <a:gd name="T35" fmla="*/ 13680 h 137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3704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3680"/>
                  </a:lnTo>
                  <a:cubicBezTo>
                    <a:pt x="984" y="13694"/>
                    <a:pt x="974" y="13704"/>
                    <a:pt x="960" y="13704"/>
                  </a:cubicBezTo>
                  <a:lnTo>
                    <a:pt x="24" y="13704"/>
                  </a:lnTo>
                  <a:cubicBezTo>
                    <a:pt x="11" y="13704"/>
                    <a:pt x="0" y="13694"/>
                    <a:pt x="0" y="13680"/>
                  </a:cubicBezTo>
                  <a:lnTo>
                    <a:pt x="0" y="24"/>
                  </a:lnTo>
                  <a:close/>
                  <a:moveTo>
                    <a:pt x="48" y="13680"/>
                  </a:moveTo>
                  <a:lnTo>
                    <a:pt x="24" y="13656"/>
                  </a:lnTo>
                  <a:lnTo>
                    <a:pt x="960" y="13656"/>
                  </a:lnTo>
                  <a:lnTo>
                    <a:pt x="936" y="13680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368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" name="Freeform 30"/>
            <p:cNvSpPr>
              <a:spLocks noEditPoints="1"/>
            </p:cNvSpPr>
            <p:nvPr/>
          </p:nvSpPr>
          <p:spPr bwMode="auto">
            <a:xfrm>
              <a:off x="2643397" y="4753386"/>
              <a:ext cx="22225" cy="139700"/>
            </a:xfrm>
            <a:custGeom>
              <a:avLst/>
              <a:gdLst>
                <a:gd name="T0" fmla="*/ 6 w 14"/>
                <a:gd name="T1" fmla="*/ 88 h 88"/>
                <a:gd name="T2" fmla="*/ 6 w 14"/>
                <a:gd name="T3" fmla="*/ 1 h 88"/>
                <a:gd name="T4" fmla="*/ 8 w 14"/>
                <a:gd name="T5" fmla="*/ 1 h 88"/>
                <a:gd name="T6" fmla="*/ 8 w 14"/>
                <a:gd name="T7" fmla="*/ 88 h 88"/>
                <a:gd name="T8" fmla="*/ 6 w 14"/>
                <a:gd name="T9" fmla="*/ 88 h 88"/>
                <a:gd name="T10" fmla="*/ 0 w 14"/>
                <a:gd name="T11" fmla="*/ 0 h 88"/>
                <a:gd name="T12" fmla="*/ 14 w 14"/>
                <a:gd name="T13" fmla="*/ 0 h 88"/>
                <a:gd name="T14" fmla="*/ 14 w 14"/>
                <a:gd name="T15" fmla="*/ 2 h 88"/>
                <a:gd name="T16" fmla="*/ 0 w 14"/>
                <a:gd name="T17" fmla="*/ 2 h 88"/>
                <a:gd name="T18" fmla="*/ 0 w 14"/>
                <a:gd name="T19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4" h="88">
                  <a:moveTo>
                    <a:pt x="6" y="88"/>
                  </a:moveTo>
                  <a:lnTo>
                    <a:pt x="6" y="1"/>
                  </a:lnTo>
                  <a:lnTo>
                    <a:pt x="8" y="1"/>
                  </a:lnTo>
                  <a:lnTo>
                    <a:pt x="8" y="88"/>
                  </a:lnTo>
                  <a:lnTo>
                    <a:pt x="6" y="88"/>
                  </a:lnTo>
                  <a:close/>
                  <a:moveTo>
                    <a:pt x="0" y="0"/>
                  </a:moveTo>
                  <a:lnTo>
                    <a:pt x="14" y="0"/>
                  </a:lnTo>
                  <a:lnTo>
                    <a:pt x="14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3049796" y="1610292"/>
            <a:ext cx="159578" cy="998538"/>
            <a:chOff x="2935497" y="4935948"/>
            <a:chExt cx="74613" cy="998538"/>
          </a:xfrm>
        </p:grpSpPr>
        <p:sp>
          <p:nvSpPr>
            <p:cNvPr id="38" name="Rectangle 9"/>
            <p:cNvSpPr>
              <a:spLocks noChangeArrowheads="1"/>
            </p:cNvSpPr>
            <p:nvPr/>
          </p:nvSpPr>
          <p:spPr bwMode="auto">
            <a:xfrm>
              <a:off x="2937084" y="4975636"/>
              <a:ext cx="71438" cy="957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" name="Freeform 10"/>
            <p:cNvSpPr>
              <a:spLocks noEditPoints="1"/>
            </p:cNvSpPr>
            <p:nvPr/>
          </p:nvSpPr>
          <p:spPr bwMode="auto">
            <a:xfrm>
              <a:off x="2935497" y="4974048"/>
              <a:ext cx="74613" cy="960438"/>
            </a:xfrm>
            <a:custGeom>
              <a:avLst/>
              <a:gdLst>
                <a:gd name="T0" fmla="*/ 0 w 984"/>
                <a:gd name="T1" fmla="*/ 24 h 12616"/>
                <a:gd name="T2" fmla="*/ 24 w 984"/>
                <a:gd name="T3" fmla="*/ 0 h 12616"/>
                <a:gd name="T4" fmla="*/ 960 w 984"/>
                <a:gd name="T5" fmla="*/ 0 h 12616"/>
                <a:gd name="T6" fmla="*/ 984 w 984"/>
                <a:gd name="T7" fmla="*/ 24 h 12616"/>
                <a:gd name="T8" fmla="*/ 984 w 984"/>
                <a:gd name="T9" fmla="*/ 12592 h 12616"/>
                <a:gd name="T10" fmla="*/ 960 w 984"/>
                <a:gd name="T11" fmla="*/ 12616 h 12616"/>
                <a:gd name="T12" fmla="*/ 24 w 984"/>
                <a:gd name="T13" fmla="*/ 12616 h 12616"/>
                <a:gd name="T14" fmla="*/ 0 w 984"/>
                <a:gd name="T15" fmla="*/ 12592 h 12616"/>
                <a:gd name="T16" fmla="*/ 0 w 984"/>
                <a:gd name="T17" fmla="*/ 24 h 12616"/>
                <a:gd name="T18" fmla="*/ 48 w 984"/>
                <a:gd name="T19" fmla="*/ 12592 h 12616"/>
                <a:gd name="T20" fmla="*/ 24 w 984"/>
                <a:gd name="T21" fmla="*/ 12568 h 12616"/>
                <a:gd name="T22" fmla="*/ 960 w 984"/>
                <a:gd name="T23" fmla="*/ 12568 h 12616"/>
                <a:gd name="T24" fmla="*/ 936 w 984"/>
                <a:gd name="T25" fmla="*/ 12592 h 12616"/>
                <a:gd name="T26" fmla="*/ 936 w 984"/>
                <a:gd name="T27" fmla="*/ 24 h 12616"/>
                <a:gd name="T28" fmla="*/ 960 w 984"/>
                <a:gd name="T29" fmla="*/ 48 h 12616"/>
                <a:gd name="T30" fmla="*/ 24 w 984"/>
                <a:gd name="T31" fmla="*/ 48 h 12616"/>
                <a:gd name="T32" fmla="*/ 48 w 984"/>
                <a:gd name="T33" fmla="*/ 24 h 12616"/>
                <a:gd name="T34" fmla="*/ 48 w 984"/>
                <a:gd name="T35" fmla="*/ 12592 h 126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26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2592"/>
                  </a:lnTo>
                  <a:cubicBezTo>
                    <a:pt x="984" y="12606"/>
                    <a:pt x="974" y="12616"/>
                    <a:pt x="960" y="12616"/>
                  </a:cubicBezTo>
                  <a:lnTo>
                    <a:pt x="24" y="12616"/>
                  </a:lnTo>
                  <a:cubicBezTo>
                    <a:pt x="11" y="12616"/>
                    <a:pt x="0" y="12606"/>
                    <a:pt x="0" y="12592"/>
                  </a:cubicBezTo>
                  <a:lnTo>
                    <a:pt x="0" y="24"/>
                  </a:lnTo>
                  <a:close/>
                  <a:moveTo>
                    <a:pt x="48" y="12592"/>
                  </a:moveTo>
                  <a:lnTo>
                    <a:pt x="24" y="12568"/>
                  </a:lnTo>
                  <a:lnTo>
                    <a:pt x="960" y="12568"/>
                  </a:lnTo>
                  <a:lnTo>
                    <a:pt x="936" y="12592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2592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" name="Freeform 31"/>
            <p:cNvSpPr>
              <a:spLocks noEditPoints="1"/>
            </p:cNvSpPr>
            <p:nvPr/>
          </p:nvSpPr>
          <p:spPr bwMode="auto">
            <a:xfrm>
              <a:off x="2960897" y="4935948"/>
              <a:ext cx="23813" cy="39688"/>
            </a:xfrm>
            <a:custGeom>
              <a:avLst/>
              <a:gdLst>
                <a:gd name="T0" fmla="*/ 7 w 15"/>
                <a:gd name="T1" fmla="*/ 25 h 25"/>
                <a:gd name="T2" fmla="*/ 7 w 15"/>
                <a:gd name="T3" fmla="*/ 2 h 25"/>
                <a:gd name="T4" fmla="*/ 9 w 15"/>
                <a:gd name="T5" fmla="*/ 2 h 25"/>
                <a:gd name="T6" fmla="*/ 9 w 15"/>
                <a:gd name="T7" fmla="*/ 25 h 25"/>
                <a:gd name="T8" fmla="*/ 7 w 15"/>
                <a:gd name="T9" fmla="*/ 25 h 25"/>
                <a:gd name="T10" fmla="*/ 0 w 15"/>
                <a:gd name="T11" fmla="*/ 0 h 25"/>
                <a:gd name="T12" fmla="*/ 15 w 15"/>
                <a:gd name="T13" fmla="*/ 0 h 25"/>
                <a:gd name="T14" fmla="*/ 15 w 15"/>
                <a:gd name="T15" fmla="*/ 3 h 25"/>
                <a:gd name="T16" fmla="*/ 0 w 15"/>
                <a:gd name="T17" fmla="*/ 3 h 25"/>
                <a:gd name="T18" fmla="*/ 0 w 15"/>
                <a:gd name="T19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5" h="25">
                  <a:moveTo>
                    <a:pt x="7" y="25"/>
                  </a:moveTo>
                  <a:lnTo>
                    <a:pt x="7" y="2"/>
                  </a:lnTo>
                  <a:lnTo>
                    <a:pt x="9" y="2"/>
                  </a:lnTo>
                  <a:lnTo>
                    <a:pt x="9" y="25"/>
                  </a:lnTo>
                  <a:lnTo>
                    <a:pt x="7" y="25"/>
                  </a:lnTo>
                  <a:close/>
                  <a:moveTo>
                    <a:pt x="0" y="0"/>
                  </a:moveTo>
                  <a:lnTo>
                    <a:pt x="15" y="0"/>
                  </a:lnTo>
                  <a:lnTo>
                    <a:pt x="15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6" name="Groupe 5"/>
          <p:cNvGrpSpPr/>
          <p:nvPr/>
        </p:nvGrpSpPr>
        <p:grpSpPr>
          <a:xfrm>
            <a:off x="3367297" y="1519805"/>
            <a:ext cx="162973" cy="1089025"/>
            <a:chOff x="3252997" y="4845461"/>
            <a:chExt cx="76200" cy="1089025"/>
          </a:xfrm>
        </p:grpSpPr>
        <p:sp>
          <p:nvSpPr>
            <p:cNvPr id="35" name="Rectangle 11"/>
            <p:cNvSpPr>
              <a:spLocks noChangeArrowheads="1"/>
            </p:cNvSpPr>
            <p:nvPr/>
          </p:nvSpPr>
          <p:spPr bwMode="auto">
            <a:xfrm>
              <a:off x="3254584" y="4875623"/>
              <a:ext cx="71438" cy="105727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" name="Freeform 12"/>
            <p:cNvSpPr>
              <a:spLocks noEditPoints="1"/>
            </p:cNvSpPr>
            <p:nvPr/>
          </p:nvSpPr>
          <p:spPr bwMode="auto">
            <a:xfrm>
              <a:off x="3252997" y="4874036"/>
              <a:ext cx="76200" cy="1060450"/>
            </a:xfrm>
            <a:custGeom>
              <a:avLst/>
              <a:gdLst>
                <a:gd name="T0" fmla="*/ 0 w 984"/>
                <a:gd name="T1" fmla="*/ 24 h 13928"/>
                <a:gd name="T2" fmla="*/ 24 w 984"/>
                <a:gd name="T3" fmla="*/ 0 h 13928"/>
                <a:gd name="T4" fmla="*/ 960 w 984"/>
                <a:gd name="T5" fmla="*/ 0 h 13928"/>
                <a:gd name="T6" fmla="*/ 984 w 984"/>
                <a:gd name="T7" fmla="*/ 24 h 13928"/>
                <a:gd name="T8" fmla="*/ 984 w 984"/>
                <a:gd name="T9" fmla="*/ 13904 h 13928"/>
                <a:gd name="T10" fmla="*/ 960 w 984"/>
                <a:gd name="T11" fmla="*/ 13928 h 13928"/>
                <a:gd name="T12" fmla="*/ 24 w 984"/>
                <a:gd name="T13" fmla="*/ 13928 h 13928"/>
                <a:gd name="T14" fmla="*/ 0 w 984"/>
                <a:gd name="T15" fmla="*/ 13904 h 13928"/>
                <a:gd name="T16" fmla="*/ 0 w 984"/>
                <a:gd name="T17" fmla="*/ 24 h 13928"/>
                <a:gd name="T18" fmla="*/ 48 w 984"/>
                <a:gd name="T19" fmla="*/ 13904 h 13928"/>
                <a:gd name="T20" fmla="*/ 24 w 984"/>
                <a:gd name="T21" fmla="*/ 13880 h 13928"/>
                <a:gd name="T22" fmla="*/ 960 w 984"/>
                <a:gd name="T23" fmla="*/ 13880 h 13928"/>
                <a:gd name="T24" fmla="*/ 936 w 984"/>
                <a:gd name="T25" fmla="*/ 13904 h 13928"/>
                <a:gd name="T26" fmla="*/ 936 w 984"/>
                <a:gd name="T27" fmla="*/ 24 h 13928"/>
                <a:gd name="T28" fmla="*/ 960 w 984"/>
                <a:gd name="T29" fmla="*/ 48 h 13928"/>
                <a:gd name="T30" fmla="*/ 24 w 984"/>
                <a:gd name="T31" fmla="*/ 48 h 13928"/>
                <a:gd name="T32" fmla="*/ 48 w 984"/>
                <a:gd name="T33" fmla="*/ 24 h 13928"/>
                <a:gd name="T34" fmla="*/ 48 w 984"/>
                <a:gd name="T35" fmla="*/ 13904 h 139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3928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3904"/>
                  </a:lnTo>
                  <a:cubicBezTo>
                    <a:pt x="984" y="13918"/>
                    <a:pt x="974" y="13928"/>
                    <a:pt x="960" y="13928"/>
                  </a:cubicBezTo>
                  <a:lnTo>
                    <a:pt x="24" y="13928"/>
                  </a:lnTo>
                  <a:cubicBezTo>
                    <a:pt x="11" y="13928"/>
                    <a:pt x="0" y="13918"/>
                    <a:pt x="0" y="13904"/>
                  </a:cubicBezTo>
                  <a:lnTo>
                    <a:pt x="0" y="24"/>
                  </a:lnTo>
                  <a:close/>
                  <a:moveTo>
                    <a:pt x="48" y="13904"/>
                  </a:moveTo>
                  <a:lnTo>
                    <a:pt x="24" y="13880"/>
                  </a:lnTo>
                  <a:lnTo>
                    <a:pt x="960" y="13880"/>
                  </a:lnTo>
                  <a:lnTo>
                    <a:pt x="936" y="13904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390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" name="Freeform 32"/>
            <p:cNvSpPr>
              <a:spLocks noEditPoints="1"/>
            </p:cNvSpPr>
            <p:nvPr/>
          </p:nvSpPr>
          <p:spPr bwMode="auto">
            <a:xfrm>
              <a:off x="3279984" y="4845461"/>
              <a:ext cx="22225" cy="30163"/>
            </a:xfrm>
            <a:custGeom>
              <a:avLst/>
              <a:gdLst>
                <a:gd name="T0" fmla="*/ 6 w 14"/>
                <a:gd name="T1" fmla="*/ 19 h 19"/>
                <a:gd name="T2" fmla="*/ 6 w 14"/>
                <a:gd name="T3" fmla="*/ 1 h 19"/>
                <a:gd name="T4" fmla="*/ 8 w 14"/>
                <a:gd name="T5" fmla="*/ 1 h 19"/>
                <a:gd name="T6" fmla="*/ 8 w 14"/>
                <a:gd name="T7" fmla="*/ 19 h 19"/>
                <a:gd name="T8" fmla="*/ 6 w 14"/>
                <a:gd name="T9" fmla="*/ 19 h 19"/>
                <a:gd name="T10" fmla="*/ 0 w 14"/>
                <a:gd name="T11" fmla="*/ 0 h 19"/>
                <a:gd name="T12" fmla="*/ 14 w 14"/>
                <a:gd name="T13" fmla="*/ 0 h 19"/>
                <a:gd name="T14" fmla="*/ 14 w 14"/>
                <a:gd name="T15" fmla="*/ 2 h 19"/>
                <a:gd name="T16" fmla="*/ 0 w 14"/>
                <a:gd name="T17" fmla="*/ 2 h 19"/>
                <a:gd name="T18" fmla="*/ 0 w 14"/>
                <a:gd name="T19" fmla="*/ 0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4" h="19">
                  <a:moveTo>
                    <a:pt x="6" y="19"/>
                  </a:moveTo>
                  <a:lnTo>
                    <a:pt x="6" y="1"/>
                  </a:lnTo>
                  <a:lnTo>
                    <a:pt x="8" y="1"/>
                  </a:lnTo>
                  <a:lnTo>
                    <a:pt x="8" y="19"/>
                  </a:lnTo>
                  <a:lnTo>
                    <a:pt x="6" y="19"/>
                  </a:lnTo>
                  <a:close/>
                  <a:moveTo>
                    <a:pt x="0" y="0"/>
                  </a:moveTo>
                  <a:lnTo>
                    <a:pt x="14" y="0"/>
                  </a:lnTo>
                  <a:lnTo>
                    <a:pt x="14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7" name="Groupe 6"/>
          <p:cNvGrpSpPr/>
          <p:nvPr/>
        </p:nvGrpSpPr>
        <p:grpSpPr>
          <a:xfrm>
            <a:off x="3686383" y="1402330"/>
            <a:ext cx="159578" cy="1206500"/>
            <a:chOff x="3572084" y="4727986"/>
            <a:chExt cx="74613" cy="1206500"/>
          </a:xfrm>
        </p:grpSpPr>
        <p:sp>
          <p:nvSpPr>
            <p:cNvPr id="32" name="Rectangle 13"/>
            <p:cNvSpPr>
              <a:spLocks noChangeArrowheads="1"/>
            </p:cNvSpPr>
            <p:nvPr/>
          </p:nvSpPr>
          <p:spPr bwMode="auto">
            <a:xfrm>
              <a:off x="3573672" y="4840698"/>
              <a:ext cx="71438" cy="10922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" name="Freeform 14"/>
            <p:cNvSpPr>
              <a:spLocks noEditPoints="1"/>
            </p:cNvSpPr>
            <p:nvPr/>
          </p:nvSpPr>
          <p:spPr bwMode="auto">
            <a:xfrm>
              <a:off x="3572084" y="4839111"/>
              <a:ext cx="74613" cy="1095375"/>
            </a:xfrm>
            <a:custGeom>
              <a:avLst/>
              <a:gdLst>
                <a:gd name="T0" fmla="*/ 0 w 984"/>
                <a:gd name="T1" fmla="*/ 24 h 14384"/>
                <a:gd name="T2" fmla="*/ 24 w 984"/>
                <a:gd name="T3" fmla="*/ 0 h 14384"/>
                <a:gd name="T4" fmla="*/ 960 w 984"/>
                <a:gd name="T5" fmla="*/ 0 h 14384"/>
                <a:gd name="T6" fmla="*/ 984 w 984"/>
                <a:gd name="T7" fmla="*/ 24 h 14384"/>
                <a:gd name="T8" fmla="*/ 984 w 984"/>
                <a:gd name="T9" fmla="*/ 14360 h 14384"/>
                <a:gd name="T10" fmla="*/ 960 w 984"/>
                <a:gd name="T11" fmla="*/ 14384 h 14384"/>
                <a:gd name="T12" fmla="*/ 24 w 984"/>
                <a:gd name="T13" fmla="*/ 14384 h 14384"/>
                <a:gd name="T14" fmla="*/ 0 w 984"/>
                <a:gd name="T15" fmla="*/ 14360 h 14384"/>
                <a:gd name="T16" fmla="*/ 0 w 984"/>
                <a:gd name="T17" fmla="*/ 24 h 14384"/>
                <a:gd name="T18" fmla="*/ 48 w 984"/>
                <a:gd name="T19" fmla="*/ 14360 h 14384"/>
                <a:gd name="T20" fmla="*/ 24 w 984"/>
                <a:gd name="T21" fmla="*/ 14336 h 14384"/>
                <a:gd name="T22" fmla="*/ 960 w 984"/>
                <a:gd name="T23" fmla="*/ 14336 h 14384"/>
                <a:gd name="T24" fmla="*/ 936 w 984"/>
                <a:gd name="T25" fmla="*/ 14360 h 14384"/>
                <a:gd name="T26" fmla="*/ 936 w 984"/>
                <a:gd name="T27" fmla="*/ 24 h 14384"/>
                <a:gd name="T28" fmla="*/ 960 w 984"/>
                <a:gd name="T29" fmla="*/ 48 h 14384"/>
                <a:gd name="T30" fmla="*/ 24 w 984"/>
                <a:gd name="T31" fmla="*/ 48 h 14384"/>
                <a:gd name="T32" fmla="*/ 48 w 984"/>
                <a:gd name="T33" fmla="*/ 24 h 14384"/>
                <a:gd name="T34" fmla="*/ 48 w 984"/>
                <a:gd name="T35" fmla="*/ 14360 h 143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4384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4360"/>
                  </a:lnTo>
                  <a:cubicBezTo>
                    <a:pt x="984" y="14374"/>
                    <a:pt x="974" y="14384"/>
                    <a:pt x="960" y="14384"/>
                  </a:cubicBezTo>
                  <a:lnTo>
                    <a:pt x="24" y="14384"/>
                  </a:lnTo>
                  <a:cubicBezTo>
                    <a:pt x="11" y="14384"/>
                    <a:pt x="0" y="14374"/>
                    <a:pt x="0" y="14360"/>
                  </a:cubicBezTo>
                  <a:lnTo>
                    <a:pt x="0" y="24"/>
                  </a:lnTo>
                  <a:close/>
                  <a:moveTo>
                    <a:pt x="48" y="14360"/>
                  </a:moveTo>
                  <a:lnTo>
                    <a:pt x="24" y="14336"/>
                  </a:lnTo>
                  <a:lnTo>
                    <a:pt x="960" y="14336"/>
                  </a:lnTo>
                  <a:lnTo>
                    <a:pt x="936" y="14360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436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" name="Freeform 33"/>
            <p:cNvSpPr>
              <a:spLocks noEditPoints="1"/>
            </p:cNvSpPr>
            <p:nvPr/>
          </p:nvSpPr>
          <p:spPr bwMode="auto">
            <a:xfrm>
              <a:off x="3597484" y="4727986"/>
              <a:ext cx="23813" cy="112713"/>
            </a:xfrm>
            <a:custGeom>
              <a:avLst/>
              <a:gdLst>
                <a:gd name="T0" fmla="*/ 6 w 15"/>
                <a:gd name="T1" fmla="*/ 71 h 71"/>
                <a:gd name="T2" fmla="*/ 6 w 15"/>
                <a:gd name="T3" fmla="*/ 2 h 71"/>
                <a:gd name="T4" fmla="*/ 8 w 15"/>
                <a:gd name="T5" fmla="*/ 2 h 71"/>
                <a:gd name="T6" fmla="*/ 8 w 15"/>
                <a:gd name="T7" fmla="*/ 71 h 71"/>
                <a:gd name="T8" fmla="*/ 6 w 15"/>
                <a:gd name="T9" fmla="*/ 71 h 71"/>
                <a:gd name="T10" fmla="*/ 0 w 15"/>
                <a:gd name="T11" fmla="*/ 0 h 71"/>
                <a:gd name="T12" fmla="*/ 15 w 15"/>
                <a:gd name="T13" fmla="*/ 0 h 71"/>
                <a:gd name="T14" fmla="*/ 15 w 15"/>
                <a:gd name="T15" fmla="*/ 3 h 71"/>
                <a:gd name="T16" fmla="*/ 0 w 15"/>
                <a:gd name="T17" fmla="*/ 3 h 71"/>
                <a:gd name="T18" fmla="*/ 0 w 15"/>
                <a:gd name="T19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5" h="71">
                  <a:moveTo>
                    <a:pt x="6" y="71"/>
                  </a:moveTo>
                  <a:lnTo>
                    <a:pt x="6" y="2"/>
                  </a:lnTo>
                  <a:lnTo>
                    <a:pt x="8" y="2"/>
                  </a:lnTo>
                  <a:lnTo>
                    <a:pt x="8" y="71"/>
                  </a:lnTo>
                  <a:lnTo>
                    <a:pt x="6" y="71"/>
                  </a:lnTo>
                  <a:close/>
                  <a:moveTo>
                    <a:pt x="0" y="0"/>
                  </a:moveTo>
                  <a:lnTo>
                    <a:pt x="15" y="0"/>
                  </a:lnTo>
                  <a:lnTo>
                    <a:pt x="15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8" name="Groupe 7"/>
          <p:cNvGrpSpPr/>
          <p:nvPr/>
        </p:nvGrpSpPr>
        <p:grpSpPr>
          <a:xfrm>
            <a:off x="4003884" y="1575367"/>
            <a:ext cx="162973" cy="1033463"/>
            <a:chOff x="3889584" y="4901023"/>
            <a:chExt cx="76200" cy="1033463"/>
          </a:xfrm>
        </p:grpSpPr>
        <p:sp>
          <p:nvSpPr>
            <p:cNvPr id="29" name="Rectangle 15"/>
            <p:cNvSpPr>
              <a:spLocks noChangeArrowheads="1"/>
            </p:cNvSpPr>
            <p:nvPr/>
          </p:nvSpPr>
          <p:spPr bwMode="auto">
            <a:xfrm>
              <a:off x="3891172" y="4947061"/>
              <a:ext cx="71438" cy="98583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" name="Freeform 16"/>
            <p:cNvSpPr>
              <a:spLocks noEditPoints="1"/>
            </p:cNvSpPr>
            <p:nvPr/>
          </p:nvSpPr>
          <p:spPr bwMode="auto">
            <a:xfrm>
              <a:off x="3889584" y="4943886"/>
              <a:ext cx="76200" cy="990600"/>
            </a:xfrm>
            <a:custGeom>
              <a:avLst/>
              <a:gdLst>
                <a:gd name="T0" fmla="*/ 0 w 984"/>
                <a:gd name="T1" fmla="*/ 24 h 13000"/>
                <a:gd name="T2" fmla="*/ 24 w 984"/>
                <a:gd name="T3" fmla="*/ 0 h 13000"/>
                <a:gd name="T4" fmla="*/ 960 w 984"/>
                <a:gd name="T5" fmla="*/ 0 h 13000"/>
                <a:gd name="T6" fmla="*/ 984 w 984"/>
                <a:gd name="T7" fmla="*/ 24 h 13000"/>
                <a:gd name="T8" fmla="*/ 984 w 984"/>
                <a:gd name="T9" fmla="*/ 12976 h 13000"/>
                <a:gd name="T10" fmla="*/ 960 w 984"/>
                <a:gd name="T11" fmla="*/ 13000 h 13000"/>
                <a:gd name="T12" fmla="*/ 24 w 984"/>
                <a:gd name="T13" fmla="*/ 13000 h 13000"/>
                <a:gd name="T14" fmla="*/ 0 w 984"/>
                <a:gd name="T15" fmla="*/ 12976 h 13000"/>
                <a:gd name="T16" fmla="*/ 0 w 984"/>
                <a:gd name="T17" fmla="*/ 24 h 13000"/>
                <a:gd name="T18" fmla="*/ 48 w 984"/>
                <a:gd name="T19" fmla="*/ 12976 h 13000"/>
                <a:gd name="T20" fmla="*/ 24 w 984"/>
                <a:gd name="T21" fmla="*/ 12952 h 13000"/>
                <a:gd name="T22" fmla="*/ 960 w 984"/>
                <a:gd name="T23" fmla="*/ 12952 h 13000"/>
                <a:gd name="T24" fmla="*/ 936 w 984"/>
                <a:gd name="T25" fmla="*/ 12976 h 13000"/>
                <a:gd name="T26" fmla="*/ 936 w 984"/>
                <a:gd name="T27" fmla="*/ 24 h 13000"/>
                <a:gd name="T28" fmla="*/ 960 w 984"/>
                <a:gd name="T29" fmla="*/ 48 h 13000"/>
                <a:gd name="T30" fmla="*/ 24 w 984"/>
                <a:gd name="T31" fmla="*/ 48 h 13000"/>
                <a:gd name="T32" fmla="*/ 48 w 984"/>
                <a:gd name="T33" fmla="*/ 24 h 13000"/>
                <a:gd name="T34" fmla="*/ 48 w 984"/>
                <a:gd name="T35" fmla="*/ 12976 h 130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3000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2976"/>
                  </a:lnTo>
                  <a:cubicBezTo>
                    <a:pt x="984" y="12990"/>
                    <a:pt x="974" y="13000"/>
                    <a:pt x="960" y="13000"/>
                  </a:cubicBezTo>
                  <a:lnTo>
                    <a:pt x="24" y="13000"/>
                  </a:lnTo>
                  <a:cubicBezTo>
                    <a:pt x="11" y="13000"/>
                    <a:pt x="0" y="12990"/>
                    <a:pt x="0" y="12976"/>
                  </a:cubicBezTo>
                  <a:lnTo>
                    <a:pt x="0" y="24"/>
                  </a:lnTo>
                  <a:close/>
                  <a:moveTo>
                    <a:pt x="48" y="12976"/>
                  </a:moveTo>
                  <a:lnTo>
                    <a:pt x="24" y="12952"/>
                  </a:lnTo>
                  <a:lnTo>
                    <a:pt x="960" y="12952"/>
                  </a:lnTo>
                  <a:lnTo>
                    <a:pt x="936" y="12976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297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" name="Freeform 34"/>
            <p:cNvSpPr>
              <a:spLocks noEditPoints="1"/>
            </p:cNvSpPr>
            <p:nvPr/>
          </p:nvSpPr>
          <p:spPr bwMode="auto">
            <a:xfrm>
              <a:off x="3914984" y="4901023"/>
              <a:ext cx="23813" cy="46038"/>
            </a:xfrm>
            <a:custGeom>
              <a:avLst/>
              <a:gdLst>
                <a:gd name="T0" fmla="*/ 7 w 15"/>
                <a:gd name="T1" fmla="*/ 29 h 29"/>
                <a:gd name="T2" fmla="*/ 7 w 15"/>
                <a:gd name="T3" fmla="*/ 1 h 29"/>
                <a:gd name="T4" fmla="*/ 9 w 15"/>
                <a:gd name="T5" fmla="*/ 1 h 29"/>
                <a:gd name="T6" fmla="*/ 9 w 15"/>
                <a:gd name="T7" fmla="*/ 29 h 29"/>
                <a:gd name="T8" fmla="*/ 7 w 15"/>
                <a:gd name="T9" fmla="*/ 29 h 29"/>
                <a:gd name="T10" fmla="*/ 0 w 15"/>
                <a:gd name="T11" fmla="*/ 0 h 29"/>
                <a:gd name="T12" fmla="*/ 15 w 15"/>
                <a:gd name="T13" fmla="*/ 0 h 29"/>
                <a:gd name="T14" fmla="*/ 15 w 15"/>
                <a:gd name="T15" fmla="*/ 2 h 29"/>
                <a:gd name="T16" fmla="*/ 0 w 15"/>
                <a:gd name="T17" fmla="*/ 2 h 29"/>
                <a:gd name="T18" fmla="*/ 0 w 15"/>
                <a:gd name="T19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5" h="29">
                  <a:moveTo>
                    <a:pt x="7" y="29"/>
                  </a:moveTo>
                  <a:lnTo>
                    <a:pt x="7" y="1"/>
                  </a:lnTo>
                  <a:lnTo>
                    <a:pt x="9" y="1"/>
                  </a:lnTo>
                  <a:lnTo>
                    <a:pt x="9" y="29"/>
                  </a:lnTo>
                  <a:lnTo>
                    <a:pt x="7" y="29"/>
                  </a:lnTo>
                  <a:close/>
                  <a:moveTo>
                    <a:pt x="0" y="0"/>
                  </a:moveTo>
                  <a:lnTo>
                    <a:pt x="15" y="0"/>
                  </a:lnTo>
                  <a:lnTo>
                    <a:pt x="15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9" name="Rectangle 41"/>
          <p:cNvSpPr>
            <a:spLocks noChangeArrowheads="1"/>
          </p:cNvSpPr>
          <p:nvPr/>
        </p:nvSpPr>
        <p:spPr bwMode="auto">
          <a:xfrm>
            <a:off x="2333834" y="926080"/>
            <a:ext cx="6350" cy="168116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" name="Freeform 42"/>
          <p:cNvSpPr>
            <a:spLocks noEditPoints="1"/>
          </p:cNvSpPr>
          <p:nvPr/>
        </p:nvSpPr>
        <p:spPr bwMode="auto">
          <a:xfrm>
            <a:off x="2311049" y="922905"/>
            <a:ext cx="28800" cy="1689100"/>
          </a:xfrm>
          <a:custGeom>
            <a:avLst/>
            <a:gdLst>
              <a:gd name="T0" fmla="*/ 0 w 9"/>
              <a:gd name="T1" fmla="*/ 1059 h 1064"/>
              <a:gd name="T2" fmla="*/ 9 w 9"/>
              <a:gd name="T3" fmla="*/ 1059 h 1064"/>
              <a:gd name="T4" fmla="*/ 9 w 9"/>
              <a:gd name="T5" fmla="*/ 1064 h 1064"/>
              <a:gd name="T6" fmla="*/ 0 w 9"/>
              <a:gd name="T7" fmla="*/ 1064 h 1064"/>
              <a:gd name="T8" fmla="*/ 0 w 9"/>
              <a:gd name="T9" fmla="*/ 1059 h 1064"/>
              <a:gd name="T10" fmla="*/ 0 w 9"/>
              <a:gd name="T11" fmla="*/ 847 h 1064"/>
              <a:gd name="T12" fmla="*/ 9 w 9"/>
              <a:gd name="T13" fmla="*/ 847 h 1064"/>
              <a:gd name="T14" fmla="*/ 9 w 9"/>
              <a:gd name="T15" fmla="*/ 852 h 1064"/>
              <a:gd name="T16" fmla="*/ 0 w 9"/>
              <a:gd name="T17" fmla="*/ 852 h 1064"/>
              <a:gd name="T18" fmla="*/ 0 w 9"/>
              <a:gd name="T19" fmla="*/ 847 h 1064"/>
              <a:gd name="T20" fmla="*/ 0 w 9"/>
              <a:gd name="T21" fmla="*/ 635 h 1064"/>
              <a:gd name="T22" fmla="*/ 9 w 9"/>
              <a:gd name="T23" fmla="*/ 635 h 1064"/>
              <a:gd name="T24" fmla="*/ 9 w 9"/>
              <a:gd name="T25" fmla="*/ 640 h 1064"/>
              <a:gd name="T26" fmla="*/ 0 w 9"/>
              <a:gd name="T27" fmla="*/ 640 h 1064"/>
              <a:gd name="T28" fmla="*/ 0 w 9"/>
              <a:gd name="T29" fmla="*/ 635 h 1064"/>
              <a:gd name="T30" fmla="*/ 0 w 9"/>
              <a:gd name="T31" fmla="*/ 423 h 1064"/>
              <a:gd name="T32" fmla="*/ 9 w 9"/>
              <a:gd name="T33" fmla="*/ 423 h 1064"/>
              <a:gd name="T34" fmla="*/ 9 w 9"/>
              <a:gd name="T35" fmla="*/ 428 h 1064"/>
              <a:gd name="T36" fmla="*/ 0 w 9"/>
              <a:gd name="T37" fmla="*/ 428 h 1064"/>
              <a:gd name="T38" fmla="*/ 0 w 9"/>
              <a:gd name="T39" fmla="*/ 423 h 1064"/>
              <a:gd name="T40" fmla="*/ 0 w 9"/>
              <a:gd name="T41" fmla="*/ 211 h 1064"/>
              <a:gd name="T42" fmla="*/ 9 w 9"/>
              <a:gd name="T43" fmla="*/ 211 h 1064"/>
              <a:gd name="T44" fmla="*/ 9 w 9"/>
              <a:gd name="T45" fmla="*/ 216 h 1064"/>
              <a:gd name="T46" fmla="*/ 0 w 9"/>
              <a:gd name="T47" fmla="*/ 216 h 1064"/>
              <a:gd name="T48" fmla="*/ 0 w 9"/>
              <a:gd name="T49" fmla="*/ 211 h 1064"/>
              <a:gd name="T50" fmla="*/ 0 w 9"/>
              <a:gd name="T51" fmla="*/ 0 h 1064"/>
              <a:gd name="T52" fmla="*/ 9 w 9"/>
              <a:gd name="T53" fmla="*/ 0 h 1064"/>
              <a:gd name="T54" fmla="*/ 9 w 9"/>
              <a:gd name="T55" fmla="*/ 4 h 1064"/>
              <a:gd name="T56" fmla="*/ 0 w 9"/>
              <a:gd name="T57" fmla="*/ 4 h 1064"/>
              <a:gd name="T58" fmla="*/ 0 w 9"/>
              <a:gd name="T59" fmla="*/ 0 h 10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9" h="1064">
                <a:moveTo>
                  <a:pt x="0" y="1059"/>
                </a:moveTo>
                <a:lnTo>
                  <a:pt x="9" y="1059"/>
                </a:lnTo>
                <a:lnTo>
                  <a:pt x="9" y="1064"/>
                </a:lnTo>
                <a:lnTo>
                  <a:pt x="0" y="1064"/>
                </a:lnTo>
                <a:lnTo>
                  <a:pt x="0" y="1059"/>
                </a:lnTo>
                <a:close/>
                <a:moveTo>
                  <a:pt x="0" y="847"/>
                </a:moveTo>
                <a:lnTo>
                  <a:pt x="9" y="847"/>
                </a:lnTo>
                <a:lnTo>
                  <a:pt x="9" y="852"/>
                </a:lnTo>
                <a:lnTo>
                  <a:pt x="0" y="852"/>
                </a:lnTo>
                <a:lnTo>
                  <a:pt x="0" y="847"/>
                </a:lnTo>
                <a:close/>
                <a:moveTo>
                  <a:pt x="0" y="635"/>
                </a:moveTo>
                <a:lnTo>
                  <a:pt x="9" y="635"/>
                </a:lnTo>
                <a:lnTo>
                  <a:pt x="9" y="640"/>
                </a:lnTo>
                <a:lnTo>
                  <a:pt x="0" y="640"/>
                </a:lnTo>
                <a:lnTo>
                  <a:pt x="0" y="635"/>
                </a:lnTo>
                <a:close/>
                <a:moveTo>
                  <a:pt x="0" y="423"/>
                </a:moveTo>
                <a:lnTo>
                  <a:pt x="9" y="423"/>
                </a:lnTo>
                <a:lnTo>
                  <a:pt x="9" y="428"/>
                </a:lnTo>
                <a:lnTo>
                  <a:pt x="0" y="428"/>
                </a:lnTo>
                <a:lnTo>
                  <a:pt x="0" y="423"/>
                </a:lnTo>
                <a:close/>
                <a:moveTo>
                  <a:pt x="0" y="211"/>
                </a:moveTo>
                <a:lnTo>
                  <a:pt x="9" y="211"/>
                </a:lnTo>
                <a:lnTo>
                  <a:pt x="9" y="216"/>
                </a:lnTo>
                <a:lnTo>
                  <a:pt x="0" y="216"/>
                </a:lnTo>
                <a:lnTo>
                  <a:pt x="0" y="211"/>
                </a:lnTo>
                <a:close/>
                <a:moveTo>
                  <a:pt x="0" y="0"/>
                </a:moveTo>
                <a:lnTo>
                  <a:pt x="9" y="0"/>
                </a:lnTo>
                <a:lnTo>
                  <a:pt x="9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" name="Rectangle 43"/>
          <p:cNvSpPr>
            <a:spLocks noChangeArrowheads="1"/>
          </p:cNvSpPr>
          <p:nvPr/>
        </p:nvSpPr>
        <p:spPr bwMode="auto">
          <a:xfrm>
            <a:off x="2337009" y="2604067"/>
            <a:ext cx="1908175" cy="793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46"/>
          <p:cNvSpPr>
            <a:spLocks noChangeArrowheads="1"/>
          </p:cNvSpPr>
          <p:nvPr/>
        </p:nvSpPr>
        <p:spPr bwMode="auto">
          <a:xfrm>
            <a:off x="2216136" y="2532630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" name="Rectangle 47"/>
          <p:cNvSpPr>
            <a:spLocks noChangeArrowheads="1"/>
          </p:cNvSpPr>
          <p:nvPr/>
        </p:nvSpPr>
        <p:spPr bwMode="auto">
          <a:xfrm>
            <a:off x="2145604" y="219449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4" name="Rectangle 48"/>
          <p:cNvSpPr>
            <a:spLocks noChangeArrowheads="1"/>
          </p:cNvSpPr>
          <p:nvPr/>
        </p:nvSpPr>
        <p:spPr bwMode="auto">
          <a:xfrm>
            <a:off x="2075072" y="185794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5" name="Rectangle 49"/>
          <p:cNvSpPr>
            <a:spLocks noChangeArrowheads="1"/>
          </p:cNvSpPr>
          <p:nvPr/>
        </p:nvSpPr>
        <p:spPr bwMode="auto">
          <a:xfrm>
            <a:off x="2075072" y="152139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6" name="Rectangle 50"/>
          <p:cNvSpPr>
            <a:spLocks noChangeArrowheads="1"/>
          </p:cNvSpPr>
          <p:nvPr/>
        </p:nvSpPr>
        <p:spPr bwMode="auto">
          <a:xfrm>
            <a:off x="2075072" y="118484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17" name="Rectangle 51"/>
          <p:cNvSpPr>
            <a:spLocks noChangeArrowheads="1"/>
          </p:cNvSpPr>
          <p:nvPr/>
        </p:nvSpPr>
        <p:spPr bwMode="auto">
          <a:xfrm>
            <a:off x="2075072" y="84829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8" name="Rectangle 52"/>
          <p:cNvSpPr>
            <a:spLocks noChangeArrowheads="1"/>
          </p:cNvSpPr>
          <p:nvPr/>
        </p:nvSpPr>
        <p:spPr bwMode="auto">
          <a:xfrm>
            <a:off x="2486854" y="2637405"/>
            <a:ext cx="4328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dirty="0">
                <a:cs typeface="Arial" panose="020B0604020202020204" pitchFamily="34" charset="0"/>
              </a:rPr>
              <a:t>-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9" name="Rectangle 53"/>
          <p:cNvSpPr>
            <a:spLocks noChangeArrowheads="1"/>
          </p:cNvSpPr>
          <p:nvPr/>
        </p:nvSpPr>
        <p:spPr bwMode="auto">
          <a:xfrm>
            <a:off x="2730709" y="2637405"/>
            <a:ext cx="24846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rPr>
              <a:t>ATP</a:t>
            </a:r>
          </a:p>
        </p:txBody>
      </p:sp>
      <p:sp>
        <p:nvSpPr>
          <p:cNvPr id="20" name="Rectangle 54"/>
          <p:cNvSpPr>
            <a:spLocks noChangeArrowheads="1"/>
          </p:cNvSpPr>
          <p:nvPr/>
        </p:nvSpPr>
        <p:spPr bwMode="auto">
          <a:xfrm>
            <a:off x="3054559" y="2637405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effectLst/>
                <a:cs typeface="Arial" panose="020B0604020202020204" pitchFamily="34" charset="0"/>
              </a:rPr>
              <a:t>Nig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1" name="Rectangle 55"/>
          <p:cNvSpPr>
            <a:spLocks noChangeArrowheads="1"/>
          </p:cNvSpPr>
          <p:nvPr/>
        </p:nvSpPr>
        <p:spPr bwMode="auto">
          <a:xfrm>
            <a:off x="3440943" y="2637405"/>
            <a:ext cx="4328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Rectangle 56"/>
          <p:cNvSpPr>
            <a:spLocks noChangeArrowheads="1"/>
          </p:cNvSpPr>
          <p:nvPr/>
        </p:nvSpPr>
        <p:spPr bwMode="auto">
          <a:xfrm>
            <a:off x="3684797" y="2637405"/>
            <a:ext cx="24846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rPr>
              <a:t>ATP</a:t>
            </a:r>
          </a:p>
        </p:txBody>
      </p:sp>
      <p:sp>
        <p:nvSpPr>
          <p:cNvPr id="23" name="Rectangle 57"/>
          <p:cNvSpPr>
            <a:spLocks noChangeArrowheads="1"/>
          </p:cNvSpPr>
          <p:nvPr/>
        </p:nvSpPr>
        <p:spPr bwMode="auto">
          <a:xfrm>
            <a:off x="4008647" y="2637405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rPr>
              <a:t>Nig</a:t>
            </a:r>
          </a:p>
        </p:txBody>
      </p:sp>
      <p:sp>
        <p:nvSpPr>
          <p:cNvPr id="24" name="Rectangle 58"/>
          <p:cNvSpPr>
            <a:spLocks noChangeArrowheads="1"/>
          </p:cNvSpPr>
          <p:nvPr/>
        </p:nvSpPr>
        <p:spPr bwMode="auto">
          <a:xfrm>
            <a:off x="2695587" y="2831422"/>
            <a:ext cx="22121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dirty="0">
                <a:cs typeface="Arial" panose="020B0604020202020204" pitchFamily="34" charset="0"/>
              </a:rPr>
              <a:t>-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HS</a:t>
            </a:r>
          </a:p>
        </p:txBody>
      </p:sp>
      <p:sp>
        <p:nvSpPr>
          <p:cNvPr id="25" name="Rectangle 59"/>
          <p:cNvSpPr>
            <a:spLocks noChangeArrowheads="1"/>
          </p:cNvSpPr>
          <p:nvPr/>
        </p:nvSpPr>
        <p:spPr bwMode="auto">
          <a:xfrm>
            <a:off x="3649675" y="2831422"/>
            <a:ext cx="25327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dirty="0">
                <a:cs typeface="Arial" panose="020B0604020202020204" pitchFamily="34" charset="0"/>
              </a:rPr>
              <a:t>+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HS</a:t>
            </a:r>
          </a:p>
        </p:txBody>
      </p:sp>
      <p:cxnSp>
        <p:nvCxnSpPr>
          <p:cNvPr id="26" name="Connecteur droit 25"/>
          <p:cNvCxnSpPr/>
          <p:nvPr/>
        </p:nvCxnSpPr>
        <p:spPr>
          <a:xfrm>
            <a:off x="2503697" y="2831422"/>
            <a:ext cx="636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>
            <a:off x="3444162" y="2831422"/>
            <a:ext cx="636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145"/>
          <p:cNvSpPr>
            <a:spLocks noChangeArrowheads="1"/>
          </p:cNvSpPr>
          <p:nvPr/>
        </p:nvSpPr>
        <p:spPr bwMode="auto">
          <a:xfrm rot="16200000">
            <a:off x="1524309" y="1690183"/>
            <a:ext cx="79989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33039"/>
            <a:r>
              <a:rPr lang="fr-FR" altLang="fr-FR" sz="1000" dirty="0" smtClean="0">
                <a:cs typeface="Arial" panose="020B0604020202020204" pitchFamily="34" charset="0"/>
              </a:rPr>
              <a:t>TNF</a:t>
            </a:r>
            <a:r>
              <a:rPr lang="el-GR" altLang="fr-FR" sz="1000" dirty="0" smtClean="0">
                <a:cs typeface="Arial" panose="020B0604020202020204" pitchFamily="34" charset="0"/>
              </a:rPr>
              <a:t>α</a:t>
            </a:r>
            <a:r>
              <a:rPr lang="fr-FR" altLang="fr-FR" sz="1000" dirty="0" smtClean="0">
                <a:cs typeface="Arial" panose="020B0604020202020204" pitchFamily="34" charset="0"/>
              </a:rPr>
              <a:t> </a:t>
            </a:r>
            <a:r>
              <a:rPr lang="fr-FR" altLang="fr-FR" sz="1000" dirty="0">
                <a:cs typeface="Arial" panose="020B0604020202020204" pitchFamily="34" charset="0"/>
              </a:rPr>
              <a:t>(</a:t>
            </a:r>
            <a:r>
              <a:rPr lang="fr-FR" altLang="fr-FR" sz="1000" dirty="0" err="1">
                <a:cs typeface="Arial" panose="020B0604020202020204" pitchFamily="34" charset="0"/>
              </a:rPr>
              <a:t>pg</a:t>
            </a:r>
            <a:r>
              <a:rPr lang="fr-FR" altLang="fr-FR" sz="1000" dirty="0">
                <a:cs typeface="Arial" panose="020B0604020202020204" pitchFamily="34" charset="0"/>
              </a:rPr>
              <a:t>/</a:t>
            </a:r>
            <a:r>
              <a:rPr lang="fr-FR" altLang="fr-FR" sz="1000" dirty="0" err="1">
                <a:cs typeface="Arial" panose="020B0604020202020204" pitchFamily="34" charset="0"/>
              </a:rPr>
              <a:t>mL</a:t>
            </a:r>
            <a:r>
              <a:rPr lang="fr-FR" altLang="fr-FR" sz="1000" dirty="0"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51" name="Connecteur droit 50"/>
          <p:cNvCxnSpPr/>
          <p:nvPr/>
        </p:nvCxnSpPr>
        <p:spPr>
          <a:xfrm>
            <a:off x="2810760" y="3050840"/>
            <a:ext cx="9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ectangle 53"/>
          <p:cNvSpPr>
            <a:spLocks noChangeArrowheads="1"/>
          </p:cNvSpPr>
          <p:nvPr/>
        </p:nvSpPr>
        <p:spPr bwMode="auto">
          <a:xfrm>
            <a:off x="3176535" y="3076240"/>
            <a:ext cx="24045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2" name="Rectangle 1"/>
          <p:cNvSpPr/>
          <p:nvPr/>
        </p:nvSpPr>
        <p:spPr>
          <a:xfrm>
            <a:off x="94478" y="5330573"/>
            <a:ext cx="664922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: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Production of TNFα by BMDMs under HS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BMDMs from WT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C57BL/6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mice were stimulated with 100ng/mL LPS for 20h and then submitted or not to a heat shock (HS – 42°C for 1h followed by 2h at 37°C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)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then left untreated or treated 30min with ATP (5mM) or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eric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– 40µM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upernatants were collected and TNFα was measured by ELISA. Data are the mean of three experiments ±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.d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</a:t>
            </a:r>
            <a:endParaRPr lang="fr-FR" sz="1200" dirty="0">
              <a:effectLst/>
              <a:latin typeface="Arial" pitchFamily="34" charset="0"/>
              <a:ea typeface="Times New Roman" panose="02020603050405020304" pitchFamily="18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71901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95250" y="4559300"/>
            <a:ext cx="66103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Production of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IL-1</a:t>
            </a:r>
            <a:r>
              <a:rPr lang="el-GR" sz="1200" b="1" dirty="0" smtClean="0">
                <a:latin typeface="Arial" pitchFamily="34" charset="0"/>
                <a:ea typeface="Cambria Math"/>
                <a:cs typeface="Arial" pitchFamily="34" charset="0"/>
              </a:rPr>
              <a:t>β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y BMDMs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BMDMs from WT or Hsp70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57BL/6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mice were stimulated with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300ng/mL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LPS for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3h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then left untreated or treated 30min with ATP (5mM) or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eric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– 40µM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or 6h with MSU (100µg/mL)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Supernatants were collected and IL-1</a:t>
            </a:r>
            <a:r>
              <a:rPr lang="el-GR" sz="1200" dirty="0">
                <a:latin typeface="Arial" pitchFamily="34" charset="0"/>
                <a:ea typeface="Cambria Math"/>
                <a:cs typeface="Arial" pitchFamily="34" charset="0"/>
              </a:rPr>
              <a:t>β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was measured by ELISA. Data are the mean of three independent experiments ±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s.d.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</a:t>
            </a:r>
            <a:endParaRPr lang="fr-FR" sz="1200" dirty="0">
              <a:latin typeface="Arial" pitchFamily="34" charset="0"/>
              <a:cs typeface="Arial" pitchFamily="34" charset="0"/>
            </a:endParaRPr>
          </a:p>
          <a:p>
            <a:pPr algn="just"/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10" name="Picture 8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7850" y="1800149"/>
            <a:ext cx="3162300" cy="220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25783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2283163" y="1952628"/>
            <a:ext cx="1162602" cy="1333500"/>
            <a:chOff x="1454488" y="695328"/>
            <a:chExt cx="870502" cy="1333500"/>
          </a:xfrm>
        </p:grpSpPr>
        <p:sp>
          <p:nvSpPr>
            <p:cNvPr id="4" name="Rectangle 5"/>
            <p:cNvSpPr>
              <a:spLocks noChangeArrowheads="1"/>
            </p:cNvSpPr>
            <p:nvPr/>
          </p:nvSpPr>
          <p:spPr bwMode="auto">
            <a:xfrm>
              <a:off x="1456791" y="887415"/>
              <a:ext cx="103599" cy="11398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" name="Freeform 6"/>
            <p:cNvSpPr>
              <a:spLocks noEditPoints="1"/>
            </p:cNvSpPr>
            <p:nvPr/>
          </p:nvSpPr>
          <p:spPr bwMode="auto">
            <a:xfrm>
              <a:off x="1454488" y="885828"/>
              <a:ext cx="110505" cy="1143000"/>
            </a:xfrm>
            <a:custGeom>
              <a:avLst/>
              <a:gdLst>
                <a:gd name="T0" fmla="*/ 0 w 984"/>
                <a:gd name="T1" fmla="*/ 24 h 15016"/>
                <a:gd name="T2" fmla="*/ 24 w 984"/>
                <a:gd name="T3" fmla="*/ 0 h 15016"/>
                <a:gd name="T4" fmla="*/ 960 w 984"/>
                <a:gd name="T5" fmla="*/ 0 h 15016"/>
                <a:gd name="T6" fmla="*/ 984 w 984"/>
                <a:gd name="T7" fmla="*/ 24 h 15016"/>
                <a:gd name="T8" fmla="*/ 984 w 984"/>
                <a:gd name="T9" fmla="*/ 14992 h 15016"/>
                <a:gd name="T10" fmla="*/ 960 w 984"/>
                <a:gd name="T11" fmla="*/ 15016 h 15016"/>
                <a:gd name="T12" fmla="*/ 24 w 984"/>
                <a:gd name="T13" fmla="*/ 15016 h 15016"/>
                <a:gd name="T14" fmla="*/ 0 w 984"/>
                <a:gd name="T15" fmla="*/ 14992 h 15016"/>
                <a:gd name="T16" fmla="*/ 0 w 984"/>
                <a:gd name="T17" fmla="*/ 24 h 15016"/>
                <a:gd name="T18" fmla="*/ 48 w 984"/>
                <a:gd name="T19" fmla="*/ 14992 h 15016"/>
                <a:gd name="T20" fmla="*/ 24 w 984"/>
                <a:gd name="T21" fmla="*/ 14968 h 15016"/>
                <a:gd name="T22" fmla="*/ 960 w 984"/>
                <a:gd name="T23" fmla="*/ 14968 h 15016"/>
                <a:gd name="T24" fmla="*/ 936 w 984"/>
                <a:gd name="T25" fmla="*/ 14992 h 15016"/>
                <a:gd name="T26" fmla="*/ 936 w 984"/>
                <a:gd name="T27" fmla="*/ 24 h 15016"/>
                <a:gd name="T28" fmla="*/ 960 w 984"/>
                <a:gd name="T29" fmla="*/ 48 h 15016"/>
                <a:gd name="T30" fmla="*/ 24 w 984"/>
                <a:gd name="T31" fmla="*/ 48 h 15016"/>
                <a:gd name="T32" fmla="*/ 48 w 984"/>
                <a:gd name="T33" fmla="*/ 24 h 15016"/>
                <a:gd name="T34" fmla="*/ 48 w 984"/>
                <a:gd name="T35" fmla="*/ 14992 h 150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50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4992"/>
                  </a:lnTo>
                  <a:cubicBezTo>
                    <a:pt x="984" y="15006"/>
                    <a:pt x="974" y="15016"/>
                    <a:pt x="960" y="15016"/>
                  </a:cubicBezTo>
                  <a:lnTo>
                    <a:pt x="24" y="15016"/>
                  </a:lnTo>
                  <a:cubicBezTo>
                    <a:pt x="11" y="15016"/>
                    <a:pt x="0" y="15006"/>
                    <a:pt x="0" y="14992"/>
                  </a:cubicBezTo>
                  <a:lnTo>
                    <a:pt x="0" y="24"/>
                  </a:lnTo>
                  <a:close/>
                  <a:moveTo>
                    <a:pt x="48" y="14992"/>
                  </a:moveTo>
                  <a:lnTo>
                    <a:pt x="24" y="14968"/>
                  </a:lnTo>
                  <a:lnTo>
                    <a:pt x="960" y="14968"/>
                  </a:lnTo>
                  <a:lnTo>
                    <a:pt x="936" y="14992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4992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" name="Rectangle 7"/>
            <p:cNvSpPr>
              <a:spLocks noChangeArrowheads="1"/>
            </p:cNvSpPr>
            <p:nvPr/>
          </p:nvSpPr>
          <p:spPr bwMode="auto">
            <a:xfrm>
              <a:off x="1786179" y="987428"/>
              <a:ext cx="101296" cy="103981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" name="Freeform 8"/>
            <p:cNvSpPr>
              <a:spLocks noEditPoints="1"/>
            </p:cNvSpPr>
            <p:nvPr/>
          </p:nvSpPr>
          <p:spPr bwMode="auto">
            <a:xfrm>
              <a:off x="1781574" y="985840"/>
              <a:ext cx="110505" cy="1042988"/>
            </a:xfrm>
            <a:custGeom>
              <a:avLst/>
              <a:gdLst>
                <a:gd name="T0" fmla="*/ 0 w 984"/>
                <a:gd name="T1" fmla="*/ 24 h 13704"/>
                <a:gd name="T2" fmla="*/ 24 w 984"/>
                <a:gd name="T3" fmla="*/ 0 h 13704"/>
                <a:gd name="T4" fmla="*/ 960 w 984"/>
                <a:gd name="T5" fmla="*/ 0 h 13704"/>
                <a:gd name="T6" fmla="*/ 984 w 984"/>
                <a:gd name="T7" fmla="*/ 24 h 13704"/>
                <a:gd name="T8" fmla="*/ 984 w 984"/>
                <a:gd name="T9" fmla="*/ 13680 h 13704"/>
                <a:gd name="T10" fmla="*/ 960 w 984"/>
                <a:gd name="T11" fmla="*/ 13704 h 13704"/>
                <a:gd name="T12" fmla="*/ 24 w 984"/>
                <a:gd name="T13" fmla="*/ 13704 h 13704"/>
                <a:gd name="T14" fmla="*/ 0 w 984"/>
                <a:gd name="T15" fmla="*/ 13680 h 13704"/>
                <a:gd name="T16" fmla="*/ 0 w 984"/>
                <a:gd name="T17" fmla="*/ 24 h 13704"/>
                <a:gd name="T18" fmla="*/ 48 w 984"/>
                <a:gd name="T19" fmla="*/ 13680 h 13704"/>
                <a:gd name="T20" fmla="*/ 24 w 984"/>
                <a:gd name="T21" fmla="*/ 13656 h 13704"/>
                <a:gd name="T22" fmla="*/ 960 w 984"/>
                <a:gd name="T23" fmla="*/ 13656 h 13704"/>
                <a:gd name="T24" fmla="*/ 936 w 984"/>
                <a:gd name="T25" fmla="*/ 13680 h 13704"/>
                <a:gd name="T26" fmla="*/ 936 w 984"/>
                <a:gd name="T27" fmla="*/ 24 h 13704"/>
                <a:gd name="T28" fmla="*/ 960 w 984"/>
                <a:gd name="T29" fmla="*/ 48 h 13704"/>
                <a:gd name="T30" fmla="*/ 24 w 984"/>
                <a:gd name="T31" fmla="*/ 48 h 13704"/>
                <a:gd name="T32" fmla="*/ 48 w 984"/>
                <a:gd name="T33" fmla="*/ 24 h 13704"/>
                <a:gd name="T34" fmla="*/ 48 w 984"/>
                <a:gd name="T35" fmla="*/ 13680 h 137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3704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3680"/>
                  </a:lnTo>
                  <a:cubicBezTo>
                    <a:pt x="984" y="13694"/>
                    <a:pt x="974" y="13704"/>
                    <a:pt x="960" y="13704"/>
                  </a:cubicBezTo>
                  <a:lnTo>
                    <a:pt x="24" y="13704"/>
                  </a:lnTo>
                  <a:cubicBezTo>
                    <a:pt x="11" y="13704"/>
                    <a:pt x="0" y="13694"/>
                    <a:pt x="0" y="13680"/>
                  </a:cubicBezTo>
                  <a:lnTo>
                    <a:pt x="0" y="24"/>
                  </a:lnTo>
                  <a:close/>
                  <a:moveTo>
                    <a:pt x="48" y="13680"/>
                  </a:moveTo>
                  <a:lnTo>
                    <a:pt x="24" y="13656"/>
                  </a:lnTo>
                  <a:lnTo>
                    <a:pt x="960" y="13656"/>
                  </a:lnTo>
                  <a:lnTo>
                    <a:pt x="936" y="13680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368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" name="Rectangle 9"/>
            <p:cNvSpPr>
              <a:spLocks noChangeArrowheads="1"/>
            </p:cNvSpPr>
            <p:nvPr/>
          </p:nvSpPr>
          <p:spPr bwMode="auto">
            <a:xfrm>
              <a:off x="2087865" y="1069978"/>
              <a:ext cx="103599" cy="957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" name="Freeform 10"/>
            <p:cNvSpPr>
              <a:spLocks noEditPoints="1"/>
            </p:cNvSpPr>
            <p:nvPr/>
          </p:nvSpPr>
          <p:spPr bwMode="auto">
            <a:xfrm>
              <a:off x="2085563" y="1068390"/>
              <a:ext cx="108203" cy="960438"/>
            </a:xfrm>
            <a:custGeom>
              <a:avLst/>
              <a:gdLst>
                <a:gd name="T0" fmla="*/ 0 w 984"/>
                <a:gd name="T1" fmla="*/ 24 h 12616"/>
                <a:gd name="T2" fmla="*/ 24 w 984"/>
                <a:gd name="T3" fmla="*/ 0 h 12616"/>
                <a:gd name="T4" fmla="*/ 960 w 984"/>
                <a:gd name="T5" fmla="*/ 0 h 12616"/>
                <a:gd name="T6" fmla="*/ 984 w 984"/>
                <a:gd name="T7" fmla="*/ 24 h 12616"/>
                <a:gd name="T8" fmla="*/ 984 w 984"/>
                <a:gd name="T9" fmla="*/ 12592 h 12616"/>
                <a:gd name="T10" fmla="*/ 960 w 984"/>
                <a:gd name="T11" fmla="*/ 12616 h 12616"/>
                <a:gd name="T12" fmla="*/ 24 w 984"/>
                <a:gd name="T13" fmla="*/ 12616 h 12616"/>
                <a:gd name="T14" fmla="*/ 0 w 984"/>
                <a:gd name="T15" fmla="*/ 12592 h 12616"/>
                <a:gd name="T16" fmla="*/ 0 w 984"/>
                <a:gd name="T17" fmla="*/ 24 h 12616"/>
                <a:gd name="T18" fmla="*/ 48 w 984"/>
                <a:gd name="T19" fmla="*/ 12592 h 12616"/>
                <a:gd name="T20" fmla="*/ 24 w 984"/>
                <a:gd name="T21" fmla="*/ 12568 h 12616"/>
                <a:gd name="T22" fmla="*/ 960 w 984"/>
                <a:gd name="T23" fmla="*/ 12568 h 12616"/>
                <a:gd name="T24" fmla="*/ 936 w 984"/>
                <a:gd name="T25" fmla="*/ 12592 h 12616"/>
                <a:gd name="T26" fmla="*/ 936 w 984"/>
                <a:gd name="T27" fmla="*/ 24 h 12616"/>
                <a:gd name="T28" fmla="*/ 960 w 984"/>
                <a:gd name="T29" fmla="*/ 48 h 12616"/>
                <a:gd name="T30" fmla="*/ 24 w 984"/>
                <a:gd name="T31" fmla="*/ 48 h 12616"/>
                <a:gd name="T32" fmla="*/ 48 w 984"/>
                <a:gd name="T33" fmla="*/ 24 h 12616"/>
                <a:gd name="T34" fmla="*/ 48 w 984"/>
                <a:gd name="T35" fmla="*/ 12592 h 126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26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2592"/>
                  </a:lnTo>
                  <a:cubicBezTo>
                    <a:pt x="984" y="12606"/>
                    <a:pt x="974" y="12616"/>
                    <a:pt x="960" y="12616"/>
                  </a:cubicBezTo>
                  <a:lnTo>
                    <a:pt x="24" y="12616"/>
                  </a:lnTo>
                  <a:cubicBezTo>
                    <a:pt x="11" y="12616"/>
                    <a:pt x="0" y="12606"/>
                    <a:pt x="0" y="12592"/>
                  </a:cubicBezTo>
                  <a:lnTo>
                    <a:pt x="0" y="24"/>
                  </a:lnTo>
                  <a:close/>
                  <a:moveTo>
                    <a:pt x="48" y="12592"/>
                  </a:moveTo>
                  <a:lnTo>
                    <a:pt x="24" y="12568"/>
                  </a:lnTo>
                  <a:lnTo>
                    <a:pt x="960" y="12568"/>
                  </a:lnTo>
                  <a:lnTo>
                    <a:pt x="936" y="12592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2592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" name="Rectangle 17"/>
            <p:cNvSpPr>
              <a:spLocks noChangeArrowheads="1"/>
            </p:cNvSpPr>
            <p:nvPr/>
          </p:nvSpPr>
          <p:spPr bwMode="auto">
            <a:xfrm>
              <a:off x="1588014" y="815978"/>
              <a:ext cx="103599" cy="12112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" name="Freeform 18"/>
            <p:cNvSpPr>
              <a:spLocks noEditPoints="1"/>
            </p:cNvSpPr>
            <p:nvPr/>
          </p:nvSpPr>
          <p:spPr bwMode="auto">
            <a:xfrm>
              <a:off x="1585713" y="814390"/>
              <a:ext cx="108203" cy="1214438"/>
            </a:xfrm>
            <a:custGeom>
              <a:avLst/>
              <a:gdLst>
                <a:gd name="T0" fmla="*/ 0 w 984"/>
                <a:gd name="T1" fmla="*/ 24 h 15952"/>
                <a:gd name="T2" fmla="*/ 24 w 984"/>
                <a:gd name="T3" fmla="*/ 0 h 15952"/>
                <a:gd name="T4" fmla="*/ 960 w 984"/>
                <a:gd name="T5" fmla="*/ 0 h 15952"/>
                <a:gd name="T6" fmla="*/ 984 w 984"/>
                <a:gd name="T7" fmla="*/ 24 h 15952"/>
                <a:gd name="T8" fmla="*/ 984 w 984"/>
                <a:gd name="T9" fmla="*/ 15928 h 15952"/>
                <a:gd name="T10" fmla="*/ 960 w 984"/>
                <a:gd name="T11" fmla="*/ 15952 h 15952"/>
                <a:gd name="T12" fmla="*/ 24 w 984"/>
                <a:gd name="T13" fmla="*/ 15952 h 15952"/>
                <a:gd name="T14" fmla="*/ 0 w 984"/>
                <a:gd name="T15" fmla="*/ 15928 h 15952"/>
                <a:gd name="T16" fmla="*/ 0 w 984"/>
                <a:gd name="T17" fmla="*/ 24 h 15952"/>
                <a:gd name="T18" fmla="*/ 48 w 984"/>
                <a:gd name="T19" fmla="*/ 15928 h 15952"/>
                <a:gd name="T20" fmla="*/ 24 w 984"/>
                <a:gd name="T21" fmla="*/ 15904 h 15952"/>
                <a:gd name="T22" fmla="*/ 960 w 984"/>
                <a:gd name="T23" fmla="*/ 15904 h 15952"/>
                <a:gd name="T24" fmla="*/ 936 w 984"/>
                <a:gd name="T25" fmla="*/ 15928 h 15952"/>
                <a:gd name="T26" fmla="*/ 936 w 984"/>
                <a:gd name="T27" fmla="*/ 24 h 15952"/>
                <a:gd name="T28" fmla="*/ 960 w 984"/>
                <a:gd name="T29" fmla="*/ 48 h 15952"/>
                <a:gd name="T30" fmla="*/ 24 w 984"/>
                <a:gd name="T31" fmla="*/ 48 h 15952"/>
                <a:gd name="T32" fmla="*/ 48 w 984"/>
                <a:gd name="T33" fmla="*/ 24 h 15952"/>
                <a:gd name="T34" fmla="*/ 48 w 984"/>
                <a:gd name="T35" fmla="*/ 15928 h 159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5952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5928"/>
                  </a:lnTo>
                  <a:cubicBezTo>
                    <a:pt x="984" y="15942"/>
                    <a:pt x="974" y="15952"/>
                    <a:pt x="960" y="15952"/>
                  </a:cubicBezTo>
                  <a:lnTo>
                    <a:pt x="24" y="15952"/>
                  </a:lnTo>
                  <a:cubicBezTo>
                    <a:pt x="11" y="15952"/>
                    <a:pt x="0" y="15942"/>
                    <a:pt x="0" y="15928"/>
                  </a:cubicBezTo>
                  <a:lnTo>
                    <a:pt x="0" y="24"/>
                  </a:lnTo>
                  <a:close/>
                  <a:moveTo>
                    <a:pt x="48" y="15928"/>
                  </a:moveTo>
                  <a:lnTo>
                    <a:pt x="24" y="15904"/>
                  </a:lnTo>
                  <a:lnTo>
                    <a:pt x="960" y="15904"/>
                  </a:lnTo>
                  <a:lnTo>
                    <a:pt x="936" y="15928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5928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" name="Rectangle 19"/>
            <p:cNvSpPr>
              <a:spLocks noChangeArrowheads="1"/>
            </p:cNvSpPr>
            <p:nvPr/>
          </p:nvSpPr>
          <p:spPr bwMode="auto">
            <a:xfrm>
              <a:off x="1917404" y="1227140"/>
              <a:ext cx="103599" cy="8001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" name="Freeform 20"/>
            <p:cNvSpPr>
              <a:spLocks noEditPoints="1"/>
            </p:cNvSpPr>
            <p:nvPr/>
          </p:nvSpPr>
          <p:spPr bwMode="auto">
            <a:xfrm>
              <a:off x="1915101" y="1225553"/>
              <a:ext cx="108203" cy="803275"/>
            </a:xfrm>
            <a:custGeom>
              <a:avLst/>
              <a:gdLst>
                <a:gd name="T0" fmla="*/ 0 w 984"/>
                <a:gd name="T1" fmla="*/ 24 h 10552"/>
                <a:gd name="T2" fmla="*/ 24 w 984"/>
                <a:gd name="T3" fmla="*/ 0 h 10552"/>
                <a:gd name="T4" fmla="*/ 960 w 984"/>
                <a:gd name="T5" fmla="*/ 0 h 10552"/>
                <a:gd name="T6" fmla="*/ 984 w 984"/>
                <a:gd name="T7" fmla="*/ 24 h 10552"/>
                <a:gd name="T8" fmla="*/ 984 w 984"/>
                <a:gd name="T9" fmla="*/ 10528 h 10552"/>
                <a:gd name="T10" fmla="*/ 960 w 984"/>
                <a:gd name="T11" fmla="*/ 10552 h 10552"/>
                <a:gd name="T12" fmla="*/ 24 w 984"/>
                <a:gd name="T13" fmla="*/ 10552 h 10552"/>
                <a:gd name="T14" fmla="*/ 0 w 984"/>
                <a:gd name="T15" fmla="*/ 10528 h 10552"/>
                <a:gd name="T16" fmla="*/ 0 w 984"/>
                <a:gd name="T17" fmla="*/ 24 h 10552"/>
                <a:gd name="T18" fmla="*/ 48 w 984"/>
                <a:gd name="T19" fmla="*/ 10528 h 10552"/>
                <a:gd name="T20" fmla="*/ 24 w 984"/>
                <a:gd name="T21" fmla="*/ 10504 h 10552"/>
                <a:gd name="T22" fmla="*/ 960 w 984"/>
                <a:gd name="T23" fmla="*/ 10504 h 10552"/>
                <a:gd name="T24" fmla="*/ 936 w 984"/>
                <a:gd name="T25" fmla="*/ 10528 h 10552"/>
                <a:gd name="T26" fmla="*/ 936 w 984"/>
                <a:gd name="T27" fmla="*/ 24 h 10552"/>
                <a:gd name="T28" fmla="*/ 960 w 984"/>
                <a:gd name="T29" fmla="*/ 48 h 10552"/>
                <a:gd name="T30" fmla="*/ 24 w 984"/>
                <a:gd name="T31" fmla="*/ 48 h 10552"/>
                <a:gd name="T32" fmla="*/ 48 w 984"/>
                <a:gd name="T33" fmla="*/ 24 h 10552"/>
                <a:gd name="T34" fmla="*/ 48 w 984"/>
                <a:gd name="T35" fmla="*/ 10528 h 105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0552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0528"/>
                  </a:lnTo>
                  <a:cubicBezTo>
                    <a:pt x="984" y="10542"/>
                    <a:pt x="974" y="10552"/>
                    <a:pt x="960" y="10552"/>
                  </a:cubicBezTo>
                  <a:lnTo>
                    <a:pt x="24" y="10552"/>
                  </a:lnTo>
                  <a:cubicBezTo>
                    <a:pt x="11" y="10552"/>
                    <a:pt x="0" y="10542"/>
                    <a:pt x="0" y="10528"/>
                  </a:cubicBezTo>
                  <a:lnTo>
                    <a:pt x="0" y="24"/>
                  </a:lnTo>
                  <a:close/>
                  <a:moveTo>
                    <a:pt x="48" y="10528"/>
                  </a:moveTo>
                  <a:lnTo>
                    <a:pt x="24" y="10504"/>
                  </a:lnTo>
                  <a:lnTo>
                    <a:pt x="960" y="10504"/>
                  </a:lnTo>
                  <a:lnTo>
                    <a:pt x="936" y="10528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0528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" name="Rectangle 21"/>
            <p:cNvSpPr>
              <a:spLocks noChangeArrowheads="1"/>
            </p:cNvSpPr>
            <p:nvPr/>
          </p:nvSpPr>
          <p:spPr bwMode="auto">
            <a:xfrm>
              <a:off x="2219090" y="1082678"/>
              <a:ext cx="103599" cy="9445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" name="Freeform 22"/>
            <p:cNvSpPr>
              <a:spLocks noEditPoints="1"/>
            </p:cNvSpPr>
            <p:nvPr/>
          </p:nvSpPr>
          <p:spPr bwMode="auto">
            <a:xfrm>
              <a:off x="2216787" y="1081090"/>
              <a:ext cx="108203" cy="947738"/>
            </a:xfrm>
            <a:custGeom>
              <a:avLst/>
              <a:gdLst>
                <a:gd name="T0" fmla="*/ 0 w 984"/>
                <a:gd name="T1" fmla="*/ 24 h 12440"/>
                <a:gd name="T2" fmla="*/ 24 w 984"/>
                <a:gd name="T3" fmla="*/ 0 h 12440"/>
                <a:gd name="T4" fmla="*/ 960 w 984"/>
                <a:gd name="T5" fmla="*/ 0 h 12440"/>
                <a:gd name="T6" fmla="*/ 984 w 984"/>
                <a:gd name="T7" fmla="*/ 24 h 12440"/>
                <a:gd name="T8" fmla="*/ 984 w 984"/>
                <a:gd name="T9" fmla="*/ 12416 h 12440"/>
                <a:gd name="T10" fmla="*/ 960 w 984"/>
                <a:gd name="T11" fmla="*/ 12440 h 12440"/>
                <a:gd name="T12" fmla="*/ 24 w 984"/>
                <a:gd name="T13" fmla="*/ 12440 h 12440"/>
                <a:gd name="T14" fmla="*/ 0 w 984"/>
                <a:gd name="T15" fmla="*/ 12416 h 12440"/>
                <a:gd name="T16" fmla="*/ 0 w 984"/>
                <a:gd name="T17" fmla="*/ 24 h 12440"/>
                <a:gd name="T18" fmla="*/ 48 w 984"/>
                <a:gd name="T19" fmla="*/ 12416 h 12440"/>
                <a:gd name="T20" fmla="*/ 24 w 984"/>
                <a:gd name="T21" fmla="*/ 12392 h 12440"/>
                <a:gd name="T22" fmla="*/ 960 w 984"/>
                <a:gd name="T23" fmla="*/ 12392 h 12440"/>
                <a:gd name="T24" fmla="*/ 936 w 984"/>
                <a:gd name="T25" fmla="*/ 12416 h 12440"/>
                <a:gd name="T26" fmla="*/ 936 w 984"/>
                <a:gd name="T27" fmla="*/ 24 h 12440"/>
                <a:gd name="T28" fmla="*/ 960 w 984"/>
                <a:gd name="T29" fmla="*/ 48 h 12440"/>
                <a:gd name="T30" fmla="*/ 24 w 984"/>
                <a:gd name="T31" fmla="*/ 48 h 12440"/>
                <a:gd name="T32" fmla="*/ 48 w 984"/>
                <a:gd name="T33" fmla="*/ 24 h 12440"/>
                <a:gd name="T34" fmla="*/ 48 w 984"/>
                <a:gd name="T35" fmla="*/ 12416 h 124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84" h="12440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960" y="0"/>
                  </a:lnTo>
                  <a:cubicBezTo>
                    <a:pt x="974" y="0"/>
                    <a:pt x="984" y="11"/>
                    <a:pt x="984" y="24"/>
                  </a:cubicBezTo>
                  <a:lnTo>
                    <a:pt x="984" y="12416"/>
                  </a:lnTo>
                  <a:cubicBezTo>
                    <a:pt x="984" y="12430"/>
                    <a:pt x="974" y="12440"/>
                    <a:pt x="960" y="12440"/>
                  </a:cubicBezTo>
                  <a:lnTo>
                    <a:pt x="24" y="12440"/>
                  </a:lnTo>
                  <a:cubicBezTo>
                    <a:pt x="11" y="12440"/>
                    <a:pt x="0" y="12430"/>
                    <a:pt x="0" y="12416"/>
                  </a:cubicBezTo>
                  <a:lnTo>
                    <a:pt x="0" y="24"/>
                  </a:lnTo>
                  <a:close/>
                  <a:moveTo>
                    <a:pt x="48" y="12416"/>
                  </a:moveTo>
                  <a:lnTo>
                    <a:pt x="24" y="12392"/>
                  </a:lnTo>
                  <a:lnTo>
                    <a:pt x="960" y="12392"/>
                  </a:lnTo>
                  <a:lnTo>
                    <a:pt x="936" y="12416"/>
                  </a:lnTo>
                  <a:lnTo>
                    <a:pt x="936" y="24"/>
                  </a:lnTo>
                  <a:lnTo>
                    <a:pt x="96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241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" name="Freeform 29"/>
            <p:cNvSpPr>
              <a:spLocks noEditPoints="1"/>
            </p:cNvSpPr>
            <p:nvPr/>
          </p:nvSpPr>
          <p:spPr bwMode="auto">
            <a:xfrm>
              <a:off x="1491323" y="779465"/>
              <a:ext cx="34533" cy="107950"/>
            </a:xfrm>
            <a:custGeom>
              <a:avLst/>
              <a:gdLst>
                <a:gd name="T0" fmla="*/ 7 w 15"/>
                <a:gd name="T1" fmla="*/ 68 h 68"/>
                <a:gd name="T2" fmla="*/ 7 w 15"/>
                <a:gd name="T3" fmla="*/ 1 h 68"/>
                <a:gd name="T4" fmla="*/ 9 w 15"/>
                <a:gd name="T5" fmla="*/ 1 h 68"/>
                <a:gd name="T6" fmla="*/ 9 w 15"/>
                <a:gd name="T7" fmla="*/ 68 h 68"/>
                <a:gd name="T8" fmla="*/ 7 w 15"/>
                <a:gd name="T9" fmla="*/ 68 h 68"/>
                <a:gd name="T10" fmla="*/ 0 w 15"/>
                <a:gd name="T11" fmla="*/ 0 h 68"/>
                <a:gd name="T12" fmla="*/ 15 w 15"/>
                <a:gd name="T13" fmla="*/ 0 h 68"/>
                <a:gd name="T14" fmla="*/ 15 w 15"/>
                <a:gd name="T15" fmla="*/ 2 h 68"/>
                <a:gd name="T16" fmla="*/ 0 w 15"/>
                <a:gd name="T17" fmla="*/ 2 h 68"/>
                <a:gd name="T18" fmla="*/ 0 w 15"/>
                <a:gd name="T19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5" h="68">
                  <a:moveTo>
                    <a:pt x="7" y="68"/>
                  </a:moveTo>
                  <a:lnTo>
                    <a:pt x="7" y="1"/>
                  </a:lnTo>
                  <a:lnTo>
                    <a:pt x="9" y="1"/>
                  </a:lnTo>
                  <a:lnTo>
                    <a:pt x="9" y="68"/>
                  </a:lnTo>
                  <a:lnTo>
                    <a:pt x="7" y="68"/>
                  </a:lnTo>
                  <a:close/>
                  <a:moveTo>
                    <a:pt x="0" y="0"/>
                  </a:moveTo>
                  <a:lnTo>
                    <a:pt x="15" y="0"/>
                  </a:lnTo>
                  <a:lnTo>
                    <a:pt x="15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" name="Freeform 30"/>
            <p:cNvSpPr>
              <a:spLocks noEditPoints="1"/>
            </p:cNvSpPr>
            <p:nvPr/>
          </p:nvSpPr>
          <p:spPr bwMode="auto">
            <a:xfrm>
              <a:off x="1820712" y="847728"/>
              <a:ext cx="32231" cy="139700"/>
            </a:xfrm>
            <a:custGeom>
              <a:avLst/>
              <a:gdLst>
                <a:gd name="T0" fmla="*/ 6 w 14"/>
                <a:gd name="T1" fmla="*/ 88 h 88"/>
                <a:gd name="T2" fmla="*/ 6 w 14"/>
                <a:gd name="T3" fmla="*/ 1 h 88"/>
                <a:gd name="T4" fmla="*/ 8 w 14"/>
                <a:gd name="T5" fmla="*/ 1 h 88"/>
                <a:gd name="T6" fmla="*/ 8 w 14"/>
                <a:gd name="T7" fmla="*/ 88 h 88"/>
                <a:gd name="T8" fmla="*/ 6 w 14"/>
                <a:gd name="T9" fmla="*/ 88 h 88"/>
                <a:gd name="T10" fmla="*/ 0 w 14"/>
                <a:gd name="T11" fmla="*/ 0 h 88"/>
                <a:gd name="T12" fmla="*/ 14 w 14"/>
                <a:gd name="T13" fmla="*/ 0 h 88"/>
                <a:gd name="T14" fmla="*/ 14 w 14"/>
                <a:gd name="T15" fmla="*/ 2 h 88"/>
                <a:gd name="T16" fmla="*/ 0 w 14"/>
                <a:gd name="T17" fmla="*/ 2 h 88"/>
                <a:gd name="T18" fmla="*/ 0 w 14"/>
                <a:gd name="T19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4" h="88">
                  <a:moveTo>
                    <a:pt x="6" y="88"/>
                  </a:moveTo>
                  <a:lnTo>
                    <a:pt x="6" y="1"/>
                  </a:lnTo>
                  <a:lnTo>
                    <a:pt x="8" y="1"/>
                  </a:lnTo>
                  <a:lnTo>
                    <a:pt x="8" y="88"/>
                  </a:lnTo>
                  <a:lnTo>
                    <a:pt x="6" y="88"/>
                  </a:lnTo>
                  <a:close/>
                  <a:moveTo>
                    <a:pt x="0" y="0"/>
                  </a:moveTo>
                  <a:lnTo>
                    <a:pt x="14" y="0"/>
                  </a:lnTo>
                  <a:lnTo>
                    <a:pt x="14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8" name="Freeform 31"/>
            <p:cNvSpPr>
              <a:spLocks noEditPoints="1"/>
            </p:cNvSpPr>
            <p:nvPr/>
          </p:nvSpPr>
          <p:spPr bwMode="auto">
            <a:xfrm>
              <a:off x="2122398" y="1030290"/>
              <a:ext cx="34533" cy="39688"/>
            </a:xfrm>
            <a:custGeom>
              <a:avLst/>
              <a:gdLst>
                <a:gd name="T0" fmla="*/ 7 w 15"/>
                <a:gd name="T1" fmla="*/ 25 h 25"/>
                <a:gd name="T2" fmla="*/ 7 w 15"/>
                <a:gd name="T3" fmla="*/ 2 h 25"/>
                <a:gd name="T4" fmla="*/ 9 w 15"/>
                <a:gd name="T5" fmla="*/ 2 h 25"/>
                <a:gd name="T6" fmla="*/ 9 w 15"/>
                <a:gd name="T7" fmla="*/ 25 h 25"/>
                <a:gd name="T8" fmla="*/ 7 w 15"/>
                <a:gd name="T9" fmla="*/ 25 h 25"/>
                <a:gd name="T10" fmla="*/ 0 w 15"/>
                <a:gd name="T11" fmla="*/ 0 h 25"/>
                <a:gd name="T12" fmla="*/ 15 w 15"/>
                <a:gd name="T13" fmla="*/ 0 h 25"/>
                <a:gd name="T14" fmla="*/ 15 w 15"/>
                <a:gd name="T15" fmla="*/ 3 h 25"/>
                <a:gd name="T16" fmla="*/ 0 w 15"/>
                <a:gd name="T17" fmla="*/ 3 h 25"/>
                <a:gd name="T18" fmla="*/ 0 w 15"/>
                <a:gd name="T19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5" h="25">
                  <a:moveTo>
                    <a:pt x="7" y="25"/>
                  </a:moveTo>
                  <a:lnTo>
                    <a:pt x="7" y="2"/>
                  </a:lnTo>
                  <a:lnTo>
                    <a:pt x="9" y="2"/>
                  </a:lnTo>
                  <a:lnTo>
                    <a:pt x="9" y="25"/>
                  </a:lnTo>
                  <a:lnTo>
                    <a:pt x="7" y="25"/>
                  </a:lnTo>
                  <a:close/>
                  <a:moveTo>
                    <a:pt x="0" y="0"/>
                  </a:moveTo>
                  <a:lnTo>
                    <a:pt x="15" y="0"/>
                  </a:lnTo>
                  <a:lnTo>
                    <a:pt x="15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9" name="Freeform 35"/>
            <p:cNvSpPr>
              <a:spLocks noEditPoints="1"/>
            </p:cNvSpPr>
            <p:nvPr/>
          </p:nvSpPr>
          <p:spPr bwMode="auto">
            <a:xfrm>
              <a:off x="1624849" y="695328"/>
              <a:ext cx="32231" cy="120650"/>
            </a:xfrm>
            <a:custGeom>
              <a:avLst/>
              <a:gdLst>
                <a:gd name="T0" fmla="*/ 6 w 14"/>
                <a:gd name="T1" fmla="*/ 76 h 76"/>
                <a:gd name="T2" fmla="*/ 6 w 14"/>
                <a:gd name="T3" fmla="*/ 1 h 76"/>
                <a:gd name="T4" fmla="*/ 8 w 14"/>
                <a:gd name="T5" fmla="*/ 1 h 76"/>
                <a:gd name="T6" fmla="*/ 8 w 14"/>
                <a:gd name="T7" fmla="*/ 76 h 76"/>
                <a:gd name="T8" fmla="*/ 6 w 14"/>
                <a:gd name="T9" fmla="*/ 76 h 76"/>
                <a:gd name="T10" fmla="*/ 0 w 14"/>
                <a:gd name="T11" fmla="*/ 0 h 76"/>
                <a:gd name="T12" fmla="*/ 14 w 14"/>
                <a:gd name="T13" fmla="*/ 0 h 76"/>
                <a:gd name="T14" fmla="*/ 14 w 14"/>
                <a:gd name="T15" fmla="*/ 2 h 76"/>
                <a:gd name="T16" fmla="*/ 0 w 14"/>
                <a:gd name="T17" fmla="*/ 2 h 76"/>
                <a:gd name="T18" fmla="*/ 0 w 14"/>
                <a:gd name="T19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4" h="76">
                  <a:moveTo>
                    <a:pt x="6" y="76"/>
                  </a:moveTo>
                  <a:lnTo>
                    <a:pt x="6" y="1"/>
                  </a:lnTo>
                  <a:lnTo>
                    <a:pt x="8" y="1"/>
                  </a:lnTo>
                  <a:lnTo>
                    <a:pt x="8" y="76"/>
                  </a:lnTo>
                  <a:lnTo>
                    <a:pt x="6" y="76"/>
                  </a:lnTo>
                  <a:close/>
                  <a:moveTo>
                    <a:pt x="0" y="0"/>
                  </a:moveTo>
                  <a:lnTo>
                    <a:pt x="14" y="0"/>
                  </a:lnTo>
                  <a:lnTo>
                    <a:pt x="14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" name="Freeform 36"/>
            <p:cNvSpPr>
              <a:spLocks noEditPoints="1"/>
            </p:cNvSpPr>
            <p:nvPr/>
          </p:nvSpPr>
          <p:spPr bwMode="auto">
            <a:xfrm>
              <a:off x="1951936" y="1147765"/>
              <a:ext cx="32231" cy="79375"/>
            </a:xfrm>
            <a:custGeom>
              <a:avLst/>
              <a:gdLst>
                <a:gd name="T0" fmla="*/ 6 w 14"/>
                <a:gd name="T1" fmla="*/ 50 h 50"/>
                <a:gd name="T2" fmla="*/ 6 w 14"/>
                <a:gd name="T3" fmla="*/ 1 h 50"/>
                <a:gd name="T4" fmla="*/ 8 w 14"/>
                <a:gd name="T5" fmla="*/ 1 h 50"/>
                <a:gd name="T6" fmla="*/ 8 w 14"/>
                <a:gd name="T7" fmla="*/ 50 h 50"/>
                <a:gd name="T8" fmla="*/ 6 w 14"/>
                <a:gd name="T9" fmla="*/ 50 h 50"/>
                <a:gd name="T10" fmla="*/ 0 w 14"/>
                <a:gd name="T11" fmla="*/ 0 h 50"/>
                <a:gd name="T12" fmla="*/ 14 w 14"/>
                <a:gd name="T13" fmla="*/ 0 h 50"/>
                <a:gd name="T14" fmla="*/ 14 w 14"/>
                <a:gd name="T15" fmla="*/ 2 h 50"/>
                <a:gd name="T16" fmla="*/ 0 w 14"/>
                <a:gd name="T17" fmla="*/ 2 h 50"/>
                <a:gd name="T18" fmla="*/ 0 w 14"/>
                <a:gd name="T1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4" h="50">
                  <a:moveTo>
                    <a:pt x="6" y="50"/>
                  </a:moveTo>
                  <a:lnTo>
                    <a:pt x="6" y="1"/>
                  </a:lnTo>
                  <a:lnTo>
                    <a:pt x="8" y="1"/>
                  </a:lnTo>
                  <a:lnTo>
                    <a:pt x="8" y="50"/>
                  </a:lnTo>
                  <a:lnTo>
                    <a:pt x="6" y="50"/>
                  </a:lnTo>
                  <a:close/>
                  <a:moveTo>
                    <a:pt x="0" y="0"/>
                  </a:moveTo>
                  <a:lnTo>
                    <a:pt x="14" y="0"/>
                  </a:lnTo>
                  <a:lnTo>
                    <a:pt x="14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" name="Freeform 37"/>
            <p:cNvSpPr>
              <a:spLocks noEditPoints="1"/>
            </p:cNvSpPr>
            <p:nvPr/>
          </p:nvSpPr>
          <p:spPr bwMode="auto">
            <a:xfrm>
              <a:off x="2255925" y="985840"/>
              <a:ext cx="32231" cy="96838"/>
            </a:xfrm>
            <a:custGeom>
              <a:avLst/>
              <a:gdLst>
                <a:gd name="T0" fmla="*/ 5 w 14"/>
                <a:gd name="T1" fmla="*/ 61 h 61"/>
                <a:gd name="T2" fmla="*/ 5 w 14"/>
                <a:gd name="T3" fmla="*/ 1 h 61"/>
                <a:gd name="T4" fmla="*/ 8 w 14"/>
                <a:gd name="T5" fmla="*/ 1 h 61"/>
                <a:gd name="T6" fmla="*/ 8 w 14"/>
                <a:gd name="T7" fmla="*/ 61 h 61"/>
                <a:gd name="T8" fmla="*/ 5 w 14"/>
                <a:gd name="T9" fmla="*/ 61 h 61"/>
                <a:gd name="T10" fmla="*/ 0 w 14"/>
                <a:gd name="T11" fmla="*/ 0 h 61"/>
                <a:gd name="T12" fmla="*/ 14 w 14"/>
                <a:gd name="T13" fmla="*/ 0 h 61"/>
                <a:gd name="T14" fmla="*/ 14 w 14"/>
                <a:gd name="T15" fmla="*/ 2 h 61"/>
                <a:gd name="T16" fmla="*/ 0 w 14"/>
                <a:gd name="T17" fmla="*/ 2 h 61"/>
                <a:gd name="T18" fmla="*/ 0 w 14"/>
                <a:gd name="T19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4" h="61">
                  <a:moveTo>
                    <a:pt x="5" y="61"/>
                  </a:moveTo>
                  <a:lnTo>
                    <a:pt x="5" y="1"/>
                  </a:lnTo>
                  <a:lnTo>
                    <a:pt x="8" y="1"/>
                  </a:lnTo>
                  <a:lnTo>
                    <a:pt x="8" y="61"/>
                  </a:lnTo>
                  <a:lnTo>
                    <a:pt x="5" y="61"/>
                  </a:lnTo>
                  <a:close/>
                  <a:moveTo>
                    <a:pt x="0" y="0"/>
                  </a:moveTo>
                  <a:lnTo>
                    <a:pt x="14" y="0"/>
                  </a:lnTo>
                  <a:lnTo>
                    <a:pt x="14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22" name="Rectangle 41"/>
          <p:cNvSpPr>
            <a:spLocks noChangeArrowheads="1"/>
          </p:cNvSpPr>
          <p:nvPr/>
        </p:nvSpPr>
        <p:spPr bwMode="auto">
          <a:xfrm>
            <a:off x="2203788" y="1603378"/>
            <a:ext cx="0" cy="1681163"/>
          </a:xfrm>
          <a:prstGeom prst="rect">
            <a:avLst/>
          </a:prstGeom>
          <a:solidFill>
            <a:srgbClr val="000000"/>
          </a:solidFill>
          <a:ln w="139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3" name="Freeform 42"/>
          <p:cNvSpPr>
            <a:spLocks noEditPoints="1"/>
          </p:cNvSpPr>
          <p:nvPr/>
        </p:nvSpPr>
        <p:spPr bwMode="auto">
          <a:xfrm>
            <a:off x="2180132" y="1600203"/>
            <a:ext cx="21600" cy="1689100"/>
          </a:xfrm>
          <a:custGeom>
            <a:avLst/>
            <a:gdLst>
              <a:gd name="T0" fmla="*/ 0 w 9"/>
              <a:gd name="T1" fmla="*/ 1059 h 1064"/>
              <a:gd name="T2" fmla="*/ 9 w 9"/>
              <a:gd name="T3" fmla="*/ 1059 h 1064"/>
              <a:gd name="T4" fmla="*/ 9 w 9"/>
              <a:gd name="T5" fmla="*/ 1064 h 1064"/>
              <a:gd name="T6" fmla="*/ 0 w 9"/>
              <a:gd name="T7" fmla="*/ 1064 h 1064"/>
              <a:gd name="T8" fmla="*/ 0 w 9"/>
              <a:gd name="T9" fmla="*/ 1059 h 1064"/>
              <a:gd name="T10" fmla="*/ 0 w 9"/>
              <a:gd name="T11" fmla="*/ 847 h 1064"/>
              <a:gd name="T12" fmla="*/ 9 w 9"/>
              <a:gd name="T13" fmla="*/ 847 h 1064"/>
              <a:gd name="T14" fmla="*/ 9 w 9"/>
              <a:gd name="T15" fmla="*/ 852 h 1064"/>
              <a:gd name="T16" fmla="*/ 0 w 9"/>
              <a:gd name="T17" fmla="*/ 852 h 1064"/>
              <a:gd name="T18" fmla="*/ 0 w 9"/>
              <a:gd name="T19" fmla="*/ 847 h 1064"/>
              <a:gd name="T20" fmla="*/ 0 w 9"/>
              <a:gd name="T21" fmla="*/ 635 h 1064"/>
              <a:gd name="T22" fmla="*/ 9 w 9"/>
              <a:gd name="T23" fmla="*/ 635 h 1064"/>
              <a:gd name="T24" fmla="*/ 9 w 9"/>
              <a:gd name="T25" fmla="*/ 640 h 1064"/>
              <a:gd name="T26" fmla="*/ 0 w 9"/>
              <a:gd name="T27" fmla="*/ 640 h 1064"/>
              <a:gd name="T28" fmla="*/ 0 w 9"/>
              <a:gd name="T29" fmla="*/ 635 h 1064"/>
              <a:gd name="T30" fmla="*/ 0 w 9"/>
              <a:gd name="T31" fmla="*/ 423 h 1064"/>
              <a:gd name="T32" fmla="*/ 9 w 9"/>
              <a:gd name="T33" fmla="*/ 423 h 1064"/>
              <a:gd name="T34" fmla="*/ 9 w 9"/>
              <a:gd name="T35" fmla="*/ 428 h 1064"/>
              <a:gd name="T36" fmla="*/ 0 w 9"/>
              <a:gd name="T37" fmla="*/ 428 h 1064"/>
              <a:gd name="T38" fmla="*/ 0 w 9"/>
              <a:gd name="T39" fmla="*/ 423 h 1064"/>
              <a:gd name="T40" fmla="*/ 0 w 9"/>
              <a:gd name="T41" fmla="*/ 211 h 1064"/>
              <a:gd name="T42" fmla="*/ 9 w 9"/>
              <a:gd name="T43" fmla="*/ 211 h 1064"/>
              <a:gd name="T44" fmla="*/ 9 w 9"/>
              <a:gd name="T45" fmla="*/ 216 h 1064"/>
              <a:gd name="T46" fmla="*/ 0 w 9"/>
              <a:gd name="T47" fmla="*/ 216 h 1064"/>
              <a:gd name="T48" fmla="*/ 0 w 9"/>
              <a:gd name="T49" fmla="*/ 211 h 1064"/>
              <a:gd name="T50" fmla="*/ 0 w 9"/>
              <a:gd name="T51" fmla="*/ 0 h 1064"/>
              <a:gd name="T52" fmla="*/ 9 w 9"/>
              <a:gd name="T53" fmla="*/ 0 h 1064"/>
              <a:gd name="T54" fmla="*/ 9 w 9"/>
              <a:gd name="T55" fmla="*/ 4 h 1064"/>
              <a:gd name="T56" fmla="*/ 0 w 9"/>
              <a:gd name="T57" fmla="*/ 4 h 1064"/>
              <a:gd name="T58" fmla="*/ 0 w 9"/>
              <a:gd name="T59" fmla="*/ 0 h 10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9" h="1064">
                <a:moveTo>
                  <a:pt x="0" y="1059"/>
                </a:moveTo>
                <a:lnTo>
                  <a:pt x="9" y="1059"/>
                </a:lnTo>
                <a:lnTo>
                  <a:pt x="9" y="1064"/>
                </a:lnTo>
                <a:lnTo>
                  <a:pt x="0" y="1064"/>
                </a:lnTo>
                <a:lnTo>
                  <a:pt x="0" y="1059"/>
                </a:lnTo>
                <a:close/>
                <a:moveTo>
                  <a:pt x="0" y="847"/>
                </a:moveTo>
                <a:lnTo>
                  <a:pt x="9" y="847"/>
                </a:lnTo>
                <a:lnTo>
                  <a:pt x="9" y="852"/>
                </a:lnTo>
                <a:lnTo>
                  <a:pt x="0" y="852"/>
                </a:lnTo>
                <a:lnTo>
                  <a:pt x="0" y="847"/>
                </a:lnTo>
                <a:close/>
                <a:moveTo>
                  <a:pt x="0" y="635"/>
                </a:moveTo>
                <a:lnTo>
                  <a:pt x="9" y="635"/>
                </a:lnTo>
                <a:lnTo>
                  <a:pt x="9" y="640"/>
                </a:lnTo>
                <a:lnTo>
                  <a:pt x="0" y="640"/>
                </a:lnTo>
                <a:lnTo>
                  <a:pt x="0" y="635"/>
                </a:lnTo>
                <a:close/>
                <a:moveTo>
                  <a:pt x="0" y="423"/>
                </a:moveTo>
                <a:lnTo>
                  <a:pt x="9" y="423"/>
                </a:lnTo>
                <a:lnTo>
                  <a:pt x="9" y="428"/>
                </a:lnTo>
                <a:lnTo>
                  <a:pt x="0" y="428"/>
                </a:lnTo>
                <a:lnTo>
                  <a:pt x="0" y="423"/>
                </a:lnTo>
                <a:close/>
                <a:moveTo>
                  <a:pt x="0" y="211"/>
                </a:moveTo>
                <a:lnTo>
                  <a:pt x="9" y="211"/>
                </a:lnTo>
                <a:lnTo>
                  <a:pt x="9" y="216"/>
                </a:lnTo>
                <a:lnTo>
                  <a:pt x="0" y="216"/>
                </a:lnTo>
                <a:lnTo>
                  <a:pt x="0" y="211"/>
                </a:lnTo>
                <a:close/>
                <a:moveTo>
                  <a:pt x="0" y="0"/>
                </a:moveTo>
                <a:lnTo>
                  <a:pt x="9" y="0"/>
                </a:lnTo>
                <a:lnTo>
                  <a:pt x="9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4" name="Rectangle 43"/>
          <p:cNvSpPr>
            <a:spLocks noChangeArrowheads="1"/>
          </p:cNvSpPr>
          <p:nvPr/>
        </p:nvSpPr>
        <p:spPr bwMode="auto">
          <a:xfrm>
            <a:off x="2206963" y="3281365"/>
            <a:ext cx="1332000" cy="793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46"/>
          <p:cNvSpPr>
            <a:spLocks noChangeArrowheads="1"/>
          </p:cNvSpPr>
          <p:nvPr/>
        </p:nvSpPr>
        <p:spPr bwMode="auto">
          <a:xfrm>
            <a:off x="2086090" y="3209928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</a:t>
            </a:r>
          </a:p>
        </p:txBody>
      </p:sp>
      <p:sp>
        <p:nvSpPr>
          <p:cNvPr id="26" name="Rectangle 47"/>
          <p:cNvSpPr>
            <a:spLocks noChangeArrowheads="1"/>
          </p:cNvSpPr>
          <p:nvPr/>
        </p:nvSpPr>
        <p:spPr bwMode="auto">
          <a:xfrm>
            <a:off x="2015558" y="287179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7" name="Rectangle 48"/>
          <p:cNvSpPr>
            <a:spLocks noChangeArrowheads="1"/>
          </p:cNvSpPr>
          <p:nvPr/>
        </p:nvSpPr>
        <p:spPr bwMode="auto">
          <a:xfrm>
            <a:off x="1945026" y="2535240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8" name="Rectangle 49"/>
          <p:cNvSpPr>
            <a:spLocks noChangeArrowheads="1"/>
          </p:cNvSpPr>
          <p:nvPr/>
        </p:nvSpPr>
        <p:spPr bwMode="auto">
          <a:xfrm>
            <a:off x="1945026" y="2198690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9" name="Rectangle 50"/>
          <p:cNvSpPr>
            <a:spLocks noChangeArrowheads="1"/>
          </p:cNvSpPr>
          <p:nvPr/>
        </p:nvSpPr>
        <p:spPr bwMode="auto">
          <a:xfrm>
            <a:off x="1945026" y="1862140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30" name="Rectangle 51"/>
          <p:cNvSpPr>
            <a:spLocks noChangeArrowheads="1"/>
          </p:cNvSpPr>
          <p:nvPr/>
        </p:nvSpPr>
        <p:spPr bwMode="auto">
          <a:xfrm>
            <a:off x="1945026" y="1525590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31" name="Rectangle 52"/>
          <p:cNvSpPr>
            <a:spLocks noChangeArrowheads="1"/>
          </p:cNvSpPr>
          <p:nvPr/>
        </p:nvSpPr>
        <p:spPr bwMode="auto">
          <a:xfrm>
            <a:off x="2426658" y="3314703"/>
            <a:ext cx="4328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dirty="0">
                <a:cs typeface="Arial" panose="020B0604020202020204" pitchFamily="34" charset="0"/>
              </a:rPr>
              <a:t>-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32" name="Rectangle 53"/>
          <p:cNvSpPr>
            <a:spLocks noChangeArrowheads="1"/>
          </p:cNvSpPr>
          <p:nvPr/>
        </p:nvSpPr>
        <p:spPr bwMode="auto">
          <a:xfrm>
            <a:off x="2759413" y="3314703"/>
            <a:ext cx="24846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ATP</a:t>
            </a:r>
          </a:p>
        </p:txBody>
      </p:sp>
      <p:sp>
        <p:nvSpPr>
          <p:cNvPr id="33" name="Rectangle 54"/>
          <p:cNvSpPr>
            <a:spLocks noChangeArrowheads="1"/>
          </p:cNvSpPr>
          <p:nvPr/>
        </p:nvSpPr>
        <p:spPr bwMode="auto">
          <a:xfrm>
            <a:off x="3191213" y="3314703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effectLst/>
                <a:cs typeface="Arial" panose="020B0604020202020204" pitchFamily="34" charset="0"/>
              </a:rPr>
              <a:t>Nig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34" name="Rectangle 64"/>
          <p:cNvSpPr>
            <a:spLocks noChangeArrowheads="1"/>
          </p:cNvSpPr>
          <p:nvPr/>
        </p:nvSpPr>
        <p:spPr bwMode="auto">
          <a:xfrm>
            <a:off x="2513355" y="1656279"/>
            <a:ext cx="72000" cy="720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5" name="Freeform 65"/>
          <p:cNvSpPr>
            <a:spLocks noEditPoints="1"/>
          </p:cNvSpPr>
          <p:nvPr/>
        </p:nvSpPr>
        <p:spPr bwMode="auto">
          <a:xfrm>
            <a:off x="2511766" y="1656279"/>
            <a:ext cx="72000" cy="72000"/>
          </a:xfrm>
          <a:custGeom>
            <a:avLst/>
            <a:gdLst>
              <a:gd name="T0" fmla="*/ 0 w 384"/>
              <a:gd name="T1" fmla="*/ 24 h 376"/>
              <a:gd name="T2" fmla="*/ 24 w 384"/>
              <a:gd name="T3" fmla="*/ 0 h 376"/>
              <a:gd name="T4" fmla="*/ 360 w 384"/>
              <a:gd name="T5" fmla="*/ 0 h 376"/>
              <a:gd name="T6" fmla="*/ 384 w 384"/>
              <a:gd name="T7" fmla="*/ 24 h 376"/>
              <a:gd name="T8" fmla="*/ 384 w 384"/>
              <a:gd name="T9" fmla="*/ 352 h 376"/>
              <a:gd name="T10" fmla="*/ 360 w 384"/>
              <a:gd name="T11" fmla="*/ 376 h 376"/>
              <a:gd name="T12" fmla="*/ 24 w 384"/>
              <a:gd name="T13" fmla="*/ 376 h 376"/>
              <a:gd name="T14" fmla="*/ 0 w 384"/>
              <a:gd name="T15" fmla="*/ 352 h 376"/>
              <a:gd name="T16" fmla="*/ 0 w 384"/>
              <a:gd name="T17" fmla="*/ 24 h 376"/>
              <a:gd name="T18" fmla="*/ 48 w 384"/>
              <a:gd name="T19" fmla="*/ 352 h 376"/>
              <a:gd name="T20" fmla="*/ 24 w 384"/>
              <a:gd name="T21" fmla="*/ 328 h 376"/>
              <a:gd name="T22" fmla="*/ 360 w 384"/>
              <a:gd name="T23" fmla="*/ 328 h 376"/>
              <a:gd name="T24" fmla="*/ 336 w 384"/>
              <a:gd name="T25" fmla="*/ 352 h 376"/>
              <a:gd name="T26" fmla="*/ 336 w 384"/>
              <a:gd name="T27" fmla="*/ 24 h 376"/>
              <a:gd name="T28" fmla="*/ 360 w 384"/>
              <a:gd name="T29" fmla="*/ 48 h 376"/>
              <a:gd name="T30" fmla="*/ 24 w 384"/>
              <a:gd name="T31" fmla="*/ 48 h 376"/>
              <a:gd name="T32" fmla="*/ 48 w 384"/>
              <a:gd name="T33" fmla="*/ 24 h 376"/>
              <a:gd name="T34" fmla="*/ 48 w 384"/>
              <a:gd name="T35" fmla="*/ 352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84" h="3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60" y="0"/>
                </a:lnTo>
                <a:cubicBezTo>
                  <a:pt x="374" y="0"/>
                  <a:pt x="384" y="11"/>
                  <a:pt x="384" y="24"/>
                </a:cubicBezTo>
                <a:lnTo>
                  <a:pt x="384" y="352"/>
                </a:lnTo>
                <a:cubicBezTo>
                  <a:pt x="384" y="366"/>
                  <a:pt x="374" y="376"/>
                  <a:pt x="360" y="376"/>
                </a:cubicBezTo>
                <a:lnTo>
                  <a:pt x="24" y="376"/>
                </a:lnTo>
                <a:cubicBezTo>
                  <a:pt x="11" y="376"/>
                  <a:pt x="0" y="366"/>
                  <a:pt x="0" y="352"/>
                </a:cubicBezTo>
                <a:lnTo>
                  <a:pt x="0" y="24"/>
                </a:lnTo>
                <a:close/>
                <a:moveTo>
                  <a:pt x="48" y="352"/>
                </a:moveTo>
                <a:lnTo>
                  <a:pt x="24" y="328"/>
                </a:lnTo>
                <a:lnTo>
                  <a:pt x="360" y="328"/>
                </a:lnTo>
                <a:lnTo>
                  <a:pt x="336" y="352"/>
                </a:lnTo>
                <a:lnTo>
                  <a:pt x="336" y="24"/>
                </a:lnTo>
                <a:lnTo>
                  <a:pt x="360" y="48"/>
                </a:lnTo>
                <a:lnTo>
                  <a:pt x="24" y="48"/>
                </a:lnTo>
                <a:lnTo>
                  <a:pt x="48" y="24"/>
                </a:lnTo>
                <a:lnTo>
                  <a:pt x="48" y="3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6" name="Rectangle 66"/>
          <p:cNvSpPr>
            <a:spLocks noChangeArrowheads="1"/>
          </p:cNvSpPr>
          <p:nvPr/>
        </p:nvSpPr>
        <p:spPr bwMode="auto">
          <a:xfrm>
            <a:off x="2616542" y="1615335"/>
            <a:ext cx="2003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7" name="Rectangle 67"/>
          <p:cNvSpPr>
            <a:spLocks noChangeArrowheads="1"/>
          </p:cNvSpPr>
          <p:nvPr/>
        </p:nvSpPr>
        <p:spPr bwMode="auto">
          <a:xfrm>
            <a:off x="2513355" y="1781691"/>
            <a:ext cx="72000" cy="720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8" name="Freeform 68"/>
          <p:cNvSpPr>
            <a:spLocks noEditPoints="1"/>
          </p:cNvSpPr>
          <p:nvPr/>
        </p:nvSpPr>
        <p:spPr bwMode="auto">
          <a:xfrm>
            <a:off x="2511766" y="1781691"/>
            <a:ext cx="72000" cy="72000"/>
          </a:xfrm>
          <a:custGeom>
            <a:avLst/>
            <a:gdLst>
              <a:gd name="T0" fmla="*/ 0 w 384"/>
              <a:gd name="T1" fmla="*/ 24 h 376"/>
              <a:gd name="T2" fmla="*/ 24 w 384"/>
              <a:gd name="T3" fmla="*/ 0 h 376"/>
              <a:gd name="T4" fmla="*/ 360 w 384"/>
              <a:gd name="T5" fmla="*/ 0 h 376"/>
              <a:gd name="T6" fmla="*/ 384 w 384"/>
              <a:gd name="T7" fmla="*/ 24 h 376"/>
              <a:gd name="T8" fmla="*/ 384 w 384"/>
              <a:gd name="T9" fmla="*/ 352 h 376"/>
              <a:gd name="T10" fmla="*/ 360 w 384"/>
              <a:gd name="T11" fmla="*/ 376 h 376"/>
              <a:gd name="T12" fmla="*/ 24 w 384"/>
              <a:gd name="T13" fmla="*/ 376 h 376"/>
              <a:gd name="T14" fmla="*/ 0 w 384"/>
              <a:gd name="T15" fmla="*/ 352 h 376"/>
              <a:gd name="T16" fmla="*/ 0 w 384"/>
              <a:gd name="T17" fmla="*/ 24 h 376"/>
              <a:gd name="T18" fmla="*/ 48 w 384"/>
              <a:gd name="T19" fmla="*/ 352 h 376"/>
              <a:gd name="T20" fmla="*/ 24 w 384"/>
              <a:gd name="T21" fmla="*/ 328 h 376"/>
              <a:gd name="T22" fmla="*/ 360 w 384"/>
              <a:gd name="T23" fmla="*/ 328 h 376"/>
              <a:gd name="T24" fmla="*/ 336 w 384"/>
              <a:gd name="T25" fmla="*/ 352 h 376"/>
              <a:gd name="T26" fmla="*/ 336 w 384"/>
              <a:gd name="T27" fmla="*/ 24 h 376"/>
              <a:gd name="T28" fmla="*/ 360 w 384"/>
              <a:gd name="T29" fmla="*/ 48 h 376"/>
              <a:gd name="T30" fmla="*/ 24 w 384"/>
              <a:gd name="T31" fmla="*/ 48 h 376"/>
              <a:gd name="T32" fmla="*/ 48 w 384"/>
              <a:gd name="T33" fmla="*/ 24 h 376"/>
              <a:gd name="T34" fmla="*/ 48 w 384"/>
              <a:gd name="T35" fmla="*/ 352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84" h="3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60" y="0"/>
                </a:lnTo>
                <a:cubicBezTo>
                  <a:pt x="374" y="0"/>
                  <a:pt x="384" y="11"/>
                  <a:pt x="384" y="24"/>
                </a:cubicBezTo>
                <a:lnTo>
                  <a:pt x="384" y="352"/>
                </a:lnTo>
                <a:cubicBezTo>
                  <a:pt x="384" y="366"/>
                  <a:pt x="374" y="376"/>
                  <a:pt x="360" y="376"/>
                </a:cubicBezTo>
                <a:lnTo>
                  <a:pt x="24" y="376"/>
                </a:lnTo>
                <a:cubicBezTo>
                  <a:pt x="11" y="376"/>
                  <a:pt x="0" y="366"/>
                  <a:pt x="0" y="352"/>
                </a:cubicBezTo>
                <a:lnTo>
                  <a:pt x="0" y="24"/>
                </a:lnTo>
                <a:close/>
                <a:moveTo>
                  <a:pt x="48" y="352"/>
                </a:moveTo>
                <a:lnTo>
                  <a:pt x="24" y="328"/>
                </a:lnTo>
                <a:lnTo>
                  <a:pt x="360" y="328"/>
                </a:lnTo>
                <a:lnTo>
                  <a:pt x="336" y="352"/>
                </a:lnTo>
                <a:lnTo>
                  <a:pt x="336" y="24"/>
                </a:lnTo>
                <a:lnTo>
                  <a:pt x="360" y="48"/>
                </a:lnTo>
                <a:lnTo>
                  <a:pt x="24" y="48"/>
                </a:lnTo>
                <a:lnTo>
                  <a:pt x="48" y="24"/>
                </a:lnTo>
                <a:lnTo>
                  <a:pt x="48" y="3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9" name="Rectangle 69"/>
          <p:cNvSpPr>
            <a:spLocks noChangeArrowheads="1"/>
          </p:cNvSpPr>
          <p:nvPr/>
        </p:nvSpPr>
        <p:spPr bwMode="auto">
          <a:xfrm>
            <a:off x="2616542" y="1740747"/>
            <a:ext cx="45044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Hsp70</a:t>
            </a:r>
            <a:r>
              <a:rPr kumimoji="0" lang="fr-FR" altLang="fr-FR" sz="1000" b="0" i="0" u="none" strike="noStrike" cap="none" normalizeH="0" baseline="30000" dirty="0" smtClean="0">
                <a:ln>
                  <a:noFill/>
                </a:ln>
                <a:effectLst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40" name="Rectangle 145"/>
          <p:cNvSpPr>
            <a:spLocks noChangeArrowheads="1"/>
          </p:cNvSpPr>
          <p:nvPr/>
        </p:nvSpPr>
        <p:spPr bwMode="auto">
          <a:xfrm rot="16200000">
            <a:off x="1419146" y="2375746"/>
            <a:ext cx="79989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33039"/>
            <a:r>
              <a:rPr lang="fr-FR" altLang="fr-FR" sz="1000" dirty="0" smtClean="0">
                <a:cs typeface="Arial" panose="020B0604020202020204" pitchFamily="34" charset="0"/>
              </a:rPr>
              <a:t>TNF</a:t>
            </a:r>
            <a:r>
              <a:rPr lang="el-GR" altLang="fr-FR" sz="1000" dirty="0" smtClean="0">
                <a:cs typeface="Arial" panose="020B0604020202020204" pitchFamily="34" charset="0"/>
              </a:rPr>
              <a:t>α</a:t>
            </a:r>
            <a:r>
              <a:rPr lang="fr-FR" altLang="fr-FR" sz="1000" dirty="0" smtClean="0">
                <a:cs typeface="Arial" panose="020B0604020202020204" pitchFamily="34" charset="0"/>
              </a:rPr>
              <a:t> </a:t>
            </a:r>
            <a:r>
              <a:rPr lang="fr-FR" altLang="fr-FR" sz="1000" dirty="0">
                <a:cs typeface="Arial" panose="020B0604020202020204" pitchFamily="34" charset="0"/>
              </a:rPr>
              <a:t>(</a:t>
            </a:r>
            <a:r>
              <a:rPr lang="fr-FR" altLang="fr-FR" sz="1000" dirty="0" err="1">
                <a:cs typeface="Arial" panose="020B0604020202020204" pitchFamily="34" charset="0"/>
              </a:rPr>
              <a:t>pg</a:t>
            </a:r>
            <a:r>
              <a:rPr lang="fr-FR" altLang="fr-FR" sz="1000" dirty="0">
                <a:cs typeface="Arial" panose="020B0604020202020204" pitchFamily="34" charset="0"/>
              </a:rPr>
              <a:t>/</a:t>
            </a:r>
            <a:r>
              <a:rPr lang="fr-FR" altLang="fr-FR" sz="1000" dirty="0" err="1">
                <a:cs typeface="Arial" panose="020B0604020202020204" pitchFamily="34" charset="0"/>
              </a:rPr>
              <a:t>mL</a:t>
            </a:r>
            <a:r>
              <a:rPr lang="fr-FR" altLang="fr-FR" sz="1000" dirty="0"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42" name="Connecteur droit 41"/>
          <p:cNvCxnSpPr/>
          <p:nvPr/>
        </p:nvCxnSpPr>
        <p:spPr>
          <a:xfrm>
            <a:off x="2510689" y="3503547"/>
            <a:ext cx="7106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53"/>
          <p:cNvSpPr>
            <a:spLocks noChangeArrowheads="1"/>
          </p:cNvSpPr>
          <p:nvPr/>
        </p:nvSpPr>
        <p:spPr bwMode="auto">
          <a:xfrm>
            <a:off x="2745776" y="3528947"/>
            <a:ext cx="24045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95250" y="4559300"/>
            <a:ext cx="661035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3: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Production of TNFα by BMDMs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BMDMs from WT or Hsp70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57BL/6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mice were stimulated with 100ng/mL LPS for 20h and then left untreated or treated 30min with ATP (5mM) or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eric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– 40µM). Supernatants were collected and TNFα was measured by ELISA. Data are the mean of three independent experiments ±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s.d.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</a:t>
            </a:r>
            <a:endParaRPr lang="fr-FR" sz="1200" dirty="0">
              <a:latin typeface="Arial" pitchFamily="34" charset="0"/>
              <a:cs typeface="Arial" pitchFamily="34" charset="0"/>
            </a:endParaRPr>
          </a:p>
          <a:p>
            <a:pPr algn="just"/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3932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1331642" y="1557335"/>
            <a:ext cx="3711781" cy="2200178"/>
            <a:chOff x="1331642" y="1557335"/>
            <a:chExt cx="3711781" cy="2200178"/>
          </a:xfrm>
        </p:grpSpPr>
        <p:sp>
          <p:nvSpPr>
            <p:cNvPr id="3" name="Rectangle 7"/>
            <p:cNvSpPr>
              <a:spLocks noChangeArrowheads="1"/>
            </p:cNvSpPr>
            <p:nvPr/>
          </p:nvSpPr>
          <p:spPr bwMode="auto">
            <a:xfrm>
              <a:off x="1954213" y="2179638"/>
              <a:ext cx="142875" cy="13811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" name="Freeform 8"/>
            <p:cNvSpPr>
              <a:spLocks noEditPoints="1"/>
            </p:cNvSpPr>
            <p:nvPr/>
          </p:nvSpPr>
          <p:spPr bwMode="auto">
            <a:xfrm>
              <a:off x="1951038" y="2176463"/>
              <a:ext cx="149225" cy="1387475"/>
            </a:xfrm>
            <a:custGeom>
              <a:avLst/>
              <a:gdLst>
                <a:gd name="T0" fmla="*/ 0 w 432"/>
                <a:gd name="T1" fmla="*/ 8 h 4016"/>
                <a:gd name="T2" fmla="*/ 8 w 432"/>
                <a:gd name="T3" fmla="*/ 0 h 4016"/>
                <a:gd name="T4" fmla="*/ 424 w 432"/>
                <a:gd name="T5" fmla="*/ 0 h 4016"/>
                <a:gd name="T6" fmla="*/ 432 w 432"/>
                <a:gd name="T7" fmla="*/ 8 h 4016"/>
                <a:gd name="T8" fmla="*/ 432 w 432"/>
                <a:gd name="T9" fmla="*/ 4008 h 4016"/>
                <a:gd name="T10" fmla="*/ 424 w 432"/>
                <a:gd name="T11" fmla="*/ 4016 h 4016"/>
                <a:gd name="T12" fmla="*/ 8 w 432"/>
                <a:gd name="T13" fmla="*/ 4016 h 4016"/>
                <a:gd name="T14" fmla="*/ 0 w 432"/>
                <a:gd name="T15" fmla="*/ 4008 h 4016"/>
                <a:gd name="T16" fmla="*/ 0 w 432"/>
                <a:gd name="T17" fmla="*/ 8 h 4016"/>
                <a:gd name="T18" fmla="*/ 16 w 432"/>
                <a:gd name="T19" fmla="*/ 4008 h 4016"/>
                <a:gd name="T20" fmla="*/ 8 w 432"/>
                <a:gd name="T21" fmla="*/ 4000 h 4016"/>
                <a:gd name="T22" fmla="*/ 424 w 432"/>
                <a:gd name="T23" fmla="*/ 4000 h 4016"/>
                <a:gd name="T24" fmla="*/ 416 w 432"/>
                <a:gd name="T25" fmla="*/ 4008 h 4016"/>
                <a:gd name="T26" fmla="*/ 416 w 432"/>
                <a:gd name="T27" fmla="*/ 8 h 4016"/>
                <a:gd name="T28" fmla="*/ 424 w 432"/>
                <a:gd name="T29" fmla="*/ 16 h 4016"/>
                <a:gd name="T30" fmla="*/ 8 w 432"/>
                <a:gd name="T31" fmla="*/ 16 h 4016"/>
                <a:gd name="T32" fmla="*/ 16 w 432"/>
                <a:gd name="T33" fmla="*/ 8 h 4016"/>
                <a:gd name="T34" fmla="*/ 16 w 432"/>
                <a:gd name="T35" fmla="*/ 4008 h 40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4016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24" y="0"/>
                  </a:lnTo>
                  <a:cubicBezTo>
                    <a:pt x="429" y="0"/>
                    <a:pt x="432" y="4"/>
                    <a:pt x="432" y="8"/>
                  </a:cubicBezTo>
                  <a:lnTo>
                    <a:pt x="432" y="4008"/>
                  </a:lnTo>
                  <a:cubicBezTo>
                    <a:pt x="432" y="4013"/>
                    <a:pt x="429" y="4016"/>
                    <a:pt x="424" y="4016"/>
                  </a:cubicBezTo>
                  <a:lnTo>
                    <a:pt x="8" y="4016"/>
                  </a:lnTo>
                  <a:cubicBezTo>
                    <a:pt x="4" y="4016"/>
                    <a:pt x="0" y="4013"/>
                    <a:pt x="0" y="4008"/>
                  </a:cubicBezTo>
                  <a:lnTo>
                    <a:pt x="0" y="8"/>
                  </a:lnTo>
                  <a:close/>
                  <a:moveTo>
                    <a:pt x="16" y="4008"/>
                  </a:moveTo>
                  <a:lnTo>
                    <a:pt x="8" y="4000"/>
                  </a:lnTo>
                  <a:lnTo>
                    <a:pt x="424" y="4000"/>
                  </a:lnTo>
                  <a:lnTo>
                    <a:pt x="416" y="4008"/>
                  </a:lnTo>
                  <a:lnTo>
                    <a:pt x="416" y="8"/>
                  </a:lnTo>
                  <a:lnTo>
                    <a:pt x="424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4008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" name="Rectangle 9"/>
            <p:cNvSpPr>
              <a:spLocks noChangeArrowheads="1"/>
            </p:cNvSpPr>
            <p:nvPr/>
          </p:nvSpPr>
          <p:spPr bwMode="auto">
            <a:xfrm>
              <a:off x="2600325" y="2693988"/>
              <a:ext cx="144463" cy="8667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" name="Freeform 10"/>
            <p:cNvSpPr>
              <a:spLocks noEditPoints="1"/>
            </p:cNvSpPr>
            <p:nvPr/>
          </p:nvSpPr>
          <p:spPr bwMode="auto">
            <a:xfrm>
              <a:off x="2597150" y="2690813"/>
              <a:ext cx="149225" cy="873125"/>
            </a:xfrm>
            <a:custGeom>
              <a:avLst/>
              <a:gdLst>
                <a:gd name="T0" fmla="*/ 0 w 432"/>
                <a:gd name="T1" fmla="*/ 8 h 2528"/>
                <a:gd name="T2" fmla="*/ 8 w 432"/>
                <a:gd name="T3" fmla="*/ 0 h 2528"/>
                <a:gd name="T4" fmla="*/ 424 w 432"/>
                <a:gd name="T5" fmla="*/ 0 h 2528"/>
                <a:gd name="T6" fmla="*/ 432 w 432"/>
                <a:gd name="T7" fmla="*/ 8 h 2528"/>
                <a:gd name="T8" fmla="*/ 432 w 432"/>
                <a:gd name="T9" fmla="*/ 2520 h 2528"/>
                <a:gd name="T10" fmla="*/ 424 w 432"/>
                <a:gd name="T11" fmla="*/ 2528 h 2528"/>
                <a:gd name="T12" fmla="*/ 8 w 432"/>
                <a:gd name="T13" fmla="*/ 2528 h 2528"/>
                <a:gd name="T14" fmla="*/ 0 w 432"/>
                <a:gd name="T15" fmla="*/ 2520 h 2528"/>
                <a:gd name="T16" fmla="*/ 0 w 432"/>
                <a:gd name="T17" fmla="*/ 8 h 2528"/>
                <a:gd name="T18" fmla="*/ 16 w 432"/>
                <a:gd name="T19" fmla="*/ 2520 h 2528"/>
                <a:gd name="T20" fmla="*/ 8 w 432"/>
                <a:gd name="T21" fmla="*/ 2512 h 2528"/>
                <a:gd name="T22" fmla="*/ 424 w 432"/>
                <a:gd name="T23" fmla="*/ 2512 h 2528"/>
                <a:gd name="T24" fmla="*/ 416 w 432"/>
                <a:gd name="T25" fmla="*/ 2520 h 2528"/>
                <a:gd name="T26" fmla="*/ 416 w 432"/>
                <a:gd name="T27" fmla="*/ 8 h 2528"/>
                <a:gd name="T28" fmla="*/ 424 w 432"/>
                <a:gd name="T29" fmla="*/ 16 h 2528"/>
                <a:gd name="T30" fmla="*/ 8 w 432"/>
                <a:gd name="T31" fmla="*/ 16 h 2528"/>
                <a:gd name="T32" fmla="*/ 16 w 432"/>
                <a:gd name="T33" fmla="*/ 8 h 2528"/>
                <a:gd name="T34" fmla="*/ 16 w 432"/>
                <a:gd name="T35" fmla="*/ 2520 h 25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2528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24" y="0"/>
                  </a:lnTo>
                  <a:cubicBezTo>
                    <a:pt x="429" y="0"/>
                    <a:pt x="432" y="4"/>
                    <a:pt x="432" y="8"/>
                  </a:cubicBezTo>
                  <a:lnTo>
                    <a:pt x="432" y="2520"/>
                  </a:lnTo>
                  <a:cubicBezTo>
                    <a:pt x="432" y="2525"/>
                    <a:pt x="429" y="2528"/>
                    <a:pt x="424" y="2528"/>
                  </a:cubicBezTo>
                  <a:lnTo>
                    <a:pt x="8" y="2528"/>
                  </a:lnTo>
                  <a:cubicBezTo>
                    <a:pt x="4" y="2528"/>
                    <a:pt x="0" y="2525"/>
                    <a:pt x="0" y="2520"/>
                  </a:cubicBezTo>
                  <a:lnTo>
                    <a:pt x="0" y="8"/>
                  </a:lnTo>
                  <a:close/>
                  <a:moveTo>
                    <a:pt x="16" y="2520"/>
                  </a:moveTo>
                  <a:lnTo>
                    <a:pt x="8" y="2512"/>
                  </a:lnTo>
                  <a:lnTo>
                    <a:pt x="424" y="2512"/>
                  </a:lnTo>
                  <a:lnTo>
                    <a:pt x="416" y="2520"/>
                  </a:lnTo>
                  <a:lnTo>
                    <a:pt x="416" y="8"/>
                  </a:lnTo>
                  <a:lnTo>
                    <a:pt x="424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2520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" name="Rectangle 11"/>
            <p:cNvSpPr>
              <a:spLocks noChangeArrowheads="1"/>
            </p:cNvSpPr>
            <p:nvPr/>
          </p:nvSpPr>
          <p:spPr bwMode="auto">
            <a:xfrm>
              <a:off x="3248025" y="2747963"/>
              <a:ext cx="149225" cy="8128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" name="Freeform 12"/>
            <p:cNvSpPr>
              <a:spLocks noEditPoints="1"/>
            </p:cNvSpPr>
            <p:nvPr/>
          </p:nvSpPr>
          <p:spPr bwMode="auto">
            <a:xfrm>
              <a:off x="3244850" y="2746375"/>
              <a:ext cx="153988" cy="817563"/>
            </a:xfrm>
            <a:custGeom>
              <a:avLst/>
              <a:gdLst>
                <a:gd name="T0" fmla="*/ 0 w 448"/>
                <a:gd name="T1" fmla="*/ 8 h 2368"/>
                <a:gd name="T2" fmla="*/ 8 w 448"/>
                <a:gd name="T3" fmla="*/ 0 h 2368"/>
                <a:gd name="T4" fmla="*/ 440 w 448"/>
                <a:gd name="T5" fmla="*/ 0 h 2368"/>
                <a:gd name="T6" fmla="*/ 448 w 448"/>
                <a:gd name="T7" fmla="*/ 8 h 2368"/>
                <a:gd name="T8" fmla="*/ 448 w 448"/>
                <a:gd name="T9" fmla="*/ 2360 h 2368"/>
                <a:gd name="T10" fmla="*/ 440 w 448"/>
                <a:gd name="T11" fmla="*/ 2368 h 2368"/>
                <a:gd name="T12" fmla="*/ 8 w 448"/>
                <a:gd name="T13" fmla="*/ 2368 h 2368"/>
                <a:gd name="T14" fmla="*/ 0 w 448"/>
                <a:gd name="T15" fmla="*/ 2360 h 2368"/>
                <a:gd name="T16" fmla="*/ 0 w 448"/>
                <a:gd name="T17" fmla="*/ 8 h 2368"/>
                <a:gd name="T18" fmla="*/ 16 w 448"/>
                <a:gd name="T19" fmla="*/ 2360 h 2368"/>
                <a:gd name="T20" fmla="*/ 8 w 448"/>
                <a:gd name="T21" fmla="*/ 2352 h 2368"/>
                <a:gd name="T22" fmla="*/ 440 w 448"/>
                <a:gd name="T23" fmla="*/ 2352 h 2368"/>
                <a:gd name="T24" fmla="*/ 432 w 448"/>
                <a:gd name="T25" fmla="*/ 2360 h 2368"/>
                <a:gd name="T26" fmla="*/ 432 w 448"/>
                <a:gd name="T27" fmla="*/ 8 h 2368"/>
                <a:gd name="T28" fmla="*/ 440 w 448"/>
                <a:gd name="T29" fmla="*/ 16 h 2368"/>
                <a:gd name="T30" fmla="*/ 8 w 448"/>
                <a:gd name="T31" fmla="*/ 16 h 2368"/>
                <a:gd name="T32" fmla="*/ 16 w 448"/>
                <a:gd name="T33" fmla="*/ 8 h 2368"/>
                <a:gd name="T34" fmla="*/ 16 w 448"/>
                <a:gd name="T35" fmla="*/ 2360 h 23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48" h="2368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40" y="0"/>
                  </a:lnTo>
                  <a:cubicBezTo>
                    <a:pt x="445" y="0"/>
                    <a:pt x="448" y="4"/>
                    <a:pt x="448" y="8"/>
                  </a:cubicBezTo>
                  <a:lnTo>
                    <a:pt x="448" y="2360"/>
                  </a:lnTo>
                  <a:cubicBezTo>
                    <a:pt x="448" y="2365"/>
                    <a:pt x="445" y="2368"/>
                    <a:pt x="440" y="2368"/>
                  </a:cubicBezTo>
                  <a:lnTo>
                    <a:pt x="8" y="2368"/>
                  </a:lnTo>
                  <a:cubicBezTo>
                    <a:pt x="4" y="2368"/>
                    <a:pt x="0" y="2365"/>
                    <a:pt x="0" y="2360"/>
                  </a:cubicBezTo>
                  <a:lnTo>
                    <a:pt x="0" y="8"/>
                  </a:lnTo>
                  <a:close/>
                  <a:moveTo>
                    <a:pt x="16" y="2360"/>
                  </a:moveTo>
                  <a:lnTo>
                    <a:pt x="8" y="2352"/>
                  </a:lnTo>
                  <a:lnTo>
                    <a:pt x="440" y="2352"/>
                  </a:lnTo>
                  <a:lnTo>
                    <a:pt x="432" y="2360"/>
                  </a:lnTo>
                  <a:lnTo>
                    <a:pt x="432" y="8"/>
                  </a:lnTo>
                  <a:lnTo>
                    <a:pt x="440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2360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" name="Rectangle 13"/>
            <p:cNvSpPr>
              <a:spLocks noChangeArrowheads="1"/>
            </p:cNvSpPr>
            <p:nvPr/>
          </p:nvSpPr>
          <p:spPr bwMode="auto">
            <a:xfrm>
              <a:off x="3898900" y="2378075"/>
              <a:ext cx="144463" cy="11826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" name="Freeform 14"/>
            <p:cNvSpPr>
              <a:spLocks noEditPoints="1"/>
            </p:cNvSpPr>
            <p:nvPr/>
          </p:nvSpPr>
          <p:spPr bwMode="auto">
            <a:xfrm>
              <a:off x="3897313" y="2374900"/>
              <a:ext cx="149225" cy="1189038"/>
            </a:xfrm>
            <a:custGeom>
              <a:avLst/>
              <a:gdLst>
                <a:gd name="T0" fmla="*/ 0 w 432"/>
                <a:gd name="T1" fmla="*/ 8 h 3440"/>
                <a:gd name="T2" fmla="*/ 8 w 432"/>
                <a:gd name="T3" fmla="*/ 0 h 3440"/>
                <a:gd name="T4" fmla="*/ 424 w 432"/>
                <a:gd name="T5" fmla="*/ 0 h 3440"/>
                <a:gd name="T6" fmla="*/ 432 w 432"/>
                <a:gd name="T7" fmla="*/ 8 h 3440"/>
                <a:gd name="T8" fmla="*/ 432 w 432"/>
                <a:gd name="T9" fmla="*/ 3432 h 3440"/>
                <a:gd name="T10" fmla="*/ 424 w 432"/>
                <a:gd name="T11" fmla="*/ 3440 h 3440"/>
                <a:gd name="T12" fmla="*/ 8 w 432"/>
                <a:gd name="T13" fmla="*/ 3440 h 3440"/>
                <a:gd name="T14" fmla="*/ 0 w 432"/>
                <a:gd name="T15" fmla="*/ 3432 h 3440"/>
                <a:gd name="T16" fmla="*/ 0 w 432"/>
                <a:gd name="T17" fmla="*/ 8 h 3440"/>
                <a:gd name="T18" fmla="*/ 16 w 432"/>
                <a:gd name="T19" fmla="*/ 3432 h 3440"/>
                <a:gd name="T20" fmla="*/ 8 w 432"/>
                <a:gd name="T21" fmla="*/ 3424 h 3440"/>
                <a:gd name="T22" fmla="*/ 424 w 432"/>
                <a:gd name="T23" fmla="*/ 3424 h 3440"/>
                <a:gd name="T24" fmla="*/ 416 w 432"/>
                <a:gd name="T25" fmla="*/ 3432 h 3440"/>
                <a:gd name="T26" fmla="*/ 416 w 432"/>
                <a:gd name="T27" fmla="*/ 8 h 3440"/>
                <a:gd name="T28" fmla="*/ 424 w 432"/>
                <a:gd name="T29" fmla="*/ 16 h 3440"/>
                <a:gd name="T30" fmla="*/ 8 w 432"/>
                <a:gd name="T31" fmla="*/ 16 h 3440"/>
                <a:gd name="T32" fmla="*/ 16 w 432"/>
                <a:gd name="T33" fmla="*/ 8 h 3440"/>
                <a:gd name="T34" fmla="*/ 16 w 432"/>
                <a:gd name="T35" fmla="*/ 3432 h 34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344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24" y="0"/>
                  </a:lnTo>
                  <a:cubicBezTo>
                    <a:pt x="429" y="0"/>
                    <a:pt x="432" y="4"/>
                    <a:pt x="432" y="8"/>
                  </a:cubicBezTo>
                  <a:lnTo>
                    <a:pt x="432" y="3432"/>
                  </a:lnTo>
                  <a:cubicBezTo>
                    <a:pt x="432" y="3437"/>
                    <a:pt x="429" y="3440"/>
                    <a:pt x="424" y="3440"/>
                  </a:cubicBezTo>
                  <a:lnTo>
                    <a:pt x="8" y="3440"/>
                  </a:lnTo>
                  <a:cubicBezTo>
                    <a:pt x="4" y="3440"/>
                    <a:pt x="0" y="3437"/>
                    <a:pt x="0" y="3432"/>
                  </a:cubicBezTo>
                  <a:lnTo>
                    <a:pt x="0" y="8"/>
                  </a:lnTo>
                  <a:close/>
                  <a:moveTo>
                    <a:pt x="16" y="3432"/>
                  </a:moveTo>
                  <a:lnTo>
                    <a:pt x="8" y="3424"/>
                  </a:lnTo>
                  <a:lnTo>
                    <a:pt x="424" y="3424"/>
                  </a:lnTo>
                  <a:lnTo>
                    <a:pt x="416" y="3432"/>
                  </a:lnTo>
                  <a:lnTo>
                    <a:pt x="416" y="8"/>
                  </a:lnTo>
                  <a:lnTo>
                    <a:pt x="424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3432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" name="Rectangle 15"/>
            <p:cNvSpPr>
              <a:spLocks noChangeArrowheads="1"/>
            </p:cNvSpPr>
            <p:nvPr/>
          </p:nvSpPr>
          <p:spPr bwMode="auto">
            <a:xfrm>
              <a:off x="2136775" y="2179638"/>
              <a:ext cx="142875" cy="13811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" name="Freeform 16"/>
            <p:cNvSpPr>
              <a:spLocks noEditPoints="1"/>
            </p:cNvSpPr>
            <p:nvPr/>
          </p:nvSpPr>
          <p:spPr bwMode="auto">
            <a:xfrm>
              <a:off x="2133600" y="2176463"/>
              <a:ext cx="149225" cy="1387475"/>
            </a:xfrm>
            <a:custGeom>
              <a:avLst/>
              <a:gdLst>
                <a:gd name="T0" fmla="*/ 0 w 432"/>
                <a:gd name="T1" fmla="*/ 8 h 4016"/>
                <a:gd name="T2" fmla="*/ 8 w 432"/>
                <a:gd name="T3" fmla="*/ 0 h 4016"/>
                <a:gd name="T4" fmla="*/ 424 w 432"/>
                <a:gd name="T5" fmla="*/ 0 h 4016"/>
                <a:gd name="T6" fmla="*/ 432 w 432"/>
                <a:gd name="T7" fmla="*/ 8 h 4016"/>
                <a:gd name="T8" fmla="*/ 432 w 432"/>
                <a:gd name="T9" fmla="*/ 4008 h 4016"/>
                <a:gd name="T10" fmla="*/ 424 w 432"/>
                <a:gd name="T11" fmla="*/ 4016 h 4016"/>
                <a:gd name="T12" fmla="*/ 8 w 432"/>
                <a:gd name="T13" fmla="*/ 4016 h 4016"/>
                <a:gd name="T14" fmla="*/ 0 w 432"/>
                <a:gd name="T15" fmla="*/ 4008 h 4016"/>
                <a:gd name="T16" fmla="*/ 0 w 432"/>
                <a:gd name="T17" fmla="*/ 8 h 4016"/>
                <a:gd name="T18" fmla="*/ 16 w 432"/>
                <a:gd name="T19" fmla="*/ 4008 h 4016"/>
                <a:gd name="T20" fmla="*/ 8 w 432"/>
                <a:gd name="T21" fmla="*/ 4000 h 4016"/>
                <a:gd name="T22" fmla="*/ 424 w 432"/>
                <a:gd name="T23" fmla="*/ 4000 h 4016"/>
                <a:gd name="T24" fmla="*/ 416 w 432"/>
                <a:gd name="T25" fmla="*/ 4008 h 4016"/>
                <a:gd name="T26" fmla="*/ 416 w 432"/>
                <a:gd name="T27" fmla="*/ 8 h 4016"/>
                <a:gd name="T28" fmla="*/ 424 w 432"/>
                <a:gd name="T29" fmla="*/ 16 h 4016"/>
                <a:gd name="T30" fmla="*/ 8 w 432"/>
                <a:gd name="T31" fmla="*/ 16 h 4016"/>
                <a:gd name="T32" fmla="*/ 16 w 432"/>
                <a:gd name="T33" fmla="*/ 8 h 4016"/>
                <a:gd name="T34" fmla="*/ 16 w 432"/>
                <a:gd name="T35" fmla="*/ 4008 h 40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4016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24" y="0"/>
                  </a:lnTo>
                  <a:cubicBezTo>
                    <a:pt x="429" y="0"/>
                    <a:pt x="432" y="4"/>
                    <a:pt x="432" y="8"/>
                  </a:cubicBezTo>
                  <a:lnTo>
                    <a:pt x="432" y="4008"/>
                  </a:lnTo>
                  <a:cubicBezTo>
                    <a:pt x="432" y="4013"/>
                    <a:pt x="429" y="4016"/>
                    <a:pt x="424" y="4016"/>
                  </a:cubicBezTo>
                  <a:lnTo>
                    <a:pt x="8" y="4016"/>
                  </a:lnTo>
                  <a:cubicBezTo>
                    <a:pt x="4" y="4016"/>
                    <a:pt x="0" y="4013"/>
                    <a:pt x="0" y="4008"/>
                  </a:cubicBezTo>
                  <a:lnTo>
                    <a:pt x="0" y="8"/>
                  </a:lnTo>
                  <a:close/>
                  <a:moveTo>
                    <a:pt x="16" y="4008"/>
                  </a:moveTo>
                  <a:lnTo>
                    <a:pt x="8" y="4000"/>
                  </a:lnTo>
                  <a:lnTo>
                    <a:pt x="424" y="4000"/>
                  </a:lnTo>
                  <a:lnTo>
                    <a:pt x="416" y="4008"/>
                  </a:lnTo>
                  <a:lnTo>
                    <a:pt x="416" y="8"/>
                  </a:lnTo>
                  <a:lnTo>
                    <a:pt x="424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4008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" name="Rectangle 17"/>
            <p:cNvSpPr>
              <a:spLocks noChangeArrowheads="1"/>
            </p:cNvSpPr>
            <p:nvPr/>
          </p:nvSpPr>
          <p:spPr bwMode="auto">
            <a:xfrm>
              <a:off x="2782888" y="2505075"/>
              <a:ext cx="149225" cy="10556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" name="Freeform 18"/>
            <p:cNvSpPr>
              <a:spLocks noEditPoints="1"/>
            </p:cNvSpPr>
            <p:nvPr/>
          </p:nvSpPr>
          <p:spPr bwMode="auto">
            <a:xfrm>
              <a:off x="2779713" y="2501900"/>
              <a:ext cx="155575" cy="1062038"/>
            </a:xfrm>
            <a:custGeom>
              <a:avLst/>
              <a:gdLst>
                <a:gd name="T0" fmla="*/ 0 w 448"/>
                <a:gd name="T1" fmla="*/ 8 h 3072"/>
                <a:gd name="T2" fmla="*/ 8 w 448"/>
                <a:gd name="T3" fmla="*/ 0 h 3072"/>
                <a:gd name="T4" fmla="*/ 440 w 448"/>
                <a:gd name="T5" fmla="*/ 0 h 3072"/>
                <a:gd name="T6" fmla="*/ 448 w 448"/>
                <a:gd name="T7" fmla="*/ 8 h 3072"/>
                <a:gd name="T8" fmla="*/ 448 w 448"/>
                <a:gd name="T9" fmla="*/ 3064 h 3072"/>
                <a:gd name="T10" fmla="*/ 440 w 448"/>
                <a:gd name="T11" fmla="*/ 3072 h 3072"/>
                <a:gd name="T12" fmla="*/ 8 w 448"/>
                <a:gd name="T13" fmla="*/ 3072 h 3072"/>
                <a:gd name="T14" fmla="*/ 0 w 448"/>
                <a:gd name="T15" fmla="*/ 3064 h 3072"/>
                <a:gd name="T16" fmla="*/ 0 w 448"/>
                <a:gd name="T17" fmla="*/ 8 h 3072"/>
                <a:gd name="T18" fmla="*/ 16 w 448"/>
                <a:gd name="T19" fmla="*/ 3064 h 3072"/>
                <a:gd name="T20" fmla="*/ 8 w 448"/>
                <a:gd name="T21" fmla="*/ 3056 h 3072"/>
                <a:gd name="T22" fmla="*/ 440 w 448"/>
                <a:gd name="T23" fmla="*/ 3056 h 3072"/>
                <a:gd name="T24" fmla="*/ 432 w 448"/>
                <a:gd name="T25" fmla="*/ 3064 h 3072"/>
                <a:gd name="T26" fmla="*/ 432 w 448"/>
                <a:gd name="T27" fmla="*/ 8 h 3072"/>
                <a:gd name="T28" fmla="*/ 440 w 448"/>
                <a:gd name="T29" fmla="*/ 16 h 3072"/>
                <a:gd name="T30" fmla="*/ 8 w 448"/>
                <a:gd name="T31" fmla="*/ 16 h 3072"/>
                <a:gd name="T32" fmla="*/ 16 w 448"/>
                <a:gd name="T33" fmla="*/ 8 h 3072"/>
                <a:gd name="T34" fmla="*/ 16 w 448"/>
                <a:gd name="T35" fmla="*/ 3064 h 30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48" h="3072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40" y="0"/>
                  </a:lnTo>
                  <a:cubicBezTo>
                    <a:pt x="445" y="0"/>
                    <a:pt x="448" y="4"/>
                    <a:pt x="448" y="8"/>
                  </a:cubicBezTo>
                  <a:lnTo>
                    <a:pt x="448" y="3064"/>
                  </a:lnTo>
                  <a:cubicBezTo>
                    <a:pt x="448" y="3069"/>
                    <a:pt x="445" y="3072"/>
                    <a:pt x="440" y="3072"/>
                  </a:cubicBezTo>
                  <a:lnTo>
                    <a:pt x="8" y="3072"/>
                  </a:lnTo>
                  <a:cubicBezTo>
                    <a:pt x="4" y="3072"/>
                    <a:pt x="0" y="3069"/>
                    <a:pt x="0" y="3064"/>
                  </a:cubicBezTo>
                  <a:lnTo>
                    <a:pt x="0" y="8"/>
                  </a:lnTo>
                  <a:close/>
                  <a:moveTo>
                    <a:pt x="16" y="3064"/>
                  </a:moveTo>
                  <a:lnTo>
                    <a:pt x="8" y="3056"/>
                  </a:lnTo>
                  <a:lnTo>
                    <a:pt x="440" y="3056"/>
                  </a:lnTo>
                  <a:lnTo>
                    <a:pt x="432" y="3064"/>
                  </a:lnTo>
                  <a:lnTo>
                    <a:pt x="432" y="8"/>
                  </a:lnTo>
                  <a:lnTo>
                    <a:pt x="440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3064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" name="Rectangle 19"/>
            <p:cNvSpPr>
              <a:spLocks noChangeArrowheads="1"/>
            </p:cNvSpPr>
            <p:nvPr/>
          </p:nvSpPr>
          <p:spPr bwMode="auto">
            <a:xfrm>
              <a:off x="3435350" y="2582863"/>
              <a:ext cx="142875" cy="9779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" name="Freeform 20"/>
            <p:cNvSpPr>
              <a:spLocks noEditPoints="1"/>
            </p:cNvSpPr>
            <p:nvPr/>
          </p:nvSpPr>
          <p:spPr bwMode="auto">
            <a:xfrm>
              <a:off x="3432175" y="2579688"/>
              <a:ext cx="149225" cy="984250"/>
            </a:xfrm>
            <a:custGeom>
              <a:avLst/>
              <a:gdLst>
                <a:gd name="T0" fmla="*/ 0 w 432"/>
                <a:gd name="T1" fmla="*/ 8 h 2848"/>
                <a:gd name="T2" fmla="*/ 8 w 432"/>
                <a:gd name="T3" fmla="*/ 0 h 2848"/>
                <a:gd name="T4" fmla="*/ 424 w 432"/>
                <a:gd name="T5" fmla="*/ 0 h 2848"/>
                <a:gd name="T6" fmla="*/ 432 w 432"/>
                <a:gd name="T7" fmla="*/ 8 h 2848"/>
                <a:gd name="T8" fmla="*/ 432 w 432"/>
                <a:gd name="T9" fmla="*/ 2840 h 2848"/>
                <a:gd name="T10" fmla="*/ 424 w 432"/>
                <a:gd name="T11" fmla="*/ 2848 h 2848"/>
                <a:gd name="T12" fmla="*/ 8 w 432"/>
                <a:gd name="T13" fmla="*/ 2848 h 2848"/>
                <a:gd name="T14" fmla="*/ 0 w 432"/>
                <a:gd name="T15" fmla="*/ 2840 h 2848"/>
                <a:gd name="T16" fmla="*/ 0 w 432"/>
                <a:gd name="T17" fmla="*/ 8 h 2848"/>
                <a:gd name="T18" fmla="*/ 16 w 432"/>
                <a:gd name="T19" fmla="*/ 2840 h 2848"/>
                <a:gd name="T20" fmla="*/ 8 w 432"/>
                <a:gd name="T21" fmla="*/ 2832 h 2848"/>
                <a:gd name="T22" fmla="*/ 424 w 432"/>
                <a:gd name="T23" fmla="*/ 2832 h 2848"/>
                <a:gd name="T24" fmla="*/ 416 w 432"/>
                <a:gd name="T25" fmla="*/ 2840 h 2848"/>
                <a:gd name="T26" fmla="*/ 416 w 432"/>
                <a:gd name="T27" fmla="*/ 8 h 2848"/>
                <a:gd name="T28" fmla="*/ 424 w 432"/>
                <a:gd name="T29" fmla="*/ 16 h 2848"/>
                <a:gd name="T30" fmla="*/ 8 w 432"/>
                <a:gd name="T31" fmla="*/ 16 h 2848"/>
                <a:gd name="T32" fmla="*/ 16 w 432"/>
                <a:gd name="T33" fmla="*/ 8 h 2848"/>
                <a:gd name="T34" fmla="*/ 16 w 432"/>
                <a:gd name="T35" fmla="*/ 2840 h 28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2848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24" y="0"/>
                  </a:lnTo>
                  <a:cubicBezTo>
                    <a:pt x="429" y="0"/>
                    <a:pt x="432" y="4"/>
                    <a:pt x="432" y="8"/>
                  </a:cubicBezTo>
                  <a:lnTo>
                    <a:pt x="432" y="2840"/>
                  </a:lnTo>
                  <a:cubicBezTo>
                    <a:pt x="432" y="2845"/>
                    <a:pt x="429" y="2848"/>
                    <a:pt x="424" y="2848"/>
                  </a:cubicBezTo>
                  <a:lnTo>
                    <a:pt x="8" y="2848"/>
                  </a:lnTo>
                  <a:cubicBezTo>
                    <a:pt x="4" y="2848"/>
                    <a:pt x="0" y="2845"/>
                    <a:pt x="0" y="2840"/>
                  </a:cubicBezTo>
                  <a:lnTo>
                    <a:pt x="0" y="8"/>
                  </a:lnTo>
                  <a:close/>
                  <a:moveTo>
                    <a:pt x="16" y="2840"/>
                  </a:moveTo>
                  <a:lnTo>
                    <a:pt x="8" y="2832"/>
                  </a:lnTo>
                  <a:lnTo>
                    <a:pt x="424" y="2832"/>
                  </a:lnTo>
                  <a:lnTo>
                    <a:pt x="416" y="2840"/>
                  </a:lnTo>
                  <a:lnTo>
                    <a:pt x="416" y="8"/>
                  </a:lnTo>
                  <a:lnTo>
                    <a:pt x="424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2840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" name="Rectangle 21"/>
            <p:cNvSpPr>
              <a:spLocks noChangeArrowheads="1"/>
            </p:cNvSpPr>
            <p:nvPr/>
          </p:nvSpPr>
          <p:spPr bwMode="auto">
            <a:xfrm>
              <a:off x="4081463" y="2489200"/>
              <a:ext cx="144463" cy="10715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8" name="Freeform 22"/>
            <p:cNvSpPr>
              <a:spLocks noEditPoints="1"/>
            </p:cNvSpPr>
            <p:nvPr/>
          </p:nvSpPr>
          <p:spPr bwMode="auto">
            <a:xfrm>
              <a:off x="4079875" y="2486025"/>
              <a:ext cx="149225" cy="1077913"/>
            </a:xfrm>
            <a:custGeom>
              <a:avLst/>
              <a:gdLst>
                <a:gd name="T0" fmla="*/ 0 w 432"/>
                <a:gd name="T1" fmla="*/ 8 h 3120"/>
                <a:gd name="T2" fmla="*/ 8 w 432"/>
                <a:gd name="T3" fmla="*/ 0 h 3120"/>
                <a:gd name="T4" fmla="*/ 424 w 432"/>
                <a:gd name="T5" fmla="*/ 0 h 3120"/>
                <a:gd name="T6" fmla="*/ 432 w 432"/>
                <a:gd name="T7" fmla="*/ 8 h 3120"/>
                <a:gd name="T8" fmla="*/ 432 w 432"/>
                <a:gd name="T9" fmla="*/ 3112 h 3120"/>
                <a:gd name="T10" fmla="*/ 424 w 432"/>
                <a:gd name="T11" fmla="*/ 3120 h 3120"/>
                <a:gd name="T12" fmla="*/ 8 w 432"/>
                <a:gd name="T13" fmla="*/ 3120 h 3120"/>
                <a:gd name="T14" fmla="*/ 0 w 432"/>
                <a:gd name="T15" fmla="*/ 3112 h 3120"/>
                <a:gd name="T16" fmla="*/ 0 w 432"/>
                <a:gd name="T17" fmla="*/ 8 h 3120"/>
                <a:gd name="T18" fmla="*/ 16 w 432"/>
                <a:gd name="T19" fmla="*/ 3112 h 3120"/>
                <a:gd name="T20" fmla="*/ 8 w 432"/>
                <a:gd name="T21" fmla="*/ 3104 h 3120"/>
                <a:gd name="T22" fmla="*/ 424 w 432"/>
                <a:gd name="T23" fmla="*/ 3104 h 3120"/>
                <a:gd name="T24" fmla="*/ 416 w 432"/>
                <a:gd name="T25" fmla="*/ 3112 h 3120"/>
                <a:gd name="T26" fmla="*/ 416 w 432"/>
                <a:gd name="T27" fmla="*/ 8 h 3120"/>
                <a:gd name="T28" fmla="*/ 424 w 432"/>
                <a:gd name="T29" fmla="*/ 16 h 3120"/>
                <a:gd name="T30" fmla="*/ 8 w 432"/>
                <a:gd name="T31" fmla="*/ 16 h 3120"/>
                <a:gd name="T32" fmla="*/ 16 w 432"/>
                <a:gd name="T33" fmla="*/ 8 h 3120"/>
                <a:gd name="T34" fmla="*/ 16 w 432"/>
                <a:gd name="T35" fmla="*/ 3112 h 3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312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24" y="0"/>
                  </a:lnTo>
                  <a:cubicBezTo>
                    <a:pt x="429" y="0"/>
                    <a:pt x="432" y="4"/>
                    <a:pt x="432" y="8"/>
                  </a:cubicBezTo>
                  <a:lnTo>
                    <a:pt x="432" y="3112"/>
                  </a:lnTo>
                  <a:cubicBezTo>
                    <a:pt x="432" y="3117"/>
                    <a:pt x="429" y="3120"/>
                    <a:pt x="424" y="3120"/>
                  </a:cubicBezTo>
                  <a:lnTo>
                    <a:pt x="8" y="3120"/>
                  </a:lnTo>
                  <a:cubicBezTo>
                    <a:pt x="4" y="3120"/>
                    <a:pt x="0" y="3117"/>
                    <a:pt x="0" y="3112"/>
                  </a:cubicBezTo>
                  <a:lnTo>
                    <a:pt x="0" y="8"/>
                  </a:lnTo>
                  <a:close/>
                  <a:moveTo>
                    <a:pt x="16" y="3112"/>
                  </a:moveTo>
                  <a:lnTo>
                    <a:pt x="8" y="3104"/>
                  </a:lnTo>
                  <a:lnTo>
                    <a:pt x="424" y="3104"/>
                  </a:lnTo>
                  <a:lnTo>
                    <a:pt x="416" y="3112"/>
                  </a:lnTo>
                  <a:lnTo>
                    <a:pt x="416" y="8"/>
                  </a:lnTo>
                  <a:lnTo>
                    <a:pt x="424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3112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9" name="Freeform 23"/>
            <p:cNvSpPr>
              <a:spLocks noEditPoints="1"/>
            </p:cNvSpPr>
            <p:nvPr/>
          </p:nvSpPr>
          <p:spPr bwMode="auto">
            <a:xfrm>
              <a:off x="2009775" y="1955800"/>
              <a:ext cx="31750" cy="223838"/>
            </a:xfrm>
            <a:custGeom>
              <a:avLst/>
              <a:gdLst>
                <a:gd name="T0" fmla="*/ 8 w 20"/>
                <a:gd name="T1" fmla="*/ 141 h 141"/>
                <a:gd name="T2" fmla="*/ 8 w 20"/>
                <a:gd name="T3" fmla="*/ 2 h 141"/>
                <a:gd name="T4" fmla="*/ 12 w 20"/>
                <a:gd name="T5" fmla="*/ 2 h 141"/>
                <a:gd name="T6" fmla="*/ 12 w 20"/>
                <a:gd name="T7" fmla="*/ 141 h 141"/>
                <a:gd name="T8" fmla="*/ 8 w 20"/>
                <a:gd name="T9" fmla="*/ 141 h 141"/>
                <a:gd name="T10" fmla="*/ 0 w 20"/>
                <a:gd name="T11" fmla="*/ 0 h 141"/>
                <a:gd name="T12" fmla="*/ 20 w 20"/>
                <a:gd name="T13" fmla="*/ 0 h 141"/>
                <a:gd name="T14" fmla="*/ 20 w 20"/>
                <a:gd name="T15" fmla="*/ 3 h 141"/>
                <a:gd name="T16" fmla="*/ 0 w 20"/>
                <a:gd name="T17" fmla="*/ 3 h 141"/>
                <a:gd name="T18" fmla="*/ 0 w 20"/>
                <a:gd name="T19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0" h="141">
                  <a:moveTo>
                    <a:pt x="8" y="141"/>
                  </a:moveTo>
                  <a:lnTo>
                    <a:pt x="8" y="2"/>
                  </a:lnTo>
                  <a:lnTo>
                    <a:pt x="12" y="2"/>
                  </a:lnTo>
                  <a:lnTo>
                    <a:pt x="12" y="141"/>
                  </a:lnTo>
                  <a:lnTo>
                    <a:pt x="8" y="141"/>
                  </a:lnTo>
                  <a:close/>
                  <a:moveTo>
                    <a:pt x="0" y="0"/>
                  </a:moveTo>
                  <a:lnTo>
                    <a:pt x="20" y="0"/>
                  </a:lnTo>
                  <a:lnTo>
                    <a:pt x="20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" name="Freeform 24"/>
            <p:cNvSpPr>
              <a:spLocks noEditPoints="1"/>
            </p:cNvSpPr>
            <p:nvPr/>
          </p:nvSpPr>
          <p:spPr bwMode="auto">
            <a:xfrm>
              <a:off x="2655888" y="2624138"/>
              <a:ext cx="33338" cy="69850"/>
            </a:xfrm>
            <a:custGeom>
              <a:avLst/>
              <a:gdLst>
                <a:gd name="T0" fmla="*/ 9 w 21"/>
                <a:gd name="T1" fmla="*/ 44 h 44"/>
                <a:gd name="T2" fmla="*/ 9 w 21"/>
                <a:gd name="T3" fmla="*/ 2 h 44"/>
                <a:gd name="T4" fmla="*/ 12 w 21"/>
                <a:gd name="T5" fmla="*/ 2 h 44"/>
                <a:gd name="T6" fmla="*/ 12 w 21"/>
                <a:gd name="T7" fmla="*/ 44 h 44"/>
                <a:gd name="T8" fmla="*/ 9 w 21"/>
                <a:gd name="T9" fmla="*/ 44 h 44"/>
                <a:gd name="T10" fmla="*/ 0 w 21"/>
                <a:gd name="T11" fmla="*/ 0 h 44"/>
                <a:gd name="T12" fmla="*/ 21 w 21"/>
                <a:gd name="T13" fmla="*/ 0 h 44"/>
                <a:gd name="T14" fmla="*/ 21 w 21"/>
                <a:gd name="T15" fmla="*/ 4 h 44"/>
                <a:gd name="T16" fmla="*/ 0 w 21"/>
                <a:gd name="T17" fmla="*/ 4 h 44"/>
                <a:gd name="T18" fmla="*/ 0 w 21"/>
                <a:gd name="T19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1" h="44">
                  <a:moveTo>
                    <a:pt x="9" y="44"/>
                  </a:moveTo>
                  <a:lnTo>
                    <a:pt x="9" y="2"/>
                  </a:lnTo>
                  <a:lnTo>
                    <a:pt x="12" y="2"/>
                  </a:lnTo>
                  <a:lnTo>
                    <a:pt x="12" y="44"/>
                  </a:lnTo>
                  <a:lnTo>
                    <a:pt x="9" y="44"/>
                  </a:lnTo>
                  <a:close/>
                  <a:moveTo>
                    <a:pt x="0" y="0"/>
                  </a:moveTo>
                  <a:lnTo>
                    <a:pt x="21" y="0"/>
                  </a:lnTo>
                  <a:lnTo>
                    <a:pt x="21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" name="Freeform 25"/>
            <p:cNvSpPr>
              <a:spLocks noEditPoints="1"/>
            </p:cNvSpPr>
            <p:nvPr/>
          </p:nvSpPr>
          <p:spPr bwMode="auto">
            <a:xfrm>
              <a:off x="3302000" y="2690813"/>
              <a:ext cx="33338" cy="57150"/>
            </a:xfrm>
            <a:custGeom>
              <a:avLst/>
              <a:gdLst>
                <a:gd name="T0" fmla="*/ 9 w 21"/>
                <a:gd name="T1" fmla="*/ 36 h 36"/>
                <a:gd name="T2" fmla="*/ 9 w 21"/>
                <a:gd name="T3" fmla="*/ 2 h 36"/>
                <a:gd name="T4" fmla="*/ 13 w 21"/>
                <a:gd name="T5" fmla="*/ 2 h 36"/>
                <a:gd name="T6" fmla="*/ 13 w 21"/>
                <a:gd name="T7" fmla="*/ 36 h 36"/>
                <a:gd name="T8" fmla="*/ 9 w 21"/>
                <a:gd name="T9" fmla="*/ 36 h 36"/>
                <a:gd name="T10" fmla="*/ 0 w 21"/>
                <a:gd name="T11" fmla="*/ 0 h 36"/>
                <a:gd name="T12" fmla="*/ 21 w 21"/>
                <a:gd name="T13" fmla="*/ 0 h 36"/>
                <a:gd name="T14" fmla="*/ 21 w 21"/>
                <a:gd name="T15" fmla="*/ 3 h 36"/>
                <a:gd name="T16" fmla="*/ 0 w 21"/>
                <a:gd name="T17" fmla="*/ 3 h 36"/>
                <a:gd name="T18" fmla="*/ 0 w 21"/>
                <a:gd name="T19" fmla="*/ 0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1" h="36">
                  <a:moveTo>
                    <a:pt x="9" y="36"/>
                  </a:moveTo>
                  <a:lnTo>
                    <a:pt x="9" y="2"/>
                  </a:lnTo>
                  <a:lnTo>
                    <a:pt x="13" y="2"/>
                  </a:lnTo>
                  <a:lnTo>
                    <a:pt x="13" y="36"/>
                  </a:lnTo>
                  <a:lnTo>
                    <a:pt x="9" y="36"/>
                  </a:lnTo>
                  <a:close/>
                  <a:moveTo>
                    <a:pt x="0" y="0"/>
                  </a:moveTo>
                  <a:lnTo>
                    <a:pt x="21" y="0"/>
                  </a:lnTo>
                  <a:lnTo>
                    <a:pt x="21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" name="Freeform 26"/>
            <p:cNvSpPr>
              <a:spLocks noEditPoints="1"/>
            </p:cNvSpPr>
            <p:nvPr/>
          </p:nvSpPr>
          <p:spPr bwMode="auto">
            <a:xfrm>
              <a:off x="3954463" y="2187575"/>
              <a:ext cx="33338" cy="190500"/>
            </a:xfrm>
            <a:custGeom>
              <a:avLst/>
              <a:gdLst>
                <a:gd name="T0" fmla="*/ 9 w 21"/>
                <a:gd name="T1" fmla="*/ 120 h 120"/>
                <a:gd name="T2" fmla="*/ 9 w 21"/>
                <a:gd name="T3" fmla="*/ 2 h 120"/>
                <a:gd name="T4" fmla="*/ 12 w 21"/>
                <a:gd name="T5" fmla="*/ 2 h 120"/>
                <a:gd name="T6" fmla="*/ 12 w 21"/>
                <a:gd name="T7" fmla="*/ 120 h 120"/>
                <a:gd name="T8" fmla="*/ 9 w 21"/>
                <a:gd name="T9" fmla="*/ 120 h 120"/>
                <a:gd name="T10" fmla="*/ 0 w 21"/>
                <a:gd name="T11" fmla="*/ 0 h 120"/>
                <a:gd name="T12" fmla="*/ 21 w 21"/>
                <a:gd name="T13" fmla="*/ 0 h 120"/>
                <a:gd name="T14" fmla="*/ 21 w 21"/>
                <a:gd name="T15" fmla="*/ 4 h 120"/>
                <a:gd name="T16" fmla="*/ 0 w 21"/>
                <a:gd name="T17" fmla="*/ 4 h 120"/>
                <a:gd name="T18" fmla="*/ 0 w 21"/>
                <a:gd name="T19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1" h="120">
                  <a:moveTo>
                    <a:pt x="9" y="120"/>
                  </a:moveTo>
                  <a:lnTo>
                    <a:pt x="9" y="2"/>
                  </a:lnTo>
                  <a:lnTo>
                    <a:pt x="12" y="2"/>
                  </a:lnTo>
                  <a:lnTo>
                    <a:pt x="12" y="120"/>
                  </a:lnTo>
                  <a:lnTo>
                    <a:pt x="9" y="120"/>
                  </a:lnTo>
                  <a:close/>
                  <a:moveTo>
                    <a:pt x="0" y="0"/>
                  </a:moveTo>
                  <a:lnTo>
                    <a:pt x="21" y="0"/>
                  </a:lnTo>
                  <a:lnTo>
                    <a:pt x="21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" name="Freeform 27"/>
            <p:cNvSpPr>
              <a:spLocks noEditPoints="1"/>
            </p:cNvSpPr>
            <p:nvPr/>
          </p:nvSpPr>
          <p:spPr bwMode="auto">
            <a:xfrm>
              <a:off x="2190750" y="1955800"/>
              <a:ext cx="33338" cy="223838"/>
            </a:xfrm>
            <a:custGeom>
              <a:avLst/>
              <a:gdLst>
                <a:gd name="T0" fmla="*/ 9 w 21"/>
                <a:gd name="T1" fmla="*/ 141 h 141"/>
                <a:gd name="T2" fmla="*/ 9 w 21"/>
                <a:gd name="T3" fmla="*/ 2 h 141"/>
                <a:gd name="T4" fmla="*/ 13 w 21"/>
                <a:gd name="T5" fmla="*/ 2 h 141"/>
                <a:gd name="T6" fmla="*/ 13 w 21"/>
                <a:gd name="T7" fmla="*/ 141 h 141"/>
                <a:gd name="T8" fmla="*/ 9 w 21"/>
                <a:gd name="T9" fmla="*/ 141 h 141"/>
                <a:gd name="T10" fmla="*/ 0 w 21"/>
                <a:gd name="T11" fmla="*/ 0 h 141"/>
                <a:gd name="T12" fmla="*/ 21 w 21"/>
                <a:gd name="T13" fmla="*/ 0 h 141"/>
                <a:gd name="T14" fmla="*/ 21 w 21"/>
                <a:gd name="T15" fmla="*/ 3 h 141"/>
                <a:gd name="T16" fmla="*/ 0 w 21"/>
                <a:gd name="T17" fmla="*/ 3 h 141"/>
                <a:gd name="T18" fmla="*/ 0 w 21"/>
                <a:gd name="T19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1" h="141">
                  <a:moveTo>
                    <a:pt x="9" y="141"/>
                  </a:moveTo>
                  <a:lnTo>
                    <a:pt x="9" y="2"/>
                  </a:lnTo>
                  <a:lnTo>
                    <a:pt x="13" y="2"/>
                  </a:lnTo>
                  <a:lnTo>
                    <a:pt x="13" y="141"/>
                  </a:lnTo>
                  <a:lnTo>
                    <a:pt x="9" y="141"/>
                  </a:lnTo>
                  <a:close/>
                  <a:moveTo>
                    <a:pt x="0" y="0"/>
                  </a:moveTo>
                  <a:lnTo>
                    <a:pt x="21" y="0"/>
                  </a:lnTo>
                  <a:lnTo>
                    <a:pt x="21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" name="Freeform 28"/>
            <p:cNvSpPr>
              <a:spLocks noEditPoints="1"/>
            </p:cNvSpPr>
            <p:nvPr/>
          </p:nvSpPr>
          <p:spPr bwMode="auto">
            <a:xfrm>
              <a:off x="2843213" y="2314575"/>
              <a:ext cx="33338" cy="190500"/>
            </a:xfrm>
            <a:custGeom>
              <a:avLst/>
              <a:gdLst>
                <a:gd name="T0" fmla="*/ 9 w 21"/>
                <a:gd name="T1" fmla="*/ 120 h 120"/>
                <a:gd name="T2" fmla="*/ 9 w 21"/>
                <a:gd name="T3" fmla="*/ 2 h 120"/>
                <a:gd name="T4" fmla="*/ 13 w 21"/>
                <a:gd name="T5" fmla="*/ 2 h 120"/>
                <a:gd name="T6" fmla="*/ 13 w 21"/>
                <a:gd name="T7" fmla="*/ 120 h 120"/>
                <a:gd name="T8" fmla="*/ 9 w 21"/>
                <a:gd name="T9" fmla="*/ 120 h 120"/>
                <a:gd name="T10" fmla="*/ 0 w 21"/>
                <a:gd name="T11" fmla="*/ 0 h 120"/>
                <a:gd name="T12" fmla="*/ 21 w 21"/>
                <a:gd name="T13" fmla="*/ 0 h 120"/>
                <a:gd name="T14" fmla="*/ 21 w 21"/>
                <a:gd name="T15" fmla="*/ 4 h 120"/>
                <a:gd name="T16" fmla="*/ 0 w 21"/>
                <a:gd name="T17" fmla="*/ 4 h 120"/>
                <a:gd name="T18" fmla="*/ 0 w 21"/>
                <a:gd name="T19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1" h="120">
                  <a:moveTo>
                    <a:pt x="9" y="120"/>
                  </a:moveTo>
                  <a:lnTo>
                    <a:pt x="9" y="2"/>
                  </a:lnTo>
                  <a:lnTo>
                    <a:pt x="13" y="2"/>
                  </a:lnTo>
                  <a:lnTo>
                    <a:pt x="13" y="120"/>
                  </a:lnTo>
                  <a:lnTo>
                    <a:pt x="9" y="120"/>
                  </a:lnTo>
                  <a:close/>
                  <a:moveTo>
                    <a:pt x="0" y="0"/>
                  </a:moveTo>
                  <a:lnTo>
                    <a:pt x="21" y="0"/>
                  </a:lnTo>
                  <a:lnTo>
                    <a:pt x="21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" name="Freeform 29"/>
            <p:cNvSpPr>
              <a:spLocks noEditPoints="1"/>
            </p:cNvSpPr>
            <p:nvPr/>
          </p:nvSpPr>
          <p:spPr bwMode="auto">
            <a:xfrm>
              <a:off x="3490913" y="2459038"/>
              <a:ext cx="33338" cy="123825"/>
            </a:xfrm>
            <a:custGeom>
              <a:avLst/>
              <a:gdLst>
                <a:gd name="T0" fmla="*/ 8 w 21"/>
                <a:gd name="T1" fmla="*/ 78 h 78"/>
                <a:gd name="T2" fmla="*/ 8 w 21"/>
                <a:gd name="T3" fmla="*/ 1 h 78"/>
                <a:gd name="T4" fmla="*/ 12 w 21"/>
                <a:gd name="T5" fmla="*/ 1 h 78"/>
                <a:gd name="T6" fmla="*/ 12 w 21"/>
                <a:gd name="T7" fmla="*/ 78 h 78"/>
                <a:gd name="T8" fmla="*/ 8 w 21"/>
                <a:gd name="T9" fmla="*/ 78 h 78"/>
                <a:gd name="T10" fmla="*/ 0 w 21"/>
                <a:gd name="T11" fmla="*/ 0 h 78"/>
                <a:gd name="T12" fmla="*/ 21 w 21"/>
                <a:gd name="T13" fmla="*/ 0 h 78"/>
                <a:gd name="T14" fmla="*/ 21 w 21"/>
                <a:gd name="T15" fmla="*/ 3 h 78"/>
                <a:gd name="T16" fmla="*/ 0 w 21"/>
                <a:gd name="T17" fmla="*/ 3 h 78"/>
                <a:gd name="T18" fmla="*/ 0 w 21"/>
                <a:gd name="T19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1" h="78">
                  <a:moveTo>
                    <a:pt x="8" y="78"/>
                  </a:moveTo>
                  <a:lnTo>
                    <a:pt x="8" y="1"/>
                  </a:lnTo>
                  <a:lnTo>
                    <a:pt x="12" y="1"/>
                  </a:lnTo>
                  <a:lnTo>
                    <a:pt x="12" y="78"/>
                  </a:lnTo>
                  <a:lnTo>
                    <a:pt x="8" y="78"/>
                  </a:lnTo>
                  <a:close/>
                  <a:moveTo>
                    <a:pt x="0" y="0"/>
                  </a:moveTo>
                  <a:lnTo>
                    <a:pt x="21" y="0"/>
                  </a:lnTo>
                  <a:lnTo>
                    <a:pt x="21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" name="Freeform 30"/>
            <p:cNvSpPr>
              <a:spLocks noEditPoints="1"/>
            </p:cNvSpPr>
            <p:nvPr/>
          </p:nvSpPr>
          <p:spPr bwMode="auto">
            <a:xfrm>
              <a:off x="4137025" y="2176463"/>
              <a:ext cx="33338" cy="312738"/>
            </a:xfrm>
            <a:custGeom>
              <a:avLst/>
              <a:gdLst>
                <a:gd name="T0" fmla="*/ 9 w 21"/>
                <a:gd name="T1" fmla="*/ 197 h 197"/>
                <a:gd name="T2" fmla="*/ 9 w 21"/>
                <a:gd name="T3" fmla="*/ 2 h 197"/>
                <a:gd name="T4" fmla="*/ 12 w 21"/>
                <a:gd name="T5" fmla="*/ 2 h 197"/>
                <a:gd name="T6" fmla="*/ 12 w 21"/>
                <a:gd name="T7" fmla="*/ 197 h 197"/>
                <a:gd name="T8" fmla="*/ 9 w 21"/>
                <a:gd name="T9" fmla="*/ 197 h 197"/>
                <a:gd name="T10" fmla="*/ 0 w 21"/>
                <a:gd name="T11" fmla="*/ 0 h 197"/>
                <a:gd name="T12" fmla="*/ 21 w 21"/>
                <a:gd name="T13" fmla="*/ 0 h 197"/>
                <a:gd name="T14" fmla="*/ 21 w 21"/>
                <a:gd name="T15" fmla="*/ 4 h 197"/>
                <a:gd name="T16" fmla="*/ 0 w 21"/>
                <a:gd name="T17" fmla="*/ 4 h 197"/>
                <a:gd name="T18" fmla="*/ 0 w 21"/>
                <a:gd name="T19" fmla="*/ 0 h 1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1" h="197">
                  <a:moveTo>
                    <a:pt x="9" y="197"/>
                  </a:moveTo>
                  <a:lnTo>
                    <a:pt x="9" y="2"/>
                  </a:lnTo>
                  <a:lnTo>
                    <a:pt x="12" y="2"/>
                  </a:lnTo>
                  <a:lnTo>
                    <a:pt x="12" y="197"/>
                  </a:lnTo>
                  <a:lnTo>
                    <a:pt x="9" y="197"/>
                  </a:lnTo>
                  <a:close/>
                  <a:moveTo>
                    <a:pt x="0" y="0"/>
                  </a:moveTo>
                  <a:lnTo>
                    <a:pt x="21" y="0"/>
                  </a:lnTo>
                  <a:lnTo>
                    <a:pt x="21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" name="Rectangle 31"/>
            <p:cNvSpPr>
              <a:spLocks noChangeArrowheads="1"/>
            </p:cNvSpPr>
            <p:nvPr/>
          </p:nvSpPr>
          <p:spPr bwMode="auto">
            <a:xfrm>
              <a:off x="1790700" y="1627188"/>
              <a:ext cx="6350" cy="1933575"/>
            </a:xfrm>
            <a:prstGeom prst="rect">
              <a:avLst/>
            </a:pr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" name="Freeform 32"/>
            <p:cNvSpPr>
              <a:spLocks noEditPoints="1"/>
            </p:cNvSpPr>
            <p:nvPr/>
          </p:nvSpPr>
          <p:spPr bwMode="auto">
            <a:xfrm>
              <a:off x="1771650" y="1624013"/>
              <a:ext cx="22225" cy="1939925"/>
            </a:xfrm>
            <a:custGeom>
              <a:avLst/>
              <a:gdLst>
                <a:gd name="T0" fmla="*/ 0 w 14"/>
                <a:gd name="T1" fmla="*/ 1218 h 1222"/>
                <a:gd name="T2" fmla="*/ 14 w 14"/>
                <a:gd name="T3" fmla="*/ 1218 h 1222"/>
                <a:gd name="T4" fmla="*/ 14 w 14"/>
                <a:gd name="T5" fmla="*/ 1222 h 1222"/>
                <a:gd name="T6" fmla="*/ 0 w 14"/>
                <a:gd name="T7" fmla="*/ 1222 h 1222"/>
                <a:gd name="T8" fmla="*/ 0 w 14"/>
                <a:gd name="T9" fmla="*/ 1218 h 1222"/>
                <a:gd name="T10" fmla="*/ 0 w 14"/>
                <a:gd name="T11" fmla="*/ 1044 h 1222"/>
                <a:gd name="T12" fmla="*/ 14 w 14"/>
                <a:gd name="T13" fmla="*/ 1044 h 1222"/>
                <a:gd name="T14" fmla="*/ 14 w 14"/>
                <a:gd name="T15" fmla="*/ 1048 h 1222"/>
                <a:gd name="T16" fmla="*/ 0 w 14"/>
                <a:gd name="T17" fmla="*/ 1048 h 1222"/>
                <a:gd name="T18" fmla="*/ 0 w 14"/>
                <a:gd name="T19" fmla="*/ 1044 h 1222"/>
                <a:gd name="T20" fmla="*/ 0 w 14"/>
                <a:gd name="T21" fmla="*/ 870 h 1222"/>
                <a:gd name="T22" fmla="*/ 14 w 14"/>
                <a:gd name="T23" fmla="*/ 870 h 1222"/>
                <a:gd name="T24" fmla="*/ 14 w 14"/>
                <a:gd name="T25" fmla="*/ 874 h 1222"/>
                <a:gd name="T26" fmla="*/ 0 w 14"/>
                <a:gd name="T27" fmla="*/ 874 h 1222"/>
                <a:gd name="T28" fmla="*/ 0 w 14"/>
                <a:gd name="T29" fmla="*/ 870 h 1222"/>
                <a:gd name="T30" fmla="*/ 0 w 14"/>
                <a:gd name="T31" fmla="*/ 696 h 1222"/>
                <a:gd name="T32" fmla="*/ 14 w 14"/>
                <a:gd name="T33" fmla="*/ 696 h 1222"/>
                <a:gd name="T34" fmla="*/ 14 w 14"/>
                <a:gd name="T35" fmla="*/ 700 h 1222"/>
                <a:gd name="T36" fmla="*/ 0 w 14"/>
                <a:gd name="T37" fmla="*/ 700 h 1222"/>
                <a:gd name="T38" fmla="*/ 0 w 14"/>
                <a:gd name="T39" fmla="*/ 696 h 1222"/>
                <a:gd name="T40" fmla="*/ 0 w 14"/>
                <a:gd name="T41" fmla="*/ 522 h 1222"/>
                <a:gd name="T42" fmla="*/ 14 w 14"/>
                <a:gd name="T43" fmla="*/ 522 h 1222"/>
                <a:gd name="T44" fmla="*/ 14 w 14"/>
                <a:gd name="T45" fmla="*/ 526 h 1222"/>
                <a:gd name="T46" fmla="*/ 0 w 14"/>
                <a:gd name="T47" fmla="*/ 526 h 1222"/>
                <a:gd name="T48" fmla="*/ 0 w 14"/>
                <a:gd name="T49" fmla="*/ 522 h 1222"/>
                <a:gd name="T50" fmla="*/ 0 w 14"/>
                <a:gd name="T51" fmla="*/ 348 h 1222"/>
                <a:gd name="T52" fmla="*/ 14 w 14"/>
                <a:gd name="T53" fmla="*/ 348 h 1222"/>
                <a:gd name="T54" fmla="*/ 14 w 14"/>
                <a:gd name="T55" fmla="*/ 352 h 1222"/>
                <a:gd name="T56" fmla="*/ 0 w 14"/>
                <a:gd name="T57" fmla="*/ 352 h 1222"/>
                <a:gd name="T58" fmla="*/ 0 w 14"/>
                <a:gd name="T59" fmla="*/ 348 h 1222"/>
                <a:gd name="T60" fmla="*/ 0 w 14"/>
                <a:gd name="T61" fmla="*/ 174 h 1222"/>
                <a:gd name="T62" fmla="*/ 14 w 14"/>
                <a:gd name="T63" fmla="*/ 174 h 1222"/>
                <a:gd name="T64" fmla="*/ 14 w 14"/>
                <a:gd name="T65" fmla="*/ 178 h 1222"/>
                <a:gd name="T66" fmla="*/ 0 w 14"/>
                <a:gd name="T67" fmla="*/ 178 h 1222"/>
                <a:gd name="T68" fmla="*/ 0 w 14"/>
                <a:gd name="T69" fmla="*/ 174 h 1222"/>
                <a:gd name="T70" fmla="*/ 0 w 14"/>
                <a:gd name="T71" fmla="*/ 0 h 1222"/>
                <a:gd name="T72" fmla="*/ 14 w 14"/>
                <a:gd name="T73" fmla="*/ 0 h 1222"/>
                <a:gd name="T74" fmla="*/ 14 w 14"/>
                <a:gd name="T75" fmla="*/ 3 h 1222"/>
                <a:gd name="T76" fmla="*/ 0 w 14"/>
                <a:gd name="T77" fmla="*/ 3 h 1222"/>
                <a:gd name="T78" fmla="*/ 0 w 14"/>
                <a:gd name="T79" fmla="*/ 0 h 1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14" h="1222">
                  <a:moveTo>
                    <a:pt x="0" y="1218"/>
                  </a:moveTo>
                  <a:lnTo>
                    <a:pt x="14" y="1218"/>
                  </a:lnTo>
                  <a:lnTo>
                    <a:pt x="14" y="1222"/>
                  </a:lnTo>
                  <a:lnTo>
                    <a:pt x="0" y="1222"/>
                  </a:lnTo>
                  <a:lnTo>
                    <a:pt x="0" y="1218"/>
                  </a:lnTo>
                  <a:close/>
                  <a:moveTo>
                    <a:pt x="0" y="1044"/>
                  </a:moveTo>
                  <a:lnTo>
                    <a:pt x="14" y="1044"/>
                  </a:lnTo>
                  <a:lnTo>
                    <a:pt x="14" y="1048"/>
                  </a:lnTo>
                  <a:lnTo>
                    <a:pt x="0" y="1048"/>
                  </a:lnTo>
                  <a:lnTo>
                    <a:pt x="0" y="1044"/>
                  </a:lnTo>
                  <a:close/>
                  <a:moveTo>
                    <a:pt x="0" y="870"/>
                  </a:moveTo>
                  <a:lnTo>
                    <a:pt x="14" y="870"/>
                  </a:lnTo>
                  <a:lnTo>
                    <a:pt x="14" y="874"/>
                  </a:lnTo>
                  <a:lnTo>
                    <a:pt x="0" y="874"/>
                  </a:lnTo>
                  <a:lnTo>
                    <a:pt x="0" y="870"/>
                  </a:lnTo>
                  <a:close/>
                  <a:moveTo>
                    <a:pt x="0" y="696"/>
                  </a:moveTo>
                  <a:lnTo>
                    <a:pt x="14" y="696"/>
                  </a:lnTo>
                  <a:lnTo>
                    <a:pt x="14" y="700"/>
                  </a:lnTo>
                  <a:lnTo>
                    <a:pt x="0" y="700"/>
                  </a:lnTo>
                  <a:lnTo>
                    <a:pt x="0" y="696"/>
                  </a:lnTo>
                  <a:close/>
                  <a:moveTo>
                    <a:pt x="0" y="522"/>
                  </a:moveTo>
                  <a:lnTo>
                    <a:pt x="14" y="522"/>
                  </a:lnTo>
                  <a:lnTo>
                    <a:pt x="14" y="526"/>
                  </a:lnTo>
                  <a:lnTo>
                    <a:pt x="0" y="526"/>
                  </a:lnTo>
                  <a:lnTo>
                    <a:pt x="0" y="522"/>
                  </a:lnTo>
                  <a:close/>
                  <a:moveTo>
                    <a:pt x="0" y="348"/>
                  </a:moveTo>
                  <a:lnTo>
                    <a:pt x="14" y="348"/>
                  </a:lnTo>
                  <a:lnTo>
                    <a:pt x="14" y="352"/>
                  </a:lnTo>
                  <a:lnTo>
                    <a:pt x="0" y="352"/>
                  </a:lnTo>
                  <a:lnTo>
                    <a:pt x="0" y="348"/>
                  </a:lnTo>
                  <a:close/>
                  <a:moveTo>
                    <a:pt x="0" y="174"/>
                  </a:moveTo>
                  <a:lnTo>
                    <a:pt x="14" y="174"/>
                  </a:lnTo>
                  <a:lnTo>
                    <a:pt x="14" y="178"/>
                  </a:lnTo>
                  <a:lnTo>
                    <a:pt x="0" y="178"/>
                  </a:lnTo>
                  <a:lnTo>
                    <a:pt x="0" y="174"/>
                  </a:lnTo>
                  <a:close/>
                  <a:moveTo>
                    <a:pt x="0" y="0"/>
                  </a:moveTo>
                  <a:lnTo>
                    <a:pt x="14" y="0"/>
                  </a:lnTo>
                  <a:lnTo>
                    <a:pt x="14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" name="Rectangle 33"/>
            <p:cNvSpPr>
              <a:spLocks noChangeArrowheads="1"/>
            </p:cNvSpPr>
            <p:nvPr/>
          </p:nvSpPr>
          <p:spPr bwMode="auto">
            <a:xfrm>
              <a:off x="1793875" y="3557588"/>
              <a:ext cx="2592388" cy="6350"/>
            </a:xfrm>
            <a:prstGeom prst="rect">
              <a:avLst/>
            </a:pr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" name="Rectangle 34"/>
            <p:cNvSpPr>
              <a:spLocks noChangeArrowheads="1"/>
            </p:cNvSpPr>
            <p:nvPr/>
          </p:nvSpPr>
          <p:spPr bwMode="auto">
            <a:xfrm>
              <a:off x="1659815" y="3489322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35"/>
            <p:cNvSpPr>
              <a:spLocks noChangeArrowheads="1"/>
            </p:cNvSpPr>
            <p:nvPr/>
          </p:nvSpPr>
          <p:spPr bwMode="auto">
            <a:xfrm>
              <a:off x="1589283" y="3213097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Rectangle 36"/>
            <p:cNvSpPr>
              <a:spLocks noChangeArrowheads="1"/>
            </p:cNvSpPr>
            <p:nvPr/>
          </p:nvSpPr>
          <p:spPr bwMode="auto">
            <a:xfrm>
              <a:off x="1589283" y="2936872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37"/>
            <p:cNvSpPr>
              <a:spLocks noChangeArrowheads="1"/>
            </p:cNvSpPr>
            <p:nvPr/>
          </p:nvSpPr>
          <p:spPr bwMode="auto">
            <a:xfrm>
              <a:off x="1589283" y="2660647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38"/>
            <p:cNvSpPr>
              <a:spLocks noChangeArrowheads="1"/>
            </p:cNvSpPr>
            <p:nvPr/>
          </p:nvSpPr>
          <p:spPr bwMode="auto">
            <a:xfrm>
              <a:off x="1589283" y="2386010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39"/>
            <p:cNvSpPr>
              <a:spLocks noChangeArrowheads="1"/>
            </p:cNvSpPr>
            <p:nvPr/>
          </p:nvSpPr>
          <p:spPr bwMode="auto">
            <a:xfrm>
              <a:off x="1518751" y="210978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40"/>
            <p:cNvSpPr>
              <a:spLocks noChangeArrowheads="1"/>
            </p:cNvSpPr>
            <p:nvPr/>
          </p:nvSpPr>
          <p:spPr bwMode="auto">
            <a:xfrm>
              <a:off x="1518751" y="1833560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0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ctangle 41"/>
            <p:cNvSpPr>
              <a:spLocks noChangeArrowheads="1"/>
            </p:cNvSpPr>
            <p:nvPr/>
          </p:nvSpPr>
          <p:spPr bwMode="auto">
            <a:xfrm>
              <a:off x="1518751" y="155733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40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ctangle 42"/>
            <p:cNvSpPr>
              <a:spLocks noChangeArrowheads="1"/>
            </p:cNvSpPr>
            <p:nvPr/>
          </p:nvSpPr>
          <p:spPr bwMode="auto">
            <a:xfrm>
              <a:off x="2065108" y="3603625"/>
              <a:ext cx="432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-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Rectangle 43"/>
            <p:cNvSpPr>
              <a:spLocks noChangeArrowheads="1"/>
            </p:cNvSpPr>
            <p:nvPr/>
          </p:nvSpPr>
          <p:spPr bwMode="auto">
            <a:xfrm>
              <a:off x="2650275" y="3603625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ig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Rectangle 44"/>
            <p:cNvSpPr>
              <a:spLocks noChangeArrowheads="1"/>
            </p:cNvSpPr>
            <p:nvPr/>
          </p:nvSpPr>
          <p:spPr bwMode="auto">
            <a:xfrm>
              <a:off x="3290038" y="3603625"/>
              <a:ext cx="2484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TP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Rectangle 45"/>
            <p:cNvSpPr>
              <a:spLocks noChangeArrowheads="1"/>
            </p:cNvSpPr>
            <p:nvPr/>
          </p:nvSpPr>
          <p:spPr bwMode="auto">
            <a:xfrm>
              <a:off x="3926625" y="3603625"/>
              <a:ext cx="28533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SU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Rectangle 46"/>
            <p:cNvSpPr>
              <a:spLocks noChangeArrowheads="1"/>
            </p:cNvSpPr>
            <p:nvPr/>
          </p:nvSpPr>
          <p:spPr bwMode="auto">
            <a:xfrm rot="16200000">
              <a:off x="952531" y="2520205"/>
              <a:ext cx="91210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ell</a:t>
              </a: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iability</a:t>
              </a: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%)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Rectangle 47"/>
            <p:cNvSpPr>
              <a:spLocks noChangeArrowheads="1"/>
            </p:cNvSpPr>
            <p:nvPr/>
          </p:nvSpPr>
          <p:spPr bwMode="auto">
            <a:xfrm>
              <a:off x="4445448" y="2570164"/>
              <a:ext cx="72000" cy="72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Freeform 48"/>
            <p:cNvSpPr>
              <a:spLocks noEditPoints="1"/>
            </p:cNvSpPr>
            <p:nvPr/>
          </p:nvSpPr>
          <p:spPr bwMode="auto">
            <a:xfrm>
              <a:off x="4442273" y="2566989"/>
              <a:ext cx="72000" cy="72000"/>
            </a:xfrm>
            <a:custGeom>
              <a:avLst/>
              <a:gdLst>
                <a:gd name="T0" fmla="*/ 0 w 128"/>
                <a:gd name="T1" fmla="*/ 8 h 128"/>
                <a:gd name="T2" fmla="*/ 8 w 128"/>
                <a:gd name="T3" fmla="*/ 0 h 128"/>
                <a:gd name="T4" fmla="*/ 120 w 128"/>
                <a:gd name="T5" fmla="*/ 0 h 128"/>
                <a:gd name="T6" fmla="*/ 128 w 128"/>
                <a:gd name="T7" fmla="*/ 8 h 128"/>
                <a:gd name="T8" fmla="*/ 128 w 128"/>
                <a:gd name="T9" fmla="*/ 120 h 128"/>
                <a:gd name="T10" fmla="*/ 120 w 128"/>
                <a:gd name="T11" fmla="*/ 128 h 128"/>
                <a:gd name="T12" fmla="*/ 8 w 128"/>
                <a:gd name="T13" fmla="*/ 128 h 128"/>
                <a:gd name="T14" fmla="*/ 0 w 128"/>
                <a:gd name="T15" fmla="*/ 120 h 128"/>
                <a:gd name="T16" fmla="*/ 0 w 128"/>
                <a:gd name="T17" fmla="*/ 8 h 128"/>
                <a:gd name="T18" fmla="*/ 16 w 128"/>
                <a:gd name="T19" fmla="*/ 120 h 128"/>
                <a:gd name="T20" fmla="*/ 8 w 128"/>
                <a:gd name="T21" fmla="*/ 112 h 128"/>
                <a:gd name="T22" fmla="*/ 120 w 128"/>
                <a:gd name="T23" fmla="*/ 112 h 128"/>
                <a:gd name="T24" fmla="*/ 112 w 128"/>
                <a:gd name="T25" fmla="*/ 120 h 128"/>
                <a:gd name="T26" fmla="*/ 112 w 128"/>
                <a:gd name="T27" fmla="*/ 8 h 128"/>
                <a:gd name="T28" fmla="*/ 120 w 128"/>
                <a:gd name="T29" fmla="*/ 16 h 128"/>
                <a:gd name="T30" fmla="*/ 8 w 128"/>
                <a:gd name="T31" fmla="*/ 16 h 128"/>
                <a:gd name="T32" fmla="*/ 16 w 128"/>
                <a:gd name="T33" fmla="*/ 8 h 128"/>
                <a:gd name="T34" fmla="*/ 16 w 128"/>
                <a:gd name="T35" fmla="*/ 12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28" h="128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20" y="0"/>
                  </a:lnTo>
                  <a:cubicBezTo>
                    <a:pt x="125" y="0"/>
                    <a:pt x="128" y="4"/>
                    <a:pt x="128" y="8"/>
                  </a:cubicBezTo>
                  <a:lnTo>
                    <a:pt x="128" y="120"/>
                  </a:lnTo>
                  <a:cubicBezTo>
                    <a:pt x="128" y="125"/>
                    <a:pt x="125" y="128"/>
                    <a:pt x="120" y="128"/>
                  </a:cubicBezTo>
                  <a:lnTo>
                    <a:pt x="8" y="128"/>
                  </a:lnTo>
                  <a:cubicBezTo>
                    <a:pt x="4" y="128"/>
                    <a:pt x="0" y="125"/>
                    <a:pt x="0" y="120"/>
                  </a:cubicBezTo>
                  <a:lnTo>
                    <a:pt x="0" y="8"/>
                  </a:lnTo>
                  <a:close/>
                  <a:moveTo>
                    <a:pt x="16" y="120"/>
                  </a:moveTo>
                  <a:lnTo>
                    <a:pt x="8" y="112"/>
                  </a:lnTo>
                  <a:lnTo>
                    <a:pt x="120" y="112"/>
                  </a:lnTo>
                  <a:lnTo>
                    <a:pt x="112" y="120"/>
                  </a:lnTo>
                  <a:lnTo>
                    <a:pt x="112" y="8"/>
                  </a:lnTo>
                  <a:lnTo>
                    <a:pt x="120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49"/>
            <p:cNvSpPr>
              <a:spLocks noChangeArrowheads="1"/>
            </p:cNvSpPr>
            <p:nvPr/>
          </p:nvSpPr>
          <p:spPr bwMode="auto">
            <a:xfrm>
              <a:off x="4557713" y="2535238"/>
              <a:ext cx="2003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T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50"/>
            <p:cNvSpPr>
              <a:spLocks noChangeArrowheads="1"/>
            </p:cNvSpPr>
            <p:nvPr/>
          </p:nvSpPr>
          <p:spPr bwMode="auto">
            <a:xfrm>
              <a:off x="4445448" y="2697164"/>
              <a:ext cx="72000" cy="720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Freeform 51"/>
            <p:cNvSpPr>
              <a:spLocks noEditPoints="1"/>
            </p:cNvSpPr>
            <p:nvPr/>
          </p:nvSpPr>
          <p:spPr bwMode="auto">
            <a:xfrm>
              <a:off x="4442273" y="2693989"/>
              <a:ext cx="72000" cy="72000"/>
            </a:xfrm>
            <a:custGeom>
              <a:avLst/>
              <a:gdLst>
                <a:gd name="T0" fmla="*/ 0 w 128"/>
                <a:gd name="T1" fmla="*/ 8 h 128"/>
                <a:gd name="T2" fmla="*/ 8 w 128"/>
                <a:gd name="T3" fmla="*/ 0 h 128"/>
                <a:gd name="T4" fmla="*/ 120 w 128"/>
                <a:gd name="T5" fmla="*/ 0 h 128"/>
                <a:gd name="T6" fmla="*/ 128 w 128"/>
                <a:gd name="T7" fmla="*/ 8 h 128"/>
                <a:gd name="T8" fmla="*/ 128 w 128"/>
                <a:gd name="T9" fmla="*/ 120 h 128"/>
                <a:gd name="T10" fmla="*/ 120 w 128"/>
                <a:gd name="T11" fmla="*/ 128 h 128"/>
                <a:gd name="T12" fmla="*/ 8 w 128"/>
                <a:gd name="T13" fmla="*/ 128 h 128"/>
                <a:gd name="T14" fmla="*/ 0 w 128"/>
                <a:gd name="T15" fmla="*/ 120 h 128"/>
                <a:gd name="T16" fmla="*/ 0 w 128"/>
                <a:gd name="T17" fmla="*/ 8 h 128"/>
                <a:gd name="T18" fmla="*/ 16 w 128"/>
                <a:gd name="T19" fmla="*/ 120 h 128"/>
                <a:gd name="T20" fmla="*/ 8 w 128"/>
                <a:gd name="T21" fmla="*/ 112 h 128"/>
                <a:gd name="T22" fmla="*/ 120 w 128"/>
                <a:gd name="T23" fmla="*/ 112 h 128"/>
                <a:gd name="T24" fmla="*/ 112 w 128"/>
                <a:gd name="T25" fmla="*/ 120 h 128"/>
                <a:gd name="T26" fmla="*/ 112 w 128"/>
                <a:gd name="T27" fmla="*/ 8 h 128"/>
                <a:gd name="T28" fmla="*/ 120 w 128"/>
                <a:gd name="T29" fmla="*/ 16 h 128"/>
                <a:gd name="T30" fmla="*/ 8 w 128"/>
                <a:gd name="T31" fmla="*/ 16 h 128"/>
                <a:gd name="T32" fmla="*/ 16 w 128"/>
                <a:gd name="T33" fmla="*/ 8 h 128"/>
                <a:gd name="T34" fmla="*/ 16 w 128"/>
                <a:gd name="T35" fmla="*/ 12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28" h="128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20" y="0"/>
                  </a:lnTo>
                  <a:cubicBezTo>
                    <a:pt x="125" y="0"/>
                    <a:pt x="128" y="4"/>
                    <a:pt x="128" y="8"/>
                  </a:cubicBezTo>
                  <a:lnTo>
                    <a:pt x="128" y="120"/>
                  </a:lnTo>
                  <a:cubicBezTo>
                    <a:pt x="128" y="125"/>
                    <a:pt x="125" y="128"/>
                    <a:pt x="120" y="128"/>
                  </a:cubicBezTo>
                  <a:lnTo>
                    <a:pt x="8" y="128"/>
                  </a:lnTo>
                  <a:cubicBezTo>
                    <a:pt x="4" y="128"/>
                    <a:pt x="0" y="125"/>
                    <a:pt x="0" y="120"/>
                  </a:cubicBezTo>
                  <a:lnTo>
                    <a:pt x="0" y="8"/>
                  </a:lnTo>
                  <a:close/>
                  <a:moveTo>
                    <a:pt x="16" y="120"/>
                  </a:moveTo>
                  <a:lnTo>
                    <a:pt x="8" y="112"/>
                  </a:lnTo>
                  <a:lnTo>
                    <a:pt x="120" y="112"/>
                  </a:lnTo>
                  <a:lnTo>
                    <a:pt x="112" y="120"/>
                  </a:lnTo>
                  <a:lnTo>
                    <a:pt x="112" y="8"/>
                  </a:lnTo>
                  <a:lnTo>
                    <a:pt x="120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 w="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52"/>
            <p:cNvSpPr>
              <a:spLocks noChangeArrowheads="1"/>
            </p:cNvSpPr>
            <p:nvPr/>
          </p:nvSpPr>
          <p:spPr bwMode="auto">
            <a:xfrm>
              <a:off x="4557713" y="2659063"/>
              <a:ext cx="48571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SP70</a:t>
              </a:r>
              <a:r>
                <a:rPr kumimoji="0" lang="fr-FR" sz="1000" b="0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/-</a:t>
              </a:r>
              <a:endParaRPr kumimoji="0" lang="fr-FR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9" name="Rectangle 48"/>
          <p:cNvSpPr/>
          <p:nvPr/>
        </p:nvSpPr>
        <p:spPr>
          <a:xfrm>
            <a:off x="49580" y="4335963"/>
            <a:ext cx="6808419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: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HSP70 deficiency 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doesn’t affect </a:t>
            </a:r>
            <a:r>
              <a:rPr lang="en-US" sz="1200" b="1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inflammasome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activators cytotoxicity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BMDMs from WT or Hsp70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C57BL/6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mice were stimulated with 100ng/mL LPS for 20h and then left untreated or treated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30min with ATP (5mM) or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eric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– 40µM) or 6h with MSU (100µg/m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Cell viability was evaluated after crystal violet staining. Data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are the mean of three independent experiments ±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.d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</a:t>
            </a:r>
            <a:endParaRPr lang="fr-FR" sz="1200" dirty="0">
              <a:effectLst/>
              <a:latin typeface="Arial" pitchFamily="34" charset="0"/>
              <a:ea typeface="Times New Roman" panose="02020603050405020304" pitchFamily="18" charset="0"/>
              <a:cs typeface="Arial" pitchFamily="34" charset="0"/>
            </a:endParaRPr>
          </a:p>
        </p:txBody>
      </p:sp>
      <p:sp>
        <p:nvSpPr>
          <p:cNvPr id="50" name="Rectangle 43"/>
          <p:cNvSpPr>
            <a:spLocks noChangeArrowheads="1"/>
          </p:cNvSpPr>
          <p:nvPr/>
        </p:nvSpPr>
        <p:spPr bwMode="auto">
          <a:xfrm>
            <a:off x="1401179" y="3608288"/>
            <a:ext cx="38632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 +:</a:t>
            </a:r>
            <a:endParaRPr kumimoji="0" 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11507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5"/>
          <p:cNvSpPr>
            <a:spLocks noChangeArrowheads="1"/>
          </p:cNvSpPr>
          <p:nvPr/>
        </p:nvSpPr>
        <p:spPr bwMode="auto">
          <a:xfrm>
            <a:off x="2001945" y="3218010"/>
            <a:ext cx="230204" cy="25209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" name="Freeform 6"/>
          <p:cNvSpPr>
            <a:spLocks noEditPoints="1"/>
          </p:cNvSpPr>
          <p:nvPr/>
        </p:nvSpPr>
        <p:spPr bwMode="auto">
          <a:xfrm>
            <a:off x="1998514" y="3214391"/>
            <a:ext cx="230204" cy="259331"/>
          </a:xfrm>
          <a:custGeom>
            <a:avLst/>
            <a:gdLst>
              <a:gd name="T0" fmla="*/ 0 w 3424"/>
              <a:gd name="T1" fmla="*/ 48 h 3584"/>
              <a:gd name="T2" fmla="*/ 48 w 3424"/>
              <a:gd name="T3" fmla="*/ 0 h 3584"/>
              <a:gd name="T4" fmla="*/ 3376 w 3424"/>
              <a:gd name="T5" fmla="*/ 0 h 3584"/>
              <a:gd name="T6" fmla="*/ 3424 w 3424"/>
              <a:gd name="T7" fmla="*/ 48 h 3584"/>
              <a:gd name="T8" fmla="*/ 3424 w 3424"/>
              <a:gd name="T9" fmla="*/ 3536 h 3584"/>
              <a:gd name="T10" fmla="*/ 3376 w 3424"/>
              <a:gd name="T11" fmla="*/ 3584 h 3584"/>
              <a:gd name="T12" fmla="*/ 48 w 3424"/>
              <a:gd name="T13" fmla="*/ 3584 h 3584"/>
              <a:gd name="T14" fmla="*/ 0 w 3424"/>
              <a:gd name="T15" fmla="*/ 3536 h 3584"/>
              <a:gd name="T16" fmla="*/ 0 w 3424"/>
              <a:gd name="T17" fmla="*/ 48 h 3584"/>
              <a:gd name="T18" fmla="*/ 96 w 3424"/>
              <a:gd name="T19" fmla="*/ 3536 h 3584"/>
              <a:gd name="T20" fmla="*/ 48 w 3424"/>
              <a:gd name="T21" fmla="*/ 3488 h 3584"/>
              <a:gd name="T22" fmla="*/ 3376 w 3424"/>
              <a:gd name="T23" fmla="*/ 3488 h 3584"/>
              <a:gd name="T24" fmla="*/ 3328 w 3424"/>
              <a:gd name="T25" fmla="*/ 3536 h 3584"/>
              <a:gd name="T26" fmla="*/ 3328 w 3424"/>
              <a:gd name="T27" fmla="*/ 48 h 3584"/>
              <a:gd name="T28" fmla="*/ 3376 w 3424"/>
              <a:gd name="T29" fmla="*/ 96 h 3584"/>
              <a:gd name="T30" fmla="*/ 48 w 3424"/>
              <a:gd name="T31" fmla="*/ 96 h 3584"/>
              <a:gd name="T32" fmla="*/ 96 w 3424"/>
              <a:gd name="T33" fmla="*/ 48 h 3584"/>
              <a:gd name="T34" fmla="*/ 96 w 3424"/>
              <a:gd name="T35" fmla="*/ 3536 h 35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424" h="3584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3376" y="0"/>
                </a:lnTo>
                <a:cubicBezTo>
                  <a:pt x="3403" y="0"/>
                  <a:pt x="3424" y="22"/>
                  <a:pt x="3424" y="48"/>
                </a:cubicBezTo>
                <a:lnTo>
                  <a:pt x="3424" y="3536"/>
                </a:lnTo>
                <a:cubicBezTo>
                  <a:pt x="3424" y="3563"/>
                  <a:pt x="3403" y="3584"/>
                  <a:pt x="3376" y="3584"/>
                </a:cubicBezTo>
                <a:lnTo>
                  <a:pt x="48" y="3584"/>
                </a:lnTo>
                <a:cubicBezTo>
                  <a:pt x="22" y="3584"/>
                  <a:pt x="0" y="3563"/>
                  <a:pt x="0" y="3536"/>
                </a:cubicBezTo>
                <a:lnTo>
                  <a:pt x="0" y="48"/>
                </a:lnTo>
                <a:close/>
                <a:moveTo>
                  <a:pt x="96" y="3536"/>
                </a:moveTo>
                <a:lnTo>
                  <a:pt x="48" y="3488"/>
                </a:lnTo>
                <a:lnTo>
                  <a:pt x="3376" y="3488"/>
                </a:lnTo>
                <a:lnTo>
                  <a:pt x="3328" y="3536"/>
                </a:lnTo>
                <a:lnTo>
                  <a:pt x="3328" y="48"/>
                </a:lnTo>
                <a:lnTo>
                  <a:pt x="3376" y="96"/>
                </a:lnTo>
                <a:lnTo>
                  <a:pt x="48" y="96"/>
                </a:lnTo>
                <a:lnTo>
                  <a:pt x="96" y="48"/>
                </a:lnTo>
                <a:lnTo>
                  <a:pt x="96" y="353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" name="Rectangle 7"/>
          <p:cNvSpPr>
            <a:spLocks noChangeArrowheads="1"/>
          </p:cNvSpPr>
          <p:nvPr/>
        </p:nvSpPr>
        <p:spPr bwMode="auto">
          <a:xfrm>
            <a:off x="2657353" y="2181894"/>
            <a:ext cx="230204" cy="128820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" name="Freeform 8"/>
          <p:cNvSpPr>
            <a:spLocks noEditPoints="1"/>
          </p:cNvSpPr>
          <p:nvPr/>
        </p:nvSpPr>
        <p:spPr bwMode="auto">
          <a:xfrm>
            <a:off x="2653921" y="2178276"/>
            <a:ext cx="230204" cy="1295445"/>
          </a:xfrm>
          <a:custGeom>
            <a:avLst/>
            <a:gdLst>
              <a:gd name="T0" fmla="*/ 0 w 3424"/>
              <a:gd name="T1" fmla="*/ 48 h 17904"/>
              <a:gd name="T2" fmla="*/ 48 w 3424"/>
              <a:gd name="T3" fmla="*/ 0 h 17904"/>
              <a:gd name="T4" fmla="*/ 3376 w 3424"/>
              <a:gd name="T5" fmla="*/ 0 h 17904"/>
              <a:gd name="T6" fmla="*/ 3424 w 3424"/>
              <a:gd name="T7" fmla="*/ 48 h 17904"/>
              <a:gd name="T8" fmla="*/ 3424 w 3424"/>
              <a:gd name="T9" fmla="*/ 17856 h 17904"/>
              <a:gd name="T10" fmla="*/ 3376 w 3424"/>
              <a:gd name="T11" fmla="*/ 17904 h 17904"/>
              <a:gd name="T12" fmla="*/ 48 w 3424"/>
              <a:gd name="T13" fmla="*/ 17904 h 17904"/>
              <a:gd name="T14" fmla="*/ 0 w 3424"/>
              <a:gd name="T15" fmla="*/ 17856 h 17904"/>
              <a:gd name="T16" fmla="*/ 0 w 3424"/>
              <a:gd name="T17" fmla="*/ 48 h 17904"/>
              <a:gd name="T18" fmla="*/ 96 w 3424"/>
              <a:gd name="T19" fmla="*/ 17856 h 17904"/>
              <a:gd name="T20" fmla="*/ 48 w 3424"/>
              <a:gd name="T21" fmla="*/ 17808 h 17904"/>
              <a:gd name="T22" fmla="*/ 3376 w 3424"/>
              <a:gd name="T23" fmla="*/ 17808 h 17904"/>
              <a:gd name="T24" fmla="*/ 3328 w 3424"/>
              <a:gd name="T25" fmla="*/ 17856 h 17904"/>
              <a:gd name="T26" fmla="*/ 3328 w 3424"/>
              <a:gd name="T27" fmla="*/ 48 h 17904"/>
              <a:gd name="T28" fmla="*/ 3376 w 3424"/>
              <a:gd name="T29" fmla="*/ 96 h 17904"/>
              <a:gd name="T30" fmla="*/ 48 w 3424"/>
              <a:gd name="T31" fmla="*/ 96 h 17904"/>
              <a:gd name="T32" fmla="*/ 96 w 3424"/>
              <a:gd name="T33" fmla="*/ 48 h 17904"/>
              <a:gd name="T34" fmla="*/ 96 w 3424"/>
              <a:gd name="T35" fmla="*/ 17856 h 179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424" h="17904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3376" y="0"/>
                </a:lnTo>
                <a:cubicBezTo>
                  <a:pt x="3403" y="0"/>
                  <a:pt x="3424" y="22"/>
                  <a:pt x="3424" y="48"/>
                </a:cubicBezTo>
                <a:lnTo>
                  <a:pt x="3424" y="17856"/>
                </a:lnTo>
                <a:cubicBezTo>
                  <a:pt x="3424" y="17883"/>
                  <a:pt x="3403" y="17904"/>
                  <a:pt x="3376" y="17904"/>
                </a:cubicBezTo>
                <a:lnTo>
                  <a:pt x="48" y="17904"/>
                </a:lnTo>
                <a:cubicBezTo>
                  <a:pt x="22" y="17904"/>
                  <a:pt x="0" y="17883"/>
                  <a:pt x="0" y="17856"/>
                </a:cubicBezTo>
                <a:lnTo>
                  <a:pt x="0" y="48"/>
                </a:lnTo>
                <a:close/>
                <a:moveTo>
                  <a:pt x="96" y="17856"/>
                </a:moveTo>
                <a:lnTo>
                  <a:pt x="48" y="17808"/>
                </a:lnTo>
                <a:lnTo>
                  <a:pt x="3376" y="17808"/>
                </a:lnTo>
                <a:lnTo>
                  <a:pt x="3328" y="17856"/>
                </a:lnTo>
                <a:lnTo>
                  <a:pt x="3328" y="48"/>
                </a:lnTo>
                <a:lnTo>
                  <a:pt x="3376" y="96"/>
                </a:lnTo>
                <a:lnTo>
                  <a:pt x="48" y="96"/>
                </a:lnTo>
                <a:lnTo>
                  <a:pt x="96" y="48"/>
                </a:lnTo>
                <a:lnTo>
                  <a:pt x="96" y="1785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" name="Rectangle 9"/>
          <p:cNvSpPr>
            <a:spLocks noChangeArrowheads="1"/>
          </p:cNvSpPr>
          <p:nvPr/>
        </p:nvSpPr>
        <p:spPr bwMode="auto">
          <a:xfrm>
            <a:off x="2284076" y="3178205"/>
            <a:ext cx="230204" cy="2918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" name="Freeform 10"/>
          <p:cNvSpPr>
            <a:spLocks noEditPoints="1"/>
          </p:cNvSpPr>
          <p:nvPr/>
        </p:nvSpPr>
        <p:spPr bwMode="auto">
          <a:xfrm>
            <a:off x="2280645" y="3174587"/>
            <a:ext cx="230204" cy="299134"/>
          </a:xfrm>
          <a:custGeom>
            <a:avLst/>
            <a:gdLst>
              <a:gd name="T0" fmla="*/ 0 w 3424"/>
              <a:gd name="T1" fmla="*/ 48 h 4128"/>
              <a:gd name="T2" fmla="*/ 48 w 3424"/>
              <a:gd name="T3" fmla="*/ 0 h 4128"/>
              <a:gd name="T4" fmla="*/ 3376 w 3424"/>
              <a:gd name="T5" fmla="*/ 0 h 4128"/>
              <a:gd name="T6" fmla="*/ 3424 w 3424"/>
              <a:gd name="T7" fmla="*/ 48 h 4128"/>
              <a:gd name="T8" fmla="*/ 3424 w 3424"/>
              <a:gd name="T9" fmla="*/ 4080 h 4128"/>
              <a:gd name="T10" fmla="*/ 3376 w 3424"/>
              <a:gd name="T11" fmla="*/ 4128 h 4128"/>
              <a:gd name="T12" fmla="*/ 48 w 3424"/>
              <a:gd name="T13" fmla="*/ 4128 h 4128"/>
              <a:gd name="T14" fmla="*/ 0 w 3424"/>
              <a:gd name="T15" fmla="*/ 4080 h 4128"/>
              <a:gd name="T16" fmla="*/ 0 w 3424"/>
              <a:gd name="T17" fmla="*/ 48 h 4128"/>
              <a:gd name="T18" fmla="*/ 96 w 3424"/>
              <a:gd name="T19" fmla="*/ 4080 h 4128"/>
              <a:gd name="T20" fmla="*/ 48 w 3424"/>
              <a:gd name="T21" fmla="*/ 4032 h 4128"/>
              <a:gd name="T22" fmla="*/ 3376 w 3424"/>
              <a:gd name="T23" fmla="*/ 4032 h 4128"/>
              <a:gd name="T24" fmla="*/ 3328 w 3424"/>
              <a:gd name="T25" fmla="*/ 4080 h 4128"/>
              <a:gd name="T26" fmla="*/ 3328 w 3424"/>
              <a:gd name="T27" fmla="*/ 48 h 4128"/>
              <a:gd name="T28" fmla="*/ 3376 w 3424"/>
              <a:gd name="T29" fmla="*/ 96 h 4128"/>
              <a:gd name="T30" fmla="*/ 48 w 3424"/>
              <a:gd name="T31" fmla="*/ 96 h 4128"/>
              <a:gd name="T32" fmla="*/ 96 w 3424"/>
              <a:gd name="T33" fmla="*/ 48 h 4128"/>
              <a:gd name="T34" fmla="*/ 96 w 3424"/>
              <a:gd name="T35" fmla="*/ 4080 h 4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424" h="4128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3376" y="0"/>
                </a:lnTo>
                <a:cubicBezTo>
                  <a:pt x="3403" y="0"/>
                  <a:pt x="3424" y="22"/>
                  <a:pt x="3424" y="48"/>
                </a:cubicBezTo>
                <a:lnTo>
                  <a:pt x="3424" y="4080"/>
                </a:lnTo>
                <a:cubicBezTo>
                  <a:pt x="3424" y="4107"/>
                  <a:pt x="3403" y="4128"/>
                  <a:pt x="3376" y="4128"/>
                </a:cubicBezTo>
                <a:lnTo>
                  <a:pt x="48" y="4128"/>
                </a:lnTo>
                <a:cubicBezTo>
                  <a:pt x="22" y="4128"/>
                  <a:pt x="0" y="4107"/>
                  <a:pt x="0" y="4080"/>
                </a:cubicBezTo>
                <a:lnTo>
                  <a:pt x="0" y="48"/>
                </a:lnTo>
                <a:close/>
                <a:moveTo>
                  <a:pt x="96" y="4080"/>
                </a:moveTo>
                <a:lnTo>
                  <a:pt x="48" y="4032"/>
                </a:lnTo>
                <a:lnTo>
                  <a:pt x="3376" y="4032"/>
                </a:lnTo>
                <a:lnTo>
                  <a:pt x="3328" y="4080"/>
                </a:lnTo>
                <a:lnTo>
                  <a:pt x="3328" y="48"/>
                </a:lnTo>
                <a:lnTo>
                  <a:pt x="3376" y="96"/>
                </a:lnTo>
                <a:lnTo>
                  <a:pt x="48" y="96"/>
                </a:lnTo>
                <a:lnTo>
                  <a:pt x="96" y="48"/>
                </a:lnTo>
                <a:lnTo>
                  <a:pt x="96" y="408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" name="Rectangle 11"/>
          <p:cNvSpPr>
            <a:spLocks noChangeArrowheads="1"/>
          </p:cNvSpPr>
          <p:nvPr/>
        </p:nvSpPr>
        <p:spPr bwMode="auto">
          <a:xfrm>
            <a:off x="2938341" y="2365235"/>
            <a:ext cx="230204" cy="11048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" name="Freeform 12"/>
          <p:cNvSpPr>
            <a:spLocks noEditPoints="1"/>
          </p:cNvSpPr>
          <p:nvPr/>
        </p:nvSpPr>
        <p:spPr bwMode="auto">
          <a:xfrm>
            <a:off x="2934910" y="2361617"/>
            <a:ext cx="230204" cy="1112105"/>
          </a:xfrm>
          <a:custGeom>
            <a:avLst/>
            <a:gdLst>
              <a:gd name="T0" fmla="*/ 0 w 1712"/>
              <a:gd name="T1" fmla="*/ 24 h 7680"/>
              <a:gd name="T2" fmla="*/ 24 w 1712"/>
              <a:gd name="T3" fmla="*/ 0 h 7680"/>
              <a:gd name="T4" fmla="*/ 1688 w 1712"/>
              <a:gd name="T5" fmla="*/ 0 h 7680"/>
              <a:gd name="T6" fmla="*/ 1712 w 1712"/>
              <a:gd name="T7" fmla="*/ 24 h 7680"/>
              <a:gd name="T8" fmla="*/ 1712 w 1712"/>
              <a:gd name="T9" fmla="*/ 7656 h 7680"/>
              <a:gd name="T10" fmla="*/ 1688 w 1712"/>
              <a:gd name="T11" fmla="*/ 7680 h 7680"/>
              <a:gd name="T12" fmla="*/ 24 w 1712"/>
              <a:gd name="T13" fmla="*/ 7680 h 7680"/>
              <a:gd name="T14" fmla="*/ 0 w 1712"/>
              <a:gd name="T15" fmla="*/ 7656 h 7680"/>
              <a:gd name="T16" fmla="*/ 0 w 1712"/>
              <a:gd name="T17" fmla="*/ 24 h 7680"/>
              <a:gd name="T18" fmla="*/ 48 w 1712"/>
              <a:gd name="T19" fmla="*/ 7656 h 7680"/>
              <a:gd name="T20" fmla="*/ 24 w 1712"/>
              <a:gd name="T21" fmla="*/ 7632 h 7680"/>
              <a:gd name="T22" fmla="*/ 1688 w 1712"/>
              <a:gd name="T23" fmla="*/ 7632 h 7680"/>
              <a:gd name="T24" fmla="*/ 1664 w 1712"/>
              <a:gd name="T25" fmla="*/ 7656 h 7680"/>
              <a:gd name="T26" fmla="*/ 1664 w 1712"/>
              <a:gd name="T27" fmla="*/ 24 h 7680"/>
              <a:gd name="T28" fmla="*/ 1688 w 1712"/>
              <a:gd name="T29" fmla="*/ 48 h 7680"/>
              <a:gd name="T30" fmla="*/ 24 w 1712"/>
              <a:gd name="T31" fmla="*/ 48 h 7680"/>
              <a:gd name="T32" fmla="*/ 48 w 1712"/>
              <a:gd name="T33" fmla="*/ 24 h 7680"/>
              <a:gd name="T34" fmla="*/ 48 w 1712"/>
              <a:gd name="T35" fmla="*/ 7656 h 76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712" h="7680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1688" y="0"/>
                </a:lnTo>
                <a:cubicBezTo>
                  <a:pt x="1702" y="0"/>
                  <a:pt x="1712" y="11"/>
                  <a:pt x="1712" y="24"/>
                </a:cubicBezTo>
                <a:lnTo>
                  <a:pt x="1712" y="7656"/>
                </a:lnTo>
                <a:cubicBezTo>
                  <a:pt x="1712" y="7670"/>
                  <a:pt x="1702" y="7680"/>
                  <a:pt x="1688" y="7680"/>
                </a:cubicBezTo>
                <a:lnTo>
                  <a:pt x="24" y="7680"/>
                </a:lnTo>
                <a:cubicBezTo>
                  <a:pt x="11" y="7680"/>
                  <a:pt x="0" y="7670"/>
                  <a:pt x="0" y="7656"/>
                </a:cubicBezTo>
                <a:lnTo>
                  <a:pt x="0" y="24"/>
                </a:lnTo>
                <a:close/>
                <a:moveTo>
                  <a:pt x="48" y="7656"/>
                </a:moveTo>
                <a:lnTo>
                  <a:pt x="24" y="7632"/>
                </a:lnTo>
                <a:lnTo>
                  <a:pt x="1688" y="7632"/>
                </a:lnTo>
                <a:lnTo>
                  <a:pt x="1664" y="7656"/>
                </a:lnTo>
                <a:lnTo>
                  <a:pt x="1664" y="24"/>
                </a:lnTo>
                <a:lnTo>
                  <a:pt x="1688" y="48"/>
                </a:lnTo>
                <a:lnTo>
                  <a:pt x="24" y="48"/>
                </a:lnTo>
                <a:lnTo>
                  <a:pt x="48" y="24"/>
                </a:lnTo>
                <a:lnTo>
                  <a:pt x="48" y="765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" name="Freeform 13"/>
          <p:cNvSpPr>
            <a:spLocks noEditPoints="1"/>
          </p:cNvSpPr>
          <p:nvPr/>
        </p:nvSpPr>
        <p:spPr bwMode="auto">
          <a:xfrm>
            <a:off x="2095723" y="3167350"/>
            <a:ext cx="41171" cy="50659"/>
          </a:xfrm>
          <a:custGeom>
            <a:avLst/>
            <a:gdLst>
              <a:gd name="T0" fmla="*/ 15 w 36"/>
              <a:gd name="T1" fmla="*/ 42 h 42"/>
              <a:gd name="T2" fmla="*/ 15 w 36"/>
              <a:gd name="T3" fmla="*/ 3 h 42"/>
              <a:gd name="T4" fmla="*/ 21 w 36"/>
              <a:gd name="T5" fmla="*/ 3 h 42"/>
              <a:gd name="T6" fmla="*/ 21 w 36"/>
              <a:gd name="T7" fmla="*/ 42 h 42"/>
              <a:gd name="T8" fmla="*/ 15 w 36"/>
              <a:gd name="T9" fmla="*/ 42 h 42"/>
              <a:gd name="T10" fmla="*/ 0 w 36"/>
              <a:gd name="T11" fmla="*/ 0 h 42"/>
              <a:gd name="T12" fmla="*/ 36 w 36"/>
              <a:gd name="T13" fmla="*/ 0 h 42"/>
              <a:gd name="T14" fmla="*/ 36 w 36"/>
              <a:gd name="T15" fmla="*/ 5 h 42"/>
              <a:gd name="T16" fmla="*/ 0 w 36"/>
              <a:gd name="T17" fmla="*/ 5 h 42"/>
              <a:gd name="T18" fmla="*/ 0 w 36"/>
              <a:gd name="T19" fmla="*/ 0 h 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36" h="42">
                <a:moveTo>
                  <a:pt x="15" y="42"/>
                </a:moveTo>
                <a:lnTo>
                  <a:pt x="15" y="3"/>
                </a:lnTo>
                <a:lnTo>
                  <a:pt x="21" y="3"/>
                </a:lnTo>
                <a:lnTo>
                  <a:pt x="21" y="42"/>
                </a:lnTo>
                <a:lnTo>
                  <a:pt x="15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" name="Freeform 14"/>
          <p:cNvSpPr>
            <a:spLocks noEditPoints="1"/>
          </p:cNvSpPr>
          <p:nvPr/>
        </p:nvSpPr>
        <p:spPr bwMode="auto">
          <a:xfrm>
            <a:off x="2751131" y="2095048"/>
            <a:ext cx="41171" cy="86846"/>
          </a:xfrm>
          <a:custGeom>
            <a:avLst/>
            <a:gdLst>
              <a:gd name="T0" fmla="*/ 15 w 36"/>
              <a:gd name="T1" fmla="*/ 72 h 72"/>
              <a:gd name="T2" fmla="*/ 15 w 36"/>
              <a:gd name="T3" fmla="*/ 3 h 72"/>
              <a:gd name="T4" fmla="*/ 21 w 36"/>
              <a:gd name="T5" fmla="*/ 3 h 72"/>
              <a:gd name="T6" fmla="*/ 21 w 36"/>
              <a:gd name="T7" fmla="*/ 72 h 72"/>
              <a:gd name="T8" fmla="*/ 15 w 36"/>
              <a:gd name="T9" fmla="*/ 72 h 72"/>
              <a:gd name="T10" fmla="*/ 0 w 36"/>
              <a:gd name="T11" fmla="*/ 0 h 72"/>
              <a:gd name="T12" fmla="*/ 36 w 36"/>
              <a:gd name="T13" fmla="*/ 0 h 72"/>
              <a:gd name="T14" fmla="*/ 36 w 36"/>
              <a:gd name="T15" fmla="*/ 6 h 72"/>
              <a:gd name="T16" fmla="*/ 0 w 36"/>
              <a:gd name="T17" fmla="*/ 6 h 72"/>
              <a:gd name="T18" fmla="*/ 0 w 36"/>
              <a:gd name="T19" fmla="*/ 0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36" h="72">
                <a:moveTo>
                  <a:pt x="15" y="72"/>
                </a:moveTo>
                <a:lnTo>
                  <a:pt x="15" y="3"/>
                </a:lnTo>
                <a:lnTo>
                  <a:pt x="21" y="3"/>
                </a:lnTo>
                <a:lnTo>
                  <a:pt x="21" y="72"/>
                </a:lnTo>
                <a:lnTo>
                  <a:pt x="15" y="7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" name="Freeform 15"/>
          <p:cNvSpPr>
            <a:spLocks noEditPoints="1"/>
          </p:cNvSpPr>
          <p:nvPr/>
        </p:nvSpPr>
        <p:spPr bwMode="auto">
          <a:xfrm>
            <a:off x="2376711" y="3098597"/>
            <a:ext cx="42315" cy="79609"/>
          </a:xfrm>
          <a:custGeom>
            <a:avLst/>
            <a:gdLst>
              <a:gd name="T0" fmla="*/ 16 w 37"/>
              <a:gd name="T1" fmla="*/ 66 h 66"/>
              <a:gd name="T2" fmla="*/ 16 w 37"/>
              <a:gd name="T3" fmla="*/ 3 h 66"/>
              <a:gd name="T4" fmla="*/ 21 w 37"/>
              <a:gd name="T5" fmla="*/ 3 h 66"/>
              <a:gd name="T6" fmla="*/ 21 w 37"/>
              <a:gd name="T7" fmla="*/ 66 h 66"/>
              <a:gd name="T8" fmla="*/ 16 w 37"/>
              <a:gd name="T9" fmla="*/ 66 h 66"/>
              <a:gd name="T10" fmla="*/ 0 w 37"/>
              <a:gd name="T11" fmla="*/ 0 h 66"/>
              <a:gd name="T12" fmla="*/ 37 w 37"/>
              <a:gd name="T13" fmla="*/ 0 h 66"/>
              <a:gd name="T14" fmla="*/ 37 w 37"/>
              <a:gd name="T15" fmla="*/ 6 h 66"/>
              <a:gd name="T16" fmla="*/ 0 w 37"/>
              <a:gd name="T17" fmla="*/ 6 h 66"/>
              <a:gd name="T18" fmla="*/ 0 w 37"/>
              <a:gd name="T19" fmla="*/ 0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37" h="66">
                <a:moveTo>
                  <a:pt x="16" y="66"/>
                </a:moveTo>
                <a:lnTo>
                  <a:pt x="16" y="3"/>
                </a:lnTo>
                <a:lnTo>
                  <a:pt x="21" y="3"/>
                </a:lnTo>
                <a:lnTo>
                  <a:pt x="21" y="66"/>
                </a:lnTo>
                <a:lnTo>
                  <a:pt x="16" y="66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" name="Freeform 16"/>
          <p:cNvSpPr>
            <a:spLocks noEditPoints="1"/>
          </p:cNvSpPr>
          <p:nvPr/>
        </p:nvSpPr>
        <p:spPr bwMode="auto">
          <a:xfrm>
            <a:off x="3032119" y="2212049"/>
            <a:ext cx="41171" cy="153186"/>
          </a:xfrm>
          <a:custGeom>
            <a:avLst/>
            <a:gdLst>
              <a:gd name="T0" fmla="*/ 15 w 36"/>
              <a:gd name="T1" fmla="*/ 127 h 127"/>
              <a:gd name="T2" fmla="*/ 15 w 36"/>
              <a:gd name="T3" fmla="*/ 3 h 127"/>
              <a:gd name="T4" fmla="*/ 21 w 36"/>
              <a:gd name="T5" fmla="*/ 3 h 127"/>
              <a:gd name="T6" fmla="*/ 21 w 36"/>
              <a:gd name="T7" fmla="*/ 127 h 127"/>
              <a:gd name="T8" fmla="*/ 15 w 36"/>
              <a:gd name="T9" fmla="*/ 127 h 127"/>
              <a:gd name="T10" fmla="*/ 0 w 36"/>
              <a:gd name="T11" fmla="*/ 0 h 127"/>
              <a:gd name="T12" fmla="*/ 36 w 36"/>
              <a:gd name="T13" fmla="*/ 0 h 127"/>
              <a:gd name="T14" fmla="*/ 36 w 36"/>
              <a:gd name="T15" fmla="*/ 5 h 127"/>
              <a:gd name="T16" fmla="*/ 0 w 36"/>
              <a:gd name="T17" fmla="*/ 5 h 127"/>
              <a:gd name="T18" fmla="*/ 0 w 36"/>
              <a:gd name="T19" fmla="*/ 0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36" h="127">
                <a:moveTo>
                  <a:pt x="15" y="127"/>
                </a:moveTo>
                <a:lnTo>
                  <a:pt x="15" y="3"/>
                </a:lnTo>
                <a:lnTo>
                  <a:pt x="21" y="3"/>
                </a:lnTo>
                <a:lnTo>
                  <a:pt x="21" y="127"/>
                </a:lnTo>
                <a:lnTo>
                  <a:pt x="15" y="127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" name="Rectangle 17"/>
          <p:cNvSpPr>
            <a:spLocks noChangeArrowheads="1"/>
          </p:cNvSpPr>
          <p:nvPr/>
        </p:nvSpPr>
        <p:spPr bwMode="auto">
          <a:xfrm>
            <a:off x="1876850" y="1968400"/>
            <a:ext cx="0" cy="1501704"/>
          </a:xfrm>
          <a:prstGeom prst="rect">
            <a:avLst/>
          </a:prstGeom>
          <a:solidFill>
            <a:srgbClr val="000000"/>
          </a:solidFill>
          <a:ln w="139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8" name="Freeform 18"/>
          <p:cNvSpPr>
            <a:spLocks noEditPoints="1"/>
          </p:cNvSpPr>
          <p:nvPr/>
        </p:nvSpPr>
        <p:spPr bwMode="auto">
          <a:xfrm>
            <a:off x="1851502" y="1962368"/>
            <a:ext cx="25160" cy="1513766"/>
          </a:xfrm>
          <a:custGeom>
            <a:avLst/>
            <a:gdLst>
              <a:gd name="T0" fmla="*/ 0 w 22"/>
              <a:gd name="T1" fmla="*/ 1245 h 1255"/>
              <a:gd name="T2" fmla="*/ 22 w 22"/>
              <a:gd name="T3" fmla="*/ 1245 h 1255"/>
              <a:gd name="T4" fmla="*/ 22 w 22"/>
              <a:gd name="T5" fmla="*/ 1255 h 1255"/>
              <a:gd name="T6" fmla="*/ 0 w 22"/>
              <a:gd name="T7" fmla="*/ 1255 h 1255"/>
              <a:gd name="T8" fmla="*/ 0 w 22"/>
              <a:gd name="T9" fmla="*/ 1245 h 1255"/>
              <a:gd name="T10" fmla="*/ 0 w 22"/>
              <a:gd name="T11" fmla="*/ 1038 h 1255"/>
              <a:gd name="T12" fmla="*/ 22 w 22"/>
              <a:gd name="T13" fmla="*/ 1038 h 1255"/>
              <a:gd name="T14" fmla="*/ 22 w 22"/>
              <a:gd name="T15" fmla="*/ 1048 h 1255"/>
              <a:gd name="T16" fmla="*/ 0 w 22"/>
              <a:gd name="T17" fmla="*/ 1048 h 1255"/>
              <a:gd name="T18" fmla="*/ 0 w 22"/>
              <a:gd name="T19" fmla="*/ 1038 h 1255"/>
              <a:gd name="T20" fmla="*/ 0 w 22"/>
              <a:gd name="T21" fmla="*/ 831 h 1255"/>
              <a:gd name="T22" fmla="*/ 22 w 22"/>
              <a:gd name="T23" fmla="*/ 831 h 1255"/>
              <a:gd name="T24" fmla="*/ 22 w 22"/>
              <a:gd name="T25" fmla="*/ 840 h 1255"/>
              <a:gd name="T26" fmla="*/ 0 w 22"/>
              <a:gd name="T27" fmla="*/ 840 h 1255"/>
              <a:gd name="T28" fmla="*/ 0 w 22"/>
              <a:gd name="T29" fmla="*/ 831 h 1255"/>
              <a:gd name="T30" fmla="*/ 0 w 22"/>
              <a:gd name="T31" fmla="*/ 623 h 1255"/>
              <a:gd name="T32" fmla="*/ 22 w 22"/>
              <a:gd name="T33" fmla="*/ 623 h 1255"/>
              <a:gd name="T34" fmla="*/ 22 w 22"/>
              <a:gd name="T35" fmla="*/ 633 h 1255"/>
              <a:gd name="T36" fmla="*/ 0 w 22"/>
              <a:gd name="T37" fmla="*/ 633 h 1255"/>
              <a:gd name="T38" fmla="*/ 0 w 22"/>
              <a:gd name="T39" fmla="*/ 623 h 1255"/>
              <a:gd name="T40" fmla="*/ 0 w 22"/>
              <a:gd name="T41" fmla="*/ 415 h 1255"/>
              <a:gd name="T42" fmla="*/ 22 w 22"/>
              <a:gd name="T43" fmla="*/ 415 h 1255"/>
              <a:gd name="T44" fmla="*/ 22 w 22"/>
              <a:gd name="T45" fmla="*/ 425 h 1255"/>
              <a:gd name="T46" fmla="*/ 0 w 22"/>
              <a:gd name="T47" fmla="*/ 425 h 1255"/>
              <a:gd name="T48" fmla="*/ 0 w 22"/>
              <a:gd name="T49" fmla="*/ 415 h 1255"/>
              <a:gd name="T50" fmla="*/ 0 w 22"/>
              <a:gd name="T51" fmla="*/ 208 h 1255"/>
              <a:gd name="T52" fmla="*/ 22 w 22"/>
              <a:gd name="T53" fmla="*/ 208 h 1255"/>
              <a:gd name="T54" fmla="*/ 22 w 22"/>
              <a:gd name="T55" fmla="*/ 217 h 1255"/>
              <a:gd name="T56" fmla="*/ 0 w 22"/>
              <a:gd name="T57" fmla="*/ 217 h 1255"/>
              <a:gd name="T58" fmla="*/ 0 w 22"/>
              <a:gd name="T59" fmla="*/ 208 h 1255"/>
              <a:gd name="T60" fmla="*/ 0 w 22"/>
              <a:gd name="T61" fmla="*/ 0 h 1255"/>
              <a:gd name="T62" fmla="*/ 22 w 22"/>
              <a:gd name="T63" fmla="*/ 0 h 1255"/>
              <a:gd name="T64" fmla="*/ 22 w 22"/>
              <a:gd name="T65" fmla="*/ 10 h 1255"/>
              <a:gd name="T66" fmla="*/ 0 w 22"/>
              <a:gd name="T67" fmla="*/ 10 h 1255"/>
              <a:gd name="T68" fmla="*/ 0 w 22"/>
              <a:gd name="T69" fmla="*/ 0 h 12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22" h="1255">
                <a:moveTo>
                  <a:pt x="0" y="1245"/>
                </a:moveTo>
                <a:lnTo>
                  <a:pt x="22" y="1245"/>
                </a:lnTo>
                <a:lnTo>
                  <a:pt x="22" y="1255"/>
                </a:lnTo>
                <a:lnTo>
                  <a:pt x="0" y="1255"/>
                </a:lnTo>
                <a:lnTo>
                  <a:pt x="0" y="1245"/>
                </a:lnTo>
                <a:close/>
                <a:moveTo>
                  <a:pt x="0" y="1038"/>
                </a:moveTo>
                <a:lnTo>
                  <a:pt x="22" y="1038"/>
                </a:lnTo>
                <a:lnTo>
                  <a:pt x="22" y="1048"/>
                </a:lnTo>
                <a:lnTo>
                  <a:pt x="0" y="1048"/>
                </a:lnTo>
                <a:lnTo>
                  <a:pt x="0" y="1038"/>
                </a:lnTo>
                <a:close/>
                <a:moveTo>
                  <a:pt x="0" y="831"/>
                </a:moveTo>
                <a:lnTo>
                  <a:pt x="22" y="831"/>
                </a:lnTo>
                <a:lnTo>
                  <a:pt x="22" y="840"/>
                </a:lnTo>
                <a:lnTo>
                  <a:pt x="0" y="840"/>
                </a:lnTo>
                <a:lnTo>
                  <a:pt x="0" y="831"/>
                </a:lnTo>
                <a:close/>
                <a:moveTo>
                  <a:pt x="0" y="623"/>
                </a:moveTo>
                <a:lnTo>
                  <a:pt x="22" y="623"/>
                </a:lnTo>
                <a:lnTo>
                  <a:pt x="22" y="633"/>
                </a:lnTo>
                <a:lnTo>
                  <a:pt x="0" y="633"/>
                </a:lnTo>
                <a:lnTo>
                  <a:pt x="0" y="623"/>
                </a:lnTo>
                <a:close/>
                <a:moveTo>
                  <a:pt x="0" y="415"/>
                </a:moveTo>
                <a:lnTo>
                  <a:pt x="22" y="415"/>
                </a:lnTo>
                <a:lnTo>
                  <a:pt x="22" y="425"/>
                </a:lnTo>
                <a:lnTo>
                  <a:pt x="0" y="425"/>
                </a:lnTo>
                <a:lnTo>
                  <a:pt x="0" y="415"/>
                </a:lnTo>
                <a:close/>
                <a:moveTo>
                  <a:pt x="0" y="208"/>
                </a:moveTo>
                <a:lnTo>
                  <a:pt x="22" y="208"/>
                </a:lnTo>
                <a:lnTo>
                  <a:pt x="22" y="217"/>
                </a:lnTo>
                <a:lnTo>
                  <a:pt x="0" y="217"/>
                </a:lnTo>
                <a:lnTo>
                  <a:pt x="0" y="208"/>
                </a:lnTo>
                <a:close/>
                <a:moveTo>
                  <a:pt x="0" y="0"/>
                </a:moveTo>
                <a:lnTo>
                  <a:pt x="22" y="0"/>
                </a:lnTo>
                <a:lnTo>
                  <a:pt x="22" y="10"/>
                </a:lnTo>
                <a:lnTo>
                  <a:pt x="0" y="1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9" name="Rectangle 19"/>
          <p:cNvSpPr>
            <a:spLocks noChangeArrowheads="1"/>
          </p:cNvSpPr>
          <p:nvPr/>
        </p:nvSpPr>
        <p:spPr bwMode="auto">
          <a:xfrm>
            <a:off x="1881425" y="3478360"/>
            <a:ext cx="1411916" cy="0"/>
          </a:xfrm>
          <a:prstGeom prst="rect">
            <a:avLst/>
          </a:prstGeom>
          <a:solidFill>
            <a:srgbClr val="000000"/>
          </a:solidFill>
          <a:ln w="139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" name="Rectangle 20"/>
          <p:cNvSpPr>
            <a:spLocks noChangeArrowheads="1"/>
          </p:cNvSpPr>
          <p:nvPr/>
        </p:nvSpPr>
        <p:spPr bwMode="auto">
          <a:xfrm>
            <a:off x="1762164" y="3400786"/>
            <a:ext cx="60136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</a:t>
            </a:r>
          </a:p>
        </p:txBody>
      </p:sp>
      <p:sp>
        <p:nvSpPr>
          <p:cNvPr id="21" name="Rectangle 21"/>
          <p:cNvSpPr>
            <a:spLocks noChangeArrowheads="1"/>
          </p:cNvSpPr>
          <p:nvPr/>
        </p:nvSpPr>
        <p:spPr bwMode="auto">
          <a:xfrm>
            <a:off x="1762164" y="3151105"/>
            <a:ext cx="60136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</a:t>
            </a:r>
          </a:p>
        </p:txBody>
      </p:sp>
      <p:sp>
        <p:nvSpPr>
          <p:cNvPr id="22" name="Rectangle 22"/>
          <p:cNvSpPr>
            <a:spLocks noChangeArrowheads="1"/>
          </p:cNvSpPr>
          <p:nvPr/>
        </p:nvSpPr>
        <p:spPr bwMode="auto">
          <a:xfrm>
            <a:off x="1762164" y="2900218"/>
            <a:ext cx="60136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</a:t>
            </a:r>
          </a:p>
        </p:txBody>
      </p:sp>
      <p:sp>
        <p:nvSpPr>
          <p:cNvPr id="23" name="Rectangle 23"/>
          <p:cNvSpPr>
            <a:spLocks noChangeArrowheads="1"/>
          </p:cNvSpPr>
          <p:nvPr/>
        </p:nvSpPr>
        <p:spPr bwMode="auto">
          <a:xfrm>
            <a:off x="1762164" y="2648125"/>
            <a:ext cx="60136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3</a:t>
            </a:r>
          </a:p>
        </p:txBody>
      </p:sp>
      <p:sp>
        <p:nvSpPr>
          <p:cNvPr id="24" name="Rectangle 24"/>
          <p:cNvSpPr>
            <a:spLocks noChangeArrowheads="1"/>
          </p:cNvSpPr>
          <p:nvPr/>
        </p:nvSpPr>
        <p:spPr bwMode="auto">
          <a:xfrm>
            <a:off x="1762164" y="2399650"/>
            <a:ext cx="60136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4</a:t>
            </a:r>
          </a:p>
        </p:txBody>
      </p:sp>
      <p:sp>
        <p:nvSpPr>
          <p:cNvPr id="25" name="Rectangle 25"/>
          <p:cNvSpPr>
            <a:spLocks noChangeArrowheads="1"/>
          </p:cNvSpPr>
          <p:nvPr/>
        </p:nvSpPr>
        <p:spPr bwMode="auto">
          <a:xfrm>
            <a:off x="1762164" y="2148763"/>
            <a:ext cx="60136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5</a:t>
            </a:r>
          </a:p>
        </p:txBody>
      </p:sp>
      <p:sp>
        <p:nvSpPr>
          <p:cNvPr id="26" name="Rectangle 26"/>
          <p:cNvSpPr>
            <a:spLocks noChangeArrowheads="1"/>
          </p:cNvSpPr>
          <p:nvPr/>
        </p:nvSpPr>
        <p:spPr bwMode="auto">
          <a:xfrm>
            <a:off x="1762164" y="1899082"/>
            <a:ext cx="60136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6</a:t>
            </a:r>
          </a:p>
        </p:txBody>
      </p:sp>
      <p:sp>
        <p:nvSpPr>
          <p:cNvPr id="27" name="Rectangle 31"/>
          <p:cNvSpPr>
            <a:spLocks noChangeArrowheads="1"/>
          </p:cNvSpPr>
          <p:nvPr/>
        </p:nvSpPr>
        <p:spPr bwMode="auto">
          <a:xfrm>
            <a:off x="1574288" y="3588243"/>
            <a:ext cx="145232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LPS :     </a:t>
            </a:r>
            <a:r>
              <a:rPr kumimoji="0" lang="fr-FR" altLang="fr-FR" sz="1000" b="0" i="0" u="none" strike="noStrike" cap="none" normalizeH="0" dirty="0" smtClean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     -                 + </a:t>
            </a:r>
          </a:p>
        </p:txBody>
      </p:sp>
      <p:sp>
        <p:nvSpPr>
          <p:cNvPr id="28" name="Rectangle 31"/>
          <p:cNvSpPr>
            <a:spLocks noChangeArrowheads="1"/>
          </p:cNvSpPr>
          <p:nvPr/>
        </p:nvSpPr>
        <p:spPr bwMode="auto">
          <a:xfrm rot="16200000">
            <a:off x="958460" y="2660631"/>
            <a:ext cx="1215169" cy="131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dirty="0" smtClean="0">
                <a:cs typeface="Arial" panose="020B0604020202020204" pitchFamily="34" charset="0"/>
              </a:rPr>
              <a:t>Nlrp3/</a:t>
            </a:r>
            <a:r>
              <a:rPr lang="fr-FR" altLang="fr-FR" sz="1000" dirty="0" err="1" smtClean="0">
                <a:cs typeface="Arial" panose="020B0604020202020204" pitchFamily="34" charset="0"/>
              </a:rPr>
              <a:t>actin</a:t>
            </a:r>
            <a:r>
              <a:rPr lang="fr-FR" altLang="fr-FR" sz="1000" dirty="0" smtClean="0">
                <a:cs typeface="Arial" panose="020B0604020202020204" pitchFamily="34" charset="0"/>
              </a:rPr>
              <a:t> </a:t>
            </a:r>
            <a:r>
              <a:rPr lang="fr-FR" altLang="fr-FR" sz="1000" dirty="0" err="1" smtClean="0">
                <a:cs typeface="Arial" panose="020B0604020202020204" pitchFamily="34" charset="0"/>
              </a:rPr>
              <a:t>mRNA</a:t>
            </a:r>
            <a:r>
              <a:rPr lang="fr-FR" altLang="fr-FR" sz="1000" dirty="0" smtClean="0">
                <a:cs typeface="Arial" panose="020B0604020202020204" pitchFamily="34" charset="0"/>
              </a:rPr>
              <a:t> (</a:t>
            </a:r>
            <a:r>
              <a:rPr lang="fr-FR" altLang="fr-FR" sz="1000" dirty="0" err="1" smtClean="0">
                <a:cs typeface="Arial" panose="020B0604020202020204" pitchFamily="34" charset="0"/>
              </a:rPr>
              <a:t>fold</a:t>
            </a:r>
            <a:r>
              <a:rPr lang="fr-FR" altLang="fr-FR" sz="1000" dirty="0" smtClean="0">
                <a:cs typeface="Arial" panose="020B0604020202020204" pitchFamily="34" charset="0"/>
              </a:rPr>
              <a:t>)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9" name="Rectangle 35"/>
          <p:cNvSpPr>
            <a:spLocks noChangeArrowheads="1"/>
          </p:cNvSpPr>
          <p:nvPr/>
        </p:nvSpPr>
        <p:spPr bwMode="auto">
          <a:xfrm>
            <a:off x="4009652" y="3456664"/>
            <a:ext cx="218781" cy="1209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" name="Freeform 36"/>
          <p:cNvSpPr>
            <a:spLocks noEditPoints="1"/>
          </p:cNvSpPr>
          <p:nvPr/>
        </p:nvSpPr>
        <p:spPr bwMode="auto">
          <a:xfrm>
            <a:off x="4006216" y="3453040"/>
            <a:ext cx="225654" cy="8457"/>
          </a:xfrm>
          <a:custGeom>
            <a:avLst/>
            <a:gdLst>
              <a:gd name="T0" fmla="*/ 0 w 3280"/>
              <a:gd name="T1" fmla="*/ 48 h 112"/>
              <a:gd name="T2" fmla="*/ 48 w 3280"/>
              <a:gd name="T3" fmla="*/ 0 h 112"/>
              <a:gd name="T4" fmla="*/ 3232 w 3280"/>
              <a:gd name="T5" fmla="*/ 0 h 112"/>
              <a:gd name="T6" fmla="*/ 3280 w 3280"/>
              <a:gd name="T7" fmla="*/ 48 h 112"/>
              <a:gd name="T8" fmla="*/ 3280 w 3280"/>
              <a:gd name="T9" fmla="*/ 64 h 112"/>
              <a:gd name="T10" fmla="*/ 3232 w 3280"/>
              <a:gd name="T11" fmla="*/ 112 h 112"/>
              <a:gd name="T12" fmla="*/ 48 w 3280"/>
              <a:gd name="T13" fmla="*/ 112 h 112"/>
              <a:gd name="T14" fmla="*/ 0 w 3280"/>
              <a:gd name="T15" fmla="*/ 64 h 112"/>
              <a:gd name="T16" fmla="*/ 0 w 3280"/>
              <a:gd name="T17" fmla="*/ 48 h 112"/>
              <a:gd name="T18" fmla="*/ 96 w 3280"/>
              <a:gd name="T19" fmla="*/ 64 h 112"/>
              <a:gd name="T20" fmla="*/ 48 w 3280"/>
              <a:gd name="T21" fmla="*/ 16 h 112"/>
              <a:gd name="T22" fmla="*/ 3232 w 3280"/>
              <a:gd name="T23" fmla="*/ 16 h 112"/>
              <a:gd name="T24" fmla="*/ 3184 w 3280"/>
              <a:gd name="T25" fmla="*/ 64 h 112"/>
              <a:gd name="T26" fmla="*/ 3184 w 3280"/>
              <a:gd name="T27" fmla="*/ 48 h 112"/>
              <a:gd name="T28" fmla="*/ 3232 w 3280"/>
              <a:gd name="T29" fmla="*/ 96 h 112"/>
              <a:gd name="T30" fmla="*/ 48 w 3280"/>
              <a:gd name="T31" fmla="*/ 96 h 112"/>
              <a:gd name="T32" fmla="*/ 96 w 3280"/>
              <a:gd name="T33" fmla="*/ 48 h 112"/>
              <a:gd name="T34" fmla="*/ 96 w 3280"/>
              <a:gd name="T35" fmla="*/ 64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280" h="112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3232" y="0"/>
                </a:lnTo>
                <a:cubicBezTo>
                  <a:pt x="3259" y="0"/>
                  <a:pt x="3280" y="22"/>
                  <a:pt x="3280" y="48"/>
                </a:cubicBezTo>
                <a:lnTo>
                  <a:pt x="3280" y="64"/>
                </a:lnTo>
                <a:cubicBezTo>
                  <a:pt x="3280" y="91"/>
                  <a:pt x="3259" y="112"/>
                  <a:pt x="3232" y="112"/>
                </a:cubicBezTo>
                <a:lnTo>
                  <a:pt x="48" y="112"/>
                </a:lnTo>
                <a:cubicBezTo>
                  <a:pt x="22" y="112"/>
                  <a:pt x="0" y="91"/>
                  <a:pt x="0" y="64"/>
                </a:cubicBezTo>
                <a:lnTo>
                  <a:pt x="0" y="48"/>
                </a:lnTo>
                <a:close/>
                <a:moveTo>
                  <a:pt x="96" y="64"/>
                </a:moveTo>
                <a:lnTo>
                  <a:pt x="48" y="16"/>
                </a:lnTo>
                <a:lnTo>
                  <a:pt x="3232" y="16"/>
                </a:lnTo>
                <a:lnTo>
                  <a:pt x="3184" y="64"/>
                </a:lnTo>
                <a:lnTo>
                  <a:pt x="3184" y="48"/>
                </a:lnTo>
                <a:lnTo>
                  <a:pt x="3232" y="96"/>
                </a:lnTo>
                <a:lnTo>
                  <a:pt x="48" y="96"/>
                </a:lnTo>
                <a:lnTo>
                  <a:pt x="96" y="48"/>
                </a:lnTo>
                <a:lnTo>
                  <a:pt x="96" y="6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" name="Rectangle 37"/>
          <p:cNvSpPr>
            <a:spLocks noChangeArrowheads="1"/>
          </p:cNvSpPr>
          <p:nvPr/>
        </p:nvSpPr>
        <p:spPr bwMode="auto">
          <a:xfrm>
            <a:off x="4659650" y="2232187"/>
            <a:ext cx="230204" cy="123588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" name="Freeform 38"/>
          <p:cNvSpPr>
            <a:spLocks noEditPoints="1"/>
          </p:cNvSpPr>
          <p:nvPr/>
        </p:nvSpPr>
        <p:spPr bwMode="auto">
          <a:xfrm>
            <a:off x="4656214" y="2228563"/>
            <a:ext cx="230204" cy="1243133"/>
          </a:xfrm>
          <a:custGeom>
            <a:avLst/>
            <a:gdLst>
              <a:gd name="T0" fmla="*/ 0 w 3280"/>
              <a:gd name="T1" fmla="*/ 48 h 17136"/>
              <a:gd name="T2" fmla="*/ 48 w 3280"/>
              <a:gd name="T3" fmla="*/ 0 h 17136"/>
              <a:gd name="T4" fmla="*/ 3232 w 3280"/>
              <a:gd name="T5" fmla="*/ 0 h 17136"/>
              <a:gd name="T6" fmla="*/ 3280 w 3280"/>
              <a:gd name="T7" fmla="*/ 48 h 17136"/>
              <a:gd name="T8" fmla="*/ 3280 w 3280"/>
              <a:gd name="T9" fmla="*/ 17088 h 17136"/>
              <a:gd name="T10" fmla="*/ 3232 w 3280"/>
              <a:gd name="T11" fmla="*/ 17136 h 17136"/>
              <a:gd name="T12" fmla="*/ 48 w 3280"/>
              <a:gd name="T13" fmla="*/ 17136 h 17136"/>
              <a:gd name="T14" fmla="*/ 0 w 3280"/>
              <a:gd name="T15" fmla="*/ 17088 h 17136"/>
              <a:gd name="T16" fmla="*/ 0 w 3280"/>
              <a:gd name="T17" fmla="*/ 48 h 17136"/>
              <a:gd name="T18" fmla="*/ 96 w 3280"/>
              <a:gd name="T19" fmla="*/ 17088 h 17136"/>
              <a:gd name="T20" fmla="*/ 48 w 3280"/>
              <a:gd name="T21" fmla="*/ 17040 h 17136"/>
              <a:gd name="T22" fmla="*/ 3232 w 3280"/>
              <a:gd name="T23" fmla="*/ 17040 h 17136"/>
              <a:gd name="T24" fmla="*/ 3184 w 3280"/>
              <a:gd name="T25" fmla="*/ 17088 h 17136"/>
              <a:gd name="T26" fmla="*/ 3184 w 3280"/>
              <a:gd name="T27" fmla="*/ 48 h 17136"/>
              <a:gd name="T28" fmla="*/ 3232 w 3280"/>
              <a:gd name="T29" fmla="*/ 96 h 17136"/>
              <a:gd name="T30" fmla="*/ 48 w 3280"/>
              <a:gd name="T31" fmla="*/ 96 h 17136"/>
              <a:gd name="T32" fmla="*/ 96 w 3280"/>
              <a:gd name="T33" fmla="*/ 48 h 17136"/>
              <a:gd name="T34" fmla="*/ 96 w 3280"/>
              <a:gd name="T35" fmla="*/ 17088 h 17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280" h="17136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3232" y="0"/>
                </a:lnTo>
                <a:cubicBezTo>
                  <a:pt x="3259" y="0"/>
                  <a:pt x="3280" y="22"/>
                  <a:pt x="3280" y="48"/>
                </a:cubicBezTo>
                <a:lnTo>
                  <a:pt x="3280" y="17088"/>
                </a:lnTo>
                <a:cubicBezTo>
                  <a:pt x="3280" y="17115"/>
                  <a:pt x="3259" y="17136"/>
                  <a:pt x="3232" y="17136"/>
                </a:cubicBezTo>
                <a:lnTo>
                  <a:pt x="48" y="17136"/>
                </a:lnTo>
                <a:cubicBezTo>
                  <a:pt x="22" y="17136"/>
                  <a:pt x="0" y="17115"/>
                  <a:pt x="0" y="17088"/>
                </a:cubicBezTo>
                <a:lnTo>
                  <a:pt x="0" y="48"/>
                </a:lnTo>
                <a:close/>
                <a:moveTo>
                  <a:pt x="96" y="17088"/>
                </a:moveTo>
                <a:lnTo>
                  <a:pt x="48" y="17040"/>
                </a:lnTo>
                <a:lnTo>
                  <a:pt x="3232" y="17040"/>
                </a:lnTo>
                <a:lnTo>
                  <a:pt x="3184" y="17088"/>
                </a:lnTo>
                <a:lnTo>
                  <a:pt x="3184" y="48"/>
                </a:lnTo>
                <a:lnTo>
                  <a:pt x="3232" y="96"/>
                </a:lnTo>
                <a:lnTo>
                  <a:pt x="48" y="96"/>
                </a:lnTo>
                <a:lnTo>
                  <a:pt x="96" y="48"/>
                </a:lnTo>
                <a:lnTo>
                  <a:pt x="96" y="17088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" name="Rectangle 39"/>
          <p:cNvSpPr>
            <a:spLocks noChangeArrowheads="1"/>
          </p:cNvSpPr>
          <p:nvPr/>
        </p:nvSpPr>
        <p:spPr bwMode="auto">
          <a:xfrm>
            <a:off x="4273334" y="3456664"/>
            <a:ext cx="218781" cy="1209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" name="Freeform 40"/>
          <p:cNvSpPr>
            <a:spLocks noEditPoints="1"/>
          </p:cNvSpPr>
          <p:nvPr/>
        </p:nvSpPr>
        <p:spPr bwMode="auto">
          <a:xfrm>
            <a:off x="4269898" y="3453040"/>
            <a:ext cx="225654" cy="8457"/>
          </a:xfrm>
          <a:custGeom>
            <a:avLst/>
            <a:gdLst>
              <a:gd name="T0" fmla="*/ 0 w 1640"/>
              <a:gd name="T1" fmla="*/ 24 h 56"/>
              <a:gd name="T2" fmla="*/ 24 w 1640"/>
              <a:gd name="T3" fmla="*/ 0 h 56"/>
              <a:gd name="T4" fmla="*/ 1616 w 1640"/>
              <a:gd name="T5" fmla="*/ 0 h 56"/>
              <a:gd name="T6" fmla="*/ 1640 w 1640"/>
              <a:gd name="T7" fmla="*/ 24 h 56"/>
              <a:gd name="T8" fmla="*/ 1640 w 1640"/>
              <a:gd name="T9" fmla="*/ 32 h 56"/>
              <a:gd name="T10" fmla="*/ 1616 w 1640"/>
              <a:gd name="T11" fmla="*/ 56 h 56"/>
              <a:gd name="T12" fmla="*/ 24 w 1640"/>
              <a:gd name="T13" fmla="*/ 56 h 56"/>
              <a:gd name="T14" fmla="*/ 0 w 1640"/>
              <a:gd name="T15" fmla="*/ 32 h 56"/>
              <a:gd name="T16" fmla="*/ 0 w 1640"/>
              <a:gd name="T17" fmla="*/ 24 h 56"/>
              <a:gd name="T18" fmla="*/ 48 w 1640"/>
              <a:gd name="T19" fmla="*/ 32 h 56"/>
              <a:gd name="T20" fmla="*/ 24 w 1640"/>
              <a:gd name="T21" fmla="*/ 8 h 56"/>
              <a:gd name="T22" fmla="*/ 1616 w 1640"/>
              <a:gd name="T23" fmla="*/ 8 h 56"/>
              <a:gd name="T24" fmla="*/ 1592 w 1640"/>
              <a:gd name="T25" fmla="*/ 32 h 56"/>
              <a:gd name="T26" fmla="*/ 1592 w 1640"/>
              <a:gd name="T27" fmla="*/ 24 h 56"/>
              <a:gd name="T28" fmla="*/ 1616 w 1640"/>
              <a:gd name="T29" fmla="*/ 48 h 56"/>
              <a:gd name="T30" fmla="*/ 24 w 1640"/>
              <a:gd name="T31" fmla="*/ 48 h 56"/>
              <a:gd name="T32" fmla="*/ 48 w 1640"/>
              <a:gd name="T33" fmla="*/ 24 h 56"/>
              <a:gd name="T34" fmla="*/ 48 w 1640"/>
              <a:gd name="T35" fmla="*/ 32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640" h="5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1616" y="0"/>
                </a:lnTo>
                <a:cubicBezTo>
                  <a:pt x="1630" y="0"/>
                  <a:pt x="1640" y="11"/>
                  <a:pt x="1640" y="24"/>
                </a:cubicBezTo>
                <a:lnTo>
                  <a:pt x="1640" y="32"/>
                </a:lnTo>
                <a:cubicBezTo>
                  <a:pt x="1640" y="46"/>
                  <a:pt x="1630" y="56"/>
                  <a:pt x="1616" y="56"/>
                </a:cubicBezTo>
                <a:lnTo>
                  <a:pt x="24" y="56"/>
                </a:lnTo>
                <a:cubicBezTo>
                  <a:pt x="11" y="56"/>
                  <a:pt x="0" y="46"/>
                  <a:pt x="0" y="32"/>
                </a:cubicBezTo>
                <a:lnTo>
                  <a:pt x="0" y="24"/>
                </a:lnTo>
                <a:close/>
                <a:moveTo>
                  <a:pt x="48" y="32"/>
                </a:moveTo>
                <a:lnTo>
                  <a:pt x="24" y="8"/>
                </a:lnTo>
                <a:lnTo>
                  <a:pt x="1616" y="8"/>
                </a:lnTo>
                <a:lnTo>
                  <a:pt x="1592" y="32"/>
                </a:lnTo>
                <a:lnTo>
                  <a:pt x="1592" y="24"/>
                </a:lnTo>
                <a:lnTo>
                  <a:pt x="1616" y="48"/>
                </a:lnTo>
                <a:lnTo>
                  <a:pt x="24" y="48"/>
                </a:lnTo>
                <a:lnTo>
                  <a:pt x="48" y="24"/>
                </a:lnTo>
                <a:lnTo>
                  <a:pt x="48" y="32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5" name="Rectangle 41"/>
          <p:cNvSpPr>
            <a:spLocks noChangeArrowheads="1"/>
          </p:cNvSpPr>
          <p:nvPr/>
        </p:nvSpPr>
        <p:spPr bwMode="auto">
          <a:xfrm>
            <a:off x="4923333" y="2389239"/>
            <a:ext cx="230204" cy="1078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6" name="Freeform 42"/>
          <p:cNvSpPr>
            <a:spLocks noEditPoints="1"/>
          </p:cNvSpPr>
          <p:nvPr/>
        </p:nvSpPr>
        <p:spPr bwMode="auto">
          <a:xfrm>
            <a:off x="4919896" y="2385615"/>
            <a:ext cx="230204" cy="1086080"/>
          </a:xfrm>
          <a:custGeom>
            <a:avLst/>
            <a:gdLst>
              <a:gd name="T0" fmla="*/ 0 w 1640"/>
              <a:gd name="T1" fmla="*/ 24 h 7488"/>
              <a:gd name="T2" fmla="*/ 24 w 1640"/>
              <a:gd name="T3" fmla="*/ 0 h 7488"/>
              <a:gd name="T4" fmla="*/ 1616 w 1640"/>
              <a:gd name="T5" fmla="*/ 0 h 7488"/>
              <a:gd name="T6" fmla="*/ 1640 w 1640"/>
              <a:gd name="T7" fmla="*/ 24 h 7488"/>
              <a:gd name="T8" fmla="*/ 1640 w 1640"/>
              <a:gd name="T9" fmla="*/ 7464 h 7488"/>
              <a:gd name="T10" fmla="*/ 1616 w 1640"/>
              <a:gd name="T11" fmla="*/ 7488 h 7488"/>
              <a:gd name="T12" fmla="*/ 24 w 1640"/>
              <a:gd name="T13" fmla="*/ 7488 h 7488"/>
              <a:gd name="T14" fmla="*/ 0 w 1640"/>
              <a:gd name="T15" fmla="*/ 7464 h 7488"/>
              <a:gd name="T16" fmla="*/ 0 w 1640"/>
              <a:gd name="T17" fmla="*/ 24 h 7488"/>
              <a:gd name="T18" fmla="*/ 48 w 1640"/>
              <a:gd name="T19" fmla="*/ 7464 h 7488"/>
              <a:gd name="T20" fmla="*/ 24 w 1640"/>
              <a:gd name="T21" fmla="*/ 7440 h 7488"/>
              <a:gd name="T22" fmla="*/ 1616 w 1640"/>
              <a:gd name="T23" fmla="*/ 7440 h 7488"/>
              <a:gd name="T24" fmla="*/ 1592 w 1640"/>
              <a:gd name="T25" fmla="*/ 7464 h 7488"/>
              <a:gd name="T26" fmla="*/ 1592 w 1640"/>
              <a:gd name="T27" fmla="*/ 24 h 7488"/>
              <a:gd name="T28" fmla="*/ 1616 w 1640"/>
              <a:gd name="T29" fmla="*/ 48 h 7488"/>
              <a:gd name="T30" fmla="*/ 24 w 1640"/>
              <a:gd name="T31" fmla="*/ 48 h 7488"/>
              <a:gd name="T32" fmla="*/ 48 w 1640"/>
              <a:gd name="T33" fmla="*/ 24 h 7488"/>
              <a:gd name="T34" fmla="*/ 48 w 1640"/>
              <a:gd name="T35" fmla="*/ 7464 h 74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640" h="7488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1616" y="0"/>
                </a:lnTo>
                <a:cubicBezTo>
                  <a:pt x="1630" y="0"/>
                  <a:pt x="1640" y="11"/>
                  <a:pt x="1640" y="24"/>
                </a:cubicBezTo>
                <a:lnTo>
                  <a:pt x="1640" y="7464"/>
                </a:lnTo>
                <a:cubicBezTo>
                  <a:pt x="1640" y="7478"/>
                  <a:pt x="1630" y="7488"/>
                  <a:pt x="1616" y="7488"/>
                </a:cubicBezTo>
                <a:lnTo>
                  <a:pt x="24" y="7488"/>
                </a:lnTo>
                <a:cubicBezTo>
                  <a:pt x="11" y="7488"/>
                  <a:pt x="0" y="7478"/>
                  <a:pt x="0" y="7464"/>
                </a:cubicBezTo>
                <a:lnTo>
                  <a:pt x="0" y="24"/>
                </a:lnTo>
                <a:close/>
                <a:moveTo>
                  <a:pt x="48" y="7464"/>
                </a:moveTo>
                <a:lnTo>
                  <a:pt x="24" y="7440"/>
                </a:lnTo>
                <a:lnTo>
                  <a:pt x="1616" y="7440"/>
                </a:lnTo>
                <a:lnTo>
                  <a:pt x="1592" y="7464"/>
                </a:lnTo>
                <a:lnTo>
                  <a:pt x="1592" y="24"/>
                </a:lnTo>
                <a:lnTo>
                  <a:pt x="1616" y="48"/>
                </a:lnTo>
                <a:lnTo>
                  <a:pt x="24" y="48"/>
                </a:lnTo>
                <a:lnTo>
                  <a:pt x="48" y="24"/>
                </a:lnTo>
                <a:lnTo>
                  <a:pt x="48" y="746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7" name="Rectangle 43"/>
          <p:cNvSpPr>
            <a:spLocks noChangeArrowheads="1"/>
          </p:cNvSpPr>
          <p:nvPr/>
        </p:nvSpPr>
        <p:spPr bwMode="auto">
          <a:xfrm>
            <a:off x="4098996" y="3453040"/>
            <a:ext cx="40091" cy="7249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8" name="Freeform 44"/>
          <p:cNvSpPr>
            <a:spLocks noEditPoints="1"/>
          </p:cNvSpPr>
          <p:nvPr/>
        </p:nvSpPr>
        <p:spPr bwMode="auto">
          <a:xfrm>
            <a:off x="4747850" y="2108960"/>
            <a:ext cx="41236" cy="123226"/>
          </a:xfrm>
          <a:custGeom>
            <a:avLst/>
            <a:gdLst>
              <a:gd name="T0" fmla="*/ 15 w 36"/>
              <a:gd name="T1" fmla="*/ 102 h 102"/>
              <a:gd name="T2" fmla="*/ 15 w 36"/>
              <a:gd name="T3" fmla="*/ 3 h 102"/>
              <a:gd name="T4" fmla="*/ 21 w 36"/>
              <a:gd name="T5" fmla="*/ 3 h 102"/>
              <a:gd name="T6" fmla="*/ 21 w 36"/>
              <a:gd name="T7" fmla="*/ 102 h 102"/>
              <a:gd name="T8" fmla="*/ 15 w 36"/>
              <a:gd name="T9" fmla="*/ 102 h 102"/>
              <a:gd name="T10" fmla="*/ 0 w 36"/>
              <a:gd name="T11" fmla="*/ 0 h 102"/>
              <a:gd name="T12" fmla="*/ 36 w 36"/>
              <a:gd name="T13" fmla="*/ 0 h 102"/>
              <a:gd name="T14" fmla="*/ 36 w 36"/>
              <a:gd name="T15" fmla="*/ 6 h 102"/>
              <a:gd name="T16" fmla="*/ 0 w 36"/>
              <a:gd name="T17" fmla="*/ 6 h 102"/>
              <a:gd name="T18" fmla="*/ 0 w 36"/>
              <a:gd name="T19" fmla="*/ 0 h 1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36" h="102">
                <a:moveTo>
                  <a:pt x="15" y="102"/>
                </a:moveTo>
                <a:lnTo>
                  <a:pt x="15" y="3"/>
                </a:lnTo>
                <a:lnTo>
                  <a:pt x="21" y="3"/>
                </a:lnTo>
                <a:lnTo>
                  <a:pt x="21" y="102"/>
                </a:lnTo>
                <a:lnTo>
                  <a:pt x="15" y="10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9" name="Rectangle 45"/>
          <p:cNvSpPr>
            <a:spLocks noChangeArrowheads="1"/>
          </p:cNvSpPr>
          <p:nvPr/>
        </p:nvSpPr>
        <p:spPr bwMode="auto">
          <a:xfrm>
            <a:off x="4362680" y="3453040"/>
            <a:ext cx="40091" cy="7249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0" name="Freeform 46"/>
          <p:cNvSpPr>
            <a:spLocks noEditPoints="1"/>
          </p:cNvSpPr>
          <p:nvPr/>
        </p:nvSpPr>
        <p:spPr bwMode="auto">
          <a:xfrm>
            <a:off x="5010388" y="2330043"/>
            <a:ext cx="42382" cy="59197"/>
          </a:xfrm>
          <a:custGeom>
            <a:avLst/>
            <a:gdLst>
              <a:gd name="T0" fmla="*/ 16 w 37"/>
              <a:gd name="T1" fmla="*/ 49 h 49"/>
              <a:gd name="T2" fmla="*/ 16 w 37"/>
              <a:gd name="T3" fmla="*/ 3 h 49"/>
              <a:gd name="T4" fmla="*/ 22 w 37"/>
              <a:gd name="T5" fmla="*/ 3 h 49"/>
              <a:gd name="T6" fmla="*/ 22 w 37"/>
              <a:gd name="T7" fmla="*/ 49 h 49"/>
              <a:gd name="T8" fmla="*/ 16 w 37"/>
              <a:gd name="T9" fmla="*/ 49 h 49"/>
              <a:gd name="T10" fmla="*/ 0 w 37"/>
              <a:gd name="T11" fmla="*/ 0 h 49"/>
              <a:gd name="T12" fmla="*/ 37 w 37"/>
              <a:gd name="T13" fmla="*/ 0 h 49"/>
              <a:gd name="T14" fmla="*/ 37 w 37"/>
              <a:gd name="T15" fmla="*/ 6 h 49"/>
              <a:gd name="T16" fmla="*/ 0 w 37"/>
              <a:gd name="T17" fmla="*/ 6 h 49"/>
              <a:gd name="T18" fmla="*/ 0 w 37"/>
              <a:gd name="T19" fmla="*/ 0 h 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37" h="49">
                <a:moveTo>
                  <a:pt x="16" y="49"/>
                </a:moveTo>
                <a:lnTo>
                  <a:pt x="16" y="3"/>
                </a:lnTo>
                <a:lnTo>
                  <a:pt x="22" y="3"/>
                </a:lnTo>
                <a:lnTo>
                  <a:pt x="22" y="49"/>
                </a:lnTo>
                <a:lnTo>
                  <a:pt x="16" y="49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" name="Rectangle 47"/>
          <p:cNvSpPr>
            <a:spLocks noChangeArrowheads="1"/>
          </p:cNvSpPr>
          <p:nvPr/>
        </p:nvSpPr>
        <p:spPr bwMode="auto">
          <a:xfrm>
            <a:off x="3853857" y="1961573"/>
            <a:ext cx="0" cy="1506498"/>
          </a:xfrm>
          <a:prstGeom prst="rect">
            <a:avLst/>
          </a:prstGeom>
          <a:solidFill>
            <a:srgbClr val="000000"/>
          </a:solidFill>
          <a:ln w="139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2" name="Freeform 48"/>
          <p:cNvSpPr>
            <a:spLocks noEditPoints="1"/>
          </p:cNvSpPr>
          <p:nvPr/>
        </p:nvSpPr>
        <p:spPr bwMode="auto">
          <a:xfrm>
            <a:off x="3829622" y="1956740"/>
            <a:ext cx="25200" cy="1517371"/>
          </a:xfrm>
          <a:custGeom>
            <a:avLst/>
            <a:gdLst>
              <a:gd name="T0" fmla="*/ 0 w 22"/>
              <a:gd name="T1" fmla="*/ 1246 h 1256"/>
              <a:gd name="T2" fmla="*/ 22 w 22"/>
              <a:gd name="T3" fmla="*/ 1246 h 1256"/>
              <a:gd name="T4" fmla="*/ 22 w 22"/>
              <a:gd name="T5" fmla="*/ 1256 h 1256"/>
              <a:gd name="T6" fmla="*/ 0 w 22"/>
              <a:gd name="T7" fmla="*/ 1256 h 1256"/>
              <a:gd name="T8" fmla="*/ 0 w 22"/>
              <a:gd name="T9" fmla="*/ 1246 h 1256"/>
              <a:gd name="T10" fmla="*/ 0 w 22"/>
              <a:gd name="T11" fmla="*/ 997 h 1256"/>
              <a:gd name="T12" fmla="*/ 22 w 22"/>
              <a:gd name="T13" fmla="*/ 997 h 1256"/>
              <a:gd name="T14" fmla="*/ 22 w 22"/>
              <a:gd name="T15" fmla="*/ 1007 h 1256"/>
              <a:gd name="T16" fmla="*/ 0 w 22"/>
              <a:gd name="T17" fmla="*/ 1007 h 1256"/>
              <a:gd name="T18" fmla="*/ 0 w 22"/>
              <a:gd name="T19" fmla="*/ 997 h 1256"/>
              <a:gd name="T20" fmla="*/ 0 w 22"/>
              <a:gd name="T21" fmla="*/ 748 h 1256"/>
              <a:gd name="T22" fmla="*/ 22 w 22"/>
              <a:gd name="T23" fmla="*/ 748 h 1256"/>
              <a:gd name="T24" fmla="*/ 22 w 22"/>
              <a:gd name="T25" fmla="*/ 757 h 1256"/>
              <a:gd name="T26" fmla="*/ 0 w 22"/>
              <a:gd name="T27" fmla="*/ 757 h 1256"/>
              <a:gd name="T28" fmla="*/ 0 w 22"/>
              <a:gd name="T29" fmla="*/ 748 h 1256"/>
              <a:gd name="T30" fmla="*/ 0 w 22"/>
              <a:gd name="T31" fmla="*/ 498 h 1256"/>
              <a:gd name="T32" fmla="*/ 22 w 22"/>
              <a:gd name="T33" fmla="*/ 498 h 1256"/>
              <a:gd name="T34" fmla="*/ 22 w 22"/>
              <a:gd name="T35" fmla="*/ 508 h 1256"/>
              <a:gd name="T36" fmla="*/ 0 w 22"/>
              <a:gd name="T37" fmla="*/ 508 h 1256"/>
              <a:gd name="T38" fmla="*/ 0 w 22"/>
              <a:gd name="T39" fmla="*/ 498 h 1256"/>
              <a:gd name="T40" fmla="*/ 0 w 22"/>
              <a:gd name="T41" fmla="*/ 249 h 1256"/>
              <a:gd name="T42" fmla="*/ 22 w 22"/>
              <a:gd name="T43" fmla="*/ 249 h 1256"/>
              <a:gd name="T44" fmla="*/ 22 w 22"/>
              <a:gd name="T45" fmla="*/ 259 h 1256"/>
              <a:gd name="T46" fmla="*/ 0 w 22"/>
              <a:gd name="T47" fmla="*/ 259 h 1256"/>
              <a:gd name="T48" fmla="*/ 0 w 22"/>
              <a:gd name="T49" fmla="*/ 249 h 1256"/>
              <a:gd name="T50" fmla="*/ 0 w 22"/>
              <a:gd name="T51" fmla="*/ 0 h 1256"/>
              <a:gd name="T52" fmla="*/ 22 w 22"/>
              <a:gd name="T53" fmla="*/ 0 h 1256"/>
              <a:gd name="T54" fmla="*/ 22 w 22"/>
              <a:gd name="T55" fmla="*/ 9 h 1256"/>
              <a:gd name="T56" fmla="*/ 0 w 22"/>
              <a:gd name="T57" fmla="*/ 9 h 1256"/>
              <a:gd name="T58" fmla="*/ 0 w 22"/>
              <a:gd name="T59" fmla="*/ 0 h 12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22" h="1256">
                <a:moveTo>
                  <a:pt x="0" y="1246"/>
                </a:moveTo>
                <a:lnTo>
                  <a:pt x="22" y="1246"/>
                </a:lnTo>
                <a:lnTo>
                  <a:pt x="22" y="1256"/>
                </a:lnTo>
                <a:lnTo>
                  <a:pt x="0" y="1256"/>
                </a:lnTo>
                <a:lnTo>
                  <a:pt x="0" y="1246"/>
                </a:lnTo>
                <a:close/>
                <a:moveTo>
                  <a:pt x="0" y="997"/>
                </a:moveTo>
                <a:lnTo>
                  <a:pt x="22" y="997"/>
                </a:lnTo>
                <a:lnTo>
                  <a:pt x="22" y="1007"/>
                </a:lnTo>
                <a:lnTo>
                  <a:pt x="0" y="1007"/>
                </a:lnTo>
                <a:lnTo>
                  <a:pt x="0" y="997"/>
                </a:lnTo>
                <a:close/>
                <a:moveTo>
                  <a:pt x="0" y="748"/>
                </a:moveTo>
                <a:lnTo>
                  <a:pt x="22" y="748"/>
                </a:lnTo>
                <a:lnTo>
                  <a:pt x="22" y="757"/>
                </a:lnTo>
                <a:lnTo>
                  <a:pt x="0" y="757"/>
                </a:lnTo>
                <a:lnTo>
                  <a:pt x="0" y="748"/>
                </a:lnTo>
                <a:close/>
                <a:moveTo>
                  <a:pt x="0" y="498"/>
                </a:moveTo>
                <a:lnTo>
                  <a:pt x="22" y="498"/>
                </a:lnTo>
                <a:lnTo>
                  <a:pt x="22" y="508"/>
                </a:lnTo>
                <a:lnTo>
                  <a:pt x="0" y="508"/>
                </a:lnTo>
                <a:lnTo>
                  <a:pt x="0" y="498"/>
                </a:lnTo>
                <a:close/>
                <a:moveTo>
                  <a:pt x="0" y="249"/>
                </a:moveTo>
                <a:lnTo>
                  <a:pt x="22" y="249"/>
                </a:lnTo>
                <a:lnTo>
                  <a:pt x="22" y="259"/>
                </a:lnTo>
                <a:lnTo>
                  <a:pt x="0" y="259"/>
                </a:lnTo>
                <a:lnTo>
                  <a:pt x="0" y="249"/>
                </a:lnTo>
                <a:close/>
                <a:moveTo>
                  <a:pt x="0" y="0"/>
                </a:moveTo>
                <a:lnTo>
                  <a:pt x="22" y="0"/>
                </a:lnTo>
                <a:lnTo>
                  <a:pt x="22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3" name="Rectangle 49"/>
          <p:cNvSpPr>
            <a:spLocks noChangeArrowheads="1"/>
          </p:cNvSpPr>
          <p:nvPr/>
        </p:nvSpPr>
        <p:spPr bwMode="auto">
          <a:xfrm>
            <a:off x="3859584" y="3466793"/>
            <a:ext cx="1411916" cy="0"/>
          </a:xfrm>
          <a:prstGeom prst="rect">
            <a:avLst/>
          </a:prstGeom>
          <a:solidFill>
            <a:srgbClr val="000000"/>
          </a:solidFill>
          <a:ln w="139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4" name="Rectangle 50"/>
          <p:cNvSpPr>
            <a:spLocks noChangeArrowheads="1"/>
          </p:cNvSpPr>
          <p:nvPr/>
        </p:nvSpPr>
        <p:spPr bwMode="auto">
          <a:xfrm>
            <a:off x="3754641" y="3410082"/>
            <a:ext cx="60136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</a:t>
            </a:r>
          </a:p>
        </p:txBody>
      </p:sp>
      <p:sp>
        <p:nvSpPr>
          <p:cNvPr id="45" name="Rectangle 51"/>
          <p:cNvSpPr>
            <a:spLocks noChangeArrowheads="1"/>
          </p:cNvSpPr>
          <p:nvPr/>
        </p:nvSpPr>
        <p:spPr bwMode="auto">
          <a:xfrm>
            <a:off x="3634369" y="3109265"/>
            <a:ext cx="180408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46" name="Rectangle 52"/>
          <p:cNvSpPr>
            <a:spLocks noChangeArrowheads="1"/>
          </p:cNvSpPr>
          <p:nvPr/>
        </p:nvSpPr>
        <p:spPr bwMode="auto">
          <a:xfrm>
            <a:off x="3574232" y="2807241"/>
            <a:ext cx="240545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47" name="Rectangle 53"/>
          <p:cNvSpPr>
            <a:spLocks noChangeArrowheads="1"/>
          </p:cNvSpPr>
          <p:nvPr/>
        </p:nvSpPr>
        <p:spPr bwMode="auto">
          <a:xfrm>
            <a:off x="3574232" y="2506425"/>
            <a:ext cx="240545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48" name="Rectangle 54"/>
          <p:cNvSpPr>
            <a:spLocks noChangeArrowheads="1"/>
          </p:cNvSpPr>
          <p:nvPr/>
        </p:nvSpPr>
        <p:spPr bwMode="auto">
          <a:xfrm>
            <a:off x="3574232" y="2205608"/>
            <a:ext cx="240545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49" name="Rectangle 55"/>
          <p:cNvSpPr>
            <a:spLocks noChangeArrowheads="1"/>
          </p:cNvSpPr>
          <p:nvPr/>
        </p:nvSpPr>
        <p:spPr bwMode="auto">
          <a:xfrm>
            <a:off x="3574232" y="1904792"/>
            <a:ext cx="240545" cy="138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500</a:t>
            </a:r>
          </a:p>
        </p:txBody>
      </p:sp>
      <p:sp>
        <p:nvSpPr>
          <p:cNvPr id="50" name="Rectangle 31"/>
          <p:cNvSpPr>
            <a:spLocks noChangeArrowheads="1"/>
          </p:cNvSpPr>
          <p:nvPr/>
        </p:nvSpPr>
        <p:spPr bwMode="auto">
          <a:xfrm>
            <a:off x="3469206" y="3594993"/>
            <a:ext cx="152285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LPS :         </a:t>
            </a:r>
            <a:r>
              <a:rPr kumimoji="0" lang="fr-FR" altLang="fr-FR" sz="1000" b="0" i="0" u="none" strike="noStrike" cap="none" normalizeH="0" dirty="0" smtClean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    -                + </a:t>
            </a:r>
          </a:p>
        </p:txBody>
      </p:sp>
      <p:sp>
        <p:nvSpPr>
          <p:cNvPr id="51" name="Rectangle 31"/>
          <p:cNvSpPr>
            <a:spLocks noChangeArrowheads="1"/>
          </p:cNvSpPr>
          <p:nvPr/>
        </p:nvSpPr>
        <p:spPr bwMode="auto">
          <a:xfrm rot="16200000">
            <a:off x="2865799" y="2667382"/>
            <a:ext cx="1124355" cy="131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dirty="0" smtClean="0">
                <a:cs typeface="Arial" panose="020B0604020202020204" pitchFamily="34" charset="0"/>
              </a:rPr>
              <a:t>Il1b/</a:t>
            </a:r>
            <a:r>
              <a:rPr lang="fr-FR" altLang="fr-FR" sz="1000" dirty="0" err="1" smtClean="0">
                <a:cs typeface="Arial" panose="020B0604020202020204" pitchFamily="34" charset="0"/>
              </a:rPr>
              <a:t>actin</a:t>
            </a:r>
            <a:r>
              <a:rPr lang="fr-FR" altLang="fr-FR" sz="1000" dirty="0" smtClean="0">
                <a:cs typeface="Arial" panose="020B0604020202020204" pitchFamily="34" charset="0"/>
              </a:rPr>
              <a:t> </a:t>
            </a:r>
            <a:r>
              <a:rPr lang="fr-FR" altLang="fr-FR" sz="1000" dirty="0" err="1" smtClean="0">
                <a:cs typeface="Arial" panose="020B0604020202020204" pitchFamily="34" charset="0"/>
              </a:rPr>
              <a:t>mRNA</a:t>
            </a:r>
            <a:r>
              <a:rPr lang="fr-FR" altLang="fr-FR" sz="1000" dirty="0" smtClean="0">
                <a:cs typeface="Arial" panose="020B0604020202020204" pitchFamily="34" charset="0"/>
              </a:rPr>
              <a:t> (</a:t>
            </a:r>
            <a:r>
              <a:rPr lang="fr-FR" altLang="fr-FR" sz="1000" dirty="0" err="1" smtClean="0">
                <a:cs typeface="Arial" panose="020B0604020202020204" pitchFamily="34" charset="0"/>
              </a:rPr>
              <a:t>fold</a:t>
            </a:r>
            <a:r>
              <a:rPr lang="fr-FR" altLang="fr-FR" sz="1000" dirty="0" smtClean="0">
                <a:cs typeface="Arial" panose="020B0604020202020204" pitchFamily="34" charset="0"/>
              </a:rPr>
              <a:t>)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52" name="Rectangle 64"/>
          <p:cNvSpPr>
            <a:spLocks noChangeArrowheads="1"/>
          </p:cNvSpPr>
          <p:nvPr/>
        </p:nvSpPr>
        <p:spPr bwMode="auto">
          <a:xfrm>
            <a:off x="1991536" y="1942816"/>
            <a:ext cx="72000" cy="720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3" name="Freeform 65"/>
          <p:cNvSpPr>
            <a:spLocks noEditPoints="1"/>
          </p:cNvSpPr>
          <p:nvPr/>
        </p:nvSpPr>
        <p:spPr bwMode="auto">
          <a:xfrm>
            <a:off x="1989947" y="1942816"/>
            <a:ext cx="72000" cy="72000"/>
          </a:xfrm>
          <a:custGeom>
            <a:avLst/>
            <a:gdLst>
              <a:gd name="T0" fmla="*/ 0 w 384"/>
              <a:gd name="T1" fmla="*/ 24 h 376"/>
              <a:gd name="T2" fmla="*/ 24 w 384"/>
              <a:gd name="T3" fmla="*/ 0 h 376"/>
              <a:gd name="T4" fmla="*/ 360 w 384"/>
              <a:gd name="T5" fmla="*/ 0 h 376"/>
              <a:gd name="T6" fmla="*/ 384 w 384"/>
              <a:gd name="T7" fmla="*/ 24 h 376"/>
              <a:gd name="T8" fmla="*/ 384 w 384"/>
              <a:gd name="T9" fmla="*/ 352 h 376"/>
              <a:gd name="T10" fmla="*/ 360 w 384"/>
              <a:gd name="T11" fmla="*/ 376 h 376"/>
              <a:gd name="T12" fmla="*/ 24 w 384"/>
              <a:gd name="T13" fmla="*/ 376 h 376"/>
              <a:gd name="T14" fmla="*/ 0 w 384"/>
              <a:gd name="T15" fmla="*/ 352 h 376"/>
              <a:gd name="T16" fmla="*/ 0 w 384"/>
              <a:gd name="T17" fmla="*/ 24 h 376"/>
              <a:gd name="T18" fmla="*/ 48 w 384"/>
              <a:gd name="T19" fmla="*/ 352 h 376"/>
              <a:gd name="T20" fmla="*/ 24 w 384"/>
              <a:gd name="T21" fmla="*/ 328 h 376"/>
              <a:gd name="T22" fmla="*/ 360 w 384"/>
              <a:gd name="T23" fmla="*/ 328 h 376"/>
              <a:gd name="T24" fmla="*/ 336 w 384"/>
              <a:gd name="T25" fmla="*/ 352 h 376"/>
              <a:gd name="T26" fmla="*/ 336 w 384"/>
              <a:gd name="T27" fmla="*/ 24 h 376"/>
              <a:gd name="T28" fmla="*/ 360 w 384"/>
              <a:gd name="T29" fmla="*/ 48 h 376"/>
              <a:gd name="T30" fmla="*/ 24 w 384"/>
              <a:gd name="T31" fmla="*/ 48 h 376"/>
              <a:gd name="T32" fmla="*/ 48 w 384"/>
              <a:gd name="T33" fmla="*/ 24 h 376"/>
              <a:gd name="T34" fmla="*/ 48 w 384"/>
              <a:gd name="T35" fmla="*/ 352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84" h="3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60" y="0"/>
                </a:lnTo>
                <a:cubicBezTo>
                  <a:pt x="374" y="0"/>
                  <a:pt x="384" y="11"/>
                  <a:pt x="384" y="24"/>
                </a:cubicBezTo>
                <a:lnTo>
                  <a:pt x="384" y="352"/>
                </a:lnTo>
                <a:cubicBezTo>
                  <a:pt x="384" y="366"/>
                  <a:pt x="374" y="376"/>
                  <a:pt x="360" y="376"/>
                </a:cubicBezTo>
                <a:lnTo>
                  <a:pt x="24" y="376"/>
                </a:lnTo>
                <a:cubicBezTo>
                  <a:pt x="11" y="376"/>
                  <a:pt x="0" y="366"/>
                  <a:pt x="0" y="352"/>
                </a:cubicBezTo>
                <a:lnTo>
                  <a:pt x="0" y="24"/>
                </a:lnTo>
                <a:close/>
                <a:moveTo>
                  <a:pt x="48" y="352"/>
                </a:moveTo>
                <a:lnTo>
                  <a:pt x="24" y="328"/>
                </a:lnTo>
                <a:lnTo>
                  <a:pt x="360" y="328"/>
                </a:lnTo>
                <a:lnTo>
                  <a:pt x="336" y="352"/>
                </a:lnTo>
                <a:lnTo>
                  <a:pt x="336" y="24"/>
                </a:lnTo>
                <a:lnTo>
                  <a:pt x="360" y="48"/>
                </a:lnTo>
                <a:lnTo>
                  <a:pt x="24" y="48"/>
                </a:lnTo>
                <a:lnTo>
                  <a:pt x="48" y="24"/>
                </a:lnTo>
                <a:lnTo>
                  <a:pt x="48" y="3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4" name="Rectangle 66"/>
          <p:cNvSpPr>
            <a:spLocks noChangeArrowheads="1"/>
          </p:cNvSpPr>
          <p:nvPr/>
        </p:nvSpPr>
        <p:spPr bwMode="auto">
          <a:xfrm>
            <a:off x="2094723" y="1901872"/>
            <a:ext cx="2003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5" name="Rectangle 67"/>
          <p:cNvSpPr>
            <a:spLocks noChangeArrowheads="1"/>
          </p:cNvSpPr>
          <p:nvPr/>
        </p:nvSpPr>
        <p:spPr bwMode="auto">
          <a:xfrm>
            <a:off x="1991536" y="2068228"/>
            <a:ext cx="72000" cy="720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6" name="Freeform 68"/>
          <p:cNvSpPr>
            <a:spLocks noEditPoints="1"/>
          </p:cNvSpPr>
          <p:nvPr/>
        </p:nvSpPr>
        <p:spPr bwMode="auto">
          <a:xfrm>
            <a:off x="1989947" y="2068228"/>
            <a:ext cx="72000" cy="72000"/>
          </a:xfrm>
          <a:custGeom>
            <a:avLst/>
            <a:gdLst>
              <a:gd name="T0" fmla="*/ 0 w 384"/>
              <a:gd name="T1" fmla="*/ 24 h 376"/>
              <a:gd name="T2" fmla="*/ 24 w 384"/>
              <a:gd name="T3" fmla="*/ 0 h 376"/>
              <a:gd name="T4" fmla="*/ 360 w 384"/>
              <a:gd name="T5" fmla="*/ 0 h 376"/>
              <a:gd name="T6" fmla="*/ 384 w 384"/>
              <a:gd name="T7" fmla="*/ 24 h 376"/>
              <a:gd name="T8" fmla="*/ 384 w 384"/>
              <a:gd name="T9" fmla="*/ 352 h 376"/>
              <a:gd name="T10" fmla="*/ 360 w 384"/>
              <a:gd name="T11" fmla="*/ 376 h 376"/>
              <a:gd name="T12" fmla="*/ 24 w 384"/>
              <a:gd name="T13" fmla="*/ 376 h 376"/>
              <a:gd name="T14" fmla="*/ 0 w 384"/>
              <a:gd name="T15" fmla="*/ 352 h 376"/>
              <a:gd name="T16" fmla="*/ 0 w 384"/>
              <a:gd name="T17" fmla="*/ 24 h 376"/>
              <a:gd name="T18" fmla="*/ 48 w 384"/>
              <a:gd name="T19" fmla="*/ 352 h 376"/>
              <a:gd name="T20" fmla="*/ 24 w 384"/>
              <a:gd name="T21" fmla="*/ 328 h 376"/>
              <a:gd name="T22" fmla="*/ 360 w 384"/>
              <a:gd name="T23" fmla="*/ 328 h 376"/>
              <a:gd name="T24" fmla="*/ 336 w 384"/>
              <a:gd name="T25" fmla="*/ 352 h 376"/>
              <a:gd name="T26" fmla="*/ 336 w 384"/>
              <a:gd name="T27" fmla="*/ 24 h 376"/>
              <a:gd name="T28" fmla="*/ 360 w 384"/>
              <a:gd name="T29" fmla="*/ 48 h 376"/>
              <a:gd name="T30" fmla="*/ 24 w 384"/>
              <a:gd name="T31" fmla="*/ 48 h 376"/>
              <a:gd name="T32" fmla="*/ 48 w 384"/>
              <a:gd name="T33" fmla="*/ 24 h 376"/>
              <a:gd name="T34" fmla="*/ 48 w 384"/>
              <a:gd name="T35" fmla="*/ 352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84" h="3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60" y="0"/>
                </a:lnTo>
                <a:cubicBezTo>
                  <a:pt x="374" y="0"/>
                  <a:pt x="384" y="11"/>
                  <a:pt x="384" y="24"/>
                </a:cubicBezTo>
                <a:lnTo>
                  <a:pt x="384" y="352"/>
                </a:lnTo>
                <a:cubicBezTo>
                  <a:pt x="384" y="366"/>
                  <a:pt x="374" y="376"/>
                  <a:pt x="360" y="376"/>
                </a:cubicBezTo>
                <a:lnTo>
                  <a:pt x="24" y="376"/>
                </a:lnTo>
                <a:cubicBezTo>
                  <a:pt x="11" y="376"/>
                  <a:pt x="0" y="366"/>
                  <a:pt x="0" y="352"/>
                </a:cubicBezTo>
                <a:lnTo>
                  <a:pt x="0" y="24"/>
                </a:lnTo>
                <a:close/>
                <a:moveTo>
                  <a:pt x="48" y="352"/>
                </a:moveTo>
                <a:lnTo>
                  <a:pt x="24" y="328"/>
                </a:lnTo>
                <a:lnTo>
                  <a:pt x="360" y="328"/>
                </a:lnTo>
                <a:lnTo>
                  <a:pt x="336" y="352"/>
                </a:lnTo>
                <a:lnTo>
                  <a:pt x="336" y="24"/>
                </a:lnTo>
                <a:lnTo>
                  <a:pt x="360" y="48"/>
                </a:lnTo>
                <a:lnTo>
                  <a:pt x="24" y="48"/>
                </a:lnTo>
                <a:lnTo>
                  <a:pt x="48" y="24"/>
                </a:lnTo>
                <a:lnTo>
                  <a:pt x="48" y="3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7" name="Rectangle 69"/>
          <p:cNvSpPr>
            <a:spLocks noChangeArrowheads="1"/>
          </p:cNvSpPr>
          <p:nvPr/>
        </p:nvSpPr>
        <p:spPr bwMode="auto">
          <a:xfrm>
            <a:off x="2094723" y="2027284"/>
            <a:ext cx="45044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Hsp70</a:t>
            </a:r>
            <a:r>
              <a:rPr kumimoji="0" lang="fr-FR" altLang="fr-FR" sz="1000" b="0" i="0" u="none" strike="noStrike" cap="none" normalizeH="0" baseline="30000" dirty="0" smtClean="0">
                <a:ln>
                  <a:noFill/>
                </a:ln>
                <a:effectLst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58" name="Rectangle 64"/>
          <p:cNvSpPr>
            <a:spLocks noChangeArrowheads="1"/>
          </p:cNvSpPr>
          <p:nvPr/>
        </p:nvSpPr>
        <p:spPr bwMode="auto">
          <a:xfrm>
            <a:off x="3970854" y="1945199"/>
            <a:ext cx="72000" cy="720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9" name="Freeform 65"/>
          <p:cNvSpPr>
            <a:spLocks noEditPoints="1"/>
          </p:cNvSpPr>
          <p:nvPr/>
        </p:nvSpPr>
        <p:spPr bwMode="auto">
          <a:xfrm>
            <a:off x="3969265" y="1945199"/>
            <a:ext cx="72000" cy="72000"/>
          </a:xfrm>
          <a:custGeom>
            <a:avLst/>
            <a:gdLst>
              <a:gd name="T0" fmla="*/ 0 w 384"/>
              <a:gd name="T1" fmla="*/ 24 h 376"/>
              <a:gd name="T2" fmla="*/ 24 w 384"/>
              <a:gd name="T3" fmla="*/ 0 h 376"/>
              <a:gd name="T4" fmla="*/ 360 w 384"/>
              <a:gd name="T5" fmla="*/ 0 h 376"/>
              <a:gd name="T6" fmla="*/ 384 w 384"/>
              <a:gd name="T7" fmla="*/ 24 h 376"/>
              <a:gd name="T8" fmla="*/ 384 w 384"/>
              <a:gd name="T9" fmla="*/ 352 h 376"/>
              <a:gd name="T10" fmla="*/ 360 w 384"/>
              <a:gd name="T11" fmla="*/ 376 h 376"/>
              <a:gd name="T12" fmla="*/ 24 w 384"/>
              <a:gd name="T13" fmla="*/ 376 h 376"/>
              <a:gd name="T14" fmla="*/ 0 w 384"/>
              <a:gd name="T15" fmla="*/ 352 h 376"/>
              <a:gd name="T16" fmla="*/ 0 w 384"/>
              <a:gd name="T17" fmla="*/ 24 h 376"/>
              <a:gd name="T18" fmla="*/ 48 w 384"/>
              <a:gd name="T19" fmla="*/ 352 h 376"/>
              <a:gd name="T20" fmla="*/ 24 w 384"/>
              <a:gd name="T21" fmla="*/ 328 h 376"/>
              <a:gd name="T22" fmla="*/ 360 w 384"/>
              <a:gd name="T23" fmla="*/ 328 h 376"/>
              <a:gd name="T24" fmla="*/ 336 w 384"/>
              <a:gd name="T25" fmla="*/ 352 h 376"/>
              <a:gd name="T26" fmla="*/ 336 w 384"/>
              <a:gd name="T27" fmla="*/ 24 h 376"/>
              <a:gd name="T28" fmla="*/ 360 w 384"/>
              <a:gd name="T29" fmla="*/ 48 h 376"/>
              <a:gd name="T30" fmla="*/ 24 w 384"/>
              <a:gd name="T31" fmla="*/ 48 h 376"/>
              <a:gd name="T32" fmla="*/ 48 w 384"/>
              <a:gd name="T33" fmla="*/ 24 h 376"/>
              <a:gd name="T34" fmla="*/ 48 w 384"/>
              <a:gd name="T35" fmla="*/ 352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84" h="3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60" y="0"/>
                </a:lnTo>
                <a:cubicBezTo>
                  <a:pt x="374" y="0"/>
                  <a:pt x="384" y="11"/>
                  <a:pt x="384" y="24"/>
                </a:cubicBezTo>
                <a:lnTo>
                  <a:pt x="384" y="352"/>
                </a:lnTo>
                <a:cubicBezTo>
                  <a:pt x="384" y="366"/>
                  <a:pt x="374" y="376"/>
                  <a:pt x="360" y="376"/>
                </a:cubicBezTo>
                <a:lnTo>
                  <a:pt x="24" y="376"/>
                </a:lnTo>
                <a:cubicBezTo>
                  <a:pt x="11" y="376"/>
                  <a:pt x="0" y="366"/>
                  <a:pt x="0" y="352"/>
                </a:cubicBezTo>
                <a:lnTo>
                  <a:pt x="0" y="24"/>
                </a:lnTo>
                <a:close/>
                <a:moveTo>
                  <a:pt x="48" y="352"/>
                </a:moveTo>
                <a:lnTo>
                  <a:pt x="24" y="328"/>
                </a:lnTo>
                <a:lnTo>
                  <a:pt x="360" y="328"/>
                </a:lnTo>
                <a:lnTo>
                  <a:pt x="336" y="352"/>
                </a:lnTo>
                <a:lnTo>
                  <a:pt x="336" y="24"/>
                </a:lnTo>
                <a:lnTo>
                  <a:pt x="360" y="48"/>
                </a:lnTo>
                <a:lnTo>
                  <a:pt x="24" y="48"/>
                </a:lnTo>
                <a:lnTo>
                  <a:pt x="48" y="24"/>
                </a:lnTo>
                <a:lnTo>
                  <a:pt x="48" y="3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0" name="Rectangle 66"/>
          <p:cNvSpPr>
            <a:spLocks noChangeArrowheads="1"/>
          </p:cNvSpPr>
          <p:nvPr/>
        </p:nvSpPr>
        <p:spPr bwMode="auto">
          <a:xfrm>
            <a:off x="4074041" y="1904255"/>
            <a:ext cx="2003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1" name="Rectangle 67"/>
          <p:cNvSpPr>
            <a:spLocks noChangeArrowheads="1"/>
          </p:cNvSpPr>
          <p:nvPr/>
        </p:nvSpPr>
        <p:spPr bwMode="auto">
          <a:xfrm>
            <a:off x="3970854" y="2070611"/>
            <a:ext cx="72000" cy="720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2" name="Freeform 68"/>
          <p:cNvSpPr>
            <a:spLocks noEditPoints="1"/>
          </p:cNvSpPr>
          <p:nvPr/>
        </p:nvSpPr>
        <p:spPr bwMode="auto">
          <a:xfrm>
            <a:off x="3969265" y="2070611"/>
            <a:ext cx="72000" cy="72000"/>
          </a:xfrm>
          <a:custGeom>
            <a:avLst/>
            <a:gdLst>
              <a:gd name="T0" fmla="*/ 0 w 384"/>
              <a:gd name="T1" fmla="*/ 24 h 376"/>
              <a:gd name="T2" fmla="*/ 24 w 384"/>
              <a:gd name="T3" fmla="*/ 0 h 376"/>
              <a:gd name="T4" fmla="*/ 360 w 384"/>
              <a:gd name="T5" fmla="*/ 0 h 376"/>
              <a:gd name="T6" fmla="*/ 384 w 384"/>
              <a:gd name="T7" fmla="*/ 24 h 376"/>
              <a:gd name="T8" fmla="*/ 384 w 384"/>
              <a:gd name="T9" fmla="*/ 352 h 376"/>
              <a:gd name="T10" fmla="*/ 360 w 384"/>
              <a:gd name="T11" fmla="*/ 376 h 376"/>
              <a:gd name="T12" fmla="*/ 24 w 384"/>
              <a:gd name="T13" fmla="*/ 376 h 376"/>
              <a:gd name="T14" fmla="*/ 0 w 384"/>
              <a:gd name="T15" fmla="*/ 352 h 376"/>
              <a:gd name="T16" fmla="*/ 0 w 384"/>
              <a:gd name="T17" fmla="*/ 24 h 376"/>
              <a:gd name="T18" fmla="*/ 48 w 384"/>
              <a:gd name="T19" fmla="*/ 352 h 376"/>
              <a:gd name="T20" fmla="*/ 24 w 384"/>
              <a:gd name="T21" fmla="*/ 328 h 376"/>
              <a:gd name="T22" fmla="*/ 360 w 384"/>
              <a:gd name="T23" fmla="*/ 328 h 376"/>
              <a:gd name="T24" fmla="*/ 336 w 384"/>
              <a:gd name="T25" fmla="*/ 352 h 376"/>
              <a:gd name="T26" fmla="*/ 336 w 384"/>
              <a:gd name="T27" fmla="*/ 24 h 376"/>
              <a:gd name="T28" fmla="*/ 360 w 384"/>
              <a:gd name="T29" fmla="*/ 48 h 376"/>
              <a:gd name="T30" fmla="*/ 24 w 384"/>
              <a:gd name="T31" fmla="*/ 48 h 376"/>
              <a:gd name="T32" fmla="*/ 48 w 384"/>
              <a:gd name="T33" fmla="*/ 24 h 376"/>
              <a:gd name="T34" fmla="*/ 48 w 384"/>
              <a:gd name="T35" fmla="*/ 352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84" h="3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60" y="0"/>
                </a:lnTo>
                <a:cubicBezTo>
                  <a:pt x="374" y="0"/>
                  <a:pt x="384" y="11"/>
                  <a:pt x="384" y="24"/>
                </a:cubicBezTo>
                <a:lnTo>
                  <a:pt x="384" y="352"/>
                </a:lnTo>
                <a:cubicBezTo>
                  <a:pt x="384" y="366"/>
                  <a:pt x="374" y="376"/>
                  <a:pt x="360" y="376"/>
                </a:cubicBezTo>
                <a:lnTo>
                  <a:pt x="24" y="376"/>
                </a:lnTo>
                <a:cubicBezTo>
                  <a:pt x="11" y="376"/>
                  <a:pt x="0" y="366"/>
                  <a:pt x="0" y="352"/>
                </a:cubicBezTo>
                <a:lnTo>
                  <a:pt x="0" y="24"/>
                </a:lnTo>
                <a:close/>
                <a:moveTo>
                  <a:pt x="48" y="352"/>
                </a:moveTo>
                <a:lnTo>
                  <a:pt x="24" y="328"/>
                </a:lnTo>
                <a:lnTo>
                  <a:pt x="360" y="328"/>
                </a:lnTo>
                <a:lnTo>
                  <a:pt x="336" y="352"/>
                </a:lnTo>
                <a:lnTo>
                  <a:pt x="336" y="24"/>
                </a:lnTo>
                <a:lnTo>
                  <a:pt x="360" y="48"/>
                </a:lnTo>
                <a:lnTo>
                  <a:pt x="24" y="48"/>
                </a:lnTo>
                <a:lnTo>
                  <a:pt x="48" y="24"/>
                </a:lnTo>
                <a:lnTo>
                  <a:pt x="48" y="3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3" name="Rectangle 69"/>
          <p:cNvSpPr>
            <a:spLocks noChangeArrowheads="1"/>
          </p:cNvSpPr>
          <p:nvPr/>
        </p:nvSpPr>
        <p:spPr bwMode="auto">
          <a:xfrm>
            <a:off x="4074041" y="2029667"/>
            <a:ext cx="45044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Hsp70</a:t>
            </a:r>
            <a:r>
              <a:rPr kumimoji="0" lang="fr-FR" altLang="fr-FR" sz="1000" b="0" i="0" u="none" strike="noStrike" cap="none" normalizeH="0" baseline="30000" dirty="0" smtClean="0">
                <a:ln>
                  <a:noFill/>
                </a:ln>
                <a:effectLst/>
                <a:cs typeface="Arial" panose="020B0604020202020204" pitchFamily="34" charset="0"/>
              </a:rPr>
              <a:t>-/-</a:t>
            </a:r>
          </a:p>
        </p:txBody>
      </p:sp>
      <p:cxnSp>
        <p:nvCxnSpPr>
          <p:cNvPr id="64" name="Connecteur droit 63"/>
          <p:cNvCxnSpPr/>
          <p:nvPr/>
        </p:nvCxnSpPr>
        <p:spPr>
          <a:xfrm>
            <a:off x="4780200" y="199754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ZoneTexte 64"/>
          <p:cNvSpPr txBox="1"/>
          <p:nvPr/>
        </p:nvSpPr>
        <p:spPr>
          <a:xfrm>
            <a:off x="4720894" y="1817064"/>
            <a:ext cx="3706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Connecteur droit 65"/>
          <p:cNvCxnSpPr/>
          <p:nvPr/>
        </p:nvCxnSpPr>
        <p:spPr>
          <a:xfrm>
            <a:off x="2799027" y="197841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ZoneTexte 66"/>
          <p:cNvSpPr txBox="1"/>
          <p:nvPr/>
        </p:nvSpPr>
        <p:spPr>
          <a:xfrm>
            <a:off x="2739721" y="1797932"/>
            <a:ext cx="3706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49580" y="4335963"/>
            <a:ext cx="680841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5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: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BMDMs from WT or Hsp70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C57/BL6 mice were stimulated or not with 100ng/mL LPS for 20h 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Nlrp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Il1b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mRNA expression was evaluated by QPCR. Data are the mean of three independent experiments ±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s.d.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Statistics compare WT and Hsp70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BMDMs: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.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not significant using two tailed t test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21338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Image 138"/>
          <p:cNvPicPr>
            <a:picLocks noChangeAspect="1"/>
          </p:cNvPicPr>
          <p:nvPr/>
        </p:nvPicPr>
        <p:blipFill rotWithShape="1">
          <a:blip r:embed="rId2"/>
          <a:srcRect l="38785" t="57349" r="50904" b="28272"/>
          <a:stretch/>
        </p:blipFill>
        <p:spPr>
          <a:xfrm>
            <a:off x="1767256" y="3804871"/>
            <a:ext cx="942975" cy="739775"/>
          </a:xfrm>
          <a:prstGeom prst="rect">
            <a:avLst/>
          </a:prstGeom>
        </p:spPr>
      </p:pic>
      <p:pic>
        <p:nvPicPr>
          <p:cNvPr id="140" name="Image 139"/>
          <p:cNvPicPr>
            <a:picLocks noChangeAspect="1"/>
          </p:cNvPicPr>
          <p:nvPr/>
        </p:nvPicPr>
        <p:blipFill rotWithShape="1">
          <a:blip r:embed="rId3"/>
          <a:srcRect l="38737" t="57386" r="50958" b="28233"/>
          <a:stretch/>
        </p:blipFill>
        <p:spPr>
          <a:xfrm>
            <a:off x="761376" y="3804871"/>
            <a:ext cx="942380" cy="739775"/>
          </a:xfrm>
          <a:prstGeom prst="rect">
            <a:avLst/>
          </a:prstGeom>
        </p:spPr>
      </p:pic>
      <p:pic>
        <p:nvPicPr>
          <p:cNvPr id="141" name="Image 140"/>
          <p:cNvPicPr>
            <a:picLocks noChangeAspect="1"/>
          </p:cNvPicPr>
          <p:nvPr/>
        </p:nvPicPr>
        <p:blipFill rotWithShape="1">
          <a:blip r:embed="rId4"/>
          <a:srcRect l="38898" t="57349" r="50791" b="28271"/>
          <a:stretch/>
        </p:blipFill>
        <p:spPr>
          <a:xfrm>
            <a:off x="2773731" y="3804871"/>
            <a:ext cx="942975" cy="739775"/>
          </a:xfrm>
          <a:prstGeom prst="rect">
            <a:avLst/>
          </a:prstGeom>
        </p:spPr>
      </p:pic>
      <p:pic>
        <p:nvPicPr>
          <p:cNvPr id="142" name="Image 141"/>
          <p:cNvPicPr>
            <a:picLocks noChangeAspect="1"/>
          </p:cNvPicPr>
          <p:nvPr/>
        </p:nvPicPr>
        <p:blipFill rotWithShape="1">
          <a:blip r:embed="rId5"/>
          <a:srcRect l="42452" t="64055" r="47236" b="21563"/>
          <a:stretch/>
        </p:blipFill>
        <p:spPr>
          <a:xfrm>
            <a:off x="2761030" y="3019060"/>
            <a:ext cx="942977" cy="739775"/>
          </a:xfrm>
          <a:prstGeom prst="rect">
            <a:avLst/>
          </a:prstGeom>
        </p:spPr>
      </p:pic>
      <p:pic>
        <p:nvPicPr>
          <p:cNvPr id="143" name="Image 142"/>
          <p:cNvPicPr>
            <a:picLocks noChangeAspect="1"/>
          </p:cNvPicPr>
          <p:nvPr/>
        </p:nvPicPr>
        <p:blipFill rotWithShape="1">
          <a:blip r:embed="rId6"/>
          <a:srcRect l="42530" t="63919" r="47159" b="21701"/>
          <a:stretch/>
        </p:blipFill>
        <p:spPr>
          <a:xfrm>
            <a:off x="1767256" y="3019060"/>
            <a:ext cx="942977" cy="739774"/>
          </a:xfrm>
          <a:prstGeom prst="rect">
            <a:avLst/>
          </a:prstGeom>
        </p:spPr>
      </p:pic>
      <p:pic>
        <p:nvPicPr>
          <p:cNvPr id="144" name="Image 143"/>
          <p:cNvPicPr>
            <a:picLocks noChangeAspect="1"/>
          </p:cNvPicPr>
          <p:nvPr/>
        </p:nvPicPr>
        <p:blipFill rotWithShape="1">
          <a:blip r:embed="rId7"/>
          <a:srcRect l="42521" t="63856" r="47169" b="21702"/>
          <a:stretch/>
        </p:blipFill>
        <p:spPr>
          <a:xfrm>
            <a:off x="767130" y="3017472"/>
            <a:ext cx="942975" cy="742950"/>
          </a:xfrm>
          <a:prstGeom prst="rect">
            <a:avLst/>
          </a:prstGeom>
        </p:spPr>
      </p:pic>
      <p:pic>
        <p:nvPicPr>
          <p:cNvPr id="145" name="Image 144"/>
          <p:cNvPicPr>
            <a:picLocks noChangeAspect="1"/>
          </p:cNvPicPr>
          <p:nvPr/>
        </p:nvPicPr>
        <p:blipFill rotWithShape="1">
          <a:blip r:embed="rId8"/>
          <a:srcRect l="48246" t="29985" r="42766" b="49661"/>
          <a:stretch/>
        </p:blipFill>
        <p:spPr>
          <a:xfrm rot="16200000">
            <a:off x="862687" y="2136699"/>
            <a:ext cx="739774" cy="942377"/>
          </a:xfrm>
          <a:prstGeom prst="rect">
            <a:avLst/>
          </a:prstGeom>
        </p:spPr>
      </p:pic>
      <p:pic>
        <p:nvPicPr>
          <p:cNvPr id="146" name="Image 145"/>
          <p:cNvPicPr>
            <a:picLocks noChangeAspect="1"/>
          </p:cNvPicPr>
          <p:nvPr/>
        </p:nvPicPr>
        <p:blipFill rotWithShape="1">
          <a:blip r:embed="rId9"/>
          <a:srcRect l="48240" t="30041" r="42735" b="49592"/>
          <a:stretch/>
        </p:blipFill>
        <p:spPr>
          <a:xfrm rot="16200000">
            <a:off x="1864098" y="2136400"/>
            <a:ext cx="742948" cy="942975"/>
          </a:xfrm>
          <a:prstGeom prst="rect">
            <a:avLst/>
          </a:prstGeom>
        </p:spPr>
      </p:pic>
      <p:pic>
        <p:nvPicPr>
          <p:cNvPr id="147" name="Image 146"/>
          <p:cNvPicPr>
            <a:picLocks noChangeAspect="1"/>
          </p:cNvPicPr>
          <p:nvPr/>
        </p:nvPicPr>
        <p:blipFill rotWithShape="1">
          <a:blip r:embed="rId10"/>
          <a:srcRect l="48231" t="30061" r="42742" b="49573"/>
          <a:stretch/>
        </p:blipFill>
        <p:spPr>
          <a:xfrm rot="16200000">
            <a:off x="2861049" y="2136401"/>
            <a:ext cx="742950" cy="942972"/>
          </a:xfrm>
          <a:prstGeom prst="rect">
            <a:avLst/>
          </a:prstGeom>
        </p:spPr>
      </p:pic>
      <p:pic>
        <p:nvPicPr>
          <p:cNvPr id="148" name="Image 147"/>
          <p:cNvPicPr>
            <a:picLocks noChangeAspect="1"/>
          </p:cNvPicPr>
          <p:nvPr/>
        </p:nvPicPr>
        <p:blipFill rotWithShape="1">
          <a:blip r:embed="rId11"/>
          <a:srcRect l="41692" t="73764" r="47993" b="11829"/>
          <a:stretch/>
        </p:blipFill>
        <p:spPr>
          <a:xfrm>
            <a:off x="2761030" y="1448810"/>
            <a:ext cx="942977" cy="741041"/>
          </a:xfrm>
          <a:prstGeom prst="rect">
            <a:avLst/>
          </a:prstGeom>
        </p:spPr>
      </p:pic>
      <p:pic>
        <p:nvPicPr>
          <p:cNvPr id="149" name="Image 148"/>
          <p:cNvPicPr>
            <a:picLocks noChangeAspect="1"/>
          </p:cNvPicPr>
          <p:nvPr/>
        </p:nvPicPr>
        <p:blipFill rotWithShape="1">
          <a:blip r:embed="rId12"/>
          <a:srcRect l="41736" t="73751" r="47954" b="11829"/>
          <a:stretch/>
        </p:blipFill>
        <p:spPr>
          <a:xfrm>
            <a:off x="767132" y="1448445"/>
            <a:ext cx="942974" cy="741771"/>
          </a:xfrm>
          <a:prstGeom prst="rect">
            <a:avLst/>
          </a:prstGeom>
        </p:spPr>
      </p:pic>
      <p:pic>
        <p:nvPicPr>
          <p:cNvPr id="150" name="Image 149"/>
          <p:cNvPicPr>
            <a:picLocks noChangeAspect="1"/>
          </p:cNvPicPr>
          <p:nvPr/>
        </p:nvPicPr>
        <p:blipFill rotWithShape="1">
          <a:blip r:embed="rId13"/>
          <a:srcRect l="41680" t="73728" r="48011" b="11832"/>
          <a:stretch/>
        </p:blipFill>
        <p:spPr>
          <a:xfrm>
            <a:off x="1764081" y="1447896"/>
            <a:ext cx="942974" cy="742868"/>
          </a:xfrm>
          <a:prstGeom prst="rect">
            <a:avLst/>
          </a:prstGeom>
        </p:spPr>
      </p:pic>
      <p:sp>
        <p:nvSpPr>
          <p:cNvPr id="151" name="ZoneTexte 150"/>
          <p:cNvSpPr txBox="1"/>
          <p:nvPr/>
        </p:nvSpPr>
        <p:spPr>
          <a:xfrm>
            <a:off x="337629" y="2330888"/>
            <a:ext cx="43313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r"/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g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ZoneTexte 151"/>
          <p:cNvSpPr txBox="1"/>
          <p:nvPr/>
        </p:nvSpPr>
        <p:spPr>
          <a:xfrm>
            <a:off x="345644" y="3265837"/>
            <a:ext cx="4251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ZoneTexte 152"/>
          <p:cNvSpPr txBox="1"/>
          <p:nvPr/>
        </p:nvSpPr>
        <p:spPr>
          <a:xfrm>
            <a:off x="337629" y="3897759"/>
            <a:ext cx="43313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r"/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g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ZoneTexte 153"/>
          <p:cNvSpPr txBox="1"/>
          <p:nvPr/>
        </p:nvSpPr>
        <p:spPr>
          <a:xfrm>
            <a:off x="345644" y="1696220"/>
            <a:ext cx="4251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ZoneTexte 154"/>
          <p:cNvSpPr txBox="1"/>
          <p:nvPr/>
        </p:nvSpPr>
        <p:spPr>
          <a:xfrm>
            <a:off x="994783" y="122129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  <a:endParaRPr lang="fr-FR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ZoneTexte 155"/>
          <p:cNvSpPr txBox="1"/>
          <p:nvPr/>
        </p:nvSpPr>
        <p:spPr>
          <a:xfrm>
            <a:off x="1733052" y="1221292"/>
            <a:ext cx="9717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1</a:t>
            </a:r>
            <a:endParaRPr lang="fr-FR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ZoneTexte 156"/>
          <p:cNvSpPr txBox="1"/>
          <p:nvPr/>
        </p:nvSpPr>
        <p:spPr>
          <a:xfrm>
            <a:off x="2868619" y="1036626"/>
            <a:ext cx="6928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</a:p>
          <a:p>
            <a:pPr algn="ctr"/>
            <a:r>
              <a:rPr lang="fr-FR" sz="10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fr-FR" sz="10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8" name="Connecteur droit 157"/>
          <p:cNvCxnSpPr>
            <a:cxnSpLocks noChangeAspect="1"/>
          </p:cNvCxnSpPr>
          <p:nvPr/>
        </p:nvCxnSpPr>
        <p:spPr>
          <a:xfrm>
            <a:off x="800820" y="1646467"/>
            <a:ext cx="28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ZoneTexte 158"/>
          <p:cNvSpPr txBox="1">
            <a:spLocks noChangeAspect="1"/>
          </p:cNvSpPr>
          <p:nvPr/>
        </p:nvSpPr>
        <p:spPr>
          <a:xfrm>
            <a:off x="688694" y="1409950"/>
            <a:ext cx="624829" cy="2631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chemeClr val="bg1"/>
                </a:solidFill>
              </a:rPr>
              <a:t>10µm</a:t>
            </a:r>
            <a:endParaRPr lang="fr-FR" sz="1200" dirty="0">
              <a:solidFill>
                <a:schemeClr val="bg1"/>
              </a:solidFill>
            </a:endParaRPr>
          </a:p>
        </p:txBody>
      </p:sp>
      <p:sp>
        <p:nvSpPr>
          <p:cNvPr id="160" name="Rectangle 159"/>
          <p:cNvSpPr>
            <a:spLocks noChangeArrowheads="1"/>
          </p:cNvSpPr>
          <p:nvPr/>
        </p:nvSpPr>
        <p:spPr bwMode="auto">
          <a:xfrm rot="16200000">
            <a:off x="30310" y="3702618"/>
            <a:ext cx="45044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33039"/>
            <a:r>
              <a:rPr lang="fr-FR" altLang="fr-FR" sz="1000" dirty="0">
                <a:cs typeface="Arial" panose="020B0604020202020204" pitchFamily="34" charset="0"/>
              </a:rPr>
              <a:t>H</a:t>
            </a:r>
            <a:r>
              <a:rPr lang="fr-FR" altLang="fr-FR" sz="1000" dirty="0" smtClean="0">
                <a:cs typeface="Arial" panose="020B0604020202020204" pitchFamily="34" charset="0"/>
              </a:rPr>
              <a:t>sp70</a:t>
            </a:r>
            <a:r>
              <a:rPr lang="fr-FR" altLang="fr-FR" sz="1000" baseline="30000" dirty="0" smtClean="0">
                <a:cs typeface="Arial" panose="020B0604020202020204" pitchFamily="34" charset="0"/>
              </a:rPr>
              <a:t>-</a:t>
            </a:r>
            <a:r>
              <a:rPr lang="fr-FR" altLang="fr-FR" sz="1000" baseline="30000" dirty="0">
                <a:cs typeface="Arial" panose="020B0604020202020204" pitchFamily="34" charset="0"/>
              </a:rPr>
              <a:t>/-</a:t>
            </a:r>
          </a:p>
        </p:txBody>
      </p:sp>
      <p:cxnSp>
        <p:nvCxnSpPr>
          <p:cNvPr id="161" name="Connecteur droit 160"/>
          <p:cNvCxnSpPr/>
          <p:nvPr/>
        </p:nvCxnSpPr>
        <p:spPr>
          <a:xfrm rot="16200000">
            <a:off x="64996" y="2224144"/>
            <a:ext cx="576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Connecteur droit 161"/>
          <p:cNvCxnSpPr/>
          <p:nvPr/>
        </p:nvCxnSpPr>
        <p:spPr>
          <a:xfrm rot="16200000">
            <a:off x="64996" y="3779562"/>
            <a:ext cx="576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Rectangle 159"/>
          <p:cNvSpPr>
            <a:spLocks noChangeArrowheads="1"/>
          </p:cNvSpPr>
          <p:nvPr/>
        </p:nvSpPr>
        <p:spPr bwMode="auto">
          <a:xfrm rot="16200000">
            <a:off x="155343" y="2147200"/>
            <a:ext cx="2003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33039"/>
            <a:r>
              <a:rPr lang="fr-FR" altLang="fr-FR" sz="1000" dirty="0" smtClean="0">
                <a:cs typeface="Arial" panose="020B0604020202020204" pitchFamily="34" charset="0"/>
              </a:rPr>
              <a:t>WT</a:t>
            </a:r>
            <a:endParaRPr lang="fr-FR" altLang="fr-FR" sz="1000" baseline="30000" dirty="0">
              <a:cs typeface="Arial" panose="020B0604020202020204" pitchFamily="34" charset="0"/>
            </a:endParaRPr>
          </a:p>
        </p:txBody>
      </p:sp>
      <p:grpSp>
        <p:nvGrpSpPr>
          <p:cNvPr id="164" name="Groupe 163"/>
          <p:cNvGrpSpPr/>
          <p:nvPr/>
        </p:nvGrpSpPr>
        <p:grpSpPr>
          <a:xfrm>
            <a:off x="4070731" y="2398459"/>
            <a:ext cx="1850533" cy="1534890"/>
            <a:chOff x="4070731" y="855409"/>
            <a:chExt cx="1850533" cy="1534890"/>
          </a:xfrm>
        </p:grpSpPr>
        <p:sp>
          <p:nvSpPr>
            <p:cNvPr id="165" name="Rectangle 23"/>
            <p:cNvSpPr>
              <a:spLocks noChangeArrowheads="1"/>
            </p:cNvSpPr>
            <p:nvPr/>
          </p:nvSpPr>
          <p:spPr bwMode="auto">
            <a:xfrm>
              <a:off x="4784011" y="2236411"/>
              <a:ext cx="2404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LPS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6" name="Rectangle 24"/>
            <p:cNvSpPr>
              <a:spLocks noChangeArrowheads="1"/>
            </p:cNvSpPr>
            <p:nvPr/>
          </p:nvSpPr>
          <p:spPr bwMode="auto">
            <a:xfrm>
              <a:off x="5341011" y="2236411"/>
              <a:ext cx="50815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LPS+Nig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7" name="Rectangle 25"/>
            <p:cNvSpPr>
              <a:spLocks noChangeArrowheads="1"/>
            </p:cNvSpPr>
            <p:nvPr/>
          </p:nvSpPr>
          <p:spPr bwMode="auto">
            <a:xfrm rot="16200000">
              <a:off x="3521414" y="1404726"/>
              <a:ext cx="140641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% of </a:t>
              </a:r>
              <a:r>
                <a:rPr lang="fr-FR" altLang="fr-FR" sz="1000" dirty="0" err="1" smtClean="0">
                  <a:solidFill>
                    <a:srgbClr val="000000"/>
                  </a:solidFill>
                  <a:cs typeface="Arial" panose="020B0604020202020204" pitchFamily="34" charset="0"/>
                </a:rPr>
                <a:t>cells</a:t>
              </a:r>
              <a:r>
                <a:rPr lang="fr-FR" altLang="fr-FR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fr-FR" altLang="fr-FR" sz="1000" dirty="0" err="1" smtClean="0">
                  <a:solidFill>
                    <a:srgbClr val="000000"/>
                  </a:solidFill>
                  <a:cs typeface="Arial" panose="020B0604020202020204" pitchFamily="34" charset="0"/>
                </a:rPr>
                <a:t>with</a:t>
              </a:r>
              <a:r>
                <a:rPr lang="fr-FR" altLang="fr-FR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more </a:t>
              </a:r>
              <a:r>
                <a:rPr lang="fr-FR" altLang="fr-FR" sz="1000" dirty="0" err="1" smtClean="0">
                  <a:solidFill>
                    <a:srgbClr val="000000"/>
                  </a:solidFill>
                  <a:cs typeface="Arial" panose="020B0604020202020204" pitchFamily="34" charset="0"/>
                </a:rPr>
                <a:t>than</a:t>
              </a:r>
              <a:r>
                <a:rPr lang="fr-FR" altLang="fr-FR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1 </a:t>
              </a: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SC/NLRP3 </a:t>
              </a:r>
              <a:r>
                <a:rPr kumimoji="0" lang="fr-FR" alt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peck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grpSp>
          <p:nvGrpSpPr>
            <p:cNvPr id="168" name="Groupe 167"/>
            <p:cNvGrpSpPr/>
            <p:nvPr/>
          </p:nvGrpSpPr>
          <p:grpSpPr>
            <a:xfrm>
              <a:off x="4496923" y="878031"/>
              <a:ext cx="1424341" cy="1371600"/>
              <a:chOff x="5303001" y="1268731"/>
              <a:chExt cx="1618093" cy="1371600"/>
            </a:xfrm>
          </p:grpSpPr>
          <p:sp>
            <p:nvSpPr>
              <p:cNvPr id="175" name="Rectangle 6"/>
              <p:cNvSpPr>
                <a:spLocks noChangeArrowheads="1"/>
              </p:cNvSpPr>
              <p:nvPr/>
            </p:nvSpPr>
            <p:spPr bwMode="auto">
              <a:xfrm>
                <a:off x="6567115" y="1700102"/>
                <a:ext cx="235131" cy="87810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76" name="Freeform 7"/>
              <p:cNvSpPr>
                <a:spLocks noEditPoints="1"/>
              </p:cNvSpPr>
              <p:nvPr/>
            </p:nvSpPr>
            <p:spPr bwMode="auto">
              <a:xfrm>
                <a:off x="6564549" y="1697536"/>
                <a:ext cx="240262" cy="883240"/>
              </a:xfrm>
              <a:custGeom>
                <a:avLst/>
                <a:gdLst>
                  <a:gd name="T0" fmla="*/ 0 w 4688"/>
                  <a:gd name="T1" fmla="*/ 48 h 17200"/>
                  <a:gd name="T2" fmla="*/ 48 w 4688"/>
                  <a:gd name="T3" fmla="*/ 0 h 17200"/>
                  <a:gd name="T4" fmla="*/ 4640 w 4688"/>
                  <a:gd name="T5" fmla="*/ 0 h 17200"/>
                  <a:gd name="T6" fmla="*/ 4688 w 4688"/>
                  <a:gd name="T7" fmla="*/ 48 h 17200"/>
                  <a:gd name="T8" fmla="*/ 4688 w 4688"/>
                  <a:gd name="T9" fmla="*/ 17152 h 17200"/>
                  <a:gd name="T10" fmla="*/ 4640 w 4688"/>
                  <a:gd name="T11" fmla="*/ 17200 h 17200"/>
                  <a:gd name="T12" fmla="*/ 48 w 4688"/>
                  <a:gd name="T13" fmla="*/ 17200 h 17200"/>
                  <a:gd name="T14" fmla="*/ 0 w 4688"/>
                  <a:gd name="T15" fmla="*/ 17152 h 17200"/>
                  <a:gd name="T16" fmla="*/ 0 w 4688"/>
                  <a:gd name="T17" fmla="*/ 48 h 17200"/>
                  <a:gd name="T18" fmla="*/ 96 w 4688"/>
                  <a:gd name="T19" fmla="*/ 17152 h 17200"/>
                  <a:gd name="T20" fmla="*/ 48 w 4688"/>
                  <a:gd name="T21" fmla="*/ 17104 h 17200"/>
                  <a:gd name="T22" fmla="*/ 4640 w 4688"/>
                  <a:gd name="T23" fmla="*/ 17104 h 17200"/>
                  <a:gd name="T24" fmla="*/ 4592 w 4688"/>
                  <a:gd name="T25" fmla="*/ 17152 h 17200"/>
                  <a:gd name="T26" fmla="*/ 4592 w 4688"/>
                  <a:gd name="T27" fmla="*/ 48 h 17200"/>
                  <a:gd name="T28" fmla="*/ 4640 w 4688"/>
                  <a:gd name="T29" fmla="*/ 96 h 17200"/>
                  <a:gd name="T30" fmla="*/ 48 w 4688"/>
                  <a:gd name="T31" fmla="*/ 96 h 17200"/>
                  <a:gd name="T32" fmla="*/ 96 w 4688"/>
                  <a:gd name="T33" fmla="*/ 48 h 17200"/>
                  <a:gd name="T34" fmla="*/ 96 w 4688"/>
                  <a:gd name="T35" fmla="*/ 17152 h 17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688" h="17200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4640" y="0"/>
                    </a:lnTo>
                    <a:cubicBezTo>
                      <a:pt x="4667" y="0"/>
                      <a:pt x="4688" y="22"/>
                      <a:pt x="4688" y="48"/>
                    </a:cubicBezTo>
                    <a:lnTo>
                      <a:pt x="4688" y="17152"/>
                    </a:lnTo>
                    <a:cubicBezTo>
                      <a:pt x="4688" y="17179"/>
                      <a:pt x="4667" y="17200"/>
                      <a:pt x="4640" y="17200"/>
                    </a:cubicBezTo>
                    <a:lnTo>
                      <a:pt x="48" y="17200"/>
                    </a:lnTo>
                    <a:cubicBezTo>
                      <a:pt x="22" y="17200"/>
                      <a:pt x="0" y="17179"/>
                      <a:pt x="0" y="17152"/>
                    </a:cubicBezTo>
                    <a:lnTo>
                      <a:pt x="0" y="48"/>
                    </a:lnTo>
                    <a:close/>
                    <a:moveTo>
                      <a:pt x="96" y="17152"/>
                    </a:moveTo>
                    <a:lnTo>
                      <a:pt x="48" y="17104"/>
                    </a:lnTo>
                    <a:lnTo>
                      <a:pt x="4640" y="17104"/>
                    </a:lnTo>
                    <a:lnTo>
                      <a:pt x="4592" y="17152"/>
                    </a:lnTo>
                    <a:lnTo>
                      <a:pt x="4592" y="48"/>
                    </a:lnTo>
                    <a:lnTo>
                      <a:pt x="4640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715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77" name="Rectangle 8"/>
              <p:cNvSpPr>
                <a:spLocks noChangeArrowheads="1"/>
              </p:cNvSpPr>
              <p:nvPr/>
            </p:nvSpPr>
            <p:spPr bwMode="auto">
              <a:xfrm>
                <a:off x="5914732" y="2575646"/>
                <a:ext cx="30781" cy="5130"/>
              </a:xfrm>
              <a:prstGeom prst="rect">
                <a:avLst/>
              </a:pr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78" name="Freeform 9"/>
              <p:cNvSpPr>
                <a:spLocks noEditPoints="1"/>
              </p:cNvSpPr>
              <p:nvPr/>
            </p:nvSpPr>
            <p:spPr bwMode="auto">
              <a:xfrm>
                <a:off x="6669717" y="1429059"/>
                <a:ext cx="29925" cy="271043"/>
              </a:xfrm>
              <a:custGeom>
                <a:avLst/>
                <a:gdLst>
                  <a:gd name="T0" fmla="*/ 15 w 35"/>
                  <a:gd name="T1" fmla="*/ 317 h 317"/>
                  <a:gd name="T2" fmla="*/ 15 w 35"/>
                  <a:gd name="T3" fmla="*/ 3 h 317"/>
                  <a:gd name="T4" fmla="*/ 21 w 35"/>
                  <a:gd name="T5" fmla="*/ 3 h 317"/>
                  <a:gd name="T6" fmla="*/ 21 w 35"/>
                  <a:gd name="T7" fmla="*/ 317 h 317"/>
                  <a:gd name="T8" fmla="*/ 15 w 35"/>
                  <a:gd name="T9" fmla="*/ 317 h 317"/>
                  <a:gd name="T10" fmla="*/ 0 w 35"/>
                  <a:gd name="T11" fmla="*/ 0 h 317"/>
                  <a:gd name="T12" fmla="*/ 35 w 35"/>
                  <a:gd name="T13" fmla="*/ 0 h 317"/>
                  <a:gd name="T14" fmla="*/ 35 w 35"/>
                  <a:gd name="T15" fmla="*/ 6 h 317"/>
                  <a:gd name="T16" fmla="*/ 0 w 35"/>
                  <a:gd name="T17" fmla="*/ 6 h 317"/>
                  <a:gd name="T18" fmla="*/ 0 w 35"/>
                  <a:gd name="T19" fmla="*/ 0 h 3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317">
                    <a:moveTo>
                      <a:pt x="15" y="317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17"/>
                    </a:lnTo>
                    <a:lnTo>
                      <a:pt x="15" y="317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79" name="Rectangle 10"/>
              <p:cNvSpPr>
                <a:spLocks noChangeArrowheads="1"/>
              </p:cNvSpPr>
              <p:nvPr/>
            </p:nvSpPr>
            <p:spPr bwMode="auto">
              <a:xfrm>
                <a:off x="5409413" y="1334152"/>
                <a:ext cx="0" cy="1244060"/>
              </a:xfrm>
              <a:prstGeom prst="rect">
                <a:avLst/>
              </a:prstGeom>
              <a:solidFill>
                <a:srgbClr val="000000"/>
              </a:solidFill>
              <a:ln w="1397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Freeform 11"/>
              <p:cNvSpPr>
                <a:spLocks noEditPoints="1"/>
              </p:cNvSpPr>
              <p:nvPr/>
            </p:nvSpPr>
            <p:spPr bwMode="auto">
              <a:xfrm>
                <a:off x="5376084" y="1331586"/>
                <a:ext cx="32718" cy="1249190"/>
              </a:xfrm>
              <a:custGeom>
                <a:avLst/>
                <a:gdLst>
                  <a:gd name="T0" fmla="*/ 0 w 23"/>
                  <a:gd name="T1" fmla="*/ 1455 h 1461"/>
                  <a:gd name="T2" fmla="*/ 23 w 23"/>
                  <a:gd name="T3" fmla="*/ 1455 h 1461"/>
                  <a:gd name="T4" fmla="*/ 23 w 23"/>
                  <a:gd name="T5" fmla="*/ 1461 h 1461"/>
                  <a:gd name="T6" fmla="*/ 0 w 23"/>
                  <a:gd name="T7" fmla="*/ 1461 h 1461"/>
                  <a:gd name="T8" fmla="*/ 0 w 23"/>
                  <a:gd name="T9" fmla="*/ 1455 h 1461"/>
                  <a:gd name="T10" fmla="*/ 0 w 23"/>
                  <a:gd name="T11" fmla="*/ 1293 h 1461"/>
                  <a:gd name="T12" fmla="*/ 23 w 23"/>
                  <a:gd name="T13" fmla="*/ 1293 h 1461"/>
                  <a:gd name="T14" fmla="*/ 23 w 23"/>
                  <a:gd name="T15" fmla="*/ 1299 h 1461"/>
                  <a:gd name="T16" fmla="*/ 0 w 23"/>
                  <a:gd name="T17" fmla="*/ 1299 h 1461"/>
                  <a:gd name="T18" fmla="*/ 0 w 23"/>
                  <a:gd name="T19" fmla="*/ 1293 h 1461"/>
                  <a:gd name="T20" fmla="*/ 0 w 23"/>
                  <a:gd name="T21" fmla="*/ 1132 h 1461"/>
                  <a:gd name="T22" fmla="*/ 23 w 23"/>
                  <a:gd name="T23" fmla="*/ 1132 h 1461"/>
                  <a:gd name="T24" fmla="*/ 23 w 23"/>
                  <a:gd name="T25" fmla="*/ 1137 h 1461"/>
                  <a:gd name="T26" fmla="*/ 0 w 23"/>
                  <a:gd name="T27" fmla="*/ 1137 h 1461"/>
                  <a:gd name="T28" fmla="*/ 0 w 23"/>
                  <a:gd name="T29" fmla="*/ 1132 h 1461"/>
                  <a:gd name="T30" fmla="*/ 0 w 23"/>
                  <a:gd name="T31" fmla="*/ 970 h 1461"/>
                  <a:gd name="T32" fmla="*/ 23 w 23"/>
                  <a:gd name="T33" fmla="*/ 970 h 1461"/>
                  <a:gd name="T34" fmla="*/ 23 w 23"/>
                  <a:gd name="T35" fmla="*/ 976 h 1461"/>
                  <a:gd name="T36" fmla="*/ 0 w 23"/>
                  <a:gd name="T37" fmla="*/ 976 h 1461"/>
                  <a:gd name="T38" fmla="*/ 0 w 23"/>
                  <a:gd name="T39" fmla="*/ 970 h 1461"/>
                  <a:gd name="T40" fmla="*/ 0 w 23"/>
                  <a:gd name="T41" fmla="*/ 808 h 1461"/>
                  <a:gd name="T42" fmla="*/ 23 w 23"/>
                  <a:gd name="T43" fmla="*/ 808 h 1461"/>
                  <a:gd name="T44" fmla="*/ 23 w 23"/>
                  <a:gd name="T45" fmla="*/ 814 h 1461"/>
                  <a:gd name="T46" fmla="*/ 0 w 23"/>
                  <a:gd name="T47" fmla="*/ 814 h 1461"/>
                  <a:gd name="T48" fmla="*/ 0 w 23"/>
                  <a:gd name="T49" fmla="*/ 808 h 1461"/>
                  <a:gd name="T50" fmla="*/ 0 w 23"/>
                  <a:gd name="T51" fmla="*/ 646 h 1461"/>
                  <a:gd name="T52" fmla="*/ 23 w 23"/>
                  <a:gd name="T53" fmla="*/ 646 h 1461"/>
                  <a:gd name="T54" fmla="*/ 23 w 23"/>
                  <a:gd name="T55" fmla="*/ 652 h 1461"/>
                  <a:gd name="T56" fmla="*/ 0 w 23"/>
                  <a:gd name="T57" fmla="*/ 652 h 1461"/>
                  <a:gd name="T58" fmla="*/ 0 w 23"/>
                  <a:gd name="T59" fmla="*/ 646 h 1461"/>
                  <a:gd name="T60" fmla="*/ 0 w 23"/>
                  <a:gd name="T61" fmla="*/ 485 h 1461"/>
                  <a:gd name="T62" fmla="*/ 23 w 23"/>
                  <a:gd name="T63" fmla="*/ 485 h 1461"/>
                  <a:gd name="T64" fmla="*/ 23 w 23"/>
                  <a:gd name="T65" fmla="*/ 491 h 1461"/>
                  <a:gd name="T66" fmla="*/ 0 w 23"/>
                  <a:gd name="T67" fmla="*/ 491 h 1461"/>
                  <a:gd name="T68" fmla="*/ 0 w 23"/>
                  <a:gd name="T69" fmla="*/ 485 h 1461"/>
                  <a:gd name="T70" fmla="*/ 0 w 23"/>
                  <a:gd name="T71" fmla="*/ 323 h 1461"/>
                  <a:gd name="T72" fmla="*/ 23 w 23"/>
                  <a:gd name="T73" fmla="*/ 323 h 1461"/>
                  <a:gd name="T74" fmla="*/ 23 w 23"/>
                  <a:gd name="T75" fmla="*/ 328 h 1461"/>
                  <a:gd name="T76" fmla="*/ 0 w 23"/>
                  <a:gd name="T77" fmla="*/ 328 h 1461"/>
                  <a:gd name="T78" fmla="*/ 0 w 23"/>
                  <a:gd name="T79" fmla="*/ 323 h 1461"/>
                  <a:gd name="T80" fmla="*/ 0 w 23"/>
                  <a:gd name="T81" fmla="*/ 161 h 1461"/>
                  <a:gd name="T82" fmla="*/ 23 w 23"/>
                  <a:gd name="T83" fmla="*/ 161 h 1461"/>
                  <a:gd name="T84" fmla="*/ 23 w 23"/>
                  <a:gd name="T85" fmla="*/ 167 h 1461"/>
                  <a:gd name="T86" fmla="*/ 0 w 23"/>
                  <a:gd name="T87" fmla="*/ 167 h 1461"/>
                  <a:gd name="T88" fmla="*/ 0 w 23"/>
                  <a:gd name="T89" fmla="*/ 161 h 1461"/>
                  <a:gd name="T90" fmla="*/ 0 w 23"/>
                  <a:gd name="T91" fmla="*/ 0 h 1461"/>
                  <a:gd name="T92" fmla="*/ 23 w 23"/>
                  <a:gd name="T93" fmla="*/ 0 h 1461"/>
                  <a:gd name="T94" fmla="*/ 23 w 23"/>
                  <a:gd name="T95" fmla="*/ 6 h 1461"/>
                  <a:gd name="T96" fmla="*/ 0 w 23"/>
                  <a:gd name="T97" fmla="*/ 6 h 1461"/>
                  <a:gd name="T98" fmla="*/ 0 w 23"/>
                  <a:gd name="T99" fmla="*/ 0 h 14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23" h="1461">
                    <a:moveTo>
                      <a:pt x="0" y="1455"/>
                    </a:moveTo>
                    <a:lnTo>
                      <a:pt x="23" y="1455"/>
                    </a:lnTo>
                    <a:lnTo>
                      <a:pt x="23" y="1461"/>
                    </a:lnTo>
                    <a:lnTo>
                      <a:pt x="0" y="1461"/>
                    </a:lnTo>
                    <a:lnTo>
                      <a:pt x="0" y="1455"/>
                    </a:lnTo>
                    <a:close/>
                    <a:moveTo>
                      <a:pt x="0" y="1293"/>
                    </a:moveTo>
                    <a:lnTo>
                      <a:pt x="23" y="1293"/>
                    </a:lnTo>
                    <a:lnTo>
                      <a:pt x="23" y="1299"/>
                    </a:lnTo>
                    <a:lnTo>
                      <a:pt x="0" y="1299"/>
                    </a:lnTo>
                    <a:lnTo>
                      <a:pt x="0" y="1293"/>
                    </a:lnTo>
                    <a:close/>
                    <a:moveTo>
                      <a:pt x="0" y="1132"/>
                    </a:moveTo>
                    <a:lnTo>
                      <a:pt x="23" y="1132"/>
                    </a:lnTo>
                    <a:lnTo>
                      <a:pt x="23" y="1137"/>
                    </a:lnTo>
                    <a:lnTo>
                      <a:pt x="0" y="1137"/>
                    </a:lnTo>
                    <a:lnTo>
                      <a:pt x="0" y="1132"/>
                    </a:lnTo>
                    <a:close/>
                    <a:moveTo>
                      <a:pt x="0" y="970"/>
                    </a:moveTo>
                    <a:lnTo>
                      <a:pt x="23" y="970"/>
                    </a:lnTo>
                    <a:lnTo>
                      <a:pt x="23" y="976"/>
                    </a:lnTo>
                    <a:lnTo>
                      <a:pt x="0" y="976"/>
                    </a:lnTo>
                    <a:lnTo>
                      <a:pt x="0" y="970"/>
                    </a:lnTo>
                    <a:close/>
                    <a:moveTo>
                      <a:pt x="0" y="808"/>
                    </a:moveTo>
                    <a:lnTo>
                      <a:pt x="23" y="808"/>
                    </a:lnTo>
                    <a:lnTo>
                      <a:pt x="23" y="814"/>
                    </a:lnTo>
                    <a:lnTo>
                      <a:pt x="0" y="814"/>
                    </a:lnTo>
                    <a:lnTo>
                      <a:pt x="0" y="808"/>
                    </a:lnTo>
                    <a:close/>
                    <a:moveTo>
                      <a:pt x="0" y="646"/>
                    </a:moveTo>
                    <a:lnTo>
                      <a:pt x="23" y="646"/>
                    </a:lnTo>
                    <a:lnTo>
                      <a:pt x="23" y="652"/>
                    </a:lnTo>
                    <a:lnTo>
                      <a:pt x="0" y="652"/>
                    </a:lnTo>
                    <a:lnTo>
                      <a:pt x="0" y="646"/>
                    </a:lnTo>
                    <a:close/>
                    <a:moveTo>
                      <a:pt x="0" y="485"/>
                    </a:moveTo>
                    <a:lnTo>
                      <a:pt x="23" y="485"/>
                    </a:lnTo>
                    <a:lnTo>
                      <a:pt x="23" y="491"/>
                    </a:lnTo>
                    <a:lnTo>
                      <a:pt x="0" y="491"/>
                    </a:lnTo>
                    <a:lnTo>
                      <a:pt x="0" y="485"/>
                    </a:lnTo>
                    <a:close/>
                    <a:moveTo>
                      <a:pt x="0" y="323"/>
                    </a:moveTo>
                    <a:lnTo>
                      <a:pt x="23" y="323"/>
                    </a:lnTo>
                    <a:lnTo>
                      <a:pt x="23" y="328"/>
                    </a:lnTo>
                    <a:lnTo>
                      <a:pt x="0" y="328"/>
                    </a:lnTo>
                    <a:lnTo>
                      <a:pt x="0" y="323"/>
                    </a:lnTo>
                    <a:close/>
                    <a:moveTo>
                      <a:pt x="0" y="161"/>
                    </a:moveTo>
                    <a:lnTo>
                      <a:pt x="23" y="161"/>
                    </a:lnTo>
                    <a:lnTo>
                      <a:pt x="23" y="167"/>
                    </a:lnTo>
                    <a:lnTo>
                      <a:pt x="0" y="167"/>
                    </a:lnTo>
                    <a:lnTo>
                      <a:pt x="0" y="161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Rectangle 12"/>
              <p:cNvSpPr>
                <a:spLocks noChangeArrowheads="1"/>
              </p:cNvSpPr>
              <p:nvPr/>
            </p:nvSpPr>
            <p:spPr bwMode="auto">
              <a:xfrm>
                <a:off x="5411979" y="2575646"/>
                <a:ext cx="1509115" cy="5130"/>
              </a:xfrm>
              <a:prstGeom prst="rect">
                <a:avLst/>
              </a:pr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82" name="Rectangle 13"/>
              <p:cNvSpPr>
                <a:spLocks noChangeArrowheads="1"/>
              </p:cNvSpPr>
              <p:nvPr/>
            </p:nvSpPr>
            <p:spPr bwMode="auto">
              <a:xfrm>
                <a:off x="5303001" y="2513646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3" name="Rectangle 14"/>
              <p:cNvSpPr>
                <a:spLocks noChangeArrowheads="1"/>
              </p:cNvSpPr>
              <p:nvPr/>
            </p:nvSpPr>
            <p:spPr bwMode="auto">
              <a:xfrm>
                <a:off x="5303001" y="2375131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4" name="Rectangle 15"/>
              <p:cNvSpPr>
                <a:spLocks noChangeArrowheads="1"/>
              </p:cNvSpPr>
              <p:nvPr/>
            </p:nvSpPr>
            <p:spPr bwMode="auto">
              <a:xfrm>
                <a:off x="5303001" y="2236618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5" name="Rectangle 16"/>
              <p:cNvSpPr>
                <a:spLocks noChangeArrowheads="1"/>
              </p:cNvSpPr>
              <p:nvPr/>
            </p:nvSpPr>
            <p:spPr bwMode="auto">
              <a:xfrm>
                <a:off x="5303001" y="2098959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6" name="Rectangle 17"/>
              <p:cNvSpPr>
                <a:spLocks noChangeArrowheads="1"/>
              </p:cNvSpPr>
              <p:nvPr/>
            </p:nvSpPr>
            <p:spPr bwMode="auto">
              <a:xfrm>
                <a:off x="5303001" y="1960445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7" name="Rectangle 18"/>
              <p:cNvSpPr>
                <a:spLocks noChangeArrowheads="1"/>
              </p:cNvSpPr>
              <p:nvPr/>
            </p:nvSpPr>
            <p:spPr bwMode="auto">
              <a:xfrm>
                <a:off x="5303001" y="1821932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8" name="Rectangle 19"/>
              <p:cNvSpPr>
                <a:spLocks noChangeArrowheads="1"/>
              </p:cNvSpPr>
              <p:nvPr/>
            </p:nvSpPr>
            <p:spPr bwMode="auto">
              <a:xfrm>
                <a:off x="5303001" y="1683418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9" name="Rectangle 20"/>
              <p:cNvSpPr>
                <a:spLocks noChangeArrowheads="1"/>
              </p:cNvSpPr>
              <p:nvPr/>
            </p:nvSpPr>
            <p:spPr bwMode="auto">
              <a:xfrm>
                <a:off x="5303001" y="1545759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0" name="Rectangle 21"/>
              <p:cNvSpPr>
                <a:spLocks noChangeArrowheads="1"/>
              </p:cNvSpPr>
              <p:nvPr/>
            </p:nvSpPr>
            <p:spPr bwMode="auto">
              <a:xfrm>
                <a:off x="5303001" y="1407245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1" name="Rectangle 22"/>
              <p:cNvSpPr>
                <a:spLocks noChangeArrowheads="1"/>
              </p:cNvSpPr>
              <p:nvPr/>
            </p:nvSpPr>
            <p:spPr bwMode="auto">
              <a:xfrm>
                <a:off x="5303001" y="1268731"/>
                <a:ext cx="58064" cy="126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9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9" name="Rectangle 26"/>
            <p:cNvSpPr>
              <a:spLocks noChangeArrowheads="1"/>
            </p:cNvSpPr>
            <p:nvPr/>
          </p:nvSpPr>
          <p:spPr bwMode="auto">
            <a:xfrm>
              <a:off x="4677259" y="958634"/>
              <a:ext cx="72000" cy="72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0" name="Freeform 27"/>
            <p:cNvSpPr>
              <a:spLocks noEditPoints="1"/>
            </p:cNvSpPr>
            <p:nvPr/>
          </p:nvSpPr>
          <p:spPr bwMode="auto">
            <a:xfrm>
              <a:off x="4675952" y="957328"/>
              <a:ext cx="72000" cy="72000"/>
            </a:xfrm>
            <a:custGeom>
              <a:avLst/>
              <a:gdLst>
                <a:gd name="T0" fmla="*/ 0 w 752"/>
                <a:gd name="T1" fmla="*/ 48 h 768"/>
                <a:gd name="T2" fmla="*/ 48 w 752"/>
                <a:gd name="T3" fmla="*/ 0 h 768"/>
                <a:gd name="T4" fmla="*/ 704 w 752"/>
                <a:gd name="T5" fmla="*/ 0 h 768"/>
                <a:gd name="T6" fmla="*/ 752 w 752"/>
                <a:gd name="T7" fmla="*/ 48 h 768"/>
                <a:gd name="T8" fmla="*/ 752 w 752"/>
                <a:gd name="T9" fmla="*/ 720 h 768"/>
                <a:gd name="T10" fmla="*/ 704 w 752"/>
                <a:gd name="T11" fmla="*/ 768 h 768"/>
                <a:gd name="T12" fmla="*/ 48 w 752"/>
                <a:gd name="T13" fmla="*/ 768 h 768"/>
                <a:gd name="T14" fmla="*/ 0 w 752"/>
                <a:gd name="T15" fmla="*/ 720 h 768"/>
                <a:gd name="T16" fmla="*/ 0 w 752"/>
                <a:gd name="T17" fmla="*/ 48 h 768"/>
                <a:gd name="T18" fmla="*/ 96 w 752"/>
                <a:gd name="T19" fmla="*/ 720 h 768"/>
                <a:gd name="T20" fmla="*/ 48 w 752"/>
                <a:gd name="T21" fmla="*/ 672 h 768"/>
                <a:gd name="T22" fmla="*/ 704 w 752"/>
                <a:gd name="T23" fmla="*/ 672 h 768"/>
                <a:gd name="T24" fmla="*/ 656 w 752"/>
                <a:gd name="T25" fmla="*/ 720 h 768"/>
                <a:gd name="T26" fmla="*/ 656 w 752"/>
                <a:gd name="T27" fmla="*/ 48 h 768"/>
                <a:gd name="T28" fmla="*/ 704 w 752"/>
                <a:gd name="T29" fmla="*/ 96 h 768"/>
                <a:gd name="T30" fmla="*/ 48 w 752"/>
                <a:gd name="T31" fmla="*/ 96 h 768"/>
                <a:gd name="T32" fmla="*/ 96 w 752"/>
                <a:gd name="T33" fmla="*/ 48 h 768"/>
                <a:gd name="T34" fmla="*/ 96 w 752"/>
                <a:gd name="T35" fmla="*/ 720 h 7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752" h="768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704" y="0"/>
                  </a:lnTo>
                  <a:cubicBezTo>
                    <a:pt x="731" y="0"/>
                    <a:pt x="752" y="22"/>
                    <a:pt x="752" y="48"/>
                  </a:cubicBezTo>
                  <a:lnTo>
                    <a:pt x="752" y="720"/>
                  </a:lnTo>
                  <a:cubicBezTo>
                    <a:pt x="752" y="747"/>
                    <a:pt x="731" y="768"/>
                    <a:pt x="704" y="768"/>
                  </a:cubicBezTo>
                  <a:lnTo>
                    <a:pt x="48" y="768"/>
                  </a:lnTo>
                  <a:cubicBezTo>
                    <a:pt x="22" y="768"/>
                    <a:pt x="0" y="747"/>
                    <a:pt x="0" y="720"/>
                  </a:cubicBezTo>
                  <a:lnTo>
                    <a:pt x="0" y="48"/>
                  </a:lnTo>
                  <a:close/>
                  <a:moveTo>
                    <a:pt x="96" y="720"/>
                  </a:moveTo>
                  <a:lnTo>
                    <a:pt x="48" y="672"/>
                  </a:lnTo>
                  <a:lnTo>
                    <a:pt x="704" y="672"/>
                  </a:lnTo>
                  <a:lnTo>
                    <a:pt x="656" y="720"/>
                  </a:lnTo>
                  <a:lnTo>
                    <a:pt x="656" y="48"/>
                  </a:lnTo>
                  <a:lnTo>
                    <a:pt x="70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72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1" name="Rectangle 28"/>
            <p:cNvSpPr>
              <a:spLocks noChangeArrowheads="1"/>
            </p:cNvSpPr>
            <p:nvPr/>
          </p:nvSpPr>
          <p:spPr bwMode="auto">
            <a:xfrm>
              <a:off x="4779455" y="925873"/>
              <a:ext cx="164956" cy="1266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WT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2" name="Rectangle 29"/>
            <p:cNvSpPr>
              <a:spLocks noChangeArrowheads="1"/>
            </p:cNvSpPr>
            <p:nvPr/>
          </p:nvSpPr>
          <p:spPr bwMode="auto">
            <a:xfrm>
              <a:off x="4677259" y="1065798"/>
              <a:ext cx="72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3" name="Freeform 30"/>
            <p:cNvSpPr>
              <a:spLocks noEditPoints="1"/>
            </p:cNvSpPr>
            <p:nvPr/>
          </p:nvSpPr>
          <p:spPr bwMode="auto">
            <a:xfrm>
              <a:off x="4675952" y="1064491"/>
              <a:ext cx="72000" cy="72000"/>
            </a:xfrm>
            <a:custGeom>
              <a:avLst/>
              <a:gdLst>
                <a:gd name="T0" fmla="*/ 0 w 752"/>
                <a:gd name="T1" fmla="*/ 48 h 752"/>
                <a:gd name="T2" fmla="*/ 48 w 752"/>
                <a:gd name="T3" fmla="*/ 0 h 752"/>
                <a:gd name="T4" fmla="*/ 704 w 752"/>
                <a:gd name="T5" fmla="*/ 0 h 752"/>
                <a:gd name="T6" fmla="*/ 752 w 752"/>
                <a:gd name="T7" fmla="*/ 48 h 752"/>
                <a:gd name="T8" fmla="*/ 752 w 752"/>
                <a:gd name="T9" fmla="*/ 704 h 752"/>
                <a:gd name="T10" fmla="*/ 704 w 752"/>
                <a:gd name="T11" fmla="*/ 752 h 752"/>
                <a:gd name="T12" fmla="*/ 48 w 752"/>
                <a:gd name="T13" fmla="*/ 752 h 752"/>
                <a:gd name="T14" fmla="*/ 0 w 752"/>
                <a:gd name="T15" fmla="*/ 704 h 752"/>
                <a:gd name="T16" fmla="*/ 0 w 752"/>
                <a:gd name="T17" fmla="*/ 48 h 752"/>
                <a:gd name="T18" fmla="*/ 96 w 752"/>
                <a:gd name="T19" fmla="*/ 704 h 752"/>
                <a:gd name="T20" fmla="*/ 48 w 752"/>
                <a:gd name="T21" fmla="*/ 656 h 752"/>
                <a:gd name="T22" fmla="*/ 704 w 752"/>
                <a:gd name="T23" fmla="*/ 656 h 752"/>
                <a:gd name="T24" fmla="*/ 656 w 752"/>
                <a:gd name="T25" fmla="*/ 704 h 752"/>
                <a:gd name="T26" fmla="*/ 656 w 752"/>
                <a:gd name="T27" fmla="*/ 48 h 752"/>
                <a:gd name="T28" fmla="*/ 704 w 752"/>
                <a:gd name="T29" fmla="*/ 96 h 752"/>
                <a:gd name="T30" fmla="*/ 48 w 752"/>
                <a:gd name="T31" fmla="*/ 96 h 752"/>
                <a:gd name="T32" fmla="*/ 96 w 752"/>
                <a:gd name="T33" fmla="*/ 48 h 752"/>
                <a:gd name="T34" fmla="*/ 96 w 752"/>
                <a:gd name="T35" fmla="*/ 704 h 7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752" h="752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704" y="0"/>
                  </a:lnTo>
                  <a:cubicBezTo>
                    <a:pt x="731" y="0"/>
                    <a:pt x="752" y="22"/>
                    <a:pt x="752" y="48"/>
                  </a:cubicBezTo>
                  <a:lnTo>
                    <a:pt x="752" y="704"/>
                  </a:lnTo>
                  <a:cubicBezTo>
                    <a:pt x="752" y="731"/>
                    <a:pt x="731" y="752"/>
                    <a:pt x="704" y="752"/>
                  </a:cubicBezTo>
                  <a:lnTo>
                    <a:pt x="48" y="752"/>
                  </a:lnTo>
                  <a:cubicBezTo>
                    <a:pt x="22" y="752"/>
                    <a:pt x="0" y="731"/>
                    <a:pt x="0" y="704"/>
                  </a:cubicBezTo>
                  <a:lnTo>
                    <a:pt x="0" y="48"/>
                  </a:lnTo>
                  <a:close/>
                  <a:moveTo>
                    <a:pt x="96" y="704"/>
                  </a:moveTo>
                  <a:lnTo>
                    <a:pt x="48" y="656"/>
                  </a:lnTo>
                  <a:lnTo>
                    <a:pt x="704" y="656"/>
                  </a:lnTo>
                  <a:lnTo>
                    <a:pt x="656" y="704"/>
                  </a:lnTo>
                  <a:lnTo>
                    <a:pt x="656" y="48"/>
                  </a:lnTo>
                  <a:lnTo>
                    <a:pt x="70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70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4" name="Rectangle 31"/>
            <p:cNvSpPr>
              <a:spLocks noChangeArrowheads="1"/>
            </p:cNvSpPr>
            <p:nvPr/>
          </p:nvSpPr>
          <p:spPr bwMode="auto">
            <a:xfrm>
              <a:off x="4779455" y="1030423"/>
              <a:ext cx="370819" cy="1266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sp70</a:t>
              </a:r>
              <a:r>
                <a:rPr lang="fr-FR" altLang="fr-FR" sz="1000" baseline="30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-/-</a:t>
              </a:r>
              <a:endParaRPr lang="fr-FR" altLang="fr-FR" sz="1000" baseline="30000" dirty="0">
                <a:cs typeface="Arial" panose="020B0604020202020204" pitchFamily="34" charset="0"/>
              </a:endParaRPr>
            </a:p>
          </p:txBody>
        </p:sp>
      </p:grpSp>
      <p:grpSp>
        <p:nvGrpSpPr>
          <p:cNvPr id="192" name="Groupe 191"/>
          <p:cNvGrpSpPr/>
          <p:nvPr/>
        </p:nvGrpSpPr>
        <p:grpSpPr>
          <a:xfrm>
            <a:off x="4031251" y="827001"/>
            <a:ext cx="1874182" cy="1571459"/>
            <a:chOff x="4047082" y="2407187"/>
            <a:chExt cx="1874182" cy="1571459"/>
          </a:xfrm>
        </p:grpSpPr>
        <p:grpSp>
          <p:nvGrpSpPr>
            <p:cNvPr id="193" name="Groupe 192"/>
            <p:cNvGrpSpPr>
              <a:grpSpLocks noChangeAspect="1"/>
            </p:cNvGrpSpPr>
            <p:nvPr/>
          </p:nvGrpSpPr>
          <p:grpSpPr>
            <a:xfrm>
              <a:off x="4420729" y="2423096"/>
              <a:ext cx="1500535" cy="1430713"/>
              <a:chOff x="5316797" y="4064922"/>
              <a:chExt cx="3109654" cy="2588200"/>
            </a:xfrm>
          </p:grpSpPr>
          <p:sp>
            <p:nvSpPr>
              <p:cNvPr id="203" name="Rectangle 37"/>
              <p:cNvSpPr>
                <a:spLocks noChangeArrowheads="1"/>
              </p:cNvSpPr>
              <p:nvPr/>
            </p:nvSpPr>
            <p:spPr bwMode="auto">
              <a:xfrm>
                <a:off x="7265988" y="5043488"/>
                <a:ext cx="430213" cy="14763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04" name="Freeform 38"/>
              <p:cNvSpPr>
                <a:spLocks noEditPoints="1"/>
              </p:cNvSpPr>
              <p:nvPr/>
            </p:nvSpPr>
            <p:spPr bwMode="auto">
              <a:xfrm>
                <a:off x="7261226" y="5038725"/>
                <a:ext cx="439738" cy="1485900"/>
              </a:xfrm>
              <a:custGeom>
                <a:avLst/>
                <a:gdLst>
                  <a:gd name="T0" fmla="*/ 0 w 4608"/>
                  <a:gd name="T1" fmla="*/ 48 h 15584"/>
                  <a:gd name="T2" fmla="*/ 48 w 4608"/>
                  <a:gd name="T3" fmla="*/ 0 h 15584"/>
                  <a:gd name="T4" fmla="*/ 4560 w 4608"/>
                  <a:gd name="T5" fmla="*/ 0 h 15584"/>
                  <a:gd name="T6" fmla="*/ 4608 w 4608"/>
                  <a:gd name="T7" fmla="*/ 48 h 15584"/>
                  <a:gd name="T8" fmla="*/ 4608 w 4608"/>
                  <a:gd name="T9" fmla="*/ 15536 h 15584"/>
                  <a:gd name="T10" fmla="*/ 4560 w 4608"/>
                  <a:gd name="T11" fmla="*/ 15584 h 15584"/>
                  <a:gd name="T12" fmla="*/ 48 w 4608"/>
                  <a:gd name="T13" fmla="*/ 15584 h 15584"/>
                  <a:gd name="T14" fmla="*/ 0 w 4608"/>
                  <a:gd name="T15" fmla="*/ 15536 h 15584"/>
                  <a:gd name="T16" fmla="*/ 0 w 4608"/>
                  <a:gd name="T17" fmla="*/ 48 h 15584"/>
                  <a:gd name="T18" fmla="*/ 96 w 4608"/>
                  <a:gd name="T19" fmla="*/ 15536 h 15584"/>
                  <a:gd name="T20" fmla="*/ 48 w 4608"/>
                  <a:gd name="T21" fmla="*/ 15488 h 15584"/>
                  <a:gd name="T22" fmla="*/ 4560 w 4608"/>
                  <a:gd name="T23" fmla="*/ 15488 h 15584"/>
                  <a:gd name="T24" fmla="*/ 4512 w 4608"/>
                  <a:gd name="T25" fmla="*/ 15536 h 15584"/>
                  <a:gd name="T26" fmla="*/ 4512 w 4608"/>
                  <a:gd name="T27" fmla="*/ 48 h 15584"/>
                  <a:gd name="T28" fmla="*/ 4560 w 4608"/>
                  <a:gd name="T29" fmla="*/ 96 h 15584"/>
                  <a:gd name="T30" fmla="*/ 48 w 4608"/>
                  <a:gd name="T31" fmla="*/ 96 h 15584"/>
                  <a:gd name="T32" fmla="*/ 96 w 4608"/>
                  <a:gd name="T33" fmla="*/ 48 h 15584"/>
                  <a:gd name="T34" fmla="*/ 96 w 4608"/>
                  <a:gd name="T35" fmla="*/ 15536 h 155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608" h="15584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4560" y="0"/>
                    </a:lnTo>
                    <a:cubicBezTo>
                      <a:pt x="4587" y="0"/>
                      <a:pt x="4608" y="22"/>
                      <a:pt x="4608" y="48"/>
                    </a:cubicBezTo>
                    <a:lnTo>
                      <a:pt x="4608" y="15536"/>
                    </a:lnTo>
                    <a:cubicBezTo>
                      <a:pt x="4608" y="15563"/>
                      <a:pt x="4587" y="15584"/>
                      <a:pt x="4560" y="15584"/>
                    </a:cubicBezTo>
                    <a:lnTo>
                      <a:pt x="48" y="15584"/>
                    </a:lnTo>
                    <a:cubicBezTo>
                      <a:pt x="22" y="15584"/>
                      <a:pt x="0" y="15563"/>
                      <a:pt x="0" y="15536"/>
                    </a:cubicBezTo>
                    <a:lnTo>
                      <a:pt x="0" y="48"/>
                    </a:lnTo>
                    <a:close/>
                    <a:moveTo>
                      <a:pt x="96" y="15536"/>
                    </a:moveTo>
                    <a:lnTo>
                      <a:pt x="48" y="15488"/>
                    </a:lnTo>
                    <a:lnTo>
                      <a:pt x="4560" y="15488"/>
                    </a:lnTo>
                    <a:lnTo>
                      <a:pt x="4512" y="15536"/>
                    </a:lnTo>
                    <a:lnTo>
                      <a:pt x="4512" y="48"/>
                    </a:lnTo>
                    <a:lnTo>
                      <a:pt x="4560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5536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05" name="Rectangle 39"/>
              <p:cNvSpPr>
                <a:spLocks noChangeArrowheads="1"/>
              </p:cNvSpPr>
              <p:nvPr/>
            </p:nvSpPr>
            <p:spPr bwMode="auto">
              <a:xfrm>
                <a:off x="6407151" y="5035550"/>
                <a:ext cx="428625" cy="148431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06" name="Freeform 40"/>
              <p:cNvSpPr>
                <a:spLocks noEditPoints="1"/>
              </p:cNvSpPr>
              <p:nvPr/>
            </p:nvSpPr>
            <p:spPr bwMode="auto">
              <a:xfrm>
                <a:off x="6402388" y="5030788"/>
                <a:ext cx="438150" cy="1493838"/>
              </a:xfrm>
              <a:custGeom>
                <a:avLst/>
                <a:gdLst>
                  <a:gd name="T0" fmla="*/ 0 w 4608"/>
                  <a:gd name="T1" fmla="*/ 48 h 15680"/>
                  <a:gd name="T2" fmla="*/ 48 w 4608"/>
                  <a:gd name="T3" fmla="*/ 0 h 15680"/>
                  <a:gd name="T4" fmla="*/ 4560 w 4608"/>
                  <a:gd name="T5" fmla="*/ 0 h 15680"/>
                  <a:gd name="T6" fmla="*/ 4608 w 4608"/>
                  <a:gd name="T7" fmla="*/ 48 h 15680"/>
                  <a:gd name="T8" fmla="*/ 4608 w 4608"/>
                  <a:gd name="T9" fmla="*/ 15632 h 15680"/>
                  <a:gd name="T10" fmla="*/ 4560 w 4608"/>
                  <a:gd name="T11" fmla="*/ 15680 h 15680"/>
                  <a:gd name="T12" fmla="*/ 48 w 4608"/>
                  <a:gd name="T13" fmla="*/ 15680 h 15680"/>
                  <a:gd name="T14" fmla="*/ 0 w 4608"/>
                  <a:gd name="T15" fmla="*/ 15632 h 15680"/>
                  <a:gd name="T16" fmla="*/ 0 w 4608"/>
                  <a:gd name="T17" fmla="*/ 48 h 15680"/>
                  <a:gd name="T18" fmla="*/ 96 w 4608"/>
                  <a:gd name="T19" fmla="*/ 15632 h 15680"/>
                  <a:gd name="T20" fmla="*/ 48 w 4608"/>
                  <a:gd name="T21" fmla="*/ 15584 h 15680"/>
                  <a:gd name="T22" fmla="*/ 4560 w 4608"/>
                  <a:gd name="T23" fmla="*/ 15584 h 15680"/>
                  <a:gd name="T24" fmla="*/ 4512 w 4608"/>
                  <a:gd name="T25" fmla="*/ 15632 h 15680"/>
                  <a:gd name="T26" fmla="*/ 4512 w 4608"/>
                  <a:gd name="T27" fmla="*/ 48 h 15680"/>
                  <a:gd name="T28" fmla="*/ 4560 w 4608"/>
                  <a:gd name="T29" fmla="*/ 96 h 15680"/>
                  <a:gd name="T30" fmla="*/ 48 w 4608"/>
                  <a:gd name="T31" fmla="*/ 96 h 15680"/>
                  <a:gd name="T32" fmla="*/ 96 w 4608"/>
                  <a:gd name="T33" fmla="*/ 48 h 15680"/>
                  <a:gd name="T34" fmla="*/ 96 w 4608"/>
                  <a:gd name="T35" fmla="*/ 15632 h 156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608" h="15680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4560" y="0"/>
                    </a:lnTo>
                    <a:cubicBezTo>
                      <a:pt x="4587" y="0"/>
                      <a:pt x="4608" y="22"/>
                      <a:pt x="4608" y="48"/>
                    </a:cubicBezTo>
                    <a:lnTo>
                      <a:pt x="4608" y="15632"/>
                    </a:lnTo>
                    <a:cubicBezTo>
                      <a:pt x="4608" y="15659"/>
                      <a:pt x="4587" y="15680"/>
                      <a:pt x="4560" y="15680"/>
                    </a:cubicBezTo>
                    <a:lnTo>
                      <a:pt x="48" y="15680"/>
                    </a:lnTo>
                    <a:cubicBezTo>
                      <a:pt x="22" y="15680"/>
                      <a:pt x="0" y="15659"/>
                      <a:pt x="0" y="15632"/>
                    </a:cubicBezTo>
                    <a:lnTo>
                      <a:pt x="0" y="48"/>
                    </a:lnTo>
                    <a:close/>
                    <a:moveTo>
                      <a:pt x="96" y="15632"/>
                    </a:moveTo>
                    <a:lnTo>
                      <a:pt x="48" y="15584"/>
                    </a:lnTo>
                    <a:lnTo>
                      <a:pt x="4560" y="15584"/>
                    </a:lnTo>
                    <a:lnTo>
                      <a:pt x="4512" y="15632"/>
                    </a:lnTo>
                    <a:lnTo>
                      <a:pt x="4512" y="48"/>
                    </a:lnTo>
                    <a:lnTo>
                      <a:pt x="4560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563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07" name="Rectangle 41"/>
              <p:cNvSpPr>
                <a:spLocks noChangeArrowheads="1"/>
              </p:cNvSpPr>
              <p:nvPr/>
            </p:nvSpPr>
            <p:spPr bwMode="auto">
              <a:xfrm>
                <a:off x="7781926" y="4627563"/>
                <a:ext cx="430213" cy="18923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08" name="Freeform 42"/>
              <p:cNvSpPr>
                <a:spLocks noEditPoints="1"/>
              </p:cNvSpPr>
              <p:nvPr/>
            </p:nvSpPr>
            <p:spPr bwMode="auto">
              <a:xfrm>
                <a:off x="7777163" y="4622800"/>
                <a:ext cx="439738" cy="1901825"/>
              </a:xfrm>
              <a:custGeom>
                <a:avLst/>
                <a:gdLst>
                  <a:gd name="T0" fmla="*/ 0 w 4608"/>
                  <a:gd name="T1" fmla="*/ 48 h 19952"/>
                  <a:gd name="T2" fmla="*/ 48 w 4608"/>
                  <a:gd name="T3" fmla="*/ 0 h 19952"/>
                  <a:gd name="T4" fmla="*/ 4560 w 4608"/>
                  <a:gd name="T5" fmla="*/ 0 h 19952"/>
                  <a:gd name="T6" fmla="*/ 4608 w 4608"/>
                  <a:gd name="T7" fmla="*/ 48 h 19952"/>
                  <a:gd name="T8" fmla="*/ 4608 w 4608"/>
                  <a:gd name="T9" fmla="*/ 19904 h 19952"/>
                  <a:gd name="T10" fmla="*/ 4560 w 4608"/>
                  <a:gd name="T11" fmla="*/ 19952 h 19952"/>
                  <a:gd name="T12" fmla="*/ 48 w 4608"/>
                  <a:gd name="T13" fmla="*/ 19952 h 19952"/>
                  <a:gd name="T14" fmla="*/ 0 w 4608"/>
                  <a:gd name="T15" fmla="*/ 19904 h 19952"/>
                  <a:gd name="T16" fmla="*/ 0 w 4608"/>
                  <a:gd name="T17" fmla="*/ 48 h 19952"/>
                  <a:gd name="T18" fmla="*/ 96 w 4608"/>
                  <a:gd name="T19" fmla="*/ 19904 h 19952"/>
                  <a:gd name="T20" fmla="*/ 48 w 4608"/>
                  <a:gd name="T21" fmla="*/ 19856 h 19952"/>
                  <a:gd name="T22" fmla="*/ 4560 w 4608"/>
                  <a:gd name="T23" fmla="*/ 19856 h 19952"/>
                  <a:gd name="T24" fmla="*/ 4512 w 4608"/>
                  <a:gd name="T25" fmla="*/ 19904 h 19952"/>
                  <a:gd name="T26" fmla="*/ 4512 w 4608"/>
                  <a:gd name="T27" fmla="*/ 48 h 19952"/>
                  <a:gd name="T28" fmla="*/ 4560 w 4608"/>
                  <a:gd name="T29" fmla="*/ 96 h 19952"/>
                  <a:gd name="T30" fmla="*/ 48 w 4608"/>
                  <a:gd name="T31" fmla="*/ 96 h 19952"/>
                  <a:gd name="T32" fmla="*/ 96 w 4608"/>
                  <a:gd name="T33" fmla="*/ 48 h 19952"/>
                  <a:gd name="T34" fmla="*/ 96 w 4608"/>
                  <a:gd name="T35" fmla="*/ 19904 h 199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608" h="19952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4560" y="0"/>
                    </a:lnTo>
                    <a:cubicBezTo>
                      <a:pt x="4587" y="0"/>
                      <a:pt x="4608" y="22"/>
                      <a:pt x="4608" y="48"/>
                    </a:cubicBezTo>
                    <a:lnTo>
                      <a:pt x="4608" y="19904"/>
                    </a:lnTo>
                    <a:cubicBezTo>
                      <a:pt x="4608" y="19931"/>
                      <a:pt x="4587" y="19952"/>
                      <a:pt x="4560" y="19952"/>
                    </a:cubicBezTo>
                    <a:lnTo>
                      <a:pt x="48" y="19952"/>
                    </a:lnTo>
                    <a:cubicBezTo>
                      <a:pt x="22" y="19952"/>
                      <a:pt x="0" y="19931"/>
                      <a:pt x="0" y="19904"/>
                    </a:cubicBezTo>
                    <a:lnTo>
                      <a:pt x="0" y="48"/>
                    </a:lnTo>
                    <a:close/>
                    <a:moveTo>
                      <a:pt x="96" y="19904"/>
                    </a:moveTo>
                    <a:lnTo>
                      <a:pt x="48" y="19856"/>
                    </a:lnTo>
                    <a:lnTo>
                      <a:pt x="4560" y="19856"/>
                    </a:lnTo>
                    <a:lnTo>
                      <a:pt x="4512" y="19904"/>
                    </a:lnTo>
                    <a:lnTo>
                      <a:pt x="4512" y="48"/>
                    </a:lnTo>
                    <a:lnTo>
                      <a:pt x="4560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990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09" name="Rectangle 43"/>
              <p:cNvSpPr>
                <a:spLocks noChangeArrowheads="1"/>
              </p:cNvSpPr>
              <p:nvPr/>
            </p:nvSpPr>
            <p:spPr bwMode="auto">
              <a:xfrm>
                <a:off x="6076951" y="6515100"/>
                <a:ext cx="57150" cy="9525"/>
              </a:xfrm>
              <a:prstGeom prst="rect">
                <a:avLst/>
              </a:pr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10" name="Freeform 44"/>
              <p:cNvSpPr>
                <a:spLocks noEditPoints="1"/>
              </p:cNvSpPr>
              <p:nvPr/>
            </p:nvSpPr>
            <p:spPr bwMode="auto">
              <a:xfrm>
                <a:off x="7451726" y="4879975"/>
                <a:ext cx="57150" cy="163513"/>
              </a:xfrm>
              <a:custGeom>
                <a:avLst/>
                <a:gdLst>
                  <a:gd name="T0" fmla="*/ 16 w 36"/>
                  <a:gd name="T1" fmla="*/ 103 h 103"/>
                  <a:gd name="T2" fmla="*/ 16 w 36"/>
                  <a:gd name="T3" fmla="*/ 2 h 103"/>
                  <a:gd name="T4" fmla="*/ 22 w 36"/>
                  <a:gd name="T5" fmla="*/ 2 h 103"/>
                  <a:gd name="T6" fmla="*/ 22 w 36"/>
                  <a:gd name="T7" fmla="*/ 103 h 103"/>
                  <a:gd name="T8" fmla="*/ 16 w 36"/>
                  <a:gd name="T9" fmla="*/ 103 h 103"/>
                  <a:gd name="T10" fmla="*/ 0 w 36"/>
                  <a:gd name="T11" fmla="*/ 0 h 103"/>
                  <a:gd name="T12" fmla="*/ 36 w 36"/>
                  <a:gd name="T13" fmla="*/ 0 h 103"/>
                  <a:gd name="T14" fmla="*/ 36 w 36"/>
                  <a:gd name="T15" fmla="*/ 5 h 103"/>
                  <a:gd name="T16" fmla="*/ 0 w 36"/>
                  <a:gd name="T17" fmla="*/ 5 h 103"/>
                  <a:gd name="T18" fmla="*/ 0 w 36"/>
                  <a:gd name="T19" fmla="*/ 0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103">
                    <a:moveTo>
                      <a:pt x="16" y="103"/>
                    </a:moveTo>
                    <a:lnTo>
                      <a:pt x="16" y="2"/>
                    </a:lnTo>
                    <a:lnTo>
                      <a:pt x="22" y="2"/>
                    </a:lnTo>
                    <a:lnTo>
                      <a:pt x="22" y="103"/>
                    </a:lnTo>
                    <a:lnTo>
                      <a:pt x="16" y="10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11" name="Freeform 45"/>
              <p:cNvSpPr>
                <a:spLocks noEditPoints="1"/>
              </p:cNvSpPr>
              <p:nvPr/>
            </p:nvSpPr>
            <p:spPr bwMode="auto">
              <a:xfrm>
                <a:off x="6592888" y="4513263"/>
                <a:ext cx="57150" cy="522288"/>
              </a:xfrm>
              <a:custGeom>
                <a:avLst/>
                <a:gdLst>
                  <a:gd name="T0" fmla="*/ 15 w 36"/>
                  <a:gd name="T1" fmla="*/ 329 h 329"/>
                  <a:gd name="T2" fmla="*/ 15 w 36"/>
                  <a:gd name="T3" fmla="*/ 3 h 329"/>
                  <a:gd name="T4" fmla="*/ 21 w 36"/>
                  <a:gd name="T5" fmla="*/ 3 h 329"/>
                  <a:gd name="T6" fmla="*/ 21 w 36"/>
                  <a:gd name="T7" fmla="*/ 329 h 329"/>
                  <a:gd name="T8" fmla="*/ 15 w 36"/>
                  <a:gd name="T9" fmla="*/ 329 h 329"/>
                  <a:gd name="T10" fmla="*/ 0 w 36"/>
                  <a:gd name="T11" fmla="*/ 0 h 329"/>
                  <a:gd name="T12" fmla="*/ 36 w 36"/>
                  <a:gd name="T13" fmla="*/ 0 h 329"/>
                  <a:gd name="T14" fmla="*/ 36 w 36"/>
                  <a:gd name="T15" fmla="*/ 6 h 329"/>
                  <a:gd name="T16" fmla="*/ 0 w 36"/>
                  <a:gd name="T17" fmla="*/ 6 h 329"/>
                  <a:gd name="T18" fmla="*/ 0 w 36"/>
                  <a:gd name="T19" fmla="*/ 0 h 3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329">
                    <a:moveTo>
                      <a:pt x="15" y="329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29"/>
                    </a:lnTo>
                    <a:lnTo>
                      <a:pt x="15" y="32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12" name="Freeform 46"/>
              <p:cNvSpPr>
                <a:spLocks noEditPoints="1"/>
              </p:cNvSpPr>
              <p:nvPr/>
            </p:nvSpPr>
            <p:spPr bwMode="auto">
              <a:xfrm>
                <a:off x="7967663" y="4348163"/>
                <a:ext cx="57150" cy="279400"/>
              </a:xfrm>
              <a:custGeom>
                <a:avLst/>
                <a:gdLst>
                  <a:gd name="T0" fmla="*/ 15 w 36"/>
                  <a:gd name="T1" fmla="*/ 176 h 176"/>
                  <a:gd name="T2" fmla="*/ 15 w 36"/>
                  <a:gd name="T3" fmla="*/ 3 h 176"/>
                  <a:gd name="T4" fmla="*/ 21 w 36"/>
                  <a:gd name="T5" fmla="*/ 3 h 176"/>
                  <a:gd name="T6" fmla="*/ 21 w 36"/>
                  <a:gd name="T7" fmla="*/ 176 h 176"/>
                  <a:gd name="T8" fmla="*/ 15 w 36"/>
                  <a:gd name="T9" fmla="*/ 176 h 176"/>
                  <a:gd name="T10" fmla="*/ 0 w 36"/>
                  <a:gd name="T11" fmla="*/ 0 h 176"/>
                  <a:gd name="T12" fmla="*/ 36 w 36"/>
                  <a:gd name="T13" fmla="*/ 0 h 176"/>
                  <a:gd name="T14" fmla="*/ 36 w 36"/>
                  <a:gd name="T15" fmla="*/ 6 h 176"/>
                  <a:gd name="T16" fmla="*/ 0 w 36"/>
                  <a:gd name="T17" fmla="*/ 6 h 176"/>
                  <a:gd name="T18" fmla="*/ 0 w 36"/>
                  <a:gd name="T19" fmla="*/ 0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176">
                    <a:moveTo>
                      <a:pt x="15" y="176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76"/>
                    </a:lnTo>
                    <a:lnTo>
                      <a:pt x="15" y="176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13" name="Rectangle 47"/>
              <p:cNvSpPr>
                <a:spLocks noChangeArrowheads="1"/>
              </p:cNvSpPr>
              <p:nvPr/>
            </p:nvSpPr>
            <p:spPr bwMode="auto">
              <a:xfrm>
                <a:off x="5672139" y="4210049"/>
                <a:ext cx="0" cy="2309812"/>
              </a:xfrm>
              <a:prstGeom prst="rect">
                <a:avLst/>
              </a:prstGeom>
              <a:solidFill>
                <a:srgbClr val="000000"/>
              </a:solidFill>
              <a:ln w="1397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14" name="Freeform 48"/>
              <p:cNvSpPr>
                <a:spLocks noEditPoints="1"/>
              </p:cNvSpPr>
              <p:nvPr/>
            </p:nvSpPr>
            <p:spPr bwMode="auto">
              <a:xfrm>
                <a:off x="5619057" y="4205288"/>
                <a:ext cx="52224" cy="2319339"/>
              </a:xfrm>
              <a:custGeom>
                <a:avLst/>
                <a:gdLst>
                  <a:gd name="T0" fmla="*/ 0 w 24"/>
                  <a:gd name="T1" fmla="*/ 1455 h 1461"/>
                  <a:gd name="T2" fmla="*/ 24 w 24"/>
                  <a:gd name="T3" fmla="*/ 1455 h 1461"/>
                  <a:gd name="T4" fmla="*/ 24 w 24"/>
                  <a:gd name="T5" fmla="*/ 1461 h 1461"/>
                  <a:gd name="T6" fmla="*/ 0 w 24"/>
                  <a:gd name="T7" fmla="*/ 1461 h 1461"/>
                  <a:gd name="T8" fmla="*/ 0 w 24"/>
                  <a:gd name="T9" fmla="*/ 1455 h 1461"/>
                  <a:gd name="T10" fmla="*/ 0 w 24"/>
                  <a:gd name="T11" fmla="*/ 1248 h 1461"/>
                  <a:gd name="T12" fmla="*/ 24 w 24"/>
                  <a:gd name="T13" fmla="*/ 1248 h 1461"/>
                  <a:gd name="T14" fmla="*/ 24 w 24"/>
                  <a:gd name="T15" fmla="*/ 1254 h 1461"/>
                  <a:gd name="T16" fmla="*/ 0 w 24"/>
                  <a:gd name="T17" fmla="*/ 1254 h 1461"/>
                  <a:gd name="T18" fmla="*/ 0 w 24"/>
                  <a:gd name="T19" fmla="*/ 1248 h 1461"/>
                  <a:gd name="T20" fmla="*/ 0 w 24"/>
                  <a:gd name="T21" fmla="*/ 1039 h 1461"/>
                  <a:gd name="T22" fmla="*/ 24 w 24"/>
                  <a:gd name="T23" fmla="*/ 1039 h 1461"/>
                  <a:gd name="T24" fmla="*/ 24 w 24"/>
                  <a:gd name="T25" fmla="*/ 1045 h 1461"/>
                  <a:gd name="T26" fmla="*/ 0 w 24"/>
                  <a:gd name="T27" fmla="*/ 1045 h 1461"/>
                  <a:gd name="T28" fmla="*/ 0 w 24"/>
                  <a:gd name="T29" fmla="*/ 1039 h 1461"/>
                  <a:gd name="T30" fmla="*/ 0 w 24"/>
                  <a:gd name="T31" fmla="*/ 832 h 1461"/>
                  <a:gd name="T32" fmla="*/ 24 w 24"/>
                  <a:gd name="T33" fmla="*/ 832 h 1461"/>
                  <a:gd name="T34" fmla="*/ 24 w 24"/>
                  <a:gd name="T35" fmla="*/ 838 h 1461"/>
                  <a:gd name="T36" fmla="*/ 0 w 24"/>
                  <a:gd name="T37" fmla="*/ 838 h 1461"/>
                  <a:gd name="T38" fmla="*/ 0 w 24"/>
                  <a:gd name="T39" fmla="*/ 832 h 1461"/>
                  <a:gd name="T40" fmla="*/ 0 w 24"/>
                  <a:gd name="T41" fmla="*/ 624 h 1461"/>
                  <a:gd name="T42" fmla="*/ 24 w 24"/>
                  <a:gd name="T43" fmla="*/ 624 h 1461"/>
                  <a:gd name="T44" fmla="*/ 24 w 24"/>
                  <a:gd name="T45" fmla="*/ 630 h 1461"/>
                  <a:gd name="T46" fmla="*/ 0 w 24"/>
                  <a:gd name="T47" fmla="*/ 630 h 1461"/>
                  <a:gd name="T48" fmla="*/ 0 w 24"/>
                  <a:gd name="T49" fmla="*/ 624 h 1461"/>
                  <a:gd name="T50" fmla="*/ 0 w 24"/>
                  <a:gd name="T51" fmla="*/ 416 h 1461"/>
                  <a:gd name="T52" fmla="*/ 24 w 24"/>
                  <a:gd name="T53" fmla="*/ 416 h 1461"/>
                  <a:gd name="T54" fmla="*/ 24 w 24"/>
                  <a:gd name="T55" fmla="*/ 422 h 1461"/>
                  <a:gd name="T56" fmla="*/ 0 w 24"/>
                  <a:gd name="T57" fmla="*/ 422 h 1461"/>
                  <a:gd name="T58" fmla="*/ 0 w 24"/>
                  <a:gd name="T59" fmla="*/ 416 h 1461"/>
                  <a:gd name="T60" fmla="*/ 0 w 24"/>
                  <a:gd name="T61" fmla="*/ 208 h 1461"/>
                  <a:gd name="T62" fmla="*/ 24 w 24"/>
                  <a:gd name="T63" fmla="*/ 208 h 1461"/>
                  <a:gd name="T64" fmla="*/ 24 w 24"/>
                  <a:gd name="T65" fmla="*/ 214 h 1461"/>
                  <a:gd name="T66" fmla="*/ 0 w 24"/>
                  <a:gd name="T67" fmla="*/ 214 h 1461"/>
                  <a:gd name="T68" fmla="*/ 0 w 24"/>
                  <a:gd name="T69" fmla="*/ 208 h 1461"/>
                  <a:gd name="T70" fmla="*/ 0 w 24"/>
                  <a:gd name="T71" fmla="*/ 0 h 1461"/>
                  <a:gd name="T72" fmla="*/ 24 w 24"/>
                  <a:gd name="T73" fmla="*/ 0 h 1461"/>
                  <a:gd name="T74" fmla="*/ 24 w 24"/>
                  <a:gd name="T75" fmla="*/ 6 h 1461"/>
                  <a:gd name="T76" fmla="*/ 0 w 24"/>
                  <a:gd name="T77" fmla="*/ 6 h 1461"/>
                  <a:gd name="T78" fmla="*/ 0 w 24"/>
                  <a:gd name="T79" fmla="*/ 0 h 14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24" h="1461">
                    <a:moveTo>
                      <a:pt x="0" y="1455"/>
                    </a:moveTo>
                    <a:lnTo>
                      <a:pt x="24" y="1455"/>
                    </a:lnTo>
                    <a:lnTo>
                      <a:pt x="24" y="1461"/>
                    </a:lnTo>
                    <a:lnTo>
                      <a:pt x="0" y="1461"/>
                    </a:lnTo>
                    <a:lnTo>
                      <a:pt x="0" y="1455"/>
                    </a:lnTo>
                    <a:close/>
                    <a:moveTo>
                      <a:pt x="0" y="1248"/>
                    </a:moveTo>
                    <a:lnTo>
                      <a:pt x="24" y="1248"/>
                    </a:lnTo>
                    <a:lnTo>
                      <a:pt x="24" y="1254"/>
                    </a:lnTo>
                    <a:lnTo>
                      <a:pt x="0" y="1254"/>
                    </a:lnTo>
                    <a:lnTo>
                      <a:pt x="0" y="1248"/>
                    </a:lnTo>
                    <a:close/>
                    <a:moveTo>
                      <a:pt x="0" y="1039"/>
                    </a:moveTo>
                    <a:lnTo>
                      <a:pt x="24" y="1039"/>
                    </a:lnTo>
                    <a:lnTo>
                      <a:pt x="24" y="1045"/>
                    </a:lnTo>
                    <a:lnTo>
                      <a:pt x="0" y="1045"/>
                    </a:lnTo>
                    <a:lnTo>
                      <a:pt x="0" y="1039"/>
                    </a:lnTo>
                    <a:close/>
                    <a:moveTo>
                      <a:pt x="0" y="832"/>
                    </a:moveTo>
                    <a:lnTo>
                      <a:pt x="24" y="832"/>
                    </a:lnTo>
                    <a:lnTo>
                      <a:pt x="24" y="838"/>
                    </a:lnTo>
                    <a:lnTo>
                      <a:pt x="0" y="838"/>
                    </a:lnTo>
                    <a:lnTo>
                      <a:pt x="0" y="832"/>
                    </a:lnTo>
                    <a:close/>
                    <a:moveTo>
                      <a:pt x="0" y="624"/>
                    </a:moveTo>
                    <a:lnTo>
                      <a:pt x="24" y="624"/>
                    </a:lnTo>
                    <a:lnTo>
                      <a:pt x="24" y="630"/>
                    </a:lnTo>
                    <a:lnTo>
                      <a:pt x="0" y="630"/>
                    </a:lnTo>
                    <a:lnTo>
                      <a:pt x="0" y="624"/>
                    </a:lnTo>
                    <a:close/>
                    <a:moveTo>
                      <a:pt x="0" y="416"/>
                    </a:moveTo>
                    <a:lnTo>
                      <a:pt x="24" y="416"/>
                    </a:lnTo>
                    <a:lnTo>
                      <a:pt x="24" y="422"/>
                    </a:lnTo>
                    <a:lnTo>
                      <a:pt x="0" y="422"/>
                    </a:lnTo>
                    <a:lnTo>
                      <a:pt x="0" y="416"/>
                    </a:lnTo>
                    <a:close/>
                    <a:moveTo>
                      <a:pt x="0" y="208"/>
                    </a:moveTo>
                    <a:lnTo>
                      <a:pt x="24" y="208"/>
                    </a:lnTo>
                    <a:lnTo>
                      <a:pt x="24" y="214"/>
                    </a:lnTo>
                    <a:lnTo>
                      <a:pt x="0" y="214"/>
                    </a:lnTo>
                    <a:lnTo>
                      <a:pt x="0" y="208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15" name="Rectangle 49"/>
              <p:cNvSpPr>
                <a:spLocks noChangeArrowheads="1"/>
              </p:cNvSpPr>
              <p:nvPr/>
            </p:nvSpPr>
            <p:spPr bwMode="auto">
              <a:xfrm>
                <a:off x="5676901" y="6515100"/>
                <a:ext cx="2749550" cy="9525"/>
              </a:xfrm>
              <a:prstGeom prst="rect">
                <a:avLst/>
              </a:pr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16" name="Rectangle 50"/>
              <p:cNvSpPr>
                <a:spLocks noChangeArrowheads="1"/>
              </p:cNvSpPr>
              <p:nvPr/>
            </p:nvSpPr>
            <p:spPr bwMode="auto">
              <a:xfrm>
                <a:off x="5444391" y="6374734"/>
                <a:ext cx="127594" cy="27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7" name="Rectangle 51"/>
              <p:cNvSpPr>
                <a:spLocks noChangeArrowheads="1"/>
              </p:cNvSpPr>
              <p:nvPr/>
            </p:nvSpPr>
            <p:spPr bwMode="auto">
              <a:xfrm>
                <a:off x="5444391" y="6044534"/>
                <a:ext cx="127594" cy="27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8" name="Rectangle 52"/>
              <p:cNvSpPr>
                <a:spLocks noChangeArrowheads="1"/>
              </p:cNvSpPr>
              <p:nvPr/>
            </p:nvSpPr>
            <p:spPr bwMode="auto">
              <a:xfrm>
                <a:off x="5316797" y="5712747"/>
                <a:ext cx="255188" cy="27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9" name="Rectangle 53"/>
              <p:cNvSpPr>
                <a:spLocks noChangeArrowheads="1"/>
              </p:cNvSpPr>
              <p:nvPr/>
            </p:nvSpPr>
            <p:spPr bwMode="auto">
              <a:xfrm>
                <a:off x="5316797" y="5385722"/>
                <a:ext cx="255188" cy="27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5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0" name="Rectangle 54"/>
              <p:cNvSpPr>
                <a:spLocks noChangeArrowheads="1"/>
              </p:cNvSpPr>
              <p:nvPr/>
            </p:nvSpPr>
            <p:spPr bwMode="auto">
              <a:xfrm>
                <a:off x="5316797" y="5055522"/>
                <a:ext cx="255188" cy="27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1" name="Rectangle 55"/>
              <p:cNvSpPr>
                <a:spLocks noChangeArrowheads="1"/>
              </p:cNvSpPr>
              <p:nvPr/>
            </p:nvSpPr>
            <p:spPr bwMode="auto">
              <a:xfrm>
                <a:off x="5316797" y="4725322"/>
                <a:ext cx="255188" cy="27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5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2" name="Rectangle 56"/>
              <p:cNvSpPr>
                <a:spLocks noChangeArrowheads="1"/>
              </p:cNvSpPr>
              <p:nvPr/>
            </p:nvSpPr>
            <p:spPr bwMode="auto">
              <a:xfrm>
                <a:off x="5316797" y="4395122"/>
                <a:ext cx="255188" cy="27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</a:t>
                </a:r>
                <a:endPara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3" name="Rectangle 57"/>
              <p:cNvSpPr>
                <a:spLocks noChangeArrowheads="1"/>
              </p:cNvSpPr>
              <p:nvPr/>
            </p:nvSpPr>
            <p:spPr bwMode="auto">
              <a:xfrm>
                <a:off x="5316797" y="4064922"/>
                <a:ext cx="255188" cy="27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5</a:t>
                </a:r>
                <a:endPara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4" name="Rectangle 60"/>
            <p:cNvSpPr>
              <a:spLocks noChangeArrowheads="1"/>
            </p:cNvSpPr>
            <p:nvPr/>
          </p:nvSpPr>
          <p:spPr bwMode="auto">
            <a:xfrm>
              <a:off x="4784011" y="3824758"/>
              <a:ext cx="2404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LPS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5" name="Rectangle 61"/>
            <p:cNvSpPr>
              <a:spLocks noChangeArrowheads="1"/>
            </p:cNvSpPr>
            <p:nvPr/>
          </p:nvSpPr>
          <p:spPr bwMode="auto">
            <a:xfrm>
              <a:off x="5341011" y="3824758"/>
              <a:ext cx="50815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LPS+Nig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6" name="Rectangle 63"/>
            <p:cNvSpPr>
              <a:spLocks noChangeArrowheads="1"/>
            </p:cNvSpPr>
            <p:nvPr/>
          </p:nvSpPr>
          <p:spPr bwMode="auto">
            <a:xfrm>
              <a:off x="4651057" y="2449866"/>
              <a:ext cx="72000" cy="72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97" name="Freeform 64"/>
            <p:cNvSpPr>
              <a:spLocks noEditPoints="1"/>
            </p:cNvSpPr>
            <p:nvPr/>
          </p:nvSpPr>
          <p:spPr bwMode="auto">
            <a:xfrm>
              <a:off x="4649469" y="2446692"/>
              <a:ext cx="72000" cy="72000"/>
            </a:xfrm>
            <a:custGeom>
              <a:avLst/>
              <a:gdLst>
                <a:gd name="T0" fmla="*/ 0 w 752"/>
                <a:gd name="T1" fmla="*/ 48 h 752"/>
                <a:gd name="T2" fmla="*/ 48 w 752"/>
                <a:gd name="T3" fmla="*/ 0 h 752"/>
                <a:gd name="T4" fmla="*/ 704 w 752"/>
                <a:gd name="T5" fmla="*/ 0 h 752"/>
                <a:gd name="T6" fmla="*/ 752 w 752"/>
                <a:gd name="T7" fmla="*/ 48 h 752"/>
                <a:gd name="T8" fmla="*/ 752 w 752"/>
                <a:gd name="T9" fmla="*/ 704 h 752"/>
                <a:gd name="T10" fmla="*/ 704 w 752"/>
                <a:gd name="T11" fmla="*/ 752 h 752"/>
                <a:gd name="T12" fmla="*/ 48 w 752"/>
                <a:gd name="T13" fmla="*/ 752 h 752"/>
                <a:gd name="T14" fmla="*/ 0 w 752"/>
                <a:gd name="T15" fmla="*/ 704 h 752"/>
                <a:gd name="T16" fmla="*/ 0 w 752"/>
                <a:gd name="T17" fmla="*/ 48 h 752"/>
                <a:gd name="T18" fmla="*/ 96 w 752"/>
                <a:gd name="T19" fmla="*/ 704 h 752"/>
                <a:gd name="T20" fmla="*/ 48 w 752"/>
                <a:gd name="T21" fmla="*/ 656 h 752"/>
                <a:gd name="T22" fmla="*/ 704 w 752"/>
                <a:gd name="T23" fmla="*/ 656 h 752"/>
                <a:gd name="T24" fmla="*/ 656 w 752"/>
                <a:gd name="T25" fmla="*/ 704 h 752"/>
                <a:gd name="T26" fmla="*/ 656 w 752"/>
                <a:gd name="T27" fmla="*/ 48 h 752"/>
                <a:gd name="T28" fmla="*/ 704 w 752"/>
                <a:gd name="T29" fmla="*/ 96 h 752"/>
                <a:gd name="T30" fmla="*/ 48 w 752"/>
                <a:gd name="T31" fmla="*/ 96 h 752"/>
                <a:gd name="T32" fmla="*/ 96 w 752"/>
                <a:gd name="T33" fmla="*/ 48 h 752"/>
                <a:gd name="T34" fmla="*/ 96 w 752"/>
                <a:gd name="T35" fmla="*/ 704 h 7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752" h="752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704" y="0"/>
                  </a:lnTo>
                  <a:cubicBezTo>
                    <a:pt x="731" y="0"/>
                    <a:pt x="752" y="22"/>
                    <a:pt x="752" y="48"/>
                  </a:cubicBezTo>
                  <a:lnTo>
                    <a:pt x="752" y="704"/>
                  </a:lnTo>
                  <a:cubicBezTo>
                    <a:pt x="752" y="731"/>
                    <a:pt x="731" y="752"/>
                    <a:pt x="704" y="752"/>
                  </a:cubicBezTo>
                  <a:lnTo>
                    <a:pt x="48" y="752"/>
                  </a:lnTo>
                  <a:cubicBezTo>
                    <a:pt x="22" y="752"/>
                    <a:pt x="0" y="731"/>
                    <a:pt x="0" y="704"/>
                  </a:cubicBezTo>
                  <a:lnTo>
                    <a:pt x="0" y="48"/>
                  </a:lnTo>
                  <a:close/>
                  <a:moveTo>
                    <a:pt x="96" y="704"/>
                  </a:moveTo>
                  <a:lnTo>
                    <a:pt x="48" y="656"/>
                  </a:lnTo>
                  <a:lnTo>
                    <a:pt x="704" y="656"/>
                  </a:lnTo>
                  <a:lnTo>
                    <a:pt x="656" y="704"/>
                  </a:lnTo>
                  <a:lnTo>
                    <a:pt x="656" y="48"/>
                  </a:lnTo>
                  <a:lnTo>
                    <a:pt x="70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70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98" name="Rectangle 65"/>
            <p:cNvSpPr>
              <a:spLocks noChangeArrowheads="1"/>
            </p:cNvSpPr>
            <p:nvPr/>
          </p:nvSpPr>
          <p:spPr bwMode="auto">
            <a:xfrm>
              <a:off x="4757288" y="2407187"/>
              <a:ext cx="2003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WT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9" name="Rectangle 66"/>
            <p:cNvSpPr>
              <a:spLocks noChangeArrowheads="1"/>
            </p:cNvSpPr>
            <p:nvPr/>
          </p:nvSpPr>
          <p:spPr bwMode="auto">
            <a:xfrm>
              <a:off x="4651057" y="2556230"/>
              <a:ext cx="72000" cy="720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0" name="Freeform 67"/>
            <p:cNvSpPr>
              <a:spLocks noEditPoints="1"/>
            </p:cNvSpPr>
            <p:nvPr/>
          </p:nvSpPr>
          <p:spPr bwMode="auto">
            <a:xfrm>
              <a:off x="4649469" y="2572105"/>
              <a:ext cx="72000" cy="72000"/>
            </a:xfrm>
            <a:custGeom>
              <a:avLst/>
              <a:gdLst>
                <a:gd name="T0" fmla="*/ 0 w 752"/>
                <a:gd name="T1" fmla="*/ 48 h 768"/>
                <a:gd name="T2" fmla="*/ 48 w 752"/>
                <a:gd name="T3" fmla="*/ 0 h 768"/>
                <a:gd name="T4" fmla="*/ 704 w 752"/>
                <a:gd name="T5" fmla="*/ 0 h 768"/>
                <a:gd name="T6" fmla="*/ 752 w 752"/>
                <a:gd name="T7" fmla="*/ 48 h 768"/>
                <a:gd name="T8" fmla="*/ 752 w 752"/>
                <a:gd name="T9" fmla="*/ 720 h 768"/>
                <a:gd name="T10" fmla="*/ 704 w 752"/>
                <a:gd name="T11" fmla="*/ 768 h 768"/>
                <a:gd name="T12" fmla="*/ 48 w 752"/>
                <a:gd name="T13" fmla="*/ 768 h 768"/>
                <a:gd name="T14" fmla="*/ 0 w 752"/>
                <a:gd name="T15" fmla="*/ 720 h 768"/>
                <a:gd name="T16" fmla="*/ 0 w 752"/>
                <a:gd name="T17" fmla="*/ 48 h 768"/>
                <a:gd name="T18" fmla="*/ 96 w 752"/>
                <a:gd name="T19" fmla="*/ 720 h 768"/>
                <a:gd name="T20" fmla="*/ 48 w 752"/>
                <a:gd name="T21" fmla="*/ 672 h 768"/>
                <a:gd name="T22" fmla="*/ 704 w 752"/>
                <a:gd name="T23" fmla="*/ 672 h 768"/>
                <a:gd name="T24" fmla="*/ 656 w 752"/>
                <a:gd name="T25" fmla="*/ 720 h 768"/>
                <a:gd name="T26" fmla="*/ 656 w 752"/>
                <a:gd name="T27" fmla="*/ 48 h 768"/>
                <a:gd name="T28" fmla="*/ 704 w 752"/>
                <a:gd name="T29" fmla="*/ 96 h 768"/>
                <a:gd name="T30" fmla="*/ 48 w 752"/>
                <a:gd name="T31" fmla="*/ 96 h 768"/>
                <a:gd name="T32" fmla="*/ 96 w 752"/>
                <a:gd name="T33" fmla="*/ 48 h 768"/>
                <a:gd name="T34" fmla="*/ 96 w 752"/>
                <a:gd name="T35" fmla="*/ 720 h 7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752" h="768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704" y="0"/>
                  </a:lnTo>
                  <a:cubicBezTo>
                    <a:pt x="731" y="0"/>
                    <a:pt x="752" y="22"/>
                    <a:pt x="752" y="48"/>
                  </a:cubicBezTo>
                  <a:lnTo>
                    <a:pt x="752" y="720"/>
                  </a:lnTo>
                  <a:cubicBezTo>
                    <a:pt x="752" y="747"/>
                    <a:pt x="731" y="768"/>
                    <a:pt x="704" y="768"/>
                  </a:cubicBezTo>
                  <a:lnTo>
                    <a:pt x="48" y="768"/>
                  </a:lnTo>
                  <a:cubicBezTo>
                    <a:pt x="22" y="768"/>
                    <a:pt x="0" y="747"/>
                    <a:pt x="0" y="720"/>
                  </a:cubicBezTo>
                  <a:lnTo>
                    <a:pt x="0" y="48"/>
                  </a:lnTo>
                  <a:close/>
                  <a:moveTo>
                    <a:pt x="96" y="720"/>
                  </a:moveTo>
                  <a:lnTo>
                    <a:pt x="48" y="672"/>
                  </a:lnTo>
                  <a:lnTo>
                    <a:pt x="704" y="672"/>
                  </a:lnTo>
                  <a:lnTo>
                    <a:pt x="656" y="720"/>
                  </a:lnTo>
                  <a:lnTo>
                    <a:pt x="656" y="48"/>
                  </a:lnTo>
                  <a:lnTo>
                    <a:pt x="70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72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1" name="Rectangle 68"/>
            <p:cNvSpPr>
              <a:spLocks noChangeArrowheads="1"/>
            </p:cNvSpPr>
            <p:nvPr/>
          </p:nvSpPr>
          <p:spPr bwMode="auto">
            <a:xfrm>
              <a:off x="4757288" y="2532600"/>
              <a:ext cx="45044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sp70</a:t>
              </a:r>
              <a:r>
                <a:rPr kumimoji="0" lang="fr-FR" altLang="fr-FR" sz="1000" b="0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/-</a:t>
              </a:r>
              <a:endParaRPr kumimoji="0" lang="fr-FR" altLang="fr-FR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2" name="Rectangle 62"/>
            <p:cNvSpPr>
              <a:spLocks noChangeArrowheads="1"/>
            </p:cNvSpPr>
            <p:nvPr/>
          </p:nvSpPr>
          <p:spPr bwMode="auto">
            <a:xfrm rot="16200000">
              <a:off x="3619945" y="2995547"/>
              <a:ext cx="116205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% of  </a:t>
              </a:r>
              <a:r>
                <a:rPr kumimoji="0" lang="fr-FR" alt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ells</a:t>
              </a: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fr-FR" alt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with</a:t>
              </a: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SC/NLRP3 </a:t>
              </a:r>
              <a:r>
                <a:rPr kumimoji="0" lang="fr-FR" alt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pecks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24" name="Groupe 223"/>
          <p:cNvGrpSpPr/>
          <p:nvPr/>
        </p:nvGrpSpPr>
        <p:grpSpPr>
          <a:xfrm>
            <a:off x="4569560" y="4040881"/>
            <a:ext cx="1351704" cy="1370651"/>
            <a:chOff x="5329835" y="4744001"/>
            <a:chExt cx="1543580" cy="1370651"/>
          </a:xfrm>
        </p:grpSpPr>
        <p:sp>
          <p:nvSpPr>
            <p:cNvPr id="225" name="Rectangle 72"/>
            <p:cNvSpPr>
              <a:spLocks noChangeArrowheads="1"/>
            </p:cNvSpPr>
            <p:nvPr/>
          </p:nvSpPr>
          <p:spPr bwMode="auto">
            <a:xfrm>
              <a:off x="5486952" y="5379582"/>
              <a:ext cx="252170" cy="7302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6" name="Freeform 73"/>
            <p:cNvSpPr>
              <a:spLocks noEditPoints="1"/>
            </p:cNvSpPr>
            <p:nvPr/>
          </p:nvSpPr>
          <p:spPr bwMode="auto">
            <a:xfrm>
              <a:off x="5484140" y="5376770"/>
              <a:ext cx="257794" cy="735887"/>
            </a:xfrm>
            <a:custGeom>
              <a:avLst/>
              <a:gdLst>
                <a:gd name="T0" fmla="*/ 0 w 4576"/>
                <a:gd name="T1" fmla="*/ 48 h 13088"/>
                <a:gd name="T2" fmla="*/ 48 w 4576"/>
                <a:gd name="T3" fmla="*/ 0 h 13088"/>
                <a:gd name="T4" fmla="*/ 4528 w 4576"/>
                <a:gd name="T5" fmla="*/ 0 h 13088"/>
                <a:gd name="T6" fmla="*/ 4576 w 4576"/>
                <a:gd name="T7" fmla="*/ 48 h 13088"/>
                <a:gd name="T8" fmla="*/ 4576 w 4576"/>
                <a:gd name="T9" fmla="*/ 13040 h 13088"/>
                <a:gd name="T10" fmla="*/ 4528 w 4576"/>
                <a:gd name="T11" fmla="*/ 13088 h 13088"/>
                <a:gd name="T12" fmla="*/ 48 w 4576"/>
                <a:gd name="T13" fmla="*/ 13088 h 13088"/>
                <a:gd name="T14" fmla="*/ 0 w 4576"/>
                <a:gd name="T15" fmla="*/ 13040 h 13088"/>
                <a:gd name="T16" fmla="*/ 0 w 4576"/>
                <a:gd name="T17" fmla="*/ 48 h 13088"/>
                <a:gd name="T18" fmla="*/ 96 w 4576"/>
                <a:gd name="T19" fmla="*/ 13040 h 13088"/>
                <a:gd name="T20" fmla="*/ 48 w 4576"/>
                <a:gd name="T21" fmla="*/ 12992 h 13088"/>
                <a:gd name="T22" fmla="*/ 4528 w 4576"/>
                <a:gd name="T23" fmla="*/ 12992 h 13088"/>
                <a:gd name="T24" fmla="*/ 4480 w 4576"/>
                <a:gd name="T25" fmla="*/ 13040 h 13088"/>
                <a:gd name="T26" fmla="*/ 4480 w 4576"/>
                <a:gd name="T27" fmla="*/ 48 h 13088"/>
                <a:gd name="T28" fmla="*/ 4528 w 4576"/>
                <a:gd name="T29" fmla="*/ 96 h 13088"/>
                <a:gd name="T30" fmla="*/ 48 w 4576"/>
                <a:gd name="T31" fmla="*/ 96 h 13088"/>
                <a:gd name="T32" fmla="*/ 96 w 4576"/>
                <a:gd name="T33" fmla="*/ 48 h 13088"/>
                <a:gd name="T34" fmla="*/ 96 w 4576"/>
                <a:gd name="T35" fmla="*/ 13040 h 130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76" h="13088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4528" y="0"/>
                  </a:lnTo>
                  <a:cubicBezTo>
                    <a:pt x="4555" y="0"/>
                    <a:pt x="4576" y="22"/>
                    <a:pt x="4576" y="48"/>
                  </a:cubicBezTo>
                  <a:lnTo>
                    <a:pt x="4576" y="13040"/>
                  </a:lnTo>
                  <a:cubicBezTo>
                    <a:pt x="4576" y="13067"/>
                    <a:pt x="4555" y="13088"/>
                    <a:pt x="4528" y="13088"/>
                  </a:cubicBezTo>
                  <a:lnTo>
                    <a:pt x="48" y="13088"/>
                  </a:lnTo>
                  <a:cubicBezTo>
                    <a:pt x="22" y="13088"/>
                    <a:pt x="0" y="13067"/>
                    <a:pt x="0" y="13040"/>
                  </a:cubicBezTo>
                  <a:lnTo>
                    <a:pt x="0" y="48"/>
                  </a:lnTo>
                  <a:close/>
                  <a:moveTo>
                    <a:pt x="96" y="13040"/>
                  </a:moveTo>
                  <a:lnTo>
                    <a:pt x="48" y="12992"/>
                  </a:lnTo>
                  <a:lnTo>
                    <a:pt x="4528" y="12992"/>
                  </a:lnTo>
                  <a:lnTo>
                    <a:pt x="4480" y="13040"/>
                  </a:lnTo>
                  <a:lnTo>
                    <a:pt x="4480" y="48"/>
                  </a:lnTo>
                  <a:lnTo>
                    <a:pt x="4528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1304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7" name="Rectangle 74"/>
            <p:cNvSpPr>
              <a:spLocks noChangeArrowheads="1"/>
            </p:cNvSpPr>
            <p:nvPr/>
          </p:nvSpPr>
          <p:spPr bwMode="auto">
            <a:xfrm>
              <a:off x="5991291" y="5461140"/>
              <a:ext cx="252170" cy="64870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8" name="Freeform 75"/>
            <p:cNvSpPr>
              <a:spLocks noEditPoints="1"/>
            </p:cNvSpPr>
            <p:nvPr/>
          </p:nvSpPr>
          <p:spPr bwMode="auto">
            <a:xfrm>
              <a:off x="5988479" y="5458327"/>
              <a:ext cx="257794" cy="654330"/>
            </a:xfrm>
            <a:custGeom>
              <a:avLst/>
              <a:gdLst>
                <a:gd name="T0" fmla="*/ 0 w 4576"/>
                <a:gd name="T1" fmla="*/ 48 h 11632"/>
                <a:gd name="T2" fmla="*/ 48 w 4576"/>
                <a:gd name="T3" fmla="*/ 0 h 11632"/>
                <a:gd name="T4" fmla="*/ 4528 w 4576"/>
                <a:gd name="T5" fmla="*/ 0 h 11632"/>
                <a:gd name="T6" fmla="*/ 4576 w 4576"/>
                <a:gd name="T7" fmla="*/ 48 h 11632"/>
                <a:gd name="T8" fmla="*/ 4576 w 4576"/>
                <a:gd name="T9" fmla="*/ 11584 h 11632"/>
                <a:gd name="T10" fmla="*/ 4528 w 4576"/>
                <a:gd name="T11" fmla="*/ 11632 h 11632"/>
                <a:gd name="T12" fmla="*/ 48 w 4576"/>
                <a:gd name="T13" fmla="*/ 11632 h 11632"/>
                <a:gd name="T14" fmla="*/ 0 w 4576"/>
                <a:gd name="T15" fmla="*/ 11584 h 11632"/>
                <a:gd name="T16" fmla="*/ 0 w 4576"/>
                <a:gd name="T17" fmla="*/ 48 h 11632"/>
                <a:gd name="T18" fmla="*/ 96 w 4576"/>
                <a:gd name="T19" fmla="*/ 11584 h 11632"/>
                <a:gd name="T20" fmla="*/ 48 w 4576"/>
                <a:gd name="T21" fmla="*/ 11536 h 11632"/>
                <a:gd name="T22" fmla="*/ 4528 w 4576"/>
                <a:gd name="T23" fmla="*/ 11536 h 11632"/>
                <a:gd name="T24" fmla="*/ 4480 w 4576"/>
                <a:gd name="T25" fmla="*/ 11584 h 11632"/>
                <a:gd name="T26" fmla="*/ 4480 w 4576"/>
                <a:gd name="T27" fmla="*/ 48 h 11632"/>
                <a:gd name="T28" fmla="*/ 4528 w 4576"/>
                <a:gd name="T29" fmla="*/ 96 h 11632"/>
                <a:gd name="T30" fmla="*/ 48 w 4576"/>
                <a:gd name="T31" fmla="*/ 96 h 11632"/>
                <a:gd name="T32" fmla="*/ 96 w 4576"/>
                <a:gd name="T33" fmla="*/ 48 h 11632"/>
                <a:gd name="T34" fmla="*/ 96 w 4576"/>
                <a:gd name="T35" fmla="*/ 11584 h 116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76" h="11632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4528" y="0"/>
                  </a:lnTo>
                  <a:cubicBezTo>
                    <a:pt x="4555" y="0"/>
                    <a:pt x="4576" y="22"/>
                    <a:pt x="4576" y="48"/>
                  </a:cubicBezTo>
                  <a:lnTo>
                    <a:pt x="4576" y="11584"/>
                  </a:lnTo>
                  <a:cubicBezTo>
                    <a:pt x="4576" y="11611"/>
                    <a:pt x="4555" y="11632"/>
                    <a:pt x="4528" y="11632"/>
                  </a:cubicBezTo>
                  <a:lnTo>
                    <a:pt x="48" y="11632"/>
                  </a:lnTo>
                  <a:cubicBezTo>
                    <a:pt x="22" y="11632"/>
                    <a:pt x="0" y="11611"/>
                    <a:pt x="0" y="11584"/>
                  </a:cubicBezTo>
                  <a:lnTo>
                    <a:pt x="0" y="48"/>
                  </a:lnTo>
                  <a:close/>
                  <a:moveTo>
                    <a:pt x="96" y="11584"/>
                  </a:moveTo>
                  <a:lnTo>
                    <a:pt x="48" y="11536"/>
                  </a:lnTo>
                  <a:lnTo>
                    <a:pt x="4528" y="11536"/>
                  </a:lnTo>
                  <a:lnTo>
                    <a:pt x="4480" y="11584"/>
                  </a:lnTo>
                  <a:lnTo>
                    <a:pt x="4480" y="48"/>
                  </a:lnTo>
                  <a:lnTo>
                    <a:pt x="4528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11584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9" name="Rectangle 76"/>
            <p:cNvSpPr>
              <a:spLocks noChangeArrowheads="1"/>
            </p:cNvSpPr>
            <p:nvPr/>
          </p:nvSpPr>
          <p:spPr bwMode="auto">
            <a:xfrm>
              <a:off x="6495629" y="5705810"/>
              <a:ext cx="251232" cy="40403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0" name="Freeform 77"/>
            <p:cNvSpPr>
              <a:spLocks noEditPoints="1"/>
            </p:cNvSpPr>
            <p:nvPr/>
          </p:nvSpPr>
          <p:spPr bwMode="auto">
            <a:xfrm>
              <a:off x="6492817" y="5702998"/>
              <a:ext cx="256856" cy="409660"/>
            </a:xfrm>
            <a:custGeom>
              <a:avLst/>
              <a:gdLst>
                <a:gd name="T0" fmla="*/ 0 w 4576"/>
                <a:gd name="T1" fmla="*/ 48 h 7280"/>
                <a:gd name="T2" fmla="*/ 48 w 4576"/>
                <a:gd name="T3" fmla="*/ 0 h 7280"/>
                <a:gd name="T4" fmla="*/ 4528 w 4576"/>
                <a:gd name="T5" fmla="*/ 0 h 7280"/>
                <a:gd name="T6" fmla="*/ 4576 w 4576"/>
                <a:gd name="T7" fmla="*/ 48 h 7280"/>
                <a:gd name="T8" fmla="*/ 4576 w 4576"/>
                <a:gd name="T9" fmla="*/ 7232 h 7280"/>
                <a:gd name="T10" fmla="*/ 4528 w 4576"/>
                <a:gd name="T11" fmla="*/ 7280 h 7280"/>
                <a:gd name="T12" fmla="*/ 48 w 4576"/>
                <a:gd name="T13" fmla="*/ 7280 h 7280"/>
                <a:gd name="T14" fmla="*/ 0 w 4576"/>
                <a:gd name="T15" fmla="*/ 7232 h 7280"/>
                <a:gd name="T16" fmla="*/ 0 w 4576"/>
                <a:gd name="T17" fmla="*/ 48 h 7280"/>
                <a:gd name="T18" fmla="*/ 96 w 4576"/>
                <a:gd name="T19" fmla="*/ 7232 h 7280"/>
                <a:gd name="T20" fmla="*/ 48 w 4576"/>
                <a:gd name="T21" fmla="*/ 7184 h 7280"/>
                <a:gd name="T22" fmla="*/ 4528 w 4576"/>
                <a:gd name="T23" fmla="*/ 7184 h 7280"/>
                <a:gd name="T24" fmla="*/ 4480 w 4576"/>
                <a:gd name="T25" fmla="*/ 7232 h 7280"/>
                <a:gd name="T26" fmla="*/ 4480 w 4576"/>
                <a:gd name="T27" fmla="*/ 48 h 7280"/>
                <a:gd name="T28" fmla="*/ 4528 w 4576"/>
                <a:gd name="T29" fmla="*/ 96 h 7280"/>
                <a:gd name="T30" fmla="*/ 48 w 4576"/>
                <a:gd name="T31" fmla="*/ 96 h 7280"/>
                <a:gd name="T32" fmla="*/ 96 w 4576"/>
                <a:gd name="T33" fmla="*/ 48 h 7280"/>
                <a:gd name="T34" fmla="*/ 96 w 4576"/>
                <a:gd name="T35" fmla="*/ 7232 h 7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76" h="7280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4528" y="0"/>
                  </a:lnTo>
                  <a:cubicBezTo>
                    <a:pt x="4555" y="0"/>
                    <a:pt x="4576" y="22"/>
                    <a:pt x="4576" y="48"/>
                  </a:cubicBezTo>
                  <a:lnTo>
                    <a:pt x="4576" y="7232"/>
                  </a:lnTo>
                  <a:cubicBezTo>
                    <a:pt x="4576" y="7259"/>
                    <a:pt x="4555" y="7280"/>
                    <a:pt x="4528" y="7280"/>
                  </a:cubicBezTo>
                  <a:lnTo>
                    <a:pt x="48" y="7280"/>
                  </a:lnTo>
                  <a:cubicBezTo>
                    <a:pt x="22" y="7280"/>
                    <a:pt x="0" y="7259"/>
                    <a:pt x="0" y="7232"/>
                  </a:cubicBezTo>
                  <a:lnTo>
                    <a:pt x="0" y="48"/>
                  </a:lnTo>
                  <a:close/>
                  <a:moveTo>
                    <a:pt x="96" y="7232"/>
                  </a:moveTo>
                  <a:lnTo>
                    <a:pt x="48" y="7184"/>
                  </a:lnTo>
                  <a:lnTo>
                    <a:pt x="4528" y="7184"/>
                  </a:lnTo>
                  <a:lnTo>
                    <a:pt x="4480" y="7232"/>
                  </a:lnTo>
                  <a:lnTo>
                    <a:pt x="4480" y="48"/>
                  </a:lnTo>
                  <a:lnTo>
                    <a:pt x="4528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723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1" name="Rectangle 78"/>
            <p:cNvSpPr>
              <a:spLocks noChangeArrowheads="1"/>
            </p:cNvSpPr>
            <p:nvPr/>
          </p:nvSpPr>
          <p:spPr bwMode="auto">
            <a:xfrm>
              <a:off x="5486952" y="5135849"/>
              <a:ext cx="252170" cy="24373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2" name="Freeform 79"/>
            <p:cNvSpPr>
              <a:spLocks noEditPoints="1"/>
            </p:cNvSpPr>
            <p:nvPr/>
          </p:nvSpPr>
          <p:spPr bwMode="auto">
            <a:xfrm>
              <a:off x="5484140" y="5133974"/>
              <a:ext cx="257794" cy="248421"/>
            </a:xfrm>
            <a:custGeom>
              <a:avLst/>
              <a:gdLst>
                <a:gd name="T0" fmla="*/ 0 w 4576"/>
                <a:gd name="T1" fmla="*/ 48 h 4416"/>
                <a:gd name="T2" fmla="*/ 48 w 4576"/>
                <a:gd name="T3" fmla="*/ 0 h 4416"/>
                <a:gd name="T4" fmla="*/ 4528 w 4576"/>
                <a:gd name="T5" fmla="*/ 0 h 4416"/>
                <a:gd name="T6" fmla="*/ 4576 w 4576"/>
                <a:gd name="T7" fmla="*/ 48 h 4416"/>
                <a:gd name="T8" fmla="*/ 4576 w 4576"/>
                <a:gd name="T9" fmla="*/ 4368 h 4416"/>
                <a:gd name="T10" fmla="*/ 4528 w 4576"/>
                <a:gd name="T11" fmla="*/ 4416 h 4416"/>
                <a:gd name="T12" fmla="*/ 48 w 4576"/>
                <a:gd name="T13" fmla="*/ 4416 h 4416"/>
                <a:gd name="T14" fmla="*/ 0 w 4576"/>
                <a:gd name="T15" fmla="*/ 4368 h 4416"/>
                <a:gd name="T16" fmla="*/ 0 w 4576"/>
                <a:gd name="T17" fmla="*/ 48 h 4416"/>
                <a:gd name="T18" fmla="*/ 96 w 4576"/>
                <a:gd name="T19" fmla="*/ 4368 h 4416"/>
                <a:gd name="T20" fmla="*/ 48 w 4576"/>
                <a:gd name="T21" fmla="*/ 4320 h 4416"/>
                <a:gd name="T22" fmla="*/ 4528 w 4576"/>
                <a:gd name="T23" fmla="*/ 4320 h 4416"/>
                <a:gd name="T24" fmla="*/ 4480 w 4576"/>
                <a:gd name="T25" fmla="*/ 4368 h 4416"/>
                <a:gd name="T26" fmla="*/ 4480 w 4576"/>
                <a:gd name="T27" fmla="*/ 48 h 4416"/>
                <a:gd name="T28" fmla="*/ 4528 w 4576"/>
                <a:gd name="T29" fmla="*/ 96 h 4416"/>
                <a:gd name="T30" fmla="*/ 48 w 4576"/>
                <a:gd name="T31" fmla="*/ 96 h 4416"/>
                <a:gd name="T32" fmla="*/ 96 w 4576"/>
                <a:gd name="T33" fmla="*/ 48 h 4416"/>
                <a:gd name="T34" fmla="*/ 96 w 4576"/>
                <a:gd name="T35" fmla="*/ 4368 h 4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76" h="4416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4528" y="0"/>
                  </a:lnTo>
                  <a:cubicBezTo>
                    <a:pt x="4555" y="0"/>
                    <a:pt x="4576" y="22"/>
                    <a:pt x="4576" y="48"/>
                  </a:cubicBezTo>
                  <a:lnTo>
                    <a:pt x="4576" y="4368"/>
                  </a:lnTo>
                  <a:cubicBezTo>
                    <a:pt x="4576" y="4395"/>
                    <a:pt x="4555" y="4416"/>
                    <a:pt x="4528" y="4416"/>
                  </a:cubicBezTo>
                  <a:lnTo>
                    <a:pt x="48" y="4416"/>
                  </a:lnTo>
                  <a:cubicBezTo>
                    <a:pt x="22" y="4416"/>
                    <a:pt x="0" y="4395"/>
                    <a:pt x="0" y="4368"/>
                  </a:cubicBezTo>
                  <a:lnTo>
                    <a:pt x="0" y="48"/>
                  </a:lnTo>
                  <a:close/>
                  <a:moveTo>
                    <a:pt x="96" y="4368"/>
                  </a:moveTo>
                  <a:lnTo>
                    <a:pt x="48" y="4320"/>
                  </a:lnTo>
                  <a:lnTo>
                    <a:pt x="4528" y="4320"/>
                  </a:lnTo>
                  <a:lnTo>
                    <a:pt x="4480" y="4368"/>
                  </a:lnTo>
                  <a:lnTo>
                    <a:pt x="4480" y="48"/>
                  </a:lnTo>
                  <a:lnTo>
                    <a:pt x="4528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4368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3" name="Rectangle 80"/>
            <p:cNvSpPr>
              <a:spLocks noChangeArrowheads="1"/>
            </p:cNvSpPr>
            <p:nvPr/>
          </p:nvSpPr>
          <p:spPr bwMode="auto">
            <a:xfrm>
              <a:off x="5991291" y="5135849"/>
              <a:ext cx="252170" cy="32529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4" name="Freeform 81"/>
            <p:cNvSpPr>
              <a:spLocks noEditPoints="1"/>
            </p:cNvSpPr>
            <p:nvPr/>
          </p:nvSpPr>
          <p:spPr bwMode="auto">
            <a:xfrm>
              <a:off x="5988479" y="5133974"/>
              <a:ext cx="257794" cy="329977"/>
            </a:xfrm>
            <a:custGeom>
              <a:avLst/>
              <a:gdLst>
                <a:gd name="T0" fmla="*/ 0 w 4576"/>
                <a:gd name="T1" fmla="*/ 48 h 5872"/>
                <a:gd name="T2" fmla="*/ 48 w 4576"/>
                <a:gd name="T3" fmla="*/ 0 h 5872"/>
                <a:gd name="T4" fmla="*/ 4528 w 4576"/>
                <a:gd name="T5" fmla="*/ 0 h 5872"/>
                <a:gd name="T6" fmla="*/ 4576 w 4576"/>
                <a:gd name="T7" fmla="*/ 48 h 5872"/>
                <a:gd name="T8" fmla="*/ 4576 w 4576"/>
                <a:gd name="T9" fmla="*/ 5824 h 5872"/>
                <a:gd name="T10" fmla="*/ 4528 w 4576"/>
                <a:gd name="T11" fmla="*/ 5872 h 5872"/>
                <a:gd name="T12" fmla="*/ 48 w 4576"/>
                <a:gd name="T13" fmla="*/ 5872 h 5872"/>
                <a:gd name="T14" fmla="*/ 0 w 4576"/>
                <a:gd name="T15" fmla="*/ 5824 h 5872"/>
                <a:gd name="T16" fmla="*/ 0 w 4576"/>
                <a:gd name="T17" fmla="*/ 48 h 5872"/>
                <a:gd name="T18" fmla="*/ 96 w 4576"/>
                <a:gd name="T19" fmla="*/ 5824 h 5872"/>
                <a:gd name="T20" fmla="*/ 48 w 4576"/>
                <a:gd name="T21" fmla="*/ 5776 h 5872"/>
                <a:gd name="T22" fmla="*/ 4528 w 4576"/>
                <a:gd name="T23" fmla="*/ 5776 h 5872"/>
                <a:gd name="T24" fmla="*/ 4480 w 4576"/>
                <a:gd name="T25" fmla="*/ 5824 h 5872"/>
                <a:gd name="T26" fmla="*/ 4480 w 4576"/>
                <a:gd name="T27" fmla="*/ 48 h 5872"/>
                <a:gd name="T28" fmla="*/ 4528 w 4576"/>
                <a:gd name="T29" fmla="*/ 96 h 5872"/>
                <a:gd name="T30" fmla="*/ 48 w 4576"/>
                <a:gd name="T31" fmla="*/ 96 h 5872"/>
                <a:gd name="T32" fmla="*/ 96 w 4576"/>
                <a:gd name="T33" fmla="*/ 48 h 5872"/>
                <a:gd name="T34" fmla="*/ 96 w 4576"/>
                <a:gd name="T35" fmla="*/ 5824 h 58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76" h="5872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4528" y="0"/>
                  </a:lnTo>
                  <a:cubicBezTo>
                    <a:pt x="4555" y="0"/>
                    <a:pt x="4576" y="22"/>
                    <a:pt x="4576" y="48"/>
                  </a:cubicBezTo>
                  <a:lnTo>
                    <a:pt x="4576" y="5824"/>
                  </a:lnTo>
                  <a:cubicBezTo>
                    <a:pt x="4576" y="5851"/>
                    <a:pt x="4555" y="5872"/>
                    <a:pt x="4528" y="5872"/>
                  </a:cubicBezTo>
                  <a:lnTo>
                    <a:pt x="48" y="5872"/>
                  </a:lnTo>
                  <a:cubicBezTo>
                    <a:pt x="22" y="5872"/>
                    <a:pt x="0" y="5851"/>
                    <a:pt x="0" y="5824"/>
                  </a:cubicBezTo>
                  <a:lnTo>
                    <a:pt x="0" y="48"/>
                  </a:lnTo>
                  <a:close/>
                  <a:moveTo>
                    <a:pt x="96" y="5824"/>
                  </a:moveTo>
                  <a:lnTo>
                    <a:pt x="48" y="5776"/>
                  </a:lnTo>
                  <a:lnTo>
                    <a:pt x="4528" y="5776"/>
                  </a:lnTo>
                  <a:lnTo>
                    <a:pt x="4480" y="5824"/>
                  </a:lnTo>
                  <a:lnTo>
                    <a:pt x="4480" y="48"/>
                  </a:lnTo>
                  <a:lnTo>
                    <a:pt x="4528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5824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5" name="Rectangle 82"/>
            <p:cNvSpPr>
              <a:spLocks noChangeArrowheads="1"/>
            </p:cNvSpPr>
            <p:nvPr/>
          </p:nvSpPr>
          <p:spPr bwMode="auto">
            <a:xfrm>
              <a:off x="6495629" y="5058042"/>
              <a:ext cx="251232" cy="647768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6" name="Freeform 83"/>
            <p:cNvSpPr>
              <a:spLocks noEditPoints="1"/>
            </p:cNvSpPr>
            <p:nvPr/>
          </p:nvSpPr>
          <p:spPr bwMode="auto">
            <a:xfrm>
              <a:off x="6492817" y="5055230"/>
              <a:ext cx="256856" cy="653393"/>
            </a:xfrm>
            <a:custGeom>
              <a:avLst/>
              <a:gdLst>
                <a:gd name="T0" fmla="*/ 0 w 4576"/>
                <a:gd name="T1" fmla="*/ 48 h 11616"/>
                <a:gd name="T2" fmla="*/ 48 w 4576"/>
                <a:gd name="T3" fmla="*/ 0 h 11616"/>
                <a:gd name="T4" fmla="*/ 4528 w 4576"/>
                <a:gd name="T5" fmla="*/ 0 h 11616"/>
                <a:gd name="T6" fmla="*/ 4576 w 4576"/>
                <a:gd name="T7" fmla="*/ 48 h 11616"/>
                <a:gd name="T8" fmla="*/ 4576 w 4576"/>
                <a:gd name="T9" fmla="*/ 11568 h 11616"/>
                <a:gd name="T10" fmla="*/ 4528 w 4576"/>
                <a:gd name="T11" fmla="*/ 11616 h 11616"/>
                <a:gd name="T12" fmla="*/ 48 w 4576"/>
                <a:gd name="T13" fmla="*/ 11616 h 11616"/>
                <a:gd name="T14" fmla="*/ 0 w 4576"/>
                <a:gd name="T15" fmla="*/ 11568 h 11616"/>
                <a:gd name="T16" fmla="*/ 0 w 4576"/>
                <a:gd name="T17" fmla="*/ 48 h 11616"/>
                <a:gd name="T18" fmla="*/ 96 w 4576"/>
                <a:gd name="T19" fmla="*/ 11568 h 11616"/>
                <a:gd name="T20" fmla="*/ 48 w 4576"/>
                <a:gd name="T21" fmla="*/ 11520 h 11616"/>
                <a:gd name="T22" fmla="*/ 4528 w 4576"/>
                <a:gd name="T23" fmla="*/ 11520 h 11616"/>
                <a:gd name="T24" fmla="*/ 4480 w 4576"/>
                <a:gd name="T25" fmla="*/ 11568 h 11616"/>
                <a:gd name="T26" fmla="*/ 4480 w 4576"/>
                <a:gd name="T27" fmla="*/ 48 h 11616"/>
                <a:gd name="T28" fmla="*/ 4528 w 4576"/>
                <a:gd name="T29" fmla="*/ 96 h 11616"/>
                <a:gd name="T30" fmla="*/ 48 w 4576"/>
                <a:gd name="T31" fmla="*/ 96 h 11616"/>
                <a:gd name="T32" fmla="*/ 96 w 4576"/>
                <a:gd name="T33" fmla="*/ 48 h 11616"/>
                <a:gd name="T34" fmla="*/ 96 w 4576"/>
                <a:gd name="T35" fmla="*/ 11568 h 116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76" h="11616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4528" y="0"/>
                  </a:lnTo>
                  <a:cubicBezTo>
                    <a:pt x="4555" y="0"/>
                    <a:pt x="4576" y="22"/>
                    <a:pt x="4576" y="48"/>
                  </a:cubicBezTo>
                  <a:lnTo>
                    <a:pt x="4576" y="11568"/>
                  </a:lnTo>
                  <a:cubicBezTo>
                    <a:pt x="4576" y="11595"/>
                    <a:pt x="4555" y="11616"/>
                    <a:pt x="4528" y="11616"/>
                  </a:cubicBezTo>
                  <a:lnTo>
                    <a:pt x="48" y="11616"/>
                  </a:lnTo>
                  <a:cubicBezTo>
                    <a:pt x="22" y="11616"/>
                    <a:pt x="0" y="11595"/>
                    <a:pt x="0" y="11568"/>
                  </a:cubicBezTo>
                  <a:lnTo>
                    <a:pt x="0" y="48"/>
                  </a:lnTo>
                  <a:close/>
                  <a:moveTo>
                    <a:pt x="96" y="11568"/>
                  </a:moveTo>
                  <a:lnTo>
                    <a:pt x="48" y="11520"/>
                  </a:lnTo>
                  <a:lnTo>
                    <a:pt x="4528" y="11520"/>
                  </a:lnTo>
                  <a:lnTo>
                    <a:pt x="4480" y="11568"/>
                  </a:lnTo>
                  <a:lnTo>
                    <a:pt x="4480" y="48"/>
                  </a:lnTo>
                  <a:lnTo>
                    <a:pt x="4528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11568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7" name="Freeform 84"/>
            <p:cNvSpPr>
              <a:spLocks noEditPoints="1"/>
            </p:cNvSpPr>
            <p:nvPr/>
          </p:nvSpPr>
          <p:spPr bwMode="auto">
            <a:xfrm>
              <a:off x="5596632" y="5217406"/>
              <a:ext cx="33748" cy="162177"/>
            </a:xfrm>
            <a:custGeom>
              <a:avLst/>
              <a:gdLst>
                <a:gd name="T0" fmla="*/ 15 w 36"/>
                <a:gd name="T1" fmla="*/ 173 h 173"/>
                <a:gd name="T2" fmla="*/ 15 w 36"/>
                <a:gd name="T3" fmla="*/ 3 h 173"/>
                <a:gd name="T4" fmla="*/ 21 w 36"/>
                <a:gd name="T5" fmla="*/ 3 h 173"/>
                <a:gd name="T6" fmla="*/ 21 w 36"/>
                <a:gd name="T7" fmla="*/ 173 h 173"/>
                <a:gd name="T8" fmla="*/ 15 w 36"/>
                <a:gd name="T9" fmla="*/ 173 h 173"/>
                <a:gd name="T10" fmla="*/ 0 w 36"/>
                <a:gd name="T11" fmla="*/ 0 h 173"/>
                <a:gd name="T12" fmla="*/ 36 w 36"/>
                <a:gd name="T13" fmla="*/ 0 h 173"/>
                <a:gd name="T14" fmla="*/ 36 w 36"/>
                <a:gd name="T15" fmla="*/ 6 h 173"/>
                <a:gd name="T16" fmla="*/ 0 w 36"/>
                <a:gd name="T17" fmla="*/ 6 h 173"/>
                <a:gd name="T18" fmla="*/ 0 w 36"/>
                <a:gd name="T19" fmla="*/ 0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6" h="173">
                  <a:moveTo>
                    <a:pt x="15" y="173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73"/>
                  </a:lnTo>
                  <a:lnTo>
                    <a:pt x="15" y="17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8" name="Freeform 85"/>
            <p:cNvSpPr>
              <a:spLocks noEditPoints="1"/>
            </p:cNvSpPr>
            <p:nvPr/>
          </p:nvSpPr>
          <p:spPr bwMode="auto">
            <a:xfrm>
              <a:off x="6100033" y="5284902"/>
              <a:ext cx="34685" cy="176238"/>
            </a:xfrm>
            <a:custGeom>
              <a:avLst/>
              <a:gdLst>
                <a:gd name="T0" fmla="*/ 15 w 37"/>
                <a:gd name="T1" fmla="*/ 188 h 188"/>
                <a:gd name="T2" fmla="*/ 15 w 37"/>
                <a:gd name="T3" fmla="*/ 3 h 188"/>
                <a:gd name="T4" fmla="*/ 21 w 37"/>
                <a:gd name="T5" fmla="*/ 3 h 188"/>
                <a:gd name="T6" fmla="*/ 21 w 37"/>
                <a:gd name="T7" fmla="*/ 188 h 188"/>
                <a:gd name="T8" fmla="*/ 15 w 37"/>
                <a:gd name="T9" fmla="*/ 188 h 188"/>
                <a:gd name="T10" fmla="*/ 0 w 37"/>
                <a:gd name="T11" fmla="*/ 0 h 188"/>
                <a:gd name="T12" fmla="*/ 37 w 37"/>
                <a:gd name="T13" fmla="*/ 0 h 188"/>
                <a:gd name="T14" fmla="*/ 37 w 37"/>
                <a:gd name="T15" fmla="*/ 6 h 188"/>
                <a:gd name="T16" fmla="*/ 0 w 37"/>
                <a:gd name="T17" fmla="*/ 6 h 188"/>
                <a:gd name="T18" fmla="*/ 0 w 37"/>
                <a:gd name="T19" fmla="*/ 0 h 1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7" h="188">
                  <a:moveTo>
                    <a:pt x="15" y="188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88"/>
                  </a:lnTo>
                  <a:lnTo>
                    <a:pt x="15" y="188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9" name="Freeform 86"/>
            <p:cNvSpPr>
              <a:spLocks noEditPoints="1"/>
            </p:cNvSpPr>
            <p:nvPr/>
          </p:nvSpPr>
          <p:spPr bwMode="auto">
            <a:xfrm>
              <a:off x="6604372" y="5611129"/>
              <a:ext cx="32810" cy="94681"/>
            </a:xfrm>
            <a:custGeom>
              <a:avLst/>
              <a:gdLst>
                <a:gd name="T0" fmla="*/ 15 w 35"/>
                <a:gd name="T1" fmla="*/ 101 h 101"/>
                <a:gd name="T2" fmla="*/ 15 w 35"/>
                <a:gd name="T3" fmla="*/ 3 h 101"/>
                <a:gd name="T4" fmla="*/ 21 w 35"/>
                <a:gd name="T5" fmla="*/ 3 h 101"/>
                <a:gd name="T6" fmla="*/ 21 w 35"/>
                <a:gd name="T7" fmla="*/ 101 h 101"/>
                <a:gd name="T8" fmla="*/ 15 w 35"/>
                <a:gd name="T9" fmla="*/ 101 h 101"/>
                <a:gd name="T10" fmla="*/ 0 w 35"/>
                <a:gd name="T11" fmla="*/ 0 h 101"/>
                <a:gd name="T12" fmla="*/ 35 w 35"/>
                <a:gd name="T13" fmla="*/ 0 h 101"/>
                <a:gd name="T14" fmla="*/ 35 w 35"/>
                <a:gd name="T15" fmla="*/ 6 h 101"/>
                <a:gd name="T16" fmla="*/ 0 w 35"/>
                <a:gd name="T17" fmla="*/ 6 h 101"/>
                <a:gd name="T18" fmla="*/ 0 w 35"/>
                <a:gd name="T19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5" h="101">
                  <a:moveTo>
                    <a:pt x="15" y="101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01"/>
                  </a:lnTo>
                  <a:lnTo>
                    <a:pt x="15" y="101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0" name="Freeform 87"/>
            <p:cNvSpPr>
              <a:spLocks noEditPoints="1"/>
            </p:cNvSpPr>
            <p:nvPr/>
          </p:nvSpPr>
          <p:spPr bwMode="auto">
            <a:xfrm>
              <a:off x="5596632" y="4974610"/>
              <a:ext cx="33748" cy="161239"/>
            </a:xfrm>
            <a:custGeom>
              <a:avLst/>
              <a:gdLst>
                <a:gd name="T0" fmla="*/ 15 w 36"/>
                <a:gd name="T1" fmla="*/ 172 h 172"/>
                <a:gd name="T2" fmla="*/ 15 w 36"/>
                <a:gd name="T3" fmla="*/ 3 h 172"/>
                <a:gd name="T4" fmla="*/ 21 w 36"/>
                <a:gd name="T5" fmla="*/ 3 h 172"/>
                <a:gd name="T6" fmla="*/ 21 w 36"/>
                <a:gd name="T7" fmla="*/ 172 h 172"/>
                <a:gd name="T8" fmla="*/ 15 w 36"/>
                <a:gd name="T9" fmla="*/ 172 h 172"/>
                <a:gd name="T10" fmla="*/ 0 w 36"/>
                <a:gd name="T11" fmla="*/ 0 h 172"/>
                <a:gd name="T12" fmla="*/ 36 w 36"/>
                <a:gd name="T13" fmla="*/ 0 h 172"/>
                <a:gd name="T14" fmla="*/ 36 w 36"/>
                <a:gd name="T15" fmla="*/ 5 h 172"/>
                <a:gd name="T16" fmla="*/ 0 w 36"/>
                <a:gd name="T17" fmla="*/ 5 h 172"/>
                <a:gd name="T18" fmla="*/ 0 w 36"/>
                <a:gd name="T19" fmla="*/ 0 h 1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6" h="172">
                  <a:moveTo>
                    <a:pt x="15" y="172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72"/>
                  </a:lnTo>
                  <a:lnTo>
                    <a:pt x="15" y="17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1" name="Freeform 88"/>
            <p:cNvSpPr>
              <a:spLocks noEditPoints="1"/>
            </p:cNvSpPr>
            <p:nvPr/>
          </p:nvSpPr>
          <p:spPr bwMode="auto">
            <a:xfrm>
              <a:off x="6100033" y="4959611"/>
              <a:ext cx="34685" cy="176238"/>
            </a:xfrm>
            <a:custGeom>
              <a:avLst/>
              <a:gdLst>
                <a:gd name="T0" fmla="*/ 15 w 37"/>
                <a:gd name="T1" fmla="*/ 188 h 188"/>
                <a:gd name="T2" fmla="*/ 15 w 37"/>
                <a:gd name="T3" fmla="*/ 3 h 188"/>
                <a:gd name="T4" fmla="*/ 21 w 37"/>
                <a:gd name="T5" fmla="*/ 3 h 188"/>
                <a:gd name="T6" fmla="*/ 21 w 37"/>
                <a:gd name="T7" fmla="*/ 188 h 188"/>
                <a:gd name="T8" fmla="*/ 15 w 37"/>
                <a:gd name="T9" fmla="*/ 188 h 188"/>
                <a:gd name="T10" fmla="*/ 0 w 37"/>
                <a:gd name="T11" fmla="*/ 0 h 188"/>
                <a:gd name="T12" fmla="*/ 37 w 37"/>
                <a:gd name="T13" fmla="*/ 0 h 188"/>
                <a:gd name="T14" fmla="*/ 37 w 37"/>
                <a:gd name="T15" fmla="*/ 6 h 188"/>
                <a:gd name="T16" fmla="*/ 0 w 37"/>
                <a:gd name="T17" fmla="*/ 6 h 188"/>
                <a:gd name="T18" fmla="*/ 0 w 37"/>
                <a:gd name="T19" fmla="*/ 0 h 1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7" h="188">
                  <a:moveTo>
                    <a:pt x="15" y="188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88"/>
                  </a:lnTo>
                  <a:lnTo>
                    <a:pt x="15" y="188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2" name="Freeform 89"/>
            <p:cNvSpPr>
              <a:spLocks noEditPoints="1"/>
            </p:cNvSpPr>
            <p:nvPr/>
          </p:nvSpPr>
          <p:spPr bwMode="auto">
            <a:xfrm>
              <a:off x="6604372" y="4980235"/>
              <a:ext cx="32810" cy="77807"/>
            </a:xfrm>
            <a:custGeom>
              <a:avLst/>
              <a:gdLst>
                <a:gd name="T0" fmla="*/ 15 w 35"/>
                <a:gd name="T1" fmla="*/ 83 h 83"/>
                <a:gd name="T2" fmla="*/ 15 w 35"/>
                <a:gd name="T3" fmla="*/ 3 h 83"/>
                <a:gd name="T4" fmla="*/ 21 w 35"/>
                <a:gd name="T5" fmla="*/ 3 h 83"/>
                <a:gd name="T6" fmla="*/ 21 w 35"/>
                <a:gd name="T7" fmla="*/ 83 h 83"/>
                <a:gd name="T8" fmla="*/ 15 w 35"/>
                <a:gd name="T9" fmla="*/ 83 h 83"/>
                <a:gd name="T10" fmla="*/ 0 w 35"/>
                <a:gd name="T11" fmla="*/ 0 h 83"/>
                <a:gd name="T12" fmla="*/ 35 w 35"/>
                <a:gd name="T13" fmla="*/ 0 h 83"/>
                <a:gd name="T14" fmla="*/ 35 w 35"/>
                <a:gd name="T15" fmla="*/ 6 h 83"/>
                <a:gd name="T16" fmla="*/ 0 w 35"/>
                <a:gd name="T17" fmla="*/ 6 h 83"/>
                <a:gd name="T18" fmla="*/ 0 w 35"/>
                <a:gd name="T19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5" h="83">
                  <a:moveTo>
                    <a:pt x="15" y="83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83"/>
                  </a:lnTo>
                  <a:lnTo>
                    <a:pt x="15" y="83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3" name="Rectangle 90"/>
            <p:cNvSpPr>
              <a:spLocks noChangeArrowheads="1"/>
            </p:cNvSpPr>
            <p:nvPr/>
          </p:nvSpPr>
          <p:spPr bwMode="auto">
            <a:xfrm>
              <a:off x="5596632" y="5133974"/>
              <a:ext cx="33748" cy="4687"/>
            </a:xfrm>
            <a:prstGeom prst="rect">
              <a:avLst/>
            </a:pr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4" name="Rectangle 91"/>
            <p:cNvSpPr>
              <a:spLocks noChangeArrowheads="1"/>
            </p:cNvSpPr>
            <p:nvPr/>
          </p:nvSpPr>
          <p:spPr bwMode="auto">
            <a:xfrm>
              <a:off x="6100033" y="5133974"/>
              <a:ext cx="34685" cy="4687"/>
            </a:xfrm>
            <a:prstGeom prst="rect">
              <a:avLst/>
            </a:pr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5" name="Rectangle 92"/>
            <p:cNvSpPr>
              <a:spLocks noChangeArrowheads="1"/>
            </p:cNvSpPr>
            <p:nvPr/>
          </p:nvSpPr>
          <p:spPr bwMode="auto">
            <a:xfrm>
              <a:off x="6604372" y="5055230"/>
              <a:ext cx="32810" cy="5625"/>
            </a:xfrm>
            <a:prstGeom prst="rect">
              <a:avLst/>
            </a:pr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6" name="Rectangle 93"/>
            <p:cNvSpPr>
              <a:spLocks noChangeArrowheads="1"/>
            </p:cNvSpPr>
            <p:nvPr/>
          </p:nvSpPr>
          <p:spPr bwMode="auto">
            <a:xfrm>
              <a:off x="5358524" y="4746814"/>
              <a:ext cx="0" cy="1363031"/>
            </a:xfrm>
            <a:prstGeom prst="rect">
              <a:avLst/>
            </a:prstGeom>
            <a:solidFill>
              <a:srgbClr val="000000"/>
            </a:solidFill>
            <a:ln w="1397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7" name="Freeform 94"/>
            <p:cNvSpPr>
              <a:spLocks noEditPoints="1"/>
            </p:cNvSpPr>
            <p:nvPr/>
          </p:nvSpPr>
          <p:spPr bwMode="auto">
            <a:xfrm>
              <a:off x="5329835" y="4744001"/>
              <a:ext cx="28777" cy="1368656"/>
            </a:xfrm>
            <a:custGeom>
              <a:avLst/>
              <a:gdLst>
                <a:gd name="T0" fmla="*/ 0 w 22"/>
                <a:gd name="T1" fmla="*/ 1454 h 1460"/>
                <a:gd name="T2" fmla="*/ 22 w 22"/>
                <a:gd name="T3" fmla="*/ 1454 h 1460"/>
                <a:gd name="T4" fmla="*/ 22 w 22"/>
                <a:gd name="T5" fmla="*/ 1460 h 1460"/>
                <a:gd name="T6" fmla="*/ 0 w 22"/>
                <a:gd name="T7" fmla="*/ 1460 h 1460"/>
                <a:gd name="T8" fmla="*/ 0 w 22"/>
                <a:gd name="T9" fmla="*/ 1454 h 1460"/>
                <a:gd name="T10" fmla="*/ 0 w 22"/>
                <a:gd name="T11" fmla="*/ 1247 h 1460"/>
                <a:gd name="T12" fmla="*/ 22 w 22"/>
                <a:gd name="T13" fmla="*/ 1247 h 1460"/>
                <a:gd name="T14" fmla="*/ 22 w 22"/>
                <a:gd name="T15" fmla="*/ 1253 h 1460"/>
                <a:gd name="T16" fmla="*/ 0 w 22"/>
                <a:gd name="T17" fmla="*/ 1253 h 1460"/>
                <a:gd name="T18" fmla="*/ 0 w 22"/>
                <a:gd name="T19" fmla="*/ 1247 h 1460"/>
                <a:gd name="T20" fmla="*/ 0 w 22"/>
                <a:gd name="T21" fmla="*/ 1039 h 1460"/>
                <a:gd name="T22" fmla="*/ 22 w 22"/>
                <a:gd name="T23" fmla="*/ 1039 h 1460"/>
                <a:gd name="T24" fmla="*/ 22 w 22"/>
                <a:gd name="T25" fmla="*/ 1044 h 1460"/>
                <a:gd name="T26" fmla="*/ 0 w 22"/>
                <a:gd name="T27" fmla="*/ 1044 h 1460"/>
                <a:gd name="T28" fmla="*/ 0 w 22"/>
                <a:gd name="T29" fmla="*/ 1039 h 1460"/>
                <a:gd name="T30" fmla="*/ 0 w 22"/>
                <a:gd name="T31" fmla="*/ 831 h 1460"/>
                <a:gd name="T32" fmla="*/ 22 w 22"/>
                <a:gd name="T33" fmla="*/ 831 h 1460"/>
                <a:gd name="T34" fmla="*/ 22 w 22"/>
                <a:gd name="T35" fmla="*/ 837 h 1460"/>
                <a:gd name="T36" fmla="*/ 0 w 22"/>
                <a:gd name="T37" fmla="*/ 837 h 1460"/>
                <a:gd name="T38" fmla="*/ 0 w 22"/>
                <a:gd name="T39" fmla="*/ 831 h 1460"/>
                <a:gd name="T40" fmla="*/ 0 w 22"/>
                <a:gd name="T41" fmla="*/ 623 h 1460"/>
                <a:gd name="T42" fmla="*/ 22 w 22"/>
                <a:gd name="T43" fmla="*/ 623 h 1460"/>
                <a:gd name="T44" fmla="*/ 22 w 22"/>
                <a:gd name="T45" fmla="*/ 629 h 1460"/>
                <a:gd name="T46" fmla="*/ 0 w 22"/>
                <a:gd name="T47" fmla="*/ 629 h 1460"/>
                <a:gd name="T48" fmla="*/ 0 w 22"/>
                <a:gd name="T49" fmla="*/ 623 h 1460"/>
                <a:gd name="T50" fmla="*/ 0 w 22"/>
                <a:gd name="T51" fmla="*/ 416 h 1460"/>
                <a:gd name="T52" fmla="*/ 22 w 22"/>
                <a:gd name="T53" fmla="*/ 416 h 1460"/>
                <a:gd name="T54" fmla="*/ 22 w 22"/>
                <a:gd name="T55" fmla="*/ 421 h 1460"/>
                <a:gd name="T56" fmla="*/ 0 w 22"/>
                <a:gd name="T57" fmla="*/ 421 h 1460"/>
                <a:gd name="T58" fmla="*/ 0 w 22"/>
                <a:gd name="T59" fmla="*/ 416 h 1460"/>
                <a:gd name="T60" fmla="*/ 0 w 22"/>
                <a:gd name="T61" fmla="*/ 207 h 1460"/>
                <a:gd name="T62" fmla="*/ 22 w 22"/>
                <a:gd name="T63" fmla="*/ 207 h 1460"/>
                <a:gd name="T64" fmla="*/ 22 w 22"/>
                <a:gd name="T65" fmla="*/ 213 h 1460"/>
                <a:gd name="T66" fmla="*/ 0 w 22"/>
                <a:gd name="T67" fmla="*/ 213 h 1460"/>
                <a:gd name="T68" fmla="*/ 0 w 22"/>
                <a:gd name="T69" fmla="*/ 207 h 1460"/>
                <a:gd name="T70" fmla="*/ 0 w 22"/>
                <a:gd name="T71" fmla="*/ 0 h 1460"/>
                <a:gd name="T72" fmla="*/ 22 w 22"/>
                <a:gd name="T73" fmla="*/ 0 h 1460"/>
                <a:gd name="T74" fmla="*/ 22 w 22"/>
                <a:gd name="T75" fmla="*/ 6 h 1460"/>
                <a:gd name="T76" fmla="*/ 0 w 22"/>
                <a:gd name="T77" fmla="*/ 6 h 1460"/>
                <a:gd name="T78" fmla="*/ 0 w 22"/>
                <a:gd name="T79" fmla="*/ 0 h 14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22" h="1460">
                  <a:moveTo>
                    <a:pt x="0" y="1454"/>
                  </a:moveTo>
                  <a:lnTo>
                    <a:pt x="22" y="1454"/>
                  </a:lnTo>
                  <a:lnTo>
                    <a:pt x="22" y="1460"/>
                  </a:lnTo>
                  <a:lnTo>
                    <a:pt x="0" y="1460"/>
                  </a:lnTo>
                  <a:lnTo>
                    <a:pt x="0" y="1454"/>
                  </a:lnTo>
                  <a:close/>
                  <a:moveTo>
                    <a:pt x="0" y="1247"/>
                  </a:moveTo>
                  <a:lnTo>
                    <a:pt x="22" y="1247"/>
                  </a:lnTo>
                  <a:lnTo>
                    <a:pt x="22" y="1253"/>
                  </a:lnTo>
                  <a:lnTo>
                    <a:pt x="0" y="1253"/>
                  </a:lnTo>
                  <a:lnTo>
                    <a:pt x="0" y="1247"/>
                  </a:lnTo>
                  <a:close/>
                  <a:moveTo>
                    <a:pt x="0" y="1039"/>
                  </a:moveTo>
                  <a:lnTo>
                    <a:pt x="22" y="1039"/>
                  </a:lnTo>
                  <a:lnTo>
                    <a:pt x="22" y="1044"/>
                  </a:lnTo>
                  <a:lnTo>
                    <a:pt x="0" y="1044"/>
                  </a:lnTo>
                  <a:lnTo>
                    <a:pt x="0" y="1039"/>
                  </a:lnTo>
                  <a:close/>
                  <a:moveTo>
                    <a:pt x="0" y="831"/>
                  </a:moveTo>
                  <a:lnTo>
                    <a:pt x="22" y="831"/>
                  </a:lnTo>
                  <a:lnTo>
                    <a:pt x="22" y="837"/>
                  </a:lnTo>
                  <a:lnTo>
                    <a:pt x="0" y="837"/>
                  </a:lnTo>
                  <a:lnTo>
                    <a:pt x="0" y="831"/>
                  </a:lnTo>
                  <a:close/>
                  <a:moveTo>
                    <a:pt x="0" y="623"/>
                  </a:moveTo>
                  <a:lnTo>
                    <a:pt x="22" y="623"/>
                  </a:lnTo>
                  <a:lnTo>
                    <a:pt x="22" y="629"/>
                  </a:lnTo>
                  <a:lnTo>
                    <a:pt x="0" y="629"/>
                  </a:lnTo>
                  <a:lnTo>
                    <a:pt x="0" y="623"/>
                  </a:lnTo>
                  <a:close/>
                  <a:moveTo>
                    <a:pt x="0" y="416"/>
                  </a:moveTo>
                  <a:lnTo>
                    <a:pt x="22" y="416"/>
                  </a:lnTo>
                  <a:lnTo>
                    <a:pt x="22" y="421"/>
                  </a:lnTo>
                  <a:lnTo>
                    <a:pt x="0" y="421"/>
                  </a:lnTo>
                  <a:lnTo>
                    <a:pt x="0" y="416"/>
                  </a:lnTo>
                  <a:close/>
                  <a:moveTo>
                    <a:pt x="0" y="207"/>
                  </a:moveTo>
                  <a:lnTo>
                    <a:pt x="22" y="207"/>
                  </a:lnTo>
                  <a:lnTo>
                    <a:pt x="22" y="213"/>
                  </a:lnTo>
                  <a:lnTo>
                    <a:pt x="0" y="213"/>
                  </a:lnTo>
                  <a:lnTo>
                    <a:pt x="0" y="207"/>
                  </a:lnTo>
                  <a:close/>
                  <a:moveTo>
                    <a:pt x="0" y="0"/>
                  </a:moveTo>
                  <a:lnTo>
                    <a:pt x="22" y="0"/>
                  </a:lnTo>
                  <a:lnTo>
                    <a:pt x="22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8" name="Rectangle 95"/>
            <p:cNvSpPr>
              <a:spLocks noChangeArrowheads="1"/>
            </p:cNvSpPr>
            <p:nvPr/>
          </p:nvSpPr>
          <p:spPr bwMode="auto">
            <a:xfrm>
              <a:off x="5361335" y="6114652"/>
              <a:ext cx="1512080" cy="0"/>
            </a:xfrm>
            <a:prstGeom prst="rect">
              <a:avLst/>
            </a:prstGeom>
            <a:solidFill>
              <a:srgbClr val="000000"/>
            </a:solidFill>
            <a:ln w="1397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249" name="Rectangle 96"/>
          <p:cNvSpPr>
            <a:spLocks noChangeArrowheads="1"/>
          </p:cNvSpPr>
          <p:nvPr/>
        </p:nvSpPr>
        <p:spPr bwMode="auto">
          <a:xfrm>
            <a:off x="4467179" y="5328388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fr-FR" alt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0" name="Rectangle 97"/>
          <p:cNvSpPr>
            <a:spLocks noChangeArrowheads="1"/>
          </p:cNvSpPr>
          <p:nvPr/>
        </p:nvSpPr>
        <p:spPr bwMode="auto">
          <a:xfrm>
            <a:off x="4396647" y="513340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fr-FR" alt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1" name="Rectangle 98"/>
          <p:cNvSpPr>
            <a:spLocks noChangeArrowheads="1"/>
          </p:cNvSpPr>
          <p:nvPr/>
        </p:nvSpPr>
        <p:spPr bwMode="auto">
          <a:xfrm>
            <a:off x="4396647" y="493935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</a:t>
            </a:r>
            <a:endParaRPr kumimoji="0" lang="fr-FR" alt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2" name="Rectangle 99"/>
          <p:cNvSpPr>
            <a:spLocks noChangeArrowheads="1"/>
          </p:cNvSpPr>
          <p:nvPr/>
        </p:nvSpPr>
        <p:spPr bwMode="auto">
          <a:xfrm>
            <a:off x="4396647" y="4744365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0</a:t>
            </a:r>
            <a:endParaRPr kumimoji="0" lang="fr-FR" alt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3" name="Rectangle 100"/>
          <p:cNvSpPr>
            <a:spLocks noChangeArrowheads="1"/>
          </p:cNvSpPr>
          <p:nvPr/>
        </p:nvSpPr>
        <p:spPr bwMode="auto">
          <a:xfrm>
            <a:off x="4396647" y="454937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fr-FR" alt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4" name="Rectangle 101"/>
          <p:cNvSpPr>
            <a:spLocks noChangeArrowheads="1"/>
          </p:cNvSpPr>
          <p:nvPr/>
        </p:nvSpPr>
        <p:spPr bwMode="auto">
          <a:xfrm>
            <a:off x="4326115" y="435439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fr-FR" alt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5" name="Rectangle 102"/>
          <p:cNvSpPr>
            <a:spLocks noChangeArrowheads="1"/>
          </p:cNvSpPr>
          <p:nvPr/>
        </p:nvSpPr>
        <p:spPr bwMode="auto">
          <a:xfrm>
            <a:off x="4326115" y="4159406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20</a:t>
            </a:r>
            <a:endParaRPr kumimoji="0" lang="fr-FR" alt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6" name="Rectangle 103"/>
          <p:cNvSpPr>
            <a:spLocks noChangeArrowheads="1"/>
          </p:cNvSpPr>
          <p:nvPr/>
        </p:nvSpPr>
        <p:spPr bwMode="auto">
          <a:xfrm>
            <a:off x="4326115" y="3965357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40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7" name="Rectangle 107"/>
          <p:cNvSpPr>
            <a:spLocks noChangeArrowheads="1"/>
          </p:cNvSpPr>
          <p:nvPr/>
        </p:nvSpPr>
        <p:spPr bwMode="auto">
          <a:xfrm>
            <a:off x="4747968" y="5613657"/>
            <a:ext cx="2003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T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8" name="Rectangle 109"/>
          <p:cNvSpPr>
            <a:spLocks noChangeArrowheads="1"/>
          </p:cNvSpPr>
          <p:nvPr/>
        </p:nvSpPr>
        <p:spPr bwMode="auto">
          <a:xfrm>
            <a:off x="5284796" y="5613657"/>
            <a:ext cx="45044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fr-FR" altLang="fr-FR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Hsp70</a:t>
            </a:r>
            <a:r>
              <a:rPr lang="fr-FR" altLang="fr-FR" sz="1000" baseline="30000" dirty="0" smtClean="0">
                <a:solidFill>
                  <a:srgbClr val="000000"/>
                </a:solidFill>
                <a:cs typeface="Arial" panose="020B0604020202020204" pitchFamily="34" charset="0"/>
              </a:rPr>
              <a:t>-/-</a:t>
            </a:r>
            <a:endParaRPr lang="fr-FR" altLang="fr-FR" sz="1000" baseline="30000" dirty="0">
              <a:cs typeface="Arial" panose="020B0604020202020204" pitchFamily="34" charset="0"/>
            </a:endParaRPr>
          </a:p>
        </p:txBody>
      </p:sp>
      <p:sp>
        <p:nvSpPr>
          <p:cNvPr id="259" name="Rectangle 110"/>
          <p:cNvSpPr>
            <a:spLocks noChangeArrowheads="1"/>
          </p:cNvSpPr>
          <p:nvPr/>
        </p:nvSpPr>
        <p:spPr bwMode="auto">
          <a:xfrm rot="16200000" flipH="1">
            <a:off x="3517356" y="4525606"/>
            <a:ext cx="12238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% of </a:t>
            </a: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ells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ith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C/NLRP3 </a:t>
            </a: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ecks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60" name="Rectangle 111"/>
          <p:cNvSpPr>
            <a:spLocks noChangeArrowheads="1"/>
          </p:cNvSpPr>
          <p:nvPr/>
        </p:nvSpPr>
        <p:spPr bwMode="auto">
          <a:xfrm>
            <a:off x="5980026" y="4700544"/>
            <a:ext cx="72000" cy="720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1" name="Freeform 112"/>
          <p:cNvSpPr>
            <a:spLocks noEditPoints="1"/>
          </p:cNvSpPr>
          <p:nvPr/>
        </p:nvSpPr>
        <p:spPr bwMode="auto">
          <a:xfrm>
            <a:off x="5976852" y="4700544"/>
            <a:ext cx="72000" cy="72000"/>
          </a:xfrm>
          <a:custGeom>
            <a:avLst/>
            <a:gdLst>
              <a:gd name="T0" fmla="*/ 0 w 376"/>
              <a:gd name="T1" fmla="*/ 24 h 376"/>
              <a:gd name="T2" fmla="*/ 24 w 376"/>
              <a:gd name="T3" fmla="*/ 0 h 376"/>
              <a:gd name="T4" fmla="*/ 352 w 376"/>
              <a:gd name="T5" fmla="*/ 0 h 376"/>
              <a:gd name="T6" fmla="*/ 376 w 376"/>
              <a:gd name="T7" fmla="*/ 24 h 376"/>
              <a:gd name="T8" fmla="*/ 376 w 376"/>
              <a:gd name="T9" fmla="*/ 352 h 376"/>
              <a:gd name="T10" fmla="*/ 352 w 376"/>
              <a:gd name="T11" fmla="*/ 376 h 376"/>
              <a:gd name="T12" fmla="*/ 24 w 376"/>
              <a:gd name="T13" fmla="*/ 376 h 376"/>
              <a:gd name="T14" fmla="*/ 0 w 376"/>
              <a:gd name="T15" fmla="*/ 352 h 376"/>
              <a:gd name="T16" fmla="*/ 0 w 376"/>
              <a:gd name="T17" fmla="*/ 24 h 376"/>
              <a:gd name="T18" fmla="*/ 48 w 376"/>
              <a:gd name="T19" fmla="*/ 352 h 376"/>
              <a:gd name="T20" fmla="*/ 24 w 376"/>
              <a:gd name="T21" fmla="*/ 328 h 376"/>
              <a:gd name="T22" fmla="*/ 352 w 376"/>
              <a:gd name="T23" fmla="*/ 328 h 376"/>
              <a:gd name="T24" fmla="*/ 328 w 376"/>
              <a:gd name="T25" fmla="*/ 352 h 376"/>
              <a:gd name="T26" fmla="*/ 328 w 376"/>
              <a:gd name="T27" fmla="*/ 24 h 376"/>
              <a:gd name="T28" fmla="*/ 352 w 376"/>
              <a:gd name="T29" fmla="*/ 48 h 376"/>
              <a:gd name="T30" fmla="*/ 24 w 376"/>
              <a:gd name="T31" fmla="*/ 48 h 376"/>
              <a:gd name="T32" fmla="*/ 48 w 376"/>
              <a:gd name="T33" fmla="*/ 24 h 376"/>
              <a:gd name="T34" fmla="*/ 48 w 376"/>
              <a:gd name="T35" fmla="*/ 352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76" h="3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52" y="0"/>
                </a:lnTo>
                <a:cubicBezTo>
                  <a:pt x="366" y="0"/>
                  <a:pt x="376" y="11"/>
                  <a:pt x="376" y="24"/>
                </a:cubicBezTo>
                <a:lnTo>
                  <a:pt x="376" y="352"/>
                </a:lnTo>
                <a:cubicBezTo>
                  <a:pt x="376" y="366"/>
                  <a:pt x="366" y="376"/>
                  <a:pt x="352" y="376"/>
                </a:cubicBezTo>
                <a:lnTo>
                  <a:pt x="24" y="376"/>
                </a:lnTo>
                <a:cubicBezTo>
                  <a:pt x="11" y="376"/>
                  <a:pt x="0" y="366"/>
                  <a:pt x="0" y="352"/>
                </a:cubicBezTo>
                <a:lnTo>
                  <a:pt x="0" y="24"/>
                </a:lnTo>
                <a:close/>
                <a:moveTo>
                  <a:pt x="48" y="352"/>
                </a:moveTo>
                <a:lnTo>
                  <a:pt x="24" y="328"/>
                </a:lnTo>
                <a:lnTo>
                  <a:pt x="352" y="328"/>
                </a:lnTo>
                <a:lnTo>
                  <a:pt x="328" y="352"/>
                </a:lnTo>
                <a:lnTo>
                  <a:pt x="328" y="24"/>
                </a:lnTo>
                <a:lnTo>
                  <a:pt x="352" y="48"/>
                </a:lnTo>
                <a:lnTo>
                  <a:pt x="24" y="48"/>
                </a:lnTo>
                <a:lnTo>
                  <a:pt x="48" y="24"/>
                </a:lnTo>
                <a:lnTo>
                  <a:pt x="48" y="3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2" name="Rectangle 113"/>
          <p:cNvSpPr>
            <a:spLocks noChangeArrowheads="1"/>
          </p:cNvSpPr>
          <p:nvPr/>
        </p:nvSpPr>
        <p:spPr bwMode="auto">
          <a:xfrm>
            <a:off x="6122108" y="4659600"/>
            <a:ext cx="43601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-10µm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63" name="Rectangle 114"/>
          <p:cNvSpPr>
            <a:spLocks noChangeArrowheads="1"/>
          </p:cNvSpPr>
          <p:nvPr/>
        </p:nvSpPr>
        <p:spPr bwMode="auto">
          <a:xfrm>
            <a:off x="5980026" y="4838657"/>
            <a:ext cx="72000" cy="72000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4" name="Freeform 115"/>
          <p:cNvSpPr>
            <a:spLocks noEditPoints="1"/>
          </p:cNvSpPr>
          <p:nvPr/>
        </p:nvSpPr>
        <p:spPr bwMode="auto">
          <a:xfrm>
            <a:off x="5976852" y="4838657"/>
            <a:ext cx="72000" cy="72000"/>
          </a:xfrm>
          <a:custGeom>
            <a:avLst/>
            <a:gdLst>
              <a:gd name="T0" fmla="*/ 0 w 376"/>
              <a:gd name="T1" fmla="*/ 24 h 376"/>
              <a:gd name="T2" fmla="*/ 24 w 376"/>
              <a:gd name="T3" fmla="*/ 0 h 376"/>
              <a:gd name="T4" fmla="*/ 352 w 376"/>
              <a:gd name="T5" fmla="*/ 0 h 376"/>
              <a:gd name="T6" fmla="*/ 376 w 376"/>
              <a:gd name="T7" fmla="*/ 24 h 376"/>
              <a:gd name="T8" fmla="*/ 376 w 376"/>
              <a:gd name="T9" fmla="*/ 352 h 376"/>
              <a:gd name="T10" fmla="*/ 352 w 376"/>
              <a:gd name="T11" fmla="*/ 376 h 376"/>
              <a:gd name="T12" fmla="*/ 24 w 376"/>
              <a:gd name="T13" fmla="*/ 376 h 376"/>
              <a:gd name="T14" fmla="*/ 0 w 376"/>
              <a:gd name="T15" fmla="*/ 352 h 376"/>
              <a:gd name="T16" fmla="*/ 0 w 376"/>
              <a:gd name="T17" fmla="*/ 24 h 376"/>
              <a:gd name="T18" fmla="*/ 48 w 376"/>
              <a:gd name="T19" fmla="*/ 352 h 376"/>
              <a:gd name="T20" fmla="*/ 24 w 376"/>
              <a:gd name="T21" fmla="*/ 328 h 376"/>
              <a:gd name="T22" fmla="*/ 352 w 376"/>
              <a:gd name="T23" fmla="*/ 328 h 376"/>
              <a:gd name="T24" fmla="*/ 328 w 376"/>
              <a:gd name="T25" fmla="*/ 352 h 376"/>
              <a:gd name="T26" fmla="*/ 328 w 376"/>
              <a:gd name="T27" fmla="*/ 24 h 376"/>
              <a:gd name="T28" fmla="*/ 352 w 376"/>
              <a:gd name="T29" fmla="*/ 48 h 376"/>
              <a:gd name="T30" fmla="*/ 24 w 376"/>
              <a:gd name="T31" fmla="*/ 48 h 376"/>
              <a:gd name="T32" fmla="*/ 48 w 376"/>
              <a:gd name="T33" fmla="*/ 24 h 376"/>
              <a:gd name="T34" fmla="*/ 48 w 376"/>
              <a:gd name="T35" fmla="*/ 352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76" h="3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52" y="0"/>
                </a:lnTo>
                <a:cubicBezTo>
                  <a:pt x="366" y="0"/>
                  <a:pt x="376" y="11"/>
                  <a:pt x="376" y="24"/>
                </a:cubicBezTo>
                <a:lnTo>
                  <a:pt x="376" y="352"/>
                </a:lnTo>
                <a:cubicBezTo>
                  <a:pt x="376" y="366"/>
                  <a:pt x="366" y="376"/>
                  <a:pt x="352" y="376"/>
                </a:cubicBezTo>
                <a:lnTo>
                  <a:pt x="24" y="376"/>
                </a:lnTo>
                <a:cubicBezTo>
                  <a:pt x="11" y="376"/>
                  <a:pt x="0" y="366"/>
                  <a:pt x="0" y="352"/>
                </a:cubicBezTo>
                <a:lnTo>
                  <a:pt x="0" y="24"/>
                </a:lnTo>
                <a:close/>
                <a:moveTo>
                  <a:pt x="48" y="352"/>
                </a:moveTo>
                <a:lnTo>
                  <a:pt x="24" y="328"/>
                </a:lnTo>
                <a:lnTo>
                  <a:pt x="352" y="328"/>
                </a:lnTo>
                <a:lnTo>
                  <a:pt x="328" y="352"/>
                </a:lnTo>
                <a:lnTo>
                  <a:pt x="328" y="24"/>
                </a:lnTo>
                <a:lnTo>
                  <a:pt x="352" y="48"/>
                </a:lnTo>
                <a:lnTo>
                  <a:pt x="24" y="48"/>
                </a:lnTo>
                <a:lnTo>
                  <a:pt x="48" y="24"/>
                </a:lnTo>
                <a:lnTo>
                  <a:pt x="48" y="3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5" name="Rectangle 116"/>
          <p:cNvSpPr>
            <a:spLocks noChangeArrowheads="1"/>
          </p:cNvSpPr>
          <p:nvPr/>
        </p:nvSpPr>
        <p:spPr bwMode="auto">
          <a:xfrm>
            <a:off x="6122108" y="4797713"/>
            <a:ext cx="36548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-5µm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66" name="Rectangle 117"/>
          <p:cNvSpPr>
            <a:spLocks noChangeArrowheads="1"/>
          </p:cNvSpPr>
          <p:nvPr/>
        </p:nvSpPr>
        <p:spPr bwMode="auto">
          <a:xfrm>
            <a:off x="5980026" y="4962482"/>
            <a:ext cx="72000" cy="720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7" name="Freeform 118"/>
          <p:cNvSpPr>
            <a:spLocks noEditPoints="1"/>
          </p:cNvSpPr>
          <p:nvPr/>
        </p:nvSpPr>
        <p:spPr bwMode="auto">
          <a:xfrm>
            <a:off x="5976852" y="4962482"/>
            <a:ext cx="72000" cy="72000"/>
          </a:xfrm>
          <a:custGeom>
            <a:avLst/>
            <a:gdLst>
              <a:gd name="T0" fmla="*/ 0 w 376"/>
              <a:gd name="T1" fmla="*/ 24 h 384"/>
              <a:gd name="T2" fmla="*/ 24 w 376"/>
              <a:gd name="T3" fmla="*/ 0 h 384"/>
              <a:gd name="T4" fmla="*/ 352 w 376"/>
              <a:gd name="T5" fmla="*/ 0 h 384"/>
              <a:gd name="T6" fmla="*/ 376 w 376"/>
              <a:gd name="T7" fmla="*/ 24 h 384"/>
              <a:gd name="T8" fmla="*/ 376 w 376"/>
              <a:gd name="T9" fmla="*/ 360 h 384"/>
              <a:gd name="T10" fmla="*/ 352 w 376"/>
              <a:gd name="T11" fmla="*/ 384 h 384"/>
              <a:gd name="T12" fmla="*/ 24 w 376"/>
              <a:gd name="T13" fmla="*/ 384 h 384"/>
              <a:gd name="T14" fmla="*/ 0 w 376"/>
              <a:gd name="T15" fmla="*/ 360 h 384"/>
              <a:gd name="T16" fmla="*/ 0 w 376"/>
              <a:gd name="T17" fmla="*/ 24 h 384"/>
              <a:gd name="T18" fmla="*/ 48 w 376"/>
              <a:gd name="T19" fmla="*/ 360 h 384"/>
              <a:gd name="T20" fmla="*/ 24 w 376"/>
              <a:gd name="T21" fmla="*/ 336 h 384"/>
              <a:gd name="T22" fmla="*/ 352 w 376"/>
              <a:gd name="T23" fmla="*/ 336 h 384"/>
              <a:gd name="T24" fmla="*/ 328 w 376"/>
              <a:gd name="T25" fmla="*/ 360 h 384"/>
              <a:gd name="T26" fmla="*/ 328 w 376"/>
              <a:gd name="T27" fmla="*/ 24 h 384"/>
              <a:gd name="T28" fmla="*/ 352 w 376"/>
              <a:gd name="T29" fmla="*/ 48 h 384"/>
              <a:gd name="T30" fmla="*/ 24 w 376"/>
              <a:gd name="T31" fmla="*/ 48 h 384"/>
              <a:gd name="T32" fmla="*/ 48 w 376"/>
              <a:gd name="T33" fmla="*/ 24 h 384"/>
              <a:gd name="T34" fmla="*/ 48 w 376"/>
              <a:gd name="T35" fmla="*/ 360 h 3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76" h="384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52" y="0"/>
                </a:lnTo>
                <a:cubicBezTo>
                  <a:pt x="366" y="0"/>
                  <a:pt x="376" y="11"/>
                  <a:pt x="376" y="24"/>
                </a:cubicBezTo>
                <a:lnTo>
                  <a:pt x="376" y="360"/>
                </a:lnTo>
                <a:cubicBezTo>
                  <a:pt x="376" y="374"/>
                  <a:pt x="366" y="384"/>
                  <a:pt x="352" y="384"/>
                </a:cubicBezTo>
                <a:lnTo>
                  <a:pt x="24" y="384"/>
                </a:lnTo>
                <a:cubicBezTo>
                  <a:pt x="11" y="384"/>
                  <a:pt x="0" y="374"/>
                  <a:pt x="0" y="360"/>
                </a:cubicBezTo>
                <a:lnTo>
                  <a:pt x="0" y="24"/>
                </a:lnTo>
                <a:close/>
                <a:moveTo>
                  <a:pt x="48" y="360"/>
                </a:moveTo>
                <a:lnTo>
                  <a:pt x="24" y="336"/>
                </a:lnTo>
                <a:lnTo>
                  <a:pt x="352" y="336"/>
                </a:lnTo>
                <a:lnTo>
                  <a:pt x="328" y="360"/>
                </a:lnTo>
                <a:lnTo>
                  <a:pt x="328" y="24"/>
                </a:lnTo>
                <a:lnTo>
                  <a:pt x="352" y="48"/>
                </a:lnTo>
                <a:lnTo>
                  <a:pt x="24" y="48"/>
                </a:lnTo>
                <a:lnTo>
                  <a:pt x="48" y="24"/>
                </a:lnTo>
                <a:lnTo>
                  <a:pt x="48" y="36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8" name="Rectangle 119"/>
          <p:cNvSpPr>
            <a:spLocks noChangeArrowheads="1"/>
          </p:cNvSpPr>
          <p:nvPr/>
        </p:nvSpPr>
        <p:spPr bwMode="auto">
          <a:xfrm>
            <a:off x="6122108" y="4921538"/>
            <a:ext cx="36548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-2µm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69" name="Rectangle 24"/>
          <p:cNvSpPr>
            <a:spLocks noChangeArrowheads="1"/>
          </p:cNvSpPr>
          <p:nvPr/>
        </p:nvSpPr>
        <p:spPr bwMode="auto">
          <a:xfrm>
            <a:off x="4103160" y="5445132"/>
            <a:ext cx="165429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PS+Nig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     +           -          +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270" name="Connecteur droit 269"/>
          <p:cNvCxnSpPr/>
          <p:nvPr/>
        </p:nvCxnSpPr>
        <p:spPr>
          <a:xfrm>
            <a:off x="5330018" y="5588257"/>
            <a:ext cx="36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Rectangle 113"/>
          <p:cNvSpPr>
            <a:spLocks noChangeArrowheads="1"/>
          </p:cNvSpPr>
          <p:nvPr/>
        </p:nvSpPr>
        <p:spPr bwMode="auto">
          <a:xfrm>
            <a:off x="5974631" y="4505613"/>
            <a:ext cx="73096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SC </a:t>
            </a: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ecks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: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7" name="Rectangle 23"/>
          <p:cNvSpPr>
            <a:spLocks noChangeArrowheads="1"/>
          </p:cNvSpPr>
          <p:nvPr/>
        </p:nvSpPr>
        <p:spPr bwMode="auto">
          <a:xfrm>
            <a:off x="4704684" y="353173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n.d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2" name="Rectangle 23"/>
          <p:cNvSpPr>
            <a:spLocks noChangeArrowheads="1"/>
          </p:cNvSpPr>
          <p:nvPr/>
        </p:nvSpPr>
        <p:spPr bwMode="auto">
          <a:xfrm>
            <a:off x="4963842" y="353173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n.d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3" name="Rectangle 23"/>
          <p:cNvSpPr>
            <a:spLocks noChangeArrowheads="1"/>
          </p:cNvSpPr>
          <p:nvPr/>
        </p:nvSpPr>
        <p:spPr bwMode="auto">
          <a:xfrm>
            <a:off x="5367660" y="353173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n.d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4" name="ZoneTexte 273"/>
          <p:cNvSpPr txBox="1"/>
          <p:nvPr/>
        </p:nvSpPr>
        <p:spPr>
          <a:xfrm>
            <a:off x="317640" y="56330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275" name="ZoneTexte 274"/>
          <p:cNvSpPr txBox="1"/>
          <p:nvPr/>
        </p:nvSpPr>
        <p:spPr>
          <a:xfrm>
            <a:off x="3792713" y="56330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276" name="ZoneTexte 275"/>
          <p:cNvSpPr txBox="1"/>
          <p:nvPr/>
        </p:nvSpPr>
        <p:spPr>
          <a:xfrm>
            <a:off x="3792713" y="2159862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277" name="ZoneTexte 276"/>
          <p:cNvSpPr txBox="1"/>
          <p:nvPr/>
        </p:nvSpPr>
        <p:spPr>
          <a:xfrm>
            <a:off x="3792713" y="373946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d</a:t>
            </a:r>
            <a:endParaRPr lang="fr-FR" dirty="0"/>
          </a:p>
        </p:txBody>
      </p:sp>
      <p:sp>
        <p:nvSpPr>
          <p:cNvPr id="3" name="Rectangle 2"/>
          <p:cNvSpPr/>
          <p:nvPr/>
        </p:nvSpPr>
        <p:spPr>
          <a:xfrm>
            <a:off x="49580" y="6477183"/>
            <a:ext cx="680841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6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: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HSP70 deficiency increases ASC/Procaspase-1 specks formation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BMDMs from WT or Hsp70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C57BL/6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mice were stimulated with 100ng/mL LPS for 20h and then left untreated or treated 30min with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nigericin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Nig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– 40µM). Cells were stained with ASC and Procaspase-1 antibodies and with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DAPI. Representative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images a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re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hown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)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The proportion of cells with specks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b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),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with more than one speck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c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)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and the repartition of cells according to the speck size within positive cells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d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)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were evaluated.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n.d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: not detected. Data are the mean of three independent experiments ±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.d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</a:t>
            </a:r>
            <a:endParaRPr lang="fr-FR" sz="1200" dirty="0">
              <a:effectLst/>
              <a:latin typeface="Arial" pitchFamily="34" charset="0"/>
              <a:ea typeface="Times New Roman" panose="02020603050405020304" pitchFamily="18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6565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4478" y="5448624"/>
            <a:ext cx="664922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7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: </a:t>
            </a:r>
            <a:r>
              <a:rPr lang="fr-FR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HSP70 </a:t>
            </a:r>
            <a:r>
              <a:rPr lang="fr-FR" sz="1200" b="1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deficiency</a:t>
            </a:r>
            <a:r>
              <a:rPr lang="fr-FR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fr-FR" sz="1200" b="1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differently</a:t>
            </a:r>
            <a:r>
              <a:rPr lang="fr-FR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fr-FR" sz="1200" b="1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regulate</a:t>
            </a:r>
            <a:r>
              <a:rPr lang="fr-FR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fr-FR" sz="1200" b="1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inflammasomes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BMDMs from WT or Hsp70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C57BL/6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mice were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infected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with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500ng/mL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LPS for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5h or treated with LPS (100ng/mL – 20h) + Poly(</a:t>
            </a:r>
            <a:r>
              <a:rPr lang="en-US" sz="12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dA:dT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) (5µg/mL – 6h)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)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aspase-1 cleavage was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evaluated by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western blot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upernatants were collected and IL-1</a:t>
            </a:r>
            <a:r>
              <a:rPr lang="el-GR" sz="1200" dirty="0">
                <a:latin typeface="Arial" pitchFamily="34" charset="0"/>
                <a:ea typeface="Cambria Math"/>
                <a:cs typeface="Arial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was measured by ELISA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(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c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) Cell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were stained with ASC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antibody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and with DAPI and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the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proportion of cells with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pecks, wa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evaluated.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n.d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: not detected. Data are the mean of three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independent experiment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±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.d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</a:t>
            </a:r>
            <a:endParaRPr lang="fr-FR" sz="1200" dirty="0">
              <a:latin typeface="Arial" pitchFamily="34" charset="0"/>
              <a:ea typeface="Times New Roman" panose="02020603050405020304" pitchFamily="18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414795" y="2942674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4810724" y="294267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8" name="Rectangle 62"/>
          <p:cNvSpPr>
            <a:spLocks noChangeArrowheads="1"/>
          </p:cNvSpPr>
          <p:nvPr/>
        </p:nvSpPr>
        <p:spPr bwMode="auto">
          <a:xfrm rot="16200000">
            <a:off x="4576898" y="3725065"/>
            <a:ext cx="116205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% of </a:t>
            </a: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ells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ith</a:t>
            </a: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C/NLRP3 </a:t>
            </a:r>
            <a:r>
              <a:rPr kumimoji="0" lang="fr-FR" alt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ecks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" name="Rectangle 19"/>
          <p:cNvSpPr>
            <a:spLocks noChangeArrowheads="1"/>
          </p:cNvSpPr>
          <p:nvPr/>
        </p:nvSpPr>
        <p:spPr bwMode="auto">
          <a:xfrm>
            <a:off x="5605717" y="3247513"/>
            <a:ext cx="6350" cy="1281112"/>
          </a:xfrm>
          <a:prstGeom prst="rect">
            <a:avLst/>
          </a:prstGeom>
          <a:solidFill>
            <a:srgbClr val="000000"/>
          </a:solidFill>
          <a:ln w="3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Freeform 20"/>
          <p:cNvSpPr>
            <a:spLocks noEditPoints="1"/>
          </p:cNvSpPr>
          <p:nvPr/>
        </p:nvSpPr>
        <p:spPr bwMode="auto">
          <a:xfrm>
            <a:off x="5577141" y="3244338"/>
            <a:ext cx="36000" cy="1287462"/>
          </a:xfrm>
          <a:custGeom>
            <a:avLst/>
            <a:gdLst>
              <a:gd name="T0" fmla="*/ 0 w 10"/>
              <a:gd name="T1" fmla="*/ 807 h 811"/>
              <a:gd name="T2" fmla="*/ 10 w 10"/>
              <a:gd name="T3" fmla="*/ 807 h 811"/>
              <a:gd name="T4" fmla="*/ 10 w 10"/>
              <a:gd name="T5" fmla="*/ 811 h 811"/>
              <a:gd name="T6" fmla="*/ 0 w 10"/>
              <a:gd name="T7" fmla="*/ 811 h 811"/>
              <a:gd name="T8" fmla="*/ 0 w 10"/>
              <a:gd name="T9" fmla="*/ 807 h 811"/>
              <a:gd name="T10" fmla="*/ 0 w 10"/>
              <a:gd name="T11" fmla="*/ 671 h 811"/>
              <a:gd name="T12" fmla="*/ 10 w 10"/>
              <a:gd name="T13" fmla="*/ 671 h 811"/>
              <a:gd name="T14" fmla="*/ 10 w 10"/>
              <a:gd name="T15" fmla="*/ 674 h 811"/>
              <a:gd name="T16" fmla="*/ 0 w 10"/>
              <a:gd name="T17" fmla="*/ 674 h 811"/>
              <a:gd name="T18" fmla="*/ 0 w 10"/>
              <a:gd name="T19" fmla="*/ 671 h 811"/>
              <a:gd name="T20" fmla="*/ 0 w 10"/>
              <a:gd name="T21" fmla="*/ 538 h 811"/>
              <a:gd name="T22" fmla="*/ 10 w 10"/>
              <a:gd name="T23" fmla="*/ 538 h 811"/>
              <a:gd name="T24" fmla="*/ 10 w 10"/>
              <a:gd name="T25" fmla="*/ 541 h 811"/>
              <a:gd name="T26" fmla="*/ 0 w 10"/>
              <a:gd name="T27" fmla="*/ 541 h 811"/>
              <a:gd name="T28" fmla="*/ 0 w 10"/>
              <a:gd name="T29" fmla="*/ 538 h 811"/>
              <a:gd name="T30" fmla="*/ 0 w 10"/>
              <a:gd name="T31" fmla="*/ 402 h 811"/>
              <a:gd name="T32" fmla="*/ 10 w 10"/>
              <a:gd name="T33" fmla="*/ 402 h 811"/>
              <a:gd name="T34" fmla="*/ 10 w 10"/>
              <a:gd name="T35" fmla="*/ 405 h 811"/>
              <a:gd name="T36" fmla="*/ 0 w 10"/>
              <a:gd name="T37" fmla="*/ 405 h 811"/>
              <a:gd name="T38" fmla="*/ 0 w 10"/>
              <a:gd name="T39" fmla="*/ 402 h 811"/>
              <a:gd name="T40" fmla="*/ 0 w 10"/>
              <a:gd name="T41" fmla="*/ 269 h 811"/>
              <a:gd name="T42" fmla="*/ 10 w 10"/>
              <a:gd name="T43" fmla="*/ 269 h 811"/>
              <a:gd name="T44" fmla="*/ 10 w 10"/>
              <a:gd name="T45" fmla="*/ 272 h 811"/>
              <a:gd name="T46" fmla="*/ 0 w 10"/>
              <a:gd name="T47" fmla="*/ 272 h 811"/>
              <a:gd name="T48" fmla="*/ 0 w 10"/>
              <a:gd name="T49" fmla="*/ 269 h 811"/>
              <a:gd name="T50" fmla="*/ 0 w 10"/>
              <a:gd name="T51" fmla="*/ 136 h 811"/>
              <a:gd name="T52" fmla="*/ 10 w 10"/>
              <a:gd name="T53" fmla="*/ 136 h 811"/>
              <a:gd name="T54" fmla="*/ 10 w 10"/>
              <a:gd name="T55" fmla="*/ 139 h 811"/>
              <a:gd name="T56" fmla="*/ 0 w 10"/>
              <a:gd name="T57" fmla="*/ 139 h 811"/>
              <a:gd name="T58" fmla="*/ 0 w 10"/>
              <a:gd name="T59" fmla="*/ 136 h 811"/>
              <a:gd name="T60" fmla="*/ 0 w 10"/>
              <a:gd name="T61" fmla="*/ 0 h 811"/>
              <a:gd name="T62" fmla="*/ 10 w 10"/>
              <a:gd name="T63" fmla="*/ 0 h 811"/>
              <a:gd name="T64" fmla="*/ 10 w 10"/>
              <a:gd name="T65" fmla="*/ 3 h 811"/>
              <a:gd name="T66" fmla="*/ 0 w 10"/>
              <a:gd name="T67" fmla="*/ 3 h 811"/>
              <a:gd name="T68" fmla="*/ 0 w 10"/>
              <a:gd name="T69" fmla="*/ 0 h 8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0" h="811">
                <a:moveTo>
                  <a:pt x="0" y="807"/>
                </a:moveTo>
                <a:lnTo>
                  <a:pt x="10" y="807"/>
                </a:lnTo>
                <a:lnTo>
                  <a:pt x="10" y="811"/>
                </a:lnTo>
                <a:lnTo>
                  <a:pt x="0" y="811"/>
                </a:lnTo>
                <a:lnTo>
                  <a:pt x="0" y="807"/>
                </a:lnTo>
                <a:close/>
                <a:moveTo>
                  <a:pt x="0" y="671"/>
                </a:moveTo>
                <a:lnTo>
                  <a:pt x="10" y="671"/>
                </a:lnTo>
                <a:lnTo>
                  <a:pt x="10" y="674"/>
                </a:lnTo>
                <a:lnTo>
                  <a:pt x="0" y="674"/>
                </a:lnTo>
                <a:lnTo>
                  <a:pt x="0" y="671"/>
                </a:lnTo>
                <a:close/>
                <a:moveTo>
                  <a:pt x="0" y="538"/>
                </a:moveTo>
                <a:lnTo>
                  <a:pt x="10" y="538"/>
                </a:lnTo>
                <a:lnTo>
                  <a:pt x="10" y="541"/>
                </a:lnTo>
                <a:lnTo>
                  <a:pt x="0" y="541"/>
                </a:lnTo>
                <a:lnTo>
                  <a:pt x="0" y="538"/>
                </a:lnTo>
                <a:close/>
                <a:moveTo>
                  <a:pt x="0" y="402"/>
                </a:moveTo>
                <a:lnTo>
                  <a:pt x="10" y="402"/>
                </a:lnTo>
                <a:lnTo>
                  <a:pt x="10" y="405"/>
                </a:lnTo>
                <a:lnTo>
                  <a:pt x="0" y="405"/>
                </a:lnTo>
                <a:lnTo>
                  <a:pt x="0" y="402"/>
                </a:lnTo>
                <a:close/>
                <a:moveTo>
                  <a:pt x="0" y="269"/>
                </a:moveTo>
                <a:lnTo>
                  <a:pt x="10" y="269"/>
                </a:lnTo>
                <a:lnTo>
                  <a:pt x="10" y="272"/>
                </a:lnTo>
                <a:lnTo>
                  <a:pt x="0" y="272"/>
                </a:lnTo>
                <a:lnTo>
                  <a:pt x="0" y="269"/>
                </a:lnTo>
                <a:close/>
                <a:moveTo>
                  <a:pt x="0" y="136"/>
                </a:moveTo>
                <a:lnTo>
                  <a:pt x="10" y="136"/>
                </a:lnTo>
                <a:lnTo>
                  <a:pt x="10" y="139"/>
                </a:lnTo>
                <a:lnTo>
                  <a:pt x="0" y="139"/>
                </a:lnTo>
                <a:lnTo>
                  <a:pt x="0" y="136"/>
                </a:lnTo>
                <a:close/>
                <a:moveTo>
                  <a:pt x="0" y="0"/>
                </a:moveTo>
                <a:lnTo>
                  <a:pt x="10" y="0"/>
                </a:lnTo>
                <a:lnTo>
                  <a:pt x="10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Rectangle 22"/>
          <p:cNvSpPr>
            <a:spLocks noChangeArrowheads="1"/>
          </p:cNvSpPr>
          <p:nvPr/>
        </p:nvSpPr>
        <p:spPr bwMode="auto">
          <a:xfrm>
            <a:off x="5444594" y="4448461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Rectangle 23"/>
          <p:cNvSpPr>
            <a:spLocks noChangeArrowheads="1"/>
          </p:cNvSpPr>
          <p:nvPr/>
        </p:nvSpPr>
        <p:spPr bwMode="auto">
          <a:xfrm>
            <a:off x="5412844" y="423573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Rectangle 24"/>
          <p:cNvSpPr>
            <a:spLocks noChangeArrowheads="1"/>
          </p:cNvSpPr>
          <p:nvPr/>
        </p:nvSpPr>
        <p:spPr bwMode="auto">
          <a:xfrm>
            <a:off x="5412844" y="402301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Rectangle 25"/>
          <p:cNvSpPr>
            <a:spLocks noChangeArrowheads="1"/>
          </p:cNvSpPr>
          <p:nvPr/>
        </p:nvSpPr>
        <p:spPr bwMode="auto">
          <a:xfrm>
            <a:off x="5412844" y="381028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Rectangle 26"/>
          <p:cNvSpPr>
            <a:spLocks noChangeArrowheads="1"/>
          </p:cNvSpPr>
          <p:nvPr/>
        </p:nvSpPr>
        <p:spPr bwMode="auto">
          <a:xfrm>
            <a:off x="5412844" y="3595974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Rectangle 27"/>
          <p:cNvSpPr>
            <a:spLocks noChangeArrowheads="1"/>
          </p:cNvSpPr>
          <p:nvPr/>
        </p:nvSpPr>
        <p:spPr bwMode="auto">
          <a:xfrm>
            <a:off x="5412844" y="338324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Rectangle 28"/>
          <p:cNvSpPr>
            <a:spLocks noChangeArrowheads="1"/>
          </p:cNvSpPr>
          <p:nvPr/>
        </p:nvSpPr>
        <p:spPr bwMode="auto">
          <a:xfrm>
            <a:off x="5412844" y="3170524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Rectangle 26"/>
          <p:cNvSpPr>
            <a:spLocks noChangeArrowheads="1"/>
          </p:cNvSpPr>
          <p:nvPr/>
        </p:nvSpPr>
        <p:spPr bwMode="auto">
          <a:xfrm>
            <a:off x="5714130" y="3307184"/>
            <a:ext cx="72000" cy="72000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3" name="Freeform 27"/>
          <p:cNvSpPr>
            <a:spLocks noEditPoints="1"/>
          </p:cNvSpPr>
          <p:nvPr/>
        </p:nvSpPr>
        <p:spPr bwMode="auto">
          <a:xfrm>
            <a:off x="5713037" y="3306033"/>
            <a:ext cx="72000" cy="72000"/>
          </a:xfrm>
          <a:custGeom>
            <a:avLst/>
            <a:gdLst>
              <a:gd name="T0" fmla="*/ 0 w 752"/>
              <a:gd name="T1" fmla="*/ 48 h 768"/>
              <a:gd name="T2" fmla="*/ 48 w 752"/>
              <a:gd name="T3" fmla="*/ 0 h 768"/>
              <a:gd name="T4" fmla="*/ 704 w 752"/>
              <a:gd name="T5" fmla="*/ 0 h 768"/>
              <a:gd name="T6" fmla="*/ 752 w 752"/>
              <a:gd name="T7" fmla="*/ 48 h 768"/>
              <a:gd name="T8" fmla="*/ 752 w 752"/>
              <a:gd name="T9" fmla="*/ 720 h 768"/>
              <a:gd name="T10" fmla="*/ 704 w 752"/>
              <a:gd name="T11" fmla="*/ 768 h 768"/>
              <a:gd name="T12" fmla="*/ 48 w 752"/>
              <a:gd name="T13" fmla="*/ 768 h 768"/>
              <a:gd name="T14" fmla="*/ 0 w 752"/>
              <a:gd name="T15" fmla="*/ 720 h 768"/>
              <a:gd name="T16" fmla="*/ 0 w 752"/>
              <a:gd name="T17" fmla="*/ 48 h 768"/>
              <a:gd name="T18" fmla="*/ 96 w 752"/>
              <a:gd name="T19" fmla="*/ 720 h 768"/>
              <a:gd name="T20" fmla="*/ 48 w 752"/>
              <a:gd name="T21" fmla="*/ 672 h 768"/>
              <a:gd name="T22" fmla="*/ 704 w 752"/>
              <a:gd name="T23" fmla="*/ 672 h 768"/>
              <a:gd name="T24" fmla="*/ 656 w 752"/>
              <a:gd name="T25" fmla="*/ 720 h 768"/>
              <a:gd name="T26" fmla="*/ 656 w 752"/>
              <a:gd name="T27" fmla="*/ 48 h 768"/>
              <a:gd name="T28" fmla="*/ 704 w 752"/>
              <a:gd name="T29" fmla="*/ 96 h 768"/>
              <a:gd name="T30" fmla="*/ 48 w 752"/>
              <a:gd name="T31" fmla="*/ 96 h 768"/>
              <a:gd name="T32" fmla="*/ 96 w 752"/>
              <a:gd name="T33" fmla="*/ 48 h 768"/>
              <a:gd name="T34" fmla="*/ 96 w 752"/>
              <a:gd name="T35" fmla="*/ 720 h 7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752" h="768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704" y="0"/>
                </a:lnTo>
                <a:cubicBezTo>
                  <a:pt x="731" y="0"/>
                  <a:pt x="752" y="22"/>
                  <a:pt x="752" y="48"/>
                </a:cubicBezTo>
                <a:lnTo>
                  <a:pt x="752" y="720"/>
                </a:lnTo>
                <a:cubicBezTo>
                  <a:pt x="752" y="747"/>
                  <a:pt x="731" y="768"/>
                  <a:pt x="704" y="768"/>
                </a:cubicBezTo>
                <a:lnTo>
                  <a:pt x="48" y="768"/>
                </a:lnTo>
                <a:cubicBezTo>
                  <a:pt x="22" y="768"/>
                  <a:pt x="0" y="747"/>
                  <a:pt x="0" y="720"/>
                </a:cubicBezTo>
                <a:lnTo>
                  <a:pt x="0" y="48"/>
                </a:lnTo>
                <a:close/>
                <a:moveTo>
                  <a:pt x="96" y="720"/>
                </a:moveTo>
                <a:lnTo>
                  <a:pt x="48" y="672"/>
                </a:lnTo>
                <a:lnTo>
                  <a:pt x="704" y="672"/>
                </a:lnTo>
                <a:lnTo>
                  <a:pt x="656" y="720"/>
                </a:lnTo>
                <a:lnTo>
                  <a:pt x="656" y="48"/>
                </a:lnTo>
                <a:lnTo>
                  <a:pt x="704" y="96"/>
                </a:lnTo>
                <a:lnTo>
                  <a:pt x="48" y="96"/>
                </a:lnTo>
                <a:lnTo>
                  <a:pt x="96" y="48"/>
                </a:lnTo>
                <a:lnTo>
                  <a:pt x="96" y="72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4" name="Rectangle 28"/>
          <p:cNvSpPr>
            <a:spLocks noChangeArrowheads="1"/>
          </p:cNvSpPr>
          <p:nvPr/>
        </p:nvSpPr>
        <p:spPr bwMode="auto">
          <a:xfrm>
            <a:off x="5830068" y="3263076"/>
            <a:ext cx="137939" cy="11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T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5" name="Rectangle 29"/>
          <p:cNvSpPr>
            <a:spLocks noChangeArrowheads="1"/>
          </p:cNvSpPr>
          <p:nvPr/>
        </p:nvSpPr>
        <p:spPr bwMode="auto">
          <a:xfrm>
            <a:off x="5714130" y="3444475"/>
            <a:ext cx="72000" cy="72000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6" name="Freeform 30"/>
          <p:cNvSpPr>
            <a:spLocks noEditPoints="1"/>
          </p:cNvSpPr>
          <p:nvPr/>
        </p:nvSpPr>
        <p:spPr bwMode="auto">
          <a:xfrm>
            <a:off x="5713037" y="3443324"/>
            <a:ext cx="72000" cy="72000"/>
          </a:xfrm>
          <a:custGeom>
            <a:avLst/>
            <a:gdLst>
              <a:gd name="T0" fmla="*/ 0 w 752"/>
              <a:gd name="T1" fmla="*/ 48 h 752"/>
              <a:gd name="T2" fmla="*/ 48 w 752"/>
              <a:gd name="T3" fmla="*/ 0 h 752"/>
              <a:gd name="T4" fmla="*/ 704 w 752"/>
              <a:gd name="T5" fmla="*/ 0 h 752"/>
              <a:gd name="T6" fmla="*/ 752 w 752"/>
              <a:gd name="T7" fmla="*/ 48 h 752"/>
              <a:gd name="T8" fmla="*/ 752 w 752"/>
              <a:gd name="T9" fmla="*/ 704 h 752"/>
              <a:gd name="T10" fmla="*/ 704 w 752"/>
              <a:gd name="T11" fmla="*/ 752 h 752"/>
              <a:gd name="T12" fmla="*/ 48 w 752"/>
              <a:gd name="T13" fmla="*/ 752 h 752"/>
              <a:gd name="T14" fmla="*/ 0 w 752"/>
              <a:gd name="T15" fmla="*/ 704 h 752"/>
              <a:gd name="T16" fmla="*/ 0 w 752"/>
              <a:gd name="T17" fmla="*/ 48 h 752"/>
              <a:gd name="T18" fmla="*/ 96 w 752"/>
              <a:gd name="T19" fmla="*/ 704 h 752"/>
              <a:gd name="T20" fmla="*/ 48 w 752"/>
              <a:gd name="T21" fmla="*/ 656 h 752"/>
              <a:gd name="T22" fmla="*/ 704 w 752"/>
              <a:gd name="T23" fmla="*/ 656 h 752"/>
              <a:gd name="T24" fmla="*/ 656 w 752"/>
              <a:gd name="T25" fmla="*/ 704 h 752"/>
              <a:gd name="T26" fmla="*/ 656 w 752"/>
              <a:gd name="T27" fmla="*/ 48 h 752"/>
              <a:gd name="T28" fmla="*/ 704 w 752"/>
              <a:gd name="T29" fmla="*/ 96 h 752"/>
              <a:gd name="T30" fmla="*/ 48 w 752"/>
              <a:gd name="T31" fmla="*/ 96 h 752"/>
              <a:gd name="T32" fmla="*/ 96 w 752"/>
              <a:gd name="T33" fmla="*/ 48 h 752"/>
              <a:gd name="T34" fmla="*/ 96 w 752"/>
              <a:gd name="T35" fmla="*/ 704 h 7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752" h="752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704" y="0"/>
                </a:lnTo>
                <a:cubicBezTo>
                  <a:pt x="731" y="0"/>
                  <a:pt x="752" y="22"/>
                  <a:pt x="752" y="48"/>
                </a:cubicBezTo>
                <a:lnTo>
                  <a:pt x="752" y="704"/>
                </a:lnTo>
                <a:cubicBezTo>
                  <a:pt x="752" y="731"/>
                  <a:pt x="731" y="752"/>
                  <a:pt x="704" y="752"/>
                </a:cubicBezTo>
                <a:lnTo>
                  <a:pt x="48" y="752"/>
                </a:lnTo>
                <a:cubicBezTo>
                  <a:pt x="22" y="752"/>
                  <a:pt x="0" y="731"/>
                  <a:pt x="0" y="704"/>
                </a:cubicBezTo>
                <a:lnTo>
                  <a:pt x="0" y="48"/>
                </a:lnTo>
                <a:close/>
                <a:moveTo>
                  <a:pt x="96" y="704"/>
                </a:moveTo>
                <a:lnTo>
                  <a:pt x="48" y="656"/>
                </a:lnTo>
                <a:lnTo>
                  <a:pt x="704" y="656"/>
                </a:lnTo>
                <a:lnTo>
                  <a:pt x="656" y="704"/>
                </a:lnTo>
                <a:lnTo>
                  <a:pt x="656" y="48"/>
                </a:lnTo>
                <a:lnTo>
                  <a:pt x="704" y="96"/>
                </a:lnTo>
                <a:lnTo>
                  <a:pt x="48" y="96"/>
                </a:lnTo>
                <a:lnTo>
                  <a:pt x="96" y="48"/>
                </a:lnTo>
                <a:lnTo>
                  <a:pt x="96" y="70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7" name="Rectangle 31"/>
          <p:cNvSpPr>
            <a:spLocks noChangeArrowheads="1"/>
          </p:cNvSpPr>
          <p:nvPr/>
        </p:nvSpPr>
        <p:spPr bwMode="auto">
          <a:xfrm>
            <a:off x="5830068" y="3414256"/>
            <a:ext cx="310086" cy="11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sp70</a:t>
            </a:r>
            <a:r>
              <a:rPr lang="fr-FR" altLang="fr-FR" sz="1000" baseline="30000" dirty="0" smtClean="0">
                <a:solidFill>
                  <a:srgbClr val="000000"/>
                </a:solidFill>
                <a:cs typeface="Arial" panose="020B0604020202020204" pitchFamily="34" charset="0"/>
              </a:rPr>
              <a:t>-/-</a:t>
            </a:r>
            <a:endParaRPr lang="fr-FR" altLang="fr-FR" sz="1000" baseline="30000" dirty="0">
              <a:cs typeface="Arial" panose="020B0604020202020204" pitchFamily="34" charset="0"/>
            </a:endParaRPr>
          </a:p>
        </p:txBody>
      </p:sp>
      <p:sp>
        <p:nvSpPr>
          <p:cNvPr id="58" name="Rectangle 98"/>
          <p:cNvSpPr>
            <a:spLocks noChangeArrowheads="1"/>
          </p:cNvSpPr>
          <p:nvPr/>
        </p:nvSpPr>
        <p:spPr bwMode="auto">
          <a:xfrm>
            <a:off x="5720398" y="3814633"/>
            <a:ext cx="234000" cy="71230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Freeform 99"/>
          <p:cNvSpPr>
            <a:spLocks noEditPoints="1"/>
          </p:cNvSpPr>
          <p:nvPr/>
        </p:nvSpPr>
        <p:spPr bwMode="auto">
          <a:xfrm>
            <a:off x="5718811" y="3813568"/>
            <a:ext cx="234000" cy="715499"/>
          </a:xfrm>
          <a:custGeom>
            <a:avLst/>
            <a:gdLst>
              <a:gd name="T0" fmla="*/ 0 w 800"/>
              <a:gd name="T1" fmla="*/ 8 h 3184"/>
              <a:gd name="T2" fmla="*/ 8 w 800"/>
              <a:gd name="T3" fmla="*/ 0 h 3184"/>
              <a:gd name="T4" fmla="*/ 792 w 800"/>
              <a:gd name="T5" fmla="*/ 0 h 3184"/>
              <a:gd name="T6" fmla="*/ 800 w 800"/>
              <a:gd name="T7" fmla="*/ 8 h 3184"/>
              <a:gd name="T8" fmla="*/ 800 w 800"/>
              <a:gd name="T9" fmla="*/ 3176 h 3184"/>
              <a:gd name="T10" fmla="*/ 792 w 800"/>
              <a:gd name="T11" fmla="*/ 3184 h 3184"/>
              <a:gd name="T12" fmla="*/ 8 w 800"/>
              <a:gd name="T13" fmla="*/ 3184 h 3184"/>
              <a:gd name="T14" fmla="*/ 0 w 800"/>
              <a:gd name="T15" fmla="*/ 3176 h 3184"/>
              <a:gd name="T16" fmla="*/ 0 w 800"/>
              <a:gd name="T17" fmla="*/ 8 h 3184"/>
              <a:gd name="T18" fmla="*/ 16 w 800"/>
              <a:gd name="T19" fmla="*/ 3176 h 3184"/>
              <a:gd name="T20" fmla="*/ 8 w 800"/>
              <a:gd name="T21" fmla="*/ 3168 h 3184"/>
              <a:gd name="T22" fmla="*/ 792 w 800"/>
              <a:gd name="T23" fmla="*/ 3168 h 3184"/>
              <a:gd name="T24" fmla="*/ 784 w 800"/>
              <a:gd name="T25" fmla="*/ 3176 h 3184"/>
              <a:gd name="T26" fmla="*/ 784 w 800"/>
              <a:gd name="T27" fmla="*/ 8 h 3184"/>
              <a:gd name="T28" fmla="*/ 792 w 800"/>
              <a:gd name="T29" fmla="*/ 16 h 3184"/>
              <a:gd name="T30" fmla="*/ 8 w 800"/>
              <a:gd name="T31" fmla="*/ 16 h 3184"/>
              <a:gd name="T32" fmla="*/ 16 w 800"/>
              <a:gd name="T33" fmla="*/ 8 h 3184"/>
              <a:gd name="T34" fmla="*/ 16 w 800"/>
              <a:gd name="T35" fmla="*/ 3176 h 3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00" h="3184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792" y="0"/>
                </a:lnTo>
                <a:cubicBezTo>
                  <a:pt x="797" y="0"/>
                  <a:pt x="800" y="4"/>
                  <a:pt x="800" y="8"/>
                </a:cubicBezTo>
                <a:lnTo>
                  <a:pt x="800" y="3176"/>
                </a:lnTo>
                <a:cubicBezTo>
                  <a:pt x="800" y="3181"/>
                  <a:pt x="797" y="3184"/>
                  <a:pt x="792" y="3184"/>
                </a:cubicBezTo>
                <a:lnTo>
                  <a:pt x="8" y="3184"/>
                </a:lnTo>
                <a:cubicBezTo>
                  <a:pt x="4" y="3184"/>
                  <a:pt x="0" y="3181"/>
                  <a:pt x="0" y="3176"/>
                </a:cubicBezTo>
                <a:lnTo>
                  <a:pt x="0" y="8"/>
                </a:lnTo>
                <a:close/>
                <a:moveTo>
                  <a:pt x="16" y="3176"/>
                </a:moveTo>
                <a:lnTo>
                  <a:pt x="8" y="3168"/>
                </a:lnTo>
                <a:lnTo>
                  <a:pt x="792" y="3168"/>
                </a:lnTo>
                <a:lnTo>
                  <a:pt x="784" y="3176"/>
                </a:lnTo>
                <a:lnTo>
                  <a:pt x="784" y="8"/>
                </a:lnTo>
                <a:lnTo>
                  <a:pt x="792" y="16"/>
                </a:lnTo>
                <a:lnTo>
                  <a:pt x="8" y="16"/>
                </a:lnTo>
                <a:lnTo>
                  <a:pt x="16" y="8"/>
                </a:lnTo>
                <a:lnTo>
                  <a:pt x="16" y="3176"/>
                </a:lnTo>
                <a:close/>
              </a:path>
            </a:pathLst>
          </a:custGeom>
          <a:solidFill>
            <a:srgbClr val="000000"/>
          </a:solidFill>
          <a:ln w="2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Rectangle 102"/>
          <p:cNvSpPr>
            <a:spLocks noChangeArrowheads="1"/>
          </p:cNvSpPr>
          <p:nvPr/>
        </p:nvSpPr>
        <p:spPr bwMode="auto">
          <a:xfrm>
            <a:off x="5963286" y="4254367"/>
            <a:ext cx="234000" cy="272571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Freeform 103"/>
          <p:cNvSpPr>
            <a:spLocks noEditPoints="1"/>
          </p:cNvSpPr>
          <p:nvPr/>
        </p:nvSpPr>
        <p:spPr bwMode="auto">
          <a:xfrm>
            <a:off x="5961698" y="4252237"/>
            <a:ext cx="234000" cy="276830"/>
          </a:xfrm>
          <a:custGeom>
            <a:avLst/>
            <a:gdLst>
              <a:gd name="T0" fmla="*/ 0 w 800"/>
              <a:gd name="T1" fmla="*/ 8 h 1232"/>
              <a:gd name="T2" fmla="*/ 8 w 800"/>
              <a:gd name="T3" fmla="*/ 0 h 1232"/>
              <a:gd name="T4" fmla="*/ 792 w 800"/>
              <a:gd name="T5" fmla="*/ 0 h 1232"/>
              <a:gd name="T6" fmla="*/ 800 w 800"/>
              <a:gd name="T7" fmla="*/ 8 h 1232"/>
              <a:gd name="T8" fmla="*/ 800 w 800"/>
              <a:gd name="T9" fmla="*/ 1224 h 1232"/>
              <a:gd name="T10" fmla="*/ 792 w 800"/>
              <a:gd name="T11" fmla="*/ 1232 h 1232"/>
              <a:gd name="T12" fmla="*/ 8 w 800"/>
              <a:gd name="T13" fmla="*/ 1232 h 1232"/>
              <a:gd name="T14" fmla="*/ 0 w 800"/>
              <a:gd name="T15" fmla="*/ 1224 h 1232"/>
              <a:gd name="T16" fmla="*/ 0 w 800"/>
              <a:gd name="T17" fmla="*/ 8 h 1232"/>
              <a:gd name="T18" fmla="*/ 16 w 800"/>
              <a:gd name="T19" fmla="*/ 1224 h 1232"/>
              <a:gd name="T20" fmla="*/ 8 w 800"/>
              <a:gd name="T21" fmla="*/ 1216 h 1232"/>
              <a:gd name="T22" fmla="*/ 792 w 800"/>
              <a:gd name="T23" fmla="*/ 1216 h 1232"/>
              <a:gd name="T24" fmla="*/ 784 w 800"/>
              <a:gd name="T25" fmla="*/ 1224 h 1232"/>
              <a:gd name="T26" fmla="*/ 784 w 800"/>
              <a:gd name="T27" fmla="*/ 8 h 1232"/>
              <a:gd name="T28" fmla="*/ 792 w 800"/>
              <a:gd name="T29" fmla="*/ 16 h 1232"/>
              <a:gd name="T30" fmla="*/ 8 w 800"/>
              <a:gd name="T31" fmla="*/ 16 h 1232"/>
              <a:gd name="T32" fmla="*/ 16 w 800"/>
              <a:gd name="T33" fmla="*/ 8 h 1232"/>
              <a:gd name="T34" fmla="*/ 16 w 800"/>
              <a:gd name="T35" fmla="*/ 1224 h 12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00" h="1232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792" y="0"/>
                </a:lnTo>
                <a:cubicBezTo>
                  <a:pt x="797" y="0"/>
                  <a:pt x="800" y="4"/>
                  <a:pt x="800" y="8"/>
                </a:cubicBezTo>
                <a:lnTo>
                  <a:pt x="800" y="1224"/>
                </a:lnTo>
                <a:cubicBezTo>
                  <a:pt x="800" y="1229"/>
                  <a:pt x="797" y="1232"/>
                  <a:pt x="792" y="1232"/>
                </a:cubicBezTo>
                <a:lnTo>
                  <a:pt x="8" y="1232"/>
                </a:lnTo>
                <a:cubicBezTo>
                  <a:pt x="4" y="1232"/>
                  <a:pt x="0" y="1229"/>
                  <a:pt x="0" y="1224"/>
                </a:cubicBezTo>
                <a:lnTo>
                  <a:pt x="0" y="8"/>
                </a:lnTo>
                <a:close/>
                <a:moveTo>
                  <a:pt x="16" y="1224"/>
                </a:moveTo>
                <a:lnTo>
                  <a:pt x="8" y="1216"/>
                </a:lnTo>
                <a:lnTo>
                  <a:pt x="792" y="1216"/>
                </a:lnTo>
                <a:lnTo>
                  <a:pt x="784" y="1224"/>
                </a:lnTo>
                <a:lnTo>
                  <a:pt x="784" y="8"/>
                </a:lnTo>
                <a:lnTo>
                  <a:pt x="792" y="16"/>
                </a:lnTo>
                <a:lnTo>
                  <a:pt x="8" y="16"/>
                </a:lnTo>
                <a:lnTo>
                  <a:pt x="16" y="8"/>
                </a:lnTo>
                <a:lnTo>
                  <a:pt x="16" y="1224"/>
                </a:lnTo>
                <a:close/>
              </a:path>
            </a:pathLst>
          </a:custGeom>
          <a:solidFill>
            <a:srgbClr val="000000"/>
          </a:solidFill>
          <a:ln w="2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Freeform 105"/>
          <p:cNvSpPr>
            <a:spLocks noEditPoints="1"/>
          </p:cNvSpPr>
          <p:nvPr/>
        </p:nvSpPr>
        <p:spPr bwMode="auto">
          <a:xfrm>
            <a:off x="5823586" y="3694318"/>
            <a:ext cx="23813" cy="120314"/>
          </a:xfrm>
          <a:custGeom>
            <a:avLst/>
            <a:gdLst>
              <a:gd name="T0" fmla="*/ 6 w 15"/>
              <a:gd name="T1" fmla="*/ 113 h 113"/>
              <a:gd name="T2" fmla="*/ 6 w 15"/>
              <a:gd name="T3" fmla="*/ 2 h 113"/>
              <a:gd name="T4" fmla="*/ 9 w 15"/>
              <a:gd name="T5" fmla="*/ 2 h 113"/>
              <a:gd name="T6" fmla="*/ 9 w 15"/>
              <a:gd name="T7" fmla="*/ 113 h 113"/>
              <a:gd name="T8" fmla="*/ 6 w 15"/>
              <a:gd name="T9" fmla="*/ 113 h 113"/>
              <a:gd name="T10" fmla="*/ 0 w 15"/>
              <a:gd name="T11" fmla="*/ 0 h 113"/>
              <a:gd name="T12" fmla="*/ 15 w 15"/>
              <a:gd name="T13" fmla="*/ 0 h 113"/>
              <a:gd name="T14" fmla="*/ 15 w 15"/>
              <a:gd name="T15" fmla="*/ 4 h 113"/>
              <a:gd name="T16" fmla="*/ 0 w 15"/>
              <a:gd name="T17" fmla="*/ 4 h 113"/>
              <a:gd name="T18" fmla="*/ 0 w 15"/>
              <a:gd name="T19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5" h="113">
                <a:moveTo>
                  <a:pt x="6" y="113"/>
                </a:moveTo>
                <a:lnTo>
                  <a:pt x="6" y="2"/>
                </a:lnTo>
                <a:lnTo>
                  <a:pt x="9" y="2"/>
                </a:lnTo>
                <a:lnTo>
                  <a:pt x="9" y="113"/>
                </a:lnTo>
                <a:lnTo>
                  <a:pt x="6" y="113"/>
                </a:lnTo>
                <a:close/>
                <a:moveTo>
                  <a:pt x="0" y="0"/>
                </a:moveTo>
                <a:lnTo>
                  <a:pt x="15" y="0"/>
                </a:lnTo>
                <a:lnTo>
                  <a:pt x="15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2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Freeform 107"/>
          <p:cNvSpPr>
            <a:spLocks noEditPoints="1"/>
          </p:cNvSpPr>
          <p:nvPr/>
        </p:nvSpPr>
        <p:spPr bwMode="auto">
          <a:xfrm>
            <a:off x="6056948" y="4101046"/>
            <a:ext cx="22225" cy="153321"/>
          </a:xfrm>
          <a:custGeom>
            <a:avLst/>
            <a:gdLst>
              <a:gd name="T0" fmla="*/ 6 w 14"/>
              <a:gd name="T1" fmla="*/ 144 h 144"/>
              <a:gd name="T2" fmla="*/ 6 w 14"/>
              <a:gd name="T3" fmla="*/ 2 h 144"/>
              <a:gd name="T4" fmla="*/ 8 w 14"/>
              <a:gd name="T5" fmla="*/ 2 h 144"/>
              <a:gd name="T6" fmla="*/ 8 w 14"/>
              <a:gd name="T7" fmla="*/ 144 h 144"/>
              <a:gd name="T8" fmla="*/ 6 w 14"/>
              <a:gd name="T9" fmla="*/ 144 h 144"/>
              <a:gd name="T10" fmla="*/ 0 w 14"/>
              <a:gd name="T11" fmla="*/ 0 h 144"/>
              <a:gd name="T12" fmla="*/ 14 w 14"/>
              <a:gd name="T13" fmla="*/ 0 h 144"/>
              <a:gd name="T14" fmla="*/ 14 w 14"/>
              <a:gd name="T15" fmla="*/ 3 h 144"/>
              <a:gd name="T16" fmla="*/ 0 w 14"/>
              <a:gd name="T17" fmla="*/ 3 h 144"/>
              <a:gd name="T18" fmla="*/ 0 w 14"/>
              <a:gd name="T19" fmla="*/ 0 h 1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4" h="144">
                <a:moveTo>
                  <a:pt x="6" y="144"/>
                </a:moveTo>
                <a:lnTo>
                  <a:pt x="6" y="2"/>
                </a:lnTo>
                <a:lnTo>
                  <a:pt x="8" y="2"/>
                </a:lnTo>
                <a:lnTo>
                  <a:pt x="8" y="144"/>
                </a:lnTo>
                <a:lnTo>
                  <a:pt x="6" y="144"/>
                </a:lnTo>
                <a:close/>
                <a:moveTo>
                  <a:pt x="0" y="0"/>
                </a:moveTo>
                <a:lnTo>
                  <a:pt x="14" y="0"/>
                </a:lnTo>
                <a:lnTo>
                  <a:pt x="14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2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Rectangle 121"/>
          <p:cNvSpPr>
            <a:spLocks noChangeArrowheads="1"/>
          </p:cNvSpPr>
          <p:nvPr/>
        </p:nvSpPr>
        <p:spPr bwMode="auto">
          <a:xfrm>
            <a:off x="5616817" y="4550362"/>
            <a:ext cx="67486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 +</a:t>
            </a:r>
            <a:r>
              <a:rPr kumimoji="0" lang="fr-FR" sz="10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oly(</a:t>
            </a:r>
            <a:r>
              <a:rPr kumimoji="0" 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A:dT</a:t>
            </a: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)</a:t>
            </a:r>
            <a:endParaRPr kumimoji="0" 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ZoneTexte 64"/>
          <p:cNvSpPr txBox="1"/>
          <p:nvPr/>
        </p:nvSpPr>
        <p:spPr>
          <a:xfrm>
            <a:off x="2472195" y="294267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97" name="Rectangle 50"/>
          <p:cNvSpPr>
            <a:spLocks noChangeArrowheads="1"/>
          </p:cNvSpPr>
          <p:nvPr/>
        </p:nvSpPr>
        <p:spPr bwMode="auto">
          <a:xfrm>
            <a:off x="3434399" y="4482544"/>
            <a:ext cx="289773" cy="162849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Freeform 51"/>
          <p:cNvSpPr>
            <a:spLocks noEditPoints="1"/>
          </p:cNvSpPr>
          <p:nvPr/>
        </p:nvSpPr>
        <p:spPr bwMode="auto">
          <a:xfrm>
            <a:off x="3431835" y="4479830"/>
            <a:ext cx="294901" cy="168278"/>
          </a:xfrm>
          <a:custGeom>
            <a:avLst/>
            <a:gdLst>
              <a:gd name="T0" fmla="*/ 0 w 864"/>
              <a:gd name="T1" fmla="*/ 8 h 464"/>
              <a:gd name="T2" fmla="*/ 8 w 864"/>
              <a:gd name="T3" fmla="*/ 0 h 464"/>
              <a:gd name="T4" fmla="*/ 856 w 864"/>
              <a:gd name="T5" fmla="*/ 0 h 464"/>
              <a:gd name="T6" fmla="*/ 864 w 864"/>
              <a:gd name="T7" fmla="*/ 8 h 464"/>
              <a:gd name="T8" fmla="*/ 864 w 864"/>
              <a:gd name="T9" fmla="*/ 456 h 464"/>
              <a:gd name="T10" fmla="*/ 856 w 864"/>
              <a:gd name="T11" fmla="*/ 464 h 464"/>
              <a:gd name="T12" fmla="*/ 8 w 864"/>
              <a:gd name="T13" fmla="*/ 464 h 464"/>
              <a:gd name="T14" fmla="*/ 0 w 864"/>
              <a:gd name="T15" fmla="*/ 456 h 464"/>
              <a:gd name="T16" fmla="*/ 0 w 864"/>
              <a:gd name="T17" fmla="*/ 8 h 464"/>
              <a:gd name="T18" fmla="*/ 16 w 864"/>
              <a:gd name="T19" fmla="*/ 456 h 464"/>
              <a:gd name="T20" fmla="*/ 8 w 864"/>
              <a:gd name="T21" fmla="*/ 448 h 464"/>
              <a:gd name="T22" fmla="*/ 856 w 864"/>
              <a:gd name="T23" fmla="*/ 448 h 464"/>
              <a:gd name="T24" fmla="*/ 848 w 864"/>
              <a:gd name="T25" fmla="*/ 456 h 464"/>
              <a:gd name="T26" fmla="*/ 848 w 864"/>
              <a:gd name="T27" fmla="*/ 8 h 464"/>
              <a:gd name="T28" fmla="*/ 856 w 864"/>
              <a:gd name="T29" fmla="*/ 16 h 464"/>
              <a:gd name="T30" fmla="*/ 8 w 864"/>
              <a:gd name="T31" fmla="*/ 16 h 464"/>
              <a:gd name="T32" fmla="*/ 16 w 864"/>
              <a:gd name="T33" fmla="*/ 8 h 464"/>
              <a:gd name="T34" fmla="*/ 16 w 864"/>
              <a:gd name="T35" fmla="*/ 456 h 4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464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856" y="0"/>
                </a:lnTo>
                <a:cubicBezTo>
                  <a:pt x="861" y="0"/>
                  <a:pt x="864" y="4"/>
                  <a:pt x="864" y="8"/>
                </a:cubicBezTo>
                <a:lnTo>
                  <a:pt x="864" y="456"/>
                </a:lnTo>
                <a:cubicBezTo>
                  <a:pt x="864" y="461"/>
                  <a:pt x="861" y="464"/>
                  <a:pt x="856" y="464"/>
                </a:cubicBezTo>
                <a:lnTo>
                  <a:pt x="8" y="464"/>
                </a:lnTo>
                <a:cubicBezTo>
                  <a:pt x="4" y="464"/>
                  <a:pt x="0" y="461"/>
                  <a:pt x="0" y="456"/>
                </a:cubicBezTo>
                <a:lnTo>
                  <a:pt x="0" y="8"/>
                </a:lnTo>
                <a:close/>
                <a:moveTo>
                  <a:pt x="16" y="456"/>
                </a:moveTo>
                <a:lnTo>
                  <a:pt x="8" y="448"/>
                </a:lnTo>
                <a:lnTo>
                  <a:pt x="856" y="448"/>
                </a:lnTo>
                <a:lnTo>
                  <a:pt x="848" y="456"/>
                </a:lnTo>
                <a:lnTo>
                  <a:pt x="848" y="8"/>
                </a:lnTo>
                <a:lnTo>
                  <a:pt x="856" y="16"/>
                </a:lnTo>
                <a:lnTo>
                  <a:pt x="8" y="16"/>
                </a:lnTo>
                <a:lnTo>
                  <a:pt x="16" y="8"/>
                </a:lnTo>
                <a:lnTo>
                  <a:pt x="16" y="456"/>
                </a:lnTo>
                <a:close/>
              </a:path>
            </a:pathLst>
          </a:custGeom>
          <a:solidFill>
            <a:srgbClr val="000000"/>
          </a:solidFill>
          <a:ln w="4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Rectangle 52"/>
          <p:cNvSpPr>
            <a:spLocks noChangeArrowheads="1"/>
          </p:cNvSpPr>
          <p:nvPr/>
        </p:nvSpPr>
        <p:spPr bwMode="auto">
          <a:xfrm>
            <a:off x="4103105" y="3470164"/>
            <a:ext cx="289773" cy="117523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Freeform 53"/>
          <p:cNvSpPr>
            <a:spLocks noEditPoints="1"/>
          </p:cNvSpPr>
          <p:nvPr/>
        </p:nvSpPr>
        <p:spPr bwMode="auto">
          <a:xfrm>
            <a:off x="4100541" y="3467450"/>
            <a:ext cx="294901" cy="1180658"/>
          </a:xfrm>
          <a:custGeom>
            <a:avLst/>
            <a:gdLst>
              <a:gd name="T0" fmla="*/ 0 w 864"/>
              <a:gd name="T1" fmla="*/ 8 h 3264"/>
              <a:gd name="T2" fmla="*/ 8 w 864"/>
              <a:gd name="T3" fmla="*/ 0 h 3264"/>
              <a:gd name="T4" fmla="*/ 856 w 864"/>
              <a:gd name="T5" fmla="*/ 0 h 3264"/>
              <a:gd name="T6" fmla="*/ 864 w 864"/>
              <a:gd name="T7" fmla="*/ 8 h 3264"/>
              <a:gd name="T8" fmla="*/ 864 w 864"/>
              <a:gd name="T9" fmla="*/ 3256 h 3264"/>
              <a:gd name="T10" fmla="*/ 856 w 864"/>
              <a:gd name="T11" fmla="*/ 3264 h 3264"/>
              <a:gd name="T12" fmla="*/ 8 w 864"/>
              <a:gd name="T13" fmla="*/ 3264 h 3264"/>
              <a:gd name="T14" fmla="*/ 0 w 864"/>
              <a:gd name="T15" fmla="*/ 3256 h 3264"/>
              <a:gd name="T16" fmla="*/ 0 w 864"/>
              <a:gd name="T17" fmla="*/ 8 h 3264"/>
              <a:gd name="T18" fmla="*/ 16 w 864"/>
              <a:gd name="T19" fmla="*/ 3256 h 3264"/>
              <a:gd name="T20" fmla="*/ 8 w 864"/>
              <a:gd name="T21" fmla="*/ 3248 h 3264"/>
              <a:gd name="T22" fmla="*/ 856 w 864"/>
              <a:gd name="T23" fmla="*/ 3248 h 3264"/>
              <a:gd name="T24" fmla="*/ 848 w 864"/>
              <a:gd name="T25" fmla="*/ 3256 h 3264"/>
              <a:gd name="T26" fmla="*/ 848 w 864"/>
              <a:gd name="T27" fmla="*/ 8 h 3264"/>
              <a:gd name="T28" fmla="*/ 856 w 864"/>
              <a:gd name="T29" fmla="*/ 16 h 3264"/>
              <a:gd name="T30" fmla="*/ 8 w 864"/>
              <a:gd name="T31" fmla="*/ 16 h 3264"/>
              <a:gd name="T32" fmla="*/ 16 w 864"/>
              <a:gd name="T33" fmla="*/ 8 h 3264"/>
              <a:gd name="T34" fmla="*/ 16 w 864"/>
              <a:gd name="T35" fmla="*/ 3256 h 32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3264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856" y="0"/>
                </a:lnTo>
                <a:cubicBezTo>
                  <a:pt x="861" y="0"/>
                  <a:pt x="864" y="4"/>
                  <a:pt x="864" y="8"/>
                </a:cubicBezTo>
                <a:lnTo>
                  <a:pt x="864" y="3256"/>
                </a:lnTo>
                <a:cubicBezTo>
                  <a:pt x="864" y="3261"/>
                  <a:pt x="861" y="3264"/>
                  <a:pt x="856" y="3264"/>
                </a:cubicBezTo>
                <a:lnTo>
                  <a:pt x="8" y="3264"/>
                </a:lnTo>
                <a:cubicBezTo>
                  <a:pt x="4" y="3264"/>
                  <a:pt x="0" y="3261"/>
                  <a:pt x="0" y="3256"/>
                </a:cubicBezTo>
                <a:lnTo>
                  <a:pt x="0" y="8"/>
                </a:lnTo>
                <a:close/>
                <a:moveTo>
                  <a:pt x="16" y="3256"/>
                </a:moveTo>
                <a:lnTo>
                  <a:pt x="8" y="3248"/>
                </a:lnTo>
                <a:lnTo>
                  <a:pt x="856" y="3248"/>
                </a:lnTo>
                <a:lnTo>
                  <a:pt x="848" y="3256"/>
                </a:lnTo>
                <a:lnTo>
                  <a:pt x="848" y="8"/>
                </a:lnTo>
                <a:lnTo>
                  <a:pt x="856" y="16"/>
                </a:lnTo>
                <a:lnTo>
                  <a:pt x="8" y="16"/>
                </a:lnTo>
                <a:lnTo>
                  <a:pt x="16" y="8"/>
                </a:lnTo>
                <a:lnTo>
                  <a:pt x="16" y="3256"/>
                </a:lnTo>
                <a:close/>
              </a:path>
            </a:pathLst>
          </a:custGeom>
          <a:solidFill>
            <a:srgbClr val="000000"/>
          </a:solidFill>
          <a:ln w="4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Rectangle 54"/>
          <p:cNvSpPr>
            <a:spLocks noChangeArrowheads="1"/>
          </p:cNvSpPr>
          <p:nvPr/>
        </p:nvSpPr>
        <p:spPr bwMode="auto">
          <a:xfrm>
            <a:off x="3724172" y="4471688"/>
            <a:ext cx="289773" cy="173706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Freeform 55"/>
          <p:cNvSpPr>
            <a:spLocks noEditPoints="1"/>
          </p:cNvSpPr>
          <p:nvPr/>
        </p:nvSpPr>
        <p:spPr bwMode="auto">
          <a:xfrm>
            <a:off x="3721607" y="4468974"/>
            <a:ext cx="294901" cy="179134"/>
          </a:xfrm>
          <a:custGeom>
            <a:avLst/>
            <a:gdLst>
              <a:gd name="T0" fmla="*/ 0 w 864"/>
              <a:gd name="T1" fmla="*/ 8 h 496"/>
              <a:gd name="T2" fmla="*/ 8 w 864"/>
              <a:gd name="T3" fmla="*/ 0 h 496"/>
              <a:gd name="T4" fmla="*/ 856 w 864"/>
              <a:gd name="T5" fmla="*/ 0 h 496"/>
              <a:gd name="T6" fmla="*/ 864 w 864"/>
              <a:gd name="T7" fmla="*/ 8 h 496"/>
              <a:gd name="T8" fmla="*/ 864 w 864"/>
              <a:gd name="T9" fmla="*/ 488 h 496"/>
              <a:gd name="T10" fmla="*/ 856 w 864"/>
              <a:gd name="T11" fmla="*/ 496 h 496"/>
              <a:gd name="T12" fmla="*/ 8 w 864"/>
              <a:gd name="T13" fmla="*/ 496 h 496"/>
              <a:gd name="T14" fmla="*/ 0 w 864"/>
              <a:gd name="T15" fmla="*/ 488 h 496"/>
              <a:gd name="T16" fmla="*/ 0 w 864"/>
              <a:gd name="T17" fmla="*/ 8 h 496"/>
              <a:gd name="T18" fmla="*/ 16 w 864"/>
              <a:gd name="T19" fmla="*/ 488 h 496"/>
              <a:gd name="T20" fmla="*/ 8 w 864"/>
              <a:gd name="T21" fmla="*/ 480 h 496"/>
              <a:gd name="T22" fmla="*/ 856 w 864"/>
              <a:gd name="T23" fmla="*/ 480 h 496"/>
              <a:gd name="T24" fmla="*/ 848 w 864"/>
              <a:gd name="T25" fmla="*/ 488 h 496"/>
              <a:gd name="T26" fmla="*/ 848 w 864"/>
              <a:gd name="T27" fmla="*/ 8 h 496"/>
              <a:gd name="T28" fmla="*/ 856 w 864"/>
              <a:gd name="T29" fmla="*/ 16 h 496"/>
              <a:gd name="T30" fmla="*/ 8 w 864"/>
              <a:gd name="T31" fmla="*/ 16 h 496"/>
              <a:gd name="T32" fmla="*/ 16 w 864"/>
              <a:gd name="T33" fmla="*/ 8 h 496"/>
              <a:gd name="T34" fmla="*/ 16 w 864"/>
              <a:gd name="T35" fmla="*/ 488 h 4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496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856" y="0"/>
                </a:lnTo>
                <a:cubicBezTo>
                  <a:pt x="861" y="0"/>
                  <a:pt x="864" y="4"/>
                  <a:pt x="864" y="8"/>
                </a:cubicBezTo>
                <a:lnTo>
                  <a:pt x="864" y="488"/>
                </a:lnTo>
                <a:cubicBezTo>
                  <a:pt x="864" y="493"/>
                  <a:pt x="861" y="496"/>
                  <a:pt x="856" y="496"/>
                </a:cubicBezTo>
                <a:lnTo>
                  <a:pt x="8" y="496"/>
                </a:lnTo>
                <a:cubicBezTo>
                  <a:pt x="4" y="496"/>
                  <a:pt x="0" y="493"/>
                  <a:pt x="0" y="488"/>
                </a:cubicBezTo>
                <a:lnTo>
                  <a:pt x="0" y="8"/>
                </a:lnTo>
                <a:close/>
                <a:moveTo>
                  <a:pt x="16" y="488"/>
                </a:moveTo>
                <a:lnTo>
                  <a:pt x="8" y="480"/>
                </a:lnTo>
                <a:lnTo>
                  <a:pt x="856" y="480"/>
                </a:lnTo>
                <a:lnTo>
                  <a:pt x="848" y="488"/>
                </a:lnTo>
                <a:lnTo>
                  <a:pt x="848" y="8"/>
                </a:lnTo>
                <a:lnTo>
                  <a:pt x="856" y="16"/>
                </a:lnTo>
                <a:lnTo>
                  <a:pt x="8" y="16"/>
                </a:lnTo>
                <a:lnTo>
                  <a:pt x="16" y="8"/>
                </a:lnTo>
                <a:lnTo>
                  <a:pt x="16" y="488"/>
                </a:lnTo>
                <a:close/>
              </a:path>
            </a:pathLst>
          </a:custGeom>
          <a:solidFill>
            <a:srgbClr val="000000"/>
          </a:solidFill>
          <a:ln w="4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Rectangle 56"/>
          <p:cNvSpPr>
            <a:spLocks noChangeArrowheads="1"/>
          </p:cNvSpPr>
          <p:nvPr/>
        </p:nvSpPr>
        <p:spPr bwMode="auto">
          <a:xfrm>
            <a:off x="4392878" y="3523091"/>
            <a:ext cx="289773" cy="112230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Freeform 57"/>
          <p:cNvSpPr>
            <a:spLocks noEditPoints="1"/>
          </p:cNvSpPr>
          <p:nvPr/>
        </p:nvSpPr>
        <p:spPr bwMode="auto">
          <a:xfrm>
            <a:off x="4390313" y="3519019"/>
            <a:ext cx="294901" cy="1129089"/>
          </a:xfrm>
          <a:custGeom>
            <a:avLst/>
            <a:gdLst>
              <a:gd name="T0" fmla="*/ 0 w 864"/>
              <a:gd name="T1" fmla="*/ 8 h 3120"/>
              <a:gd name="T2" fmla="*/ 8 w 864"/>
              <a:gd name="T3" fmla="*/ 0 h 3120"/>
              <a:gd name="T4" fmla="*/ 856 w 864"/>
              <a:gd name="T5" fmla="*/ 0 h 3120"/>
              <a:gd name="T6" fmla="*/ 864 w 864"/>
              <a:gd name="T7" fmla="*/ 8 h 3120"/>
              <a:gd name="T8" fmla="*/ 864 w 864"/>
              <a:gd name="T9" fmla="*/ 3112 h 3120"/>
              <a:gd name="T10" fmla="*/ 856 w 864"/>
              <a:gd name="T11" fmla="*/ 3120 h 3120"/>
              <a:gd name="T12" fmla="*/ 8 w 864"/>
              <a:gd name="T13" fmla="*/ 3120 h 3120"/>
              <a:gd name="T14" fmla="*/ 0 w 864"/>
              <a:gd name="T15" fmla="*/ 3112 h 3120"/>
              <a:gd name="T16" fmla="*/ 0 w 864"/>
              <a:gd name="T17" fmla="*/ 8 h 3120"/>
              <a:gd name="T18" fmla="*/ 16 w 864"/>
              <a:gd name="T19" fmla="*/ 3112 h 3120"/>
              <a:gd name="T20" fmla="*/ 8 w 864"/>
              <a:gd name="T21" fmla="*/ 3104 h 3120"/>
              <a:gd name="T22" fmla="*/ 856 w 864"/>
              <a:gd name="T23" fmla="*/ 3104 h 3120"/>
              <a:gd name="T24" fmla="*/ 848 w 864"/>
              <a:gd name="T25" fmla="*/ 3112 h 3120"/>
              <a:gd name="T26" fmla="*/ 848 w 864"/>
              <a:gd name="T27" fmla="*/ 8 h 3120"/>
              <a:gd name="T28" fmla="*/ 856 w 864"/>
              <a:gd name="T29" fmla="*/ 16 h 3120"/>
              <a:gd name="T30" fmla="*/ 8 w 864"/>
              <a:gd name="T31" fmla="*/ 16 h 3120"/>
              <a:gd name="T32" fmla="*/ 16 w 864"/>
              <a:gd name="T33" fmla="*/ 8 h 3120"/>
              <a:gd name="T34" fmla="*/ 16 w 864"/>
              <a:gd name="T35" fmla="*/ 3112 h 31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3120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856" y="0"/>
                </a:lnTo>
                <a:cubicBezTo>
                  <a:pt x="861" y="0"/>
                  <a:pt x="864" y="4"/>
                  <a:pt x="864" y="8"/>
                </a:cubicBezTo>
                <a:lnTo>
                  <a:pt x="864" y="3112"/>
                </a:lnTo>
                <a:cubicBezTo>
                  <a:pt x="864" y="3117"/>
                  <a:pt x="861" y="3120"/>
                  <a:pt x="856" y="3120"/>
                </a:cubicBezTo>
                <a:lnTo>
                  <a:pt x="8" y="3120"/>
                </a:lnTo>
                <a:cubicBezTo>
                  <a:pt x="4" y="3120"/>
                  <a:pt x="0" y="3117"/>
                  <a:pt x="0" y="3112"/>
                </a:cubicBezTo>
                <a:lnTo>
                  <a:pt x="0" y="8"/>
                </a:lnTo>
                <a:close/>
                <a:moveTo>
                  <a:pt x="16" y="3112"/>
                </a:moveTo>
                <a:lnTo>
                  <a:pt x="8" y="3104"/>
                </a:lnTo>
                <a:lnTo>
                  <a:pt x="856" y="3104"/>
                </a:lnTo>
                <a:lnTo>
                  <a:pt x="848" y="3112"/>
                </a:lnTo>
                <a:lnTo>
                  <a:pt x="848" y="8"/>
                </a:lnTo>
                <a:lnTo>
                  <a:pt x="856" y="16"/>
                </a:lnTo>
                <a:lnTo>
                  <a:pt x="8" y="16"/>
                </a:lnTo>
                <a:lnTo>
                  <a:pt x="16" y="8"/>
                </a:lnTo>
                <a:lnTo>
                  <a:pt x="16" y="3112"/>
                </a:lnTo>
                <a:close/>
              </a:path>
            </a:pathLst>
          </a:custGeom>
          <a:solidFill>
            <a:srgbClr val="000000"/>
          </a:solidFill>
          <a:ln w="4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Freeform 58"/>
          <p:cNvSpPr>
            <a:spLocks noEditPoints="1"/>
          </p:cNvSpPr>
          <p:nvPr/>
        </p:nvSpPr>
        <p:spPr bwMode="auto">
          <a:xfrm>
            <a:off x="3560053" y="4445904"/>
            <a:ext cx="33337" cy="36642"/>
          </a:xfrm>
          <a:custGeom>
            <a:avLst/>
            <a:gdLst>
              <a:gd name="T0" fmla="*/ 11 w 26"/>
              <a:gd name="T1" fmla="*/ 27 h 27"/>
              <a:gd name="T2" fmla="*/ 11 w 26"/>
              <a:gd name="T3" fmla="*/ 2 h 27"/>
              <a:gd name="T4" fmla="*/ 15 w 26"/>
              <a:gd name="T5" fmla="*/ 2 h 27"/>
              <a:gd name="T6" fmla="*/ 15 w 26"/>
              <a:gd name="T7" fmla="*/ 27 h 27"/>
              <a:gd name="T8" fmla="*/ 11 w 26"/>
              <a:gd name="T9" fmla="*/ 27 h 27"/>
              <a:gd name="T10" fmla="*/ 0 w 26"/>
              <a:gd name="T11" fmla="*/ 0 h 27"/>
              <a:gd name="T12" fmla="*/ 26 w 26"/>
              <a:gd name="T13" fmla="*/ 0 h 27"/>
              <a:gd name="T14" fmla="*/ 26 w 26"/>
              <a:gd name="T15" fmla="*/ 4 h 27"/>
              <a:gd name="T16" fmla="*/ 0 w 26"/>
              <a:gd name="T17" fmla="*/ 4 h 27"/>
              <a:gd name="T18" fmla="*/ 0 w 26"/>
              <a:gd name="T19" fmla="*/ 0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6" h="27">
                <a:moveTo>
                  <a:pt x="11" y="27"/>
                </a:moveTo>
                <a:lnTo>
                  <a:pt x="11" y="2"/>
                </a:lnTo>
                <a:lnTo>
                  <a:pt x="15" y="2"/>
                </a:lnTo>
                <a:lnTo>
                  <a:pt x="15" y="27"/>
                </a:lnTo>
                <a:lnTo>
                  <a:pt x="11" y="27"/>
                </a:lnTo>
                <a:close/>
                <a:moveTo>
                  <a:pt x="0" y="0"/>
                </a:moveTo>
                <a:lnTo>
                  <a:pt x="26" y="0"/>
                </a:lnTo>
                <a:lnTo>
                  <a:pt x="26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595959"/>
          </a:solidFill>
          <a:ln w="4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Freeform 59"/>
          <p:cNvSpPr>
            <a:spLocks noEditPoints="1"/>
          </p:cNvSpPr>
          <p:nvPr/>
        </p:nvSpPr>
        <p:spPr bwMode="auto">
          <a:xfrm>
            <a:off x="4233888" y="3398239"/>
            <a:ext cx="33337" cy="71926"/>
          </a:xfrm>
          <a:custGeom>
            <a:avLst/>
            <a:gdLst>
              <a:gd name="T0" fmla="*/ 11 w 26"/>
              <a:gd name="T1" fmla="*/ 53 h 53"/>
              <a:gd name="T2" fmla="*/ 11 w 26"/>
              <a:gd name="T3" fmla="*/ 2 h 53"/>
              <a:gd name="T4" fmla="*/ 15 w 26"/>
              <a:gd name="T5" fmla="*/ 2 h 53"/>
              <a:gd name="T6" fmla="*/ 15 w 26"/>
              <a:gd name="T7" fmla="*/ 53 h 53"/>
              <a:gd name="T8" fmla="*/ 11 w 26"/>
              <a:gd name="T9" fmla="*/ 53 h 53"/>
              <a:gd name="T10" fmla="*/ 0 w 26"/>
              <a:gd name="T11" fmla="*/ 0 h 53"/>
              <a:gd name="T12" fmla="*/ 26 w 26"/>
              <a:gd name="T13" fmla="*/ 0 h 53"/>
              <a:gd name="T14" fmla="*/ 26 w 26"/>
              <a:gd name="T15" fmla="*/ 4 h 53"/>
              <a:gd name="T16" fmla="*/ 0 w 26"/>
              <a:gd name="T17" fmla="*/ 4 h 53"/>
              <a:gd name="T18" fmla="*/ 0 w 26"/>
              <a:gd name="T19" fmla="*/ 0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6" h="53">
                <a:moveTo>
                  <a:pt x="11" y="53"/>
                </a:moveTo>
                <a:lnTo>
                  <a:pt x="11" y="2"/>
                </a:lnTo>
                <a:lnTo>
                  <a:pt x="15" y="2"/>
                </a:lnTo>
                <a:lnTo>
                  <a:pt x="15" y="53"/>
                </a:lnTo>
                <a:lnTo>
                  <a:pt x="11" y="53"/>
                </a:lnTo>
                <a:close/>
                <a:moveTo>
                  <a:pt x="0" y="0"/>
                </a:moveTo>
                <a:lnTo>
                  <a:pt x="26" y="0"/>
                </a:lnTo>
                <a:lnTo>
                  <a:pt x="26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595959"/>
          </a:solidFill>
          <a:ln w="4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Freeform 60"/>
          <p:cNvSpPr>
            <a:spLocks noEditPoints="1"/>
          </p:cNvSpPr>
          <p:nvPr/>
        </p:nvSpPr>
        <p:spPr bwMode="auto">
          <a:xfrm>
            <a:off x="3854954" y="4439118"/>
            <a:ext cx="33337" cy="32570"/>
          </a:xfrm>
          <a:custGeom>
            <a:avLst/>
            <a:gdLst>
              <a:gd name="T0" fmla="*/ 11 w 26"/>
              <a:gd name="T1" fmla="*/ 24 h 24"/>
              <a:gd name="T2" fmla="*/ 11 w 26"/>
              <a:gd name="T3" fmla="*/ 3 h 24"/>
              <a:gd name="T4" fmla="*/ 15 w 26"/>
              <a:gd name="T5" fmla="*/ 3 h 24"/>
              <a:gd name="T6" fmla="*/ 15 w 26"/>
              <a:gd name="T7" fmla="*/ 24 h 24"/>
              <a:gd name="T8" fmla="*/ 11 w 26"/>
              <a:gd name="T9" fmla="*/ 24 h 24"/>
              <a:gd name="T10" fmla="*/ 0 w 26"/>
              <a:gd name="T11" fmla="*/ 0 h 24"/>
              <a:gd name="T12" fmla="*/ 26 w 26"/>
              <a:gd name="T13" fmla="*/ 0 h 24"/>
              <a:gd name="T14" fmla="*/ 26 w 26"/>
              <a:gd name="T15" fmla="*/ 5 h 24"/>
              <a:gd name="T16" fmla="*/ 0 w 26"/>
              <a:gd name="T17" fmla="*/ 5 h 24"/>
              <a:gd name="T18" fmla="*/ 0 w 26"/>
              <a:gd name="T19" fmla="*/ 0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6" h="24">
                <a:moveTo>
                  <a:pt x="11" y="24"/>
                </a:moveTo>
                <a:lnTo>
                  <a:pt x="11" y="3"/>
                </a:lnTo>
                <a:lnTo>
                  <a:pt x="15" y="3"/>
                </a:lnTo>
                <a:lnTo>
                  <a:pt x="15" y="24"/>
                </a:lnTo>
                <a:lnTo>
                  <a:pt x="11" y="24"/>
                </a:lnTo>
                <a:close/>
                <a:moveTo>
                  <a:pt x="0" y="0"/>
                </a:moveTo>
                <a:lnTo>
                  <a:pt x="26" y="0"/>
                </a:lnTo>
                <a:lnTo>
                  <a:pt x="2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595959"/>
          </a:solidFill>
          <a:ln w="4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Freeform 61"/>
          <p:cNvSpPr>
            <a:spLocks noEditPoints="1"/>
          </p:cNvSpPr>
          <p:nvPr/>
        </p:nvSpPr>
        <p:spPr bwMode="auto">
          <a:xfrm>
            <a:off x="4523660" y="3433523"/>
            <a:ext cx="33337" cy="89567"/>
          </a:xfrm>
          <a:custGeom>
            <a:avLst/>
            <a:gdLst>
              <a:gd name="T0" fmla="*/ 11 w 26"/>
              <a:gd name="T1" fmla="*/ 66 h 66"/>
              <a:gd name="T2" fmla="*/ 11 w 26"/>
              <a:gd name="T3" fmla="*/ 2 h 66"/>
              <a:gd name="T4" fmla="*/ 15 w 26"/>
              <a:gd name="T5" fmla="*/ 2 h 66"/>
              <a:gd name="T6" fmla="*/ 15 w 26"/>
              <a:gd name="T7" fmla="*/ 66 h 66"/>
              <a:gd name="T8" fmla="*/ 11 w 26"/>
              <a:gd name="T9" fmla="*/ 66 h 66"/>
              <a:gd name="T10" fmla="*/ 0 w 26"/>
              <a:gd name="T11" fmla="*/ 0 h 66"/>
              <a:gd name="T12" fmla="*/ 26 w 26"/>
              <a:gd name="T13" fmla="*/ 0 h 66"/>
              <a:gd name="T14" fmla="*/ 26 w 26"/>
              <a:gd name="T15" fmla="*/ 4 h 66"/>
              <a:gd name="T16" fmla="*/ 0 w 26"/>
              <a:gd name="T17" fmla="*/ 4 h 66"/>
              <a:gd name="T18" fmla="*/ 0 w 26"/>
              <a:gd name="T19" fmla="*/ 0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6" h="66">
                <a:moveTo>
                  <a:pt x="11" y="66"/>
                </a:moveTo>
                <a:lnTo>
                  <a:pt x="11" y="2"/>
                </a:lnTo>
                <a:lnTo>
                  <a:pt x="15" y="2"/>
                </a:lnTo>
                <a:lnTo>
                  <a:pt x="15" y="66"/>
                </a:lnTo>
                <a:lnTo>
                  <a:pt x="11" y="66"/>
                </a:lnTo>
                <a:close/>
                <a:moveTo>
                  <a:pt x="0" y="0"/>
                </a:moveTo>
                <a:lnTo>
                  <a:pt x="26" y="0"/>
                </a:lnTo>
                <a:lnTo>
                  <a:pt x="26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595959"/>
          </a:solidFill>
          <a:ln w="4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Rectangle 62"/>
          <p:cNvSpPr>
            <a:spLocks noChangeArrowheads="1"/>
          </p:cNvSpPr>
          <p:nvPr/>
        </p:nvSpPr>
        <p:spPr bwMode="auto">
          <a:xfrm>
            <a:off x="3352965" y="3239461"/>
            <a:ext cx="5129" cy="1405933"/>
          </a:xfrm>
          <a:prstGeom prst="rect">
            <a:avLst/>
          </a:prstGeom>
          <a:solidFill>
            <a:srgbClr val="000000"/>
          </a:solidFill>
          <a:ln w="1270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Freeform 63"/>
          <p:cNvSpPr>
            <a:spLocks noEditPoints="1"/>
          </p:cNvSpPr>
          <p:nvPr/>
        </p:nvSpPr>
        <p:spPr bwMode="auto">
          <a:xfrm>
            <a:off x="3310870" y="3236747"/>
            <a:ext cx="36000" cy="1411361"/>
          </a:xfrm>
          <a:custGeom>
            <a:avLst/>
            <a:gdLst>
              <a:gd name="T0" fmla="*/ 0 w 17"/>
              <a:gd name="T1" fmla="*/ 1036 h 1040"/>
              <a:gd name="T2" fmla="*/ 17 w 17"/>
              <a:gd name="T3" fmla="*/ 1036 h 1040"/>
              <a:gd name="T4" fmla="*/ 17 w 17"/>
              <a:gd name="T5" fmla="*/ 1040 h 1040"/>
              <a:gd name="T6" fmla="*/ 0 w 17"/>
              <a:gd name="T7" fmla="*/ 1040 h 1040"/>
              <a:gd name="T8" fmla="*/ 0 w 17"/>
              <a:gd name="T9" fmla="*/ 1036 h 1040"/>
              <a:gd name="T10" fmla="*/ 0 w 17"/>
              <a:gd name="T11" fmla="*/ 861 h 1040"/>
              <a:gd name="T12" fmla="*/ 17 w 17"/>
              <a:gd name="T13" fmla="*/ 861 h 1040"/>
              <a:gd name="T14" fmla="*/ 17 w 17"/>
              <a:gd name="T15" fmla="*/ 865 h 1040"/>
              <a:gd name="T16" fmla="*/ 0 w 17"/>
              <a:gd name="T17" fmla="*/ 865 h 1040"/>
              <a:gd name="T18" fmla="*/ 0 w 17"/>
              <a:gd name="T19" fmla="*/ 861 h 1040"/>
              <a:gd name="T20" fmla="*/ 0 w 17"/>
              <a:gd name="T21" fmla="*/ 690 h 1040"/>
              <a:gd name="T22" fmla="*/ 17 w 17"/>
              <a:gd name="T23" fmla="*/ 690 h 1040"/>
              <a:gd name="T24" fmla="*/ 17 w 17"/>
              <a:gd name="T25" fmla="*/ 695 h 1040"/>
              <a:gd name="T26" fmla="*/ 0 w 17"/>
              <a:gd name="T27" fmla="*/ 695 h 1040"/>
              <a:gd name="T28" fmla="*/ 0 w 17"/>
              <a:gd name="T29" fmla="*/ 690 h 1040"/>
              <a:gd name="T30" fmla="*/ 0 w 17"/>
              <a:gd name="T31" fmla="*/ 515 h 1040"/>
              <a:gd name="T32" fmla="*/ 17 w 17"/>
              <a:gd name="T33" fmla="*/ 515 h 1040"/>
              <a:gd name="T34" fmla="*/ 17 w 17"/>
              <a:gd name="T35" fmla="*/ 520 h 1040"/>
              <a:gd name="T36" fmla="*/ 0 w 17"/>
              <a:gd name="T37" fmla="*/ 520 h 1040"/>
              <a:gd name="T38" fmla="*/ 0 w 17"/>
              <a:gd name="T39" fmla="*/ 515 h 1040"/>
              <a:gd name="T40" fmla="*/ 0 w 17"/>
              <a:gd name="T41" fmla="*/ 345 h 1040"/>
              <a:gd name="T42" fmla="*/ 17 w 17"/>
              <a:gd name="T43" fmla="*/ 345 h 1040"/>
              <a:gd name="T44" fmla="*/ 17 w 17"/>
              <a:gd name="T45" fmla="*/ 349 h 1040"/>
              <a:gd name="T46" fmla="*/ 0 w 17"/>
              <a:gd name="T47" fmla="*/ 349 h 1040"/>
              <a:gd name="T48" fmla="*/ 0 w 17"/>
              <a:gd name="T49" fmla="*/ 345 h 1040"/>
              <a:gd name="T50" fmla="*/ 0 w 17"/>
              <a:gd name="T51" fmla="*/ 174 h 1040"/>
              <a:gd name="T52" fmla="*/ 17 w 17"/>
              <a:gd name="T53" fmla="*/ 174 h 1040"/>
              <a:gd name="T54" fmla="*/ 17 w 17"/>
              <a:gd name="T55" fmla="*/ 179 h 1040"/>
              <a:gd name="T56" fmla="*/ 0 w 17"/>
              <a:gd name="T57" fmla="*/ 179 h 1040"/>
              <a:gd name="T58" fmla="*/ 0 w 17"/>
              <a:gd name="T59" fmla="*/ 174 h 1040"/>
              <a:gd name="T60" fmla="*/ 0 w 17"/>
              <a:gd name="T61" fmla="*/ 0 h 1040"/>
              <a:gd name="T62" fmla="*/ 17 w 17"/>
              <a:gd name="T63" fmla="*/ 0 h 1040"/>
              <a:gd name="T64" fmla="*/ 17 w 17"/>
              <a:gd name="T65" fmla="*/ 4 h 1040"/>
              <a:gd name="T66" fmla="*/ 0 w 17"/>
              <a:gd name="T67" fmla="*/ 4 h 1040"/>
              <a:gd name="T68" fmla="*/ 0 w 17"/>
              <a:gd name="T69" fmla="*/ 0 h 10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7" h="1040">
                <a:moveTo>
                  <a:pt x="0" y="1036"/>
                </a:moveTo>
                <a:lnTo>
                  <a:pt x="17" y="1036"/>
                </a:lnTo>
                <a:lnTo>
                  <a:pt x="17" y="1040"/>
                </a:lnTo>
                <a:lnTo>
                  <a:pt x="0" y="1040"/>
                </a:lnTo>
                <a:lnTo>
                  <a:pt x="0" y="1036"/>
                </a:lnTo>
                <a:close/>
                <a:moveTo>
                  <a:pt x="0" y="861"/>
                </a:moveTo>
                <a:lnTo>
                  <a:pt x="17" y="861"/>
                </a:lnTo>
                <a:lnTo>
                  <a:pt x="17" y="865"/>
                </a:lnTo>
                <a:lnTo>
                  <a:pt x="0" y="865"/>
                </a:lnTo>
                <a:lnTo>
                  <a:pt x="0" y="861"/>
                </a:lnTo>
                <a:close/>
                <a:moveTo>
                  <a:pt x="0" y="690"/>
                </a:moveTo>
                <a:lnTo>
                  <a:pt x="17" y="690"/>
                </a:lnTo>
                <a:lnTo>
                  <a:pt x="17" y="695"/>
                </a:lnTo>
                <a:lnTo>
                  <a:pt x="0" y="695"/>
                </a:lnTo>
                <a:lnTo>
                  <a:pt x="0" y="690"/>
                </a:lnTo>
                <a:close/>
                <a:moveTo>
                  <a:pt x="0" y="515"/>
                </a:moveTo>
                <a:lnTo>
                  <a:pt x="17" y="515"/>
                </a:lnTo>
                <a:lnTo>
                  <a:pt x="17" y="520"/>
                </a:lnTo>
                <a:lnTo>
                  <a:pt x="0" y="520"/>
                </a:lnTo>
                <a:lnTo>
                  <a:pt x="0" y="515"/>
                </a:lnTo>
                <a:close/>
                <a:moveTo>
                  <a:pt x="0" y="345"/>
                </a:moveTo>
                <a:lnTo>
                  <a:pt x="17" y="345"/>
                </a:lnTo>
                <a:lnTo>
                  <a:pt x="17" y="349"/>
                </a:lnTo>
                <a:lnTo>
                  <a:pt x="0" y="349"/>
                </a:lnTo>
                <a:lnTo>
                  <a:pt x="0" y="345"/>
                </a:lnTo>
                <a:close/>
                <a:moveTo>
                  <a:pt x="0" y="174"/>
                </a:moveTo>
                <a:lnTo>
                  <a:pt x="17" y="174"/>
                </a:lnTo>
                <a:lnTo>
                  <a:pt x="17" y="179"/>
                </a:lnTo>
                <a:lnTo>
                  <a:pt x="0" y="179"/>
                </a:lnTo>
                <a:lnTo>
                  <a:pt x="0" y="174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17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4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Rectangle 64"/>
          <p:cNvSpPr>
            <a:spLocks noChangeArrowheads="1"/>
          </p:cNvSpPr>
          <p:nvPr/>
        </p:nvSpPr>
        <p:spPr bwMode="auto">
          <a:xfrm>
            <a:off x="3355529" y="4642680"/>
            <a:ext cx="1404000" cy="5428"/>
          </a:xfrm>
          <a:prstGeom prst="rect">
            <a:avLst/>
          </a:prstGeom>
          <a:solidFill>
            <a:srgbClr val="000000"/>
          </a:solidFill>
          <a:ln w="4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Rectangle 66"/>
          <p:cNvSpPr>
            <a:spLocks noChangeArrowheads="1"/>
          </p:cNvSpPr>
          <p:nvPr/>
        </p:nvSpPr>
        <p:spPr bwMode="auto">
          <a:xfrm>
            <a:off x="3214779" y="4563867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Rectangle 67"/>
          <p:cNvSpPr>
            <a:spLocks noChangeArrowheads="1"/>
          </p:cNvSpPr>
          <p:nvPr/>
        </p:nvSpPr>
        <p:spPr bwMode="auto">
          <a:xfrm>
            <a:off x="3073715" y="4330450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Rectangle 68"/>
          <p:cNvSpPr>
            <a:spLocks noChangeArrowheads="1"/>
          </p:cNvSpPr>
          <p:nvPr/>
        </p:nvSpPr>
        <p:spPr bwMode="auto">
          <a:xfrm>
            <a:off x="3073715" y="409703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Rectangle 69"/>
          <p:cNvSpPr>
            <a:spLocks noChangeArrowheads="1"/>
          </p:cNvSpPr>
          <p:nvPr/>
        </p:nvSpPr>
        <p:spPr bwMode="auto">
          <a:xfrm>
            <a:off x="3073715" y="3862258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Rectangle 70"/>
          <p:cNvSpPr>
            <a:spLocks noChangeArrowheads="1"/>
          </p:cNvSpPr>
          <p:nvPr/>
        </p:nvSpPr>
        <p:spPr bwMode="auto">
          <a:xfrm>
            <a:off x="3073715" y="3628841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Rectangle 71"/>
          <p:cNvSpPr>
            <a:spLocks noChangeArrowheads="1"/>
          </p:cNvSpPr>
          <p:nvPr/>
        </p:nvSpPr>
        <p:spPr bwMode="auto">
          <a:xfrm>
            <a:off x="3003182" y="3395423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Rectangle 72"/>
          <p:cNvSpPr>
            <a:spLocks noChangeArrowheads="1"/>
          </p:cNvSpPr>
          <p:nvPr/>
        </p:nvSpPr>
        <p:spPr bwMode="auto">
          <a:xfrm>
            <a:off x="3003182" y="3162006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00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Rectangle 109"/>
          <p:cNvSpPr>
            <a:spLocks noChangeArrowheads="1"/>
          </p:cNvSpPr>
          <p:nvPr/>
        </p:nvSpPr>
        <p:spPr bwMode="auto">
          <a:xfrm>
            <a:off x="3677424" y="4712211"/>
            <a:ext cx="54072" cy="11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-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Rectangle 110"/>
          <p:cNvSpPr>
            <a:spLocks noChangeArrowheads="1"/>
          </p:cNvSpPr>
          <p:nvPr/>
        </p:nvSpPr>
        <p:spPr bwMode="auto">
          <a:xfrm>
            <a:off x="4376797" y="4712211"/>
            <a:ext cx="76143" cy="11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+</a:t>
            </a:r>
            <a:endParaRPr kumimoji="0" lang="fr-F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Rectangle 109"/>
          <p:cNvSpPr>
            <a:spLocks noChangeArrowheads="1"/>
          </p:cNvSpPr>
          <p:nvPr/>
        </p:nvSpPr>
        <p:spPr bwMode="auto">
          <a:xfrm>
            <a:off x="2507715" y="4717755"/>
            <a:ext cx="627896" cy="11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LPS 500ng/</a:t>
            </a:r>
            <a:r>
              <a:rPr kumimoji="0" lang="fr-F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L</a:t>
            </a:r>
            <a:r>
              <a:rPr kumimoji="0" 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:</a:t>
            </a:r>
            <a:endParaRPr kumimoji="0" 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Rectangle 145"/>
          <p:cNvSpPr>
            <a:spLocks noChangeArrowheads="1"/>
          </p:cNvSpPr>
          <p:nvPr/>
        </p:nvSpPr>
        <p:spPr bwMode="auto">
          <a:xfrm rot="16200000">
            <a:off x="2488171" y="3857088"/>
            <a:ext cx="76944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33039"/>
            <a:r>
              <a:rPr lang="fr-FR" altLang="fr-FR" sz="1000" dirty="0" smtClean="0">
                <a:cs typeface="Arial" panose="020B0604020202020204" pitchFamily="34" charset="0"/>
              </a:rPr>
              <a:t>IL-1</a:t>
            </a:r>
            <a:r>
              <a:rPr lang="el-GR" altLang="fr-FR" sz="1000" dirty="0" smtClean="0">
                <a:latin typeface="Cambria Math"/>
                <a:ea typeface="Cambria Math"/>
                <a:cs typeface="Arial" panose="020B0604020202020204" pitchFamily="34" charset="0"/>
              </a:rPr>
              <a:t>β</a:t>
            </a:r>
            <a:r>
              <a:rPr lang="fr-FR" altLang="fr-FR" sz="1000" dirty="0" smtClean="0">
                <a:cs typeface="Arial" panose="020B0604020202020204" pitchFamily="34" charset="0"/>
              </a:rPr>
              <a:t> </a:t>
            </a:r>
            <a:r>
              <a:rPr lang="fr-FR" altLang="fr-FR" sz="1000" dirty="0">
                <a:cs typeface="Arial" panose="020B0604020202020204" pitchFamily="34" charset="0"/>
              </a:rPr>
              <a:t>(</a:t>
            </a:r>
            <a:r>
              <a:rPr lang="fr-FR" altLang="fr-FR" sz="1000" dirty="0" err="1">
                <a:cs typeface="Arial" panose="020B0604020202020204" pitchFamily="34" charset="0"/>
              </a:rPr>
              <a:t>pg</a:t>
            </a:r>
            <a:r>
              <a:rPr lang="fr-FR" altLang="fr-FR" sz="1000" dirty="0">
                <a:cs typeface="Arial" panose="020B0604020202020204" pitchFamily="34" charset="0"/>
              </a:rPr>
              <a:t>/</a:t>
            </a:r>
            <a:r>
              <a:rPr lang="fr-FR" altLang="fr-FR" sz="1000" dirty="0" err="1">
                <a:cs typeface="Arial" panose="020B0604020202020204" pitchFamily="34" charset="0"/>
              </a:rPr>
              <a:t>mL</a:t>
            </a:r>
            <a:r>
              <a:rPr lang="fr-FR" altLang="fr-FR" sz="1000" dirty="0">
                <a:cs typeface="Arial" panose="020B0604020202020204" pitchFamily="34" charset="0"/>
              </a:rPr>
              <a:t>)</a:t>
            </a:r>
          </a:p>
        </p:txBody>
      </p:sp>
      <p:sp>
        <p:nvSpPr>
          <p:cNvPr id="132" name="Rectangle 26"/>
          <p:cNvSpPr>
            <a:spLocks noChangeArrowheads="1"/>
          </p:cNvSpPr>
          <p:nvPr/>
        </p:nvSpPr>
        <p:spPr bwMode="auto">
          <a:xfrm>
            <a:off x="3471311" y="3350248"/>
            <a:ext cx="72000" cy="72000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3" name="Freeform 27"/>
          <p:cNvSpPr>
            <a:spLocks noEditPoints="1"/>
          </p:cNvSpPr>
          <p:nvPr/>
        </p:nvSpPr>
        <p:spPr bwMode="auto">
          <a:xfrm>
            <a:off x="3470218" y="3349097"/>
            <a:ext cx="72000" cy="72000"/>
          </a:xfrm>
          <a:custGeom>
            <a:avLst/>
            <a:gdLst>
              <a:gd name="T0" fmla="*/ 0 w 752"/>
              <a:gd name="T1" fmla="*/ 48 h 768"/>
              <a:gd name="T2" fmla="*/ 48 w 752"/>
              <a:gd name="T3" fmla="*/ 0 h 768"/>
              <a:gd name="T4" fmla="*/ 704 w 752"/>
              <a:gd name="T5" fmla="*/ 0 h 768"/>
              <a:gd name="T6" fmla="*/ 752 w 752"/>
              <a:gd name="T7" fmla="*/ 48 h 768"/>
              <a:gd name="T8" fmla="*/ 752 w 752"/>
              <a:gd name="T9" fmla="*/ 720 h 768"/>
              <a:gd name="T10" fmla="*/ 704 w 752"/>
              <a:gd name="T11" fmla="*/ 768 h 768"/>
              <a:gd name="T12" fmla="*/ 48 w 752"/>
              <a:gd name="T13" fmla="*/ 768 h 768"/>
              <a:gd name="T14" fmla="*/ 0 w 752"/>
              <a:gd name="T15" fmla="*/ 720 h 768"/>
              <a:gd name="T16" fmla="*/ 0 w 752"/>
              <a:gd name="T17" fmla="*/ 48 h 768"/>
              <a:gd name="T18" fmla="*/ 96 w 752"/>
              <a:gd name="T19" fmla="*/ 720 h 768"/>
              <a:gd name="T20" fmla="*/ 48 w 752"/>
              <a:gd name="T21" fmla="*/ 672 h 768"/>
              <a:gd name="T22" fmla="*/ 704 w 752"/>
              <a:gd name="T23" fmla="*/ 672 h 768"/>
              <a:gd name="T24" fmla="*/ 656 w 752"/>
              <a:gd name="T25" fmla="*/ 720 h 768"/>
              <a:gd name="T26" fmla="*/ 656 w 752"/>
              <a:gd name="T27" fmla="*/ 48 h 768"/>
              <a:gd name="T28" fmla="*/ 704 w 752"/>
              <a:gd name="T29" fmla="*/ 96 h 768"/>
              <a:gd name="T30" fmla="*/ 48 w 752"/>
              <a:gd name="T31" fmla="*/ 96 h 768"/>
              <a:gd name="T32" fmla="*/ 96 w 752"/>
              <a:gd name="T33" fmla="*/ 48 h 768"/>
              <a:gd name="T34" fmla="*/ 96 w 752"/>
              <a:gd name="T35" fmla="*/ 720 h 7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752" h="768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704" y="0"/>
                </a:lnTo>
                <a:cubicBezTo>
                  <a:pt x="731" y="0"/>
                  <a:pt x="752" y="22"/>
                  <a:pt x="752" y="48"/>
                </a:cubicBezTo>
                <a:lnTo>
                  <a:pt x="752" y="720"/>
                </a:lnTo>
                <a:cubicBezTo>
                  <a:pt x="752" y="747"/>
                  <a:pt x="731" y="768"/>
                  <a:pt x="704" y="768"/>
                </a:cubicBezTo>
                <a:lnTo>
                  <a:pt x="48" y="768"/>
                </a:lnTo>
                <a:cubicBezTo>
                  <a:pt x="22" y="768"/>
                  <a:pt x="0" y="747"/>
                  <a:pt x="0" y="720"/>
                </a:cubicBezTo>
                <a:lnTo>
                  <a:pt x="0" y="48"/>
                </a:lnTo>
                <a:close/>
                <a:moveTo>
                  <a:pt x="96" y="720"/>
                </a:moveTo>
                <a:lnTo>
                  <a:pt x="48" y="672"/>
                </a:lnTo>
                <a:lnTo>
                  <a:pt x="704" y="672"/>
                </a:lnTo>
                <a:lnTo>
                  <a:pt x="656" y="720"/>
                </a:lnTo>
                <a:lnTo>
                  <a:pt x="656" y="48"/>
                </a:lnTo>
                <a:lnTo>
                  <a:pt x="704" y="96"/>
                </a:lnTo>
                <a:lnTo>
                  <a:pt x="48" y="96"/>
                </a:lnTo>
                <a:lnTo>
                  <a:pt x="96" y="48"/>
                </a:lnTo>
                <a:lnTo>
                  <a:pt x="96" y="72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4" name="Rectangle 28"/>
          <p:cNvSpPr>
            <a:spLocks noChangeArrowheads="1"/>
          </p:cNvSpPr>
          <p:nvPr/>
        </p:nvSpPr>
        <p:spPr bwMode="auto">
          <a:xfrm>
            <a:off x="3587249" y="3306140"/>
            <a:ext cx="137939" cy="11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T</a:t>
            </a:r>
            <a:endParaRPr kumimoji="0" lang="fr-FR" altLang="fr-F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5" name="Rectangle 29"/>
          <p:cNvSpPr>
            <a:spLocks noChangeArrowheads="1"/>
          </p:cNvSpPr>
          <p:nvPr/>
        </p:nvSpPr>
        <p:spPr bwMode="auto">
          <a:xfrm>
            <a:off x="3471311" y="3487539"/>
            <a:ext cx="72000" cy="72000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6" name="Freeform 30"/>
          <p:cNvSpPr>
            <a:spLocks noEditPoints="1"/>
          </p:cNvSpPr>
          <p:nvPr/>
        </p:nvSpPr>
        <p:spPr bwMode="auto">
          <a:xfrm>
            <a:off x="3470218" y="3486388"/>
            <a:ext cx="72000" cy="72000"/>
          </a:xfrm>
          <a:custGeom>
            <a:avLst/>
            <a:gdLst>
              <a:gd name="T0" fmla="*/ 0 w 752"/>
              <a:gd name="T1" fmla="*/ 48 h 752"/>
              <a:gd name="T2" fmla="*/ 48 w 752"/>
              <a:gd name="T3" fmla="*/ 0 h 752"/>
              <a:gd name="T4" fmla="*/ 704 w 752"/>
              <a:gd name="T5" fmla="*/ 0 h 752"/>
              <a:gd name="T6" fmla="*/ 752 w 752"/>
              <a:gd name="T7" fmla="*/ 48 h 752"/>
              <a:gd name="T8" fmla="*/ 752 w 752"/>
              <a:gd name="T9" fmla="*/ 704 h 752"/>
              <a:gd name="T10" fmla="*/ 704 w 752"/>
              <a:gd name="T11" fmla="*/ 752 h 752"/>
              <a:gd name="T12" fmla="*/ 48 w 752"/>
              <a:gd name="T13" fmla="*/ 752 h 752"/>
              <a:gd name="T14" fmla="*/ 0 w 752"/>
              <a:gd name="T15" fmla="*/ 704 h 752"/>
              <a:gd name="T16" fmla="*/ 0 w 752"/>
              <a:gd name="T17" fmla="*/ 48 h 752"/>
              <a:gd name="T18" fmla="*/ 96 w 752"/>
              <a:gd name="T19" fmla="*/ 704 h 752"/>
              <a:gd name="T20" fmla="*/ 48 w 752"/>
              <a:gd name="T21" fmla="*/ 656 h 752"/>
              <a:gd name="T22" fmla="*/ 704 w 752"/>
              <a:gd name="T23" fmla="*/ 656 h 752"/>
              <a:gd name="T24" fmla="*/ 656 w 752"/>
              <a:gd name="T25" fmla="*/ 704 h 752"/>
              <a:gd name="T26" fmla="*/ 656 w 752"/>
              <a:gd name="T27" fmla="*/ 48 h 752"/>
              <a:gd name="T28" fmla="*/ 704 w 752"/>
              <a:gd name="T29" fmla="*/ 96 h 752"/>
              <a:gd name="T30" fmla="*/ 48 w 752"/>
              <a:gd name="T31" fmla="*/ 96 h 752"/>
              <a:gd name="T32" fmla="*/ 96 w 752"/>
              <a:gd name="T33" fmla="*/ 48 h 752"/>
              <a:gd name="T34" fmla="*/ 96 w 752"/>
              <a:gd name="T35" fmla="*/ 704 h 7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752" h="752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704" y="0"/>
                </a:lnTo>
                <a:cubicBezTo>
                  <a:pt x="731" y="0"/>
                  <a:pt x="752" y="22"/>
                  <a:pt x="752" y="48"/>
                </a:cubicBezTo>
                <a:lnTo>
                  <a:pt x="752" y="704"/>
                </a:lnTo>
                <a:cubicBezTo>
                  <a:pt x="752" y="731"/>
                  <a:pt x="731" y="752"/>
                  <a:pt x="704" y="752"/>
                </a:cubicBezTo>
                <a:lnTo>
                  <a:pt x="48" y="752"/>
                </a:lnTo>
                <a:cubicBezTo>
                  <a:pt x="22" y="752"/>
                  <a:pt x="0" y="731"/>
                  <a:pt x="0" y="704"/>
                </a:cubicBezTo>
                <a:lnTo>
                  <a:pt x="0" y="48"/>
                </a:lnTo>
                <a:close/>
                <a:moveTo>
                  <a:pt x="96" y="704"/>
                </a:moveTo>
                <a:lnTo>
                  <a:pt x="48" y="656"/>
                </a:lnTo>
                <a:lnTo>
                  <a:pt x="704" y="656"/>
                </a:lnTo>
                <a:lnTo>
                  <a:pt x="656" y="704"/>
                </a:lnTo>
                <a:lnTo>
                  <a:pt x="656" y="48"/>
                </a:lnTo>
                <a:lnTo>
                  <a:pt x="704" y="96"/>
                </a:lnTo>
                <a:lnTo>
                  <a:pt x="48" y="96"/>
                </a:lnTo>
                <a:lnTo>
                  <a:pt x="96" y="48"/>
                </a:lnTo>
                <a:lnTo>
                  <a:pt x="96" y="70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7" name="Rectangle 31"/>
          <p:cNvSpPr>
            <a:spLocks noChangeArrowheads="1"/>
          </p:cNvSpPr>
          <p:nvPr/>
        </p:nvSpPr>
        <p:spPr bwMode="auto">
          <a:xfrm>
            <a:off x="3587249" y="3457320"/>
            <a:ext cx="310086" cy="11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sp70</a:t>
            </a:r>
            <a:r>
              <a:rPr lang="fr-FR" altLang="fr-FR" sz="1000" baseline="30000" dirty="0" smtClean="0">
                <a:solidFill>
                  <a:srgbClr val="000000"/>
                </a:solidFill>
                <a:cs typeface="Arial" panose="020B0604020202020204" pitchFamily="34" charset="0"/>
              </a:rPr>
              <a:t>-/-</a:t>
            </a:r>
            <a:endParaRPr lang="fr-FR" altLang="fr-FR" sz="1000" baseline="30000" dirty="0">
              <a:cs typeface="Arial" panose="020B0604020202020204" pitchFamily="34" charset="0"/>
            </a:endParaRPr>
          </a:p>
        </p:txBody>
      </p:sp>
      <p:sp>
        <p:nvSpPr>
          <p:cNvPr id="15" name="Rectangle 21"/>
          <p:cNvSpPr>
            <a:spLocks noChangeArrowheads="1"/>
          </p:cNvSpPr>
          <p:nvPr/>
        </p:nvSpPr>
        <p:spPr bwMode="auto">
          <a:xfrm>
            <a:off x="5608892" y="4525451"/>
            <a:ext cx="720000" cy="6350"/>
          </a:xfrm>
          <a:prstGeom prst="rect">
            <a:avLst/>
          </a:prstGeom>
          <a:solidFill>
            <a:srgbClr val="000000"/>
          </a:solidFill>
          <a:ln w="3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0" name="Image 89"/>
          <p:cNvPicPr>
            <a:picLocks noChangeAspect="1"/>
          </p:cNvPicPr>
          <p:nvPr/>
        </p:nvPicPr>
        <p:blipFill rotWithShape="1">
          <a:blip r:embed="rId2"/>
          <a:srcRect l="55" t="30132" r="35959" b="9323"/>
          <a:stretch/>
        </p:blipFill>
        <p:spPr>
          <a:xfrm>
            <a:off x="1029157" y="3774139"/>
            <a:ext cx="1451183" cy="283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1" name="ZoneTexte 1"/>
          <p:cNvSpPr txBox="1"/>
          <p:nvPr/>
        </p:nvSpPr>
        <p:spPr>
          <a:xfrm>
            <a:off x="449887" y="4117935"/>
            <a:ext cx="7505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0ng/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Connecteur droit 91"/>
          <p:cNvCxnSpPr/>
          <p:nvPr/>
        </p:nvCxnSpPr>
        <p:spPr>
          <a:xfrm>
            <a:off x="1162871" y="3688880"/>
            <a:ext cx="432000" cy="0"/>
          </a:xfrm>
          <a:prstGeom prst="line">
            <a:avLst/>
          </a:prstGeom>
          <a:ln w="9525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3" name="Connecteur droit 92"/>
          <p:cNvCxnSpPr/>
          <p:nvPr/>
        </p:nvCxnSpPr>
        <p:spPr>
          <a:xfrm>
            <a:off x="1851460" y="3690680"/>
            <a:ext cx="432000" cy="0"/>
          </a:xfrm>
          <a:prstGeom prst="line">
            <a:avLst/>
          </a:prstGeom>
          <a:ln w="9525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4" name="ZoneTexte 5"/>
          <p:cNvSpPr txBox="1"/>
          <p:nvPr/>
        </p:nvSpPr>
        <p:spPr>
          <a:xfrm>
            <a:off x="1189381" y="343059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ZoneTexte 9"/>
          <p:cNvSpPr txBox="1"/>
          <p:nvPr/>
        </p:nvSpPr>
        <p:spPr>
          <a:xfrm>
            <a:off x="1785033" y="3430593"/>
            <a:ext cx="6351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p70</a:t>
            </a:r>
            <a:r>
              <a:rPr lang="fr-F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fr-FR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ZoneTexte 11"/>
          <p:cNvSpPr txBox="1"/>
          <p:nvPr/>
        </p:nvSpPr>
        <p:spPr>
          <a:xfrm>
            <a:off x="1087466" y="418461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ZoneTexte 12"/>
          <p:cNvSpPr txBox="1"/>
          <p:nvPr/>
        </p:nvSpPr>
        <p:spPr>
          <a:xfrm>
            <a:off x="1798298" y="4184610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ZoneTexte 13"/>
          <p:cNvSpPr txBox="1"/>
          <p:nvPr/>
        </p:nvSpPr>
        <p:spPr>
          <a:xfrm>
            <a:off x="1403407" y="4184610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ZoneTexte 14"/>
          <p:cNvSpPr txBox="1"/>
          <p:nvPr/>
        </p:nvSpPr>
        <p:spPr>
          <a:xfrm>
            <a:off x="2106945" y="418461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2" name="ZoneTexte 15"/>
          <p:cNvSpPr txBox="1"/>
          <p:nvPr/>
        </p:nvSpPr>
        <p:spPr>
          <a:xfrm>
            <a:off x="449887" y="3728490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asp1</a:t>
            </a:r>
          </a:p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1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82351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Image 92"/>
          <p:cNvPicPr preferRelativeResize="0">
            <a:picLocks/>
          </p:cNvPicPr>
          <p:nvPr/>
        </p:nvPicPr>
        <p:blipFill rotWithShape="1">
          <a:blip r:embed="rId2">
            <a:lum bright="-20000" contrast="20000"/>
          </a:blip>
          <a:srcRect l="3527" t="11154" r="2851" b="18013"/>
          <a:stretch/>
        </p:blipFill>
        <p:spPr>
          <a:xfrm>
            <a:off x="3715291" y="1835763"/>
            <a:ext cx="648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4" name="Image 93"/>
          <p:cNvPicPr preferRelativeResize="0">
            <a:picLocks/>
          </p:cNvPicPr>
          <p:nvPr/>
        </p:nvPicPr>
        <p:blipFill rotWithShape="1">
          <a:blip r:embed="rId3">
            <a:lum bright="-20000" contrast="20000"/>
          </a:blip>
          <a:srcRect l="4118" t="8757" r="2941" b="13617"/>
          <a:stretch/>
        </p:blipFill>
        <p:spPr>
          <a:xfrm>
            <a:off x="3715291" y="1560378"/>
            <a:ext cx="648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Image 94"/>
          <p:cNvPicPr preferRelativeResize="0">
            <a:picLocks/>
          </p:cNvPicPr>
          <p:nvPr/>
        </p:nvPicPr>
        <p:blipFill rotWithShape="1">
          <a:blip r:embed="rId4">
            <a:lum bright="-20000" contrast="20000"/>
          </a:blip>
          <a:srcRect l="3829" t="15404" r="5244" b="14460"/>
          <a:stretch/>
        </p:blipFill>
        <p:spPr>
          <a:xfrm>
            <a:off x="3715291" y="2105364"/>
            <a:ext cx="648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6" name="Image 95"/>
          <p:cNvPicPr preferRelativeResize="0">
            <a:picLocks/>
          </p:cNvPicPr>
          <p:nvPr/>
        </p:nvPicPr>
        <p:blipFill rotWithShape="1">
          <a:blip r:embed="rId5">
            <a:lum bright="-20000" contrast="40000"/>
          </a:blip>
          <a:srcRect l="7220" t="7618" r="6058" b="10435"/>
          <a:stretch/>
        </p:blipFill>
        <p:spPr>
          <a:xfrm>
            <a:off x="3715291" y="2367547"/>
            <a:ext cx="648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7" name="Image 96"/>
          <p:cNvPicPr preferRelativeResize="0">
            <a:picLocks/>
          </p:cNvPicPr>
          <p:nvPr/>
        </p:nvPicPr>
        <p:blipFill rotWithShape="1">
          <a:blip r:embed="rId6">
            <a:lum bright="-20000" contrast="20000"/>
          </a:blip>
          <a:srcRect l="6058" t="14473" r="6399" b="11969"/>
          <a:stretch/>
        </p:blipFill>
        <p:spPr>
          <a:xfrm>
            <a:off x="3715291" y="2637629"/>
            <a:ext cx="648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8" name="ZoneTexte 97"/>
          <p:cNvSpPr txBox="1"/>
          <p:nvPr/>
        </p:nvSpPr>
        <p:spPr>
          <a:xfrm>
            <a:off x="3151200" y="1545268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ZoneTexte 98"/>
          <p:cNvSpPr txBox="1"/>
          <p:nvPr/>
        </p:nvSpPr>
        <p:spPr>
          <a:xfrm>
            <a:off x="3151200" y="182065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P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ZoneTexte 99"/>
          <p:cNvSpPr txBox="1"/>
          <p:nvPr/>
        </p:nvSpPr>
        <p:spPr>
          <a:xfrm>
            <a:off x="3151200" y="209025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3151200" y="2352437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P27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3168833" y="2622519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ZoneTexte 102"/>
          <p:cNvSpPr txBox="1"/>
          <p:nvPr/>
        </p:nvSpPr>
        <p:spPr>
          <a:xfrm>
            <a:off x="3862755" y="1093485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ZoneTexte 103"/>
          <p:cNvSpPr txBox="1"/>
          <p:nvPr/>
        </p:nvSpPr>
        <p:spPr>
          <a:xfrm>
            <a:off x="3751346" y="1333234"/>
            <a:ext cx="5854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-       +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Connecteur droit 104"/>
          <p:cNvCxnSpPr/>
          <p:nvPr/>
        </p:nvCxnSpPr>
        <p:spPr>
          <a:xfrm>
            <a:off x="3900055" y="1358668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6" name="Picture 2"/>
          <p:cNvPicPr preferRelativeResize="0">
            <a:picLocks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59368" t="13360" r="1092" b="4874"/>
          <a:stretch/>
        </p:blipFill>
        <p:spPr bwMode="auto">
          <a:xfrm flipV="1">
            <a:off x="2169022" y="1560378"/>
            <a:ext cx="648000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07" name="Picture 4"/>
          <p:cNvPicPr preferRelativeResize="0">
            <a:picLocks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60984" t="13446" r="1092" b="4597"/>
          <a:stretch/>
        </p:blipFill>
        <p:spPr bwMode="auto">
          <a:xfrm flipV="1">
            <a:off x="2169022" y="1835763"/>
            <a:ext cx="648000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108" name="ZoneTexte 107"/>
          <p:cNvSpPr txBox="1"/>
          <p:nvPr/>
        </p:nvSpPr>
        <p:spPr>
          <a:xfrm>
            <a:off x="1463642" y="2352437"/>
            <a:ext cx="7053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ZoneTexte 108"/>
          <p:cNvSpPr txBox="1"/>
          <p:nvPr/>
        </p:nvSpPr>
        <p:spPr>
          <a:xfrm>
            <a:off x="1535650" y="1545268"/>
            <a:ext cx="633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ZoneTexte 109"/>
          <p:cNvSpPr txBox="1"/>
          <p:nvPr/>
        </p:nvSpPr>
        <p:spPr>
          <a:xfrm>
            <a:off x="1374295" y="1820654"/>
            <a:ext cx="7947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casp1</a:t>
            </a:r>
          </a:p>
        </p:txBody>
      </p:sp>
      <p:sp>
        <p:nvSpPr>
          <p:cNvPr id="111" name="Rectangle 110"/>
          <p:cNvSpPr/>
          <p:nvPr/>
        </p:nvSpPr>
        <p:spPr>
          <a:xfrm>
            <a:off x="1679517" y="2090254"/>
            <a:ext cx="48950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SC                   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2" name="Image 111"/>
          <p:cNvPicPr preferRelativeResize="0">
            <a:picLocks/>
          </p:cNvPicPr>
          <p:nvPr/>
        </p:nvPicPr>
        <p:blipFill rotWithShape="1">
          <a:blip r:embed="rId11">
            <a:lum contrast="20000"/>
          </a:blip>
          <a:srcRect l="56019" t="4248" r="858" b="10872"/>
          <a:stretch/>
        </p:blipFill>
        <p:spPr>
          <a:xfrm>
            <a:off x="2169022" y="2105364"/>
            <a:ext cx="648000" cy="216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13" name="Image 112"/>
          <p:cNvPicPr preferRelativeResize="0">
            <a:picLocks/>
          </p:cNvPicPr>
          <p:nvPr/>
        </p:nvPicPr>
        <p:blipFill rotWithShape="1">
          <a:blip r:embed="rId12">
            <a:lum bright="-20000"/>
          </a:blip>
          <a:srcRect l="57904" t="6523" r="1086" b="11328"/>
          <a:stretch/>
        </p:blipFill>
        <p:spPr>
          <a:xfrm>
            <a:off x="2169022" y="2367547"/>
            <a:ext cx="648000" cy="216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14" name="ZoneTexte 113"/>
          <p:cNvSpPr txBox="1"/>
          <p:nvPr/>
        </p:nvSpPr>
        <p:spPr>
          <a:xfrm>
            <a:off x="2315528" y="1091277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ZoneTexte 114"/>
          <p:cNvSpPr txBox="1"/>
          <p:nvPr/>
        </p:nvSpPr>
        <p:spPr>
          <a:xfrm>
            <a:off x="2204119" y="1331026"/>
            <a:ext cx="5854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-       +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Connecteur droit 115"/>
          <p:cNvCxnSpPr/>
          <p:nvPr/>
        </p:nvCxnSpPr>
        <p:spPr>
          <a:xfrm>
            <a:off x="2352828" y="1356460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ZoneTexte 83"/>
          <p:cNvSpPr txBox="1"/>
          <p:nvPr/>
        </p:nvSpPr>
        <p:spPr>
          <a:xfrm>
            <a:off x="2890227" y="735119"/>
            <a:ext cx="7870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46718" y="5269572"/>
            <a:ext cx="659698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8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: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Expression of HSPs and NLRP3 </a:t>
            </a:r>
            <a:r>
              <a:rPr lang="en-US" sz="1200" b="1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inflammasome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en-US" sz="1200" b="1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contituants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in HS stimulated THP-1 cells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THP-1 cells were stimulated with 10ng/mL LPS for 20h.  Protein expression was evaluated by western blot. </a:t>
            </a:r>
            <a:r>
              <a:rPr lang="fr-FR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-Actin was used as a loading control. Data are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representative of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at least three independent experiments.</a:t>
            </a:r>
            <a:endParaRPr lang="fr-FR" sz="1200" dirty="0">
              <a:effectLst/>
              <a:latin typeface="Arial" pitchFamily="34" charset="0"/>
              <a:ea typeface="Times New Roman" panose="02020603050405020304" pitchFamily="18" charset="0"/>
              <a:cs typeface="Arial" pitchFamily="34" charset="0"/>
            </a:endParaRPr>
          </a:p>
        </p:txBody>
      </p:sp>
      <p:cxnSp>
        <p:nvCxnSpPr>
          <p:cNvPr id="35" name="Connecteur droit 34"/>
          <p:cNvCxnSpPr/>
          <p:nvPr/>
        </p:nvCxnSpPr>
        <p:spPr>
          <a:xfrm flipV="1">
            <a:off x="4369326" y="1666495"/>
            <a:ext cx="7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ZoneTexte 15"/>
          <p:cNvSpPr txBox="1"/>
          <p:nvPr/>
        </p:nvSpPr>
        <p:spPr>
          <a:xfrm>
            <a:off x="4371696" y="1547180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Connecteur droit 36"/>
          <p:cNvCxnSpPr/>
          <p:nvPr/>
        </p:nvCxnSpPr>
        <p:spPr>
          <a:xfrm flipV="1">
            <a:off x="4369326" y="1930548"/>
            <a:ext cx="7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ZoneTexte 15"/>
          <p:cNvSpPr txBox="1"/>
          <p:nvPr/>
        </p:nvSpPr>
        <p:spPr>
          <a:xfrm>
            <a:off x="4371696" y="1811233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Connecteur droit 38"/>
          <p:cNvCxnSpPr/>
          <p:nvPr/>
        </p:nvCxnSpPr>
        <p:spPr>
          <a:xfrm flipV="1">
            <a:off x="4369326" y="2215704"/>
            <a:ext cx="7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ZoneTexte 15"/>
          <p:cNvSpPr txBox="1"/>
          <p:nvPr/>
        </p:nvSpPr>
        <p:spPr>
          <a:xfrm>
            <a:off x="4371696" y="2103532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Connecteur droit 40"/>
          <p:cNvCxnSpPr/>
          <p:nvPr/>
        </p:nvCxnSpPr>
        <p:spPr>
          <a:xfrm flipV="1">
            <a:off x="4369326" y="2471521"/>
            <a:ext cx="7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15"/>
          <p:cNvSpPr txBox="1"/>
          <p:nvPr/>
        </p:nvSpPr>
        <p:spPr>
          <a:xfrm>
            <a:off x="4371696" y="2352206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Connecteur droit 42"/>
          <p:cNvCxnSpPr/>
          <p:nvPr/>
        </p:nvCxnSpPr>
        <p:spPr>
          <a:xfrm flipV="1">
            <a:off x="4369326" y="2738212"/>
            <a:ext cx="7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ZoneTexte 15"/>
          <p:cNvSpPr txBox="1"/>
          <p:nvPr/>
        </p:nvSpPr>
        <p:spPr>
          <a:xfrm>
            <a:off x="4371696" y="2618897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Connecteur droit 44"/>
          <p:cNvCxnSpPr/>
          <p:nvPr/>
        </p:nvCxnSpPr>
        <p:spPr>
          <a:xfrm flipV="1">
            <a:off x="2822319" y="1650993"/>
            <a:ext cx="7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ZoneTexte 15"/>
          <p:cNvSpPr txBox="1"/>
          <p:nvPr/>
        </p:nvSpPr>
        <p:spPr>
          <a:xfrm>
            <a:off x="2810852" y="1531678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18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Connecteur droit 46"/>
          <p:cNvCxnSpPr/>
          <p:nvPr/>
        </p:nvCxnSpPr>
        <p:spPr>
          <a:xfrm flipV="1">
            <a:off x="2822319" y="1936149"/>
            <a:ext cx="7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ZoneTexte 15"/>
          <p:cNvSpPr txBox="1"/>
          <p:nvPr/>
        </p:nvSpPr>
        <p:spPr>
          <a:xfrm>
            <a:off x="2824689" y="1823977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Connecteur droit 48"/>
          <p:cNvCxnSpPr/>
          <p:nvPr/>
        </p:nvCxnSpPr>
        <p:spPr>
          <a:xfrm flipV="1">
            <a:off x="2822319" y="2220538"/>
            <a:ext cx="7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ZoneTexte 15"/>
          <p:cNvSpPr txBox="1"/>
          <p:nvPr/>
        </p:nvSpPr>
        <p:spPr>
          <a:xfrm>
            <a:off x="2824689" y="2101223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Connecteur droit 50"/>
          <p:cNvCxnSpPr/>
          <p:nvPr/>
        </p:nvCxnSpPr>
        <p:spPr>
          <a:xfrm flipV="1">
            <a:off x="2822319" y="2487229"/>
            <a:ext cx="7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ZoneTexte 15"/>
          <p:cNvSpPr txBox="1"/>
          <p:nvPr/>
        </p:nvSpPr>
        <p:spPr>
          <a:xfrm>
            <a:off x="2824689" y="2367914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77517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4478" y="4768539"/>
            <a:ext cx="664922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9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: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Production of 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IL-1</a:t>
            </a:r>
            <a:r>
              <a:rPr lang="el-GR" sz="1200" b="1" dirty="0" smtClean="0">
                <a:latin typeface="Arial" pitchFamily="34" charset="0"/>
                <a:ea typeface="Cambria Math"/>
                <a:cs typeface="Arial" pitchFamily="34" charset="0"/>
              </a:rPr>
              <a:t>β</a:t>
            </a: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by BMDMs under HS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BMDMs from WT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C57BL/6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mice were stimulated with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300ng/mL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LPS for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3h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and then submitted or not to a heat shock (HS – 42°C for 1h followed by 2h at 37°C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)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then left untreated or treated 30min with ATP (5mM) or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eric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i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– 40µM) or 6h with MSU (100µg/mL)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upernatants were collected and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IL-1</a:t>
            </a:r>
            <a:r>
              <a:rPr lang="el-GR" sz="1200" dirty="0" smtClean="0">
                <a:latin typeface="Arial" pitchFamily="34" charset="0"/>
                <a:ea typeface="Cambria Math"/>
                <a:cs typeface="Arial" pitchFamily="34" charset="0"/>
              </a:rPr>
              <a:t>β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was measured by ELISA. Data are the mean of three experiments ±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s.d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itchFamily="34" charset="0"/>
              </a:rPr>
              <a:t>. </a:t>
            </a:r>
            <a:endParaRPr lang="fr-FR" sz="1200" dirty="0">
              <a:effectLst/>
              <a:latin typeface="Arial" pitchFamily="34" charset="0"/>
              <a:ea typeface="Times New Roman" panose="02020603050405020304" pitchFamily="18" charset="0"/>
              <a:cs typeface="Arial" pitchFamily="34" charset="0"/>
            </a:endParaRPr>
          </a:p>
        </p:txBody>
      </p:sp>
      <p:sp>
        <p:nvSpPr>
          <p:cNvPr id="4" name="Rectangle 145"/>
          <p:cNvSpPr>
            <a:spLocks noChangeArrowheads="1"/>
          </p:cNvSpPr>
          <p:nvPr/>
        </p:nvSpPr>
        <p:spPr bwMode="auto">
          <a:xfrm rot="16200000">
            <a:off x="1173778" y="2794524"/>
            <a:ext cx="76944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33039"/>
            <a:r>
              <a:rPr lang="fr-FR" altLang="fr-FR" sz="1000" dirty="0" smtClean="0">
                <a:cs typeface="Arial" panose="020B0604020202020204" pitchFamily="34" charset="0"/>
              </a:rPr>
              <a:t>IL-1</a:t>
            </a:r>
            <a:r>
              <a:rPr lang="el-GR" altLang="fr-FR" sz="1000" dirty="0" smtClean="0">
                <a:latin typeface="Cambria Math"/>
                <a:ea typeface="Cambria Math"/>
                <a:cs typeface="Arial" panose="020B0604020202020204" pitchFamily="34" charset="0"/>
              </a:rPr>
              <a:t>β</a:t>
            </a:r>
            <a:r>
              <a:rPr lang="fr-FR" altLang="fr-FR" sz="1000" dirty="0" smtClean="0">
                <a:cs typeface="Arial" panose="020B0604020202020204" pitchFamily="34" charset="0"/>
              </a:rPr>
              <a:t> </a:t>
            </a:r>
            <a:r>
              <a:rPr lang="fr-FR" altLang="fr-FR" sz="1000" dirty="0">
                <a:cs typeface="Arial" panose="020B0604020202020204" pitchFamily="34" charset="0"/>
              </a:rPr>
              <a:t>(</a:t>
            </a:r>
            <a:r>
              <a:rPr lang="fr-FR" altLang="fr-FR" sz="1000" dirty="0" err="1">
                <a:cs typeface="Arial" panose="020B0604020202020204" pitchFamily="34" charset="0"/>
              </a:rPr>
              <a:t>pg</a:t>
            </a:r>
            <a:r>
              <a:rPr lang="fr-FR" altLang="fr-FR" sz="1000" dirty="0">
                <a:cs typeface="Arial" panose="020B0604020202020204" pitchFamily="34" charset="0"/>
              </a:rPr>
              <a:t>/</a:t>
            </a:r>
            <a:r>
              <a:rPr lang="fr-FR" altLang="fr-FR" sz="1000" dirty="0" err="1">
                <a:cs typeface="Arial" panose="020B0604020202020204" pitchFamily="34" charset="0"/>
              </a:rPr>
              <a:t>mL</a:t>
            </a:r>
            <a:r>
              <a:rPr lang="fr-FR" altLang="fr-FR" sz="1000" dirty="0"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9446" y="1792277"/>
            <a:ext cx="3286125" cy="2352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830490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37</TotalTime>
  <Words>1078</Words>
  <Application>Microsoft Office PowerPoint</Application>
  <PresentationFormat>Format A4 (210 x 297 mm)</PresentationFormat>
  <Paragraphs>215</Paragraphs>
  <Slides>1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1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édric</dc:creator>
  <cp:lastModifiedBy>CGFL</cp:lastModifiedBy>
  <cp:revision>287</cp:revision>
  <cp:lastPrinted>2017-05-18T12:51:01Z</cp:lastPrinted>
  <dcterms:created xsi:type="dcterms:W3CDTF">2014-03-17T15:25:32Z</dcterms:created>
  <dcterms:modified xsi:type="dcterms:W3CDTF">2019-02-15T15:05:20Z</dcterms:modified>
</cp:coreProperties>
</file>